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tiff" ContentType="image/tiff"/>
  <Default Extension="emf" ContentType="image/x-emf"/>
  <Default Extension="rels" ContentType="application/vnd.openxmlformats-package.relationships+xml"/>
  <Default Extension="tif" ContentType="image/tiff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2"/>
  </p:notesMasterIdLst>
  <p:sldIdLst>
    <p:sldId id="403" r:id="rId2"/>
    <p:sldId id="412" r:id="rId3"/>
    <p:sldId id="413" r:id="rId4"/>
    <p:sldId id="390" r:id="rId5"/>
    <p:sldId id="392" r:id="rId6"/>
    <p:sldId id="393" r:id="rId7"/>
    <p:sldId id="394" r:id="rId8"/>
    <p:sldId id="395" r:id="rId9"/>
    <p:sldId id="396" r:id="rId10"/>
    <p:sldId id="397" r:id="rId11"/>
    <p:sldId id="398" r:id="rId12"/>
    <p:sldId id="399" r:id="rId13"/>
    <p:sldId id="400" r:id="rId14"/>
    <p:sldId id="401" r:id="rId15"/>
    <p:sldId id="402" r:id="rId16"/>
    <p:sldId id="404" r:id="rId17"/>
    <p:sldId id="405" r:id="rId18"/>
    <p:sldId id="406" r:id="rId19"/>
    <p:sldId id="407" r:id="rId20"/>
    <p:sldId id="408" r:id="rId21"/>
    <p:sldId id="414" r:id="rId22"/>
    <p:sldId id="409" r:id="rId23"/>
    <p:sldId id="416" r:id="rId24"/>
    <p:sldId id="410" r:id="rId25"/>
    <p:sldId id="411" r:id="rId26"/>
    <p:sldId id="380" r:id="rId27"/>
    <p:sldId id="381" r:id="rId28"/>
    <p:sldId id="382" r:id="rId29"/>
    <p:sldId id="383" r:id="rId30"/>
    <p:sldId id="384" r:id="rId31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B34FFF"/>
    <a:srgbClr val="FF2D77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814" autoAdjust="0"/>
    <p:restoredTop sz="91304" autoAdjust="0"/>
  </p:normalViewPr>
  <p:slideViewPr>
    <p:cSldViewPr snapToGrid="0">
      <p:cViewPr varScale="1">
        <p:scale>
          <a:sx n="99" d="100"/>
          <a:sy n="99" d="100"/>
        </p:scale>
        <p:origin x="176" y="1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notesMaster" Target="notesMasters/notesMaster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presProps" Target="presProps.xml"/><Relationship Id="rId34" Type="http://schemas.openxmlformats.org/officeDocument/2006/relationships/viewProps" Target="viewProps.xml"/><Relationship Id="rId35" Type="http://schemas.openxmlformats.org/officeDocument/2006/relationships/theme" Target="theme/theme1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\\localhost\Users\FumiakiSato\Dropbox\&#12394;&#12388;&#12360;folder\IlluminaHM450\HM450_1_120_meantable&#25244;&#31883;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microsoft.com/office/2011/relationships/chartStyle" Target="style10.xml"/><Relationship Id="rId2" Type="http://schemas.microsoft.com/office/2011/relationships/chartColorStyle" Target="colors10.xml"/><Relationship Id="rId3" Type="http://schemas.openxmlformats.org/officeDocument/2006/relationships/oleObject" Target="file:///\\localhost\Users\FumiakiSato\Dropbox\&#12394;&#12388;&#12360;folder\IlluminaHM450\HM450_1_120_meantable&#25244;&#31883;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microsoft.com/office/2011/relationships/chartStyle" Target="style11.xml"/><Relationship Id="rId2" Type="http://schemas.microsoft.com/office/2011/relationships/chartColorStyle" Target="colors11.xml"/><Relationship Id="rId3" Type="http://schemas.openxmlformats.org/officeDocument/2006/relationships/oleObject" Target="file:///\\localhost\Users\FumiakiSato\Dropbox\&#12394;&#12388;&#12360;folder\IlluminaHM450\HM450_1_120_meantable&#25244;&#31883;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microsoft.com/office/2011/relationships/chartStyle" Target="style12.xml"/><Relationship Id="rId2" Type="http://schemas.microsoft.com/office/2011/relationships/chartColorStyle" Target="colors12.xml"/><Relationship Id="rId3" Type="http://schemas.openxmlformats.org/officeDocument/2006/relationships/oleObject" Target="file:///\\localhost\Users\FumiakiSato\Dropbox\&#27425;&#19990;&#20195;&#35299;&#26512;\&#27425;&#19990;&#20195;&#35542;&#25991;\Supplement%20table%20v2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microsoft.com/office/2011/relationships/chartStyle" Target="style13.xml"/><Relationship Id="rId2" Type="http://schemas.microsoft.com/office/2011/relationships/chartColorStyle" Target="colors13.xml"/><Relationship Id="rId3" Type="http://schemas.openxmlformats.org/officeDocument/2006/relationships/oleObject" Target="file:///G:\HM450K%20after%20PBC\MSP%20Control\BBB%20samples%20MSP%20control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microsoft.com/office/2011/relationships/chartStyle" Target="style14.xml"/><Relationship Id="rId2" Type="http://schemas.microsoft.com/office/2011/relationships/chartColorStyle" Target="colors14.xml"/><Relationship Id="rId3" Type="http://schemas.openxmlformats.org/officeDocument/2006/relationships/oleObject" Target="file:///G:\pearson%20HV%20new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\\localhost\Users\FumiakiSato\Dropbox\&#27425;&#19990;&#20195;&#35299;&#26512;\&#27425;&#19990;&#20195;&#35542;&#25991;\Supplement%20table%20v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\\localhost\Users\FumiakiSato\Dropbox\&#27425;&#19990;&#20195;&#35299;&#26512;\&#27425;&#19990;&#20195;&#35542;&#25991;\Supplement%20table%20v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\\localhost\Users\FumiakiSato\Dropbox\&#27425;&#19990;&#20195;&#35299;&#26512;\&#27425;&#19990;&#20195;&#35542;&#25991;\Supplement%20table%20v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oleObject" Target="file:///\\localhost\Users\FumiakiSato\Dropbox\&#27425;&#19990;&#20195;&#35299;&#26512;\&#27425;&#19990;&#20195;&#35542;&#25991;\Supplement%20table%20v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6.xml"/><Relationship Id="rId2" Type="http://schemas.microsoft.com/office/2011/relationships/chartColorStyle" Target="colors6.xml"/><Relationship Id="rId3" Type="http://schemas.openxmlformats.org/officeDocument/2006/relationships/oleObject" Target="file:///\\localhost\Users\FumiakiSato\Dropbox\&#12394;&#12388;&#12360;folder\IlluminaHM450\HM450_1_120_meantable&#25244;&#31883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microsoft.com/office/2011/relationships/chartStyle" Target="style7.xml"/><Relationship Id="rId2" Type="http://schemas.microsoft.com/office/2011/relationships/chartColorStyle" Target="colors7.xml"/><Relationship Id="rId3" Type="http://schemas.openxmlformats.org/officeDocument/2006/relationships/oleObject" Target="file:///\\localhost\Users\FumiakiSato\Dropbox\&#27425;&#19990;&#20195;&#35299;&#26512;\&#27425;&#19990;&#20195;&#35542;&#25991;\Supplement%20table%20v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microsoft.com/office/2011/relationships/chartStyle" Target="style8.xml"/><Relationship Id="rId2" Type="http://schemas.microsoft.com/office/2011/relationships/chartColorStyle" Target="colors8.xml"/><Relationship Id="rId3" Type="http://schemas.openxmlformats.org/officeDocument/2006/relationships/oleObject" Target="file:///\\localhost\Users\FumiakiSato\Dropbox\&#27425;&#19990;&#20195;&#35299;&#26512;\&#27425;&#19990;&#20195;&#35542;&#25991;\Supplement%20table%20v2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microsoft.com/office/2011/relationships/chartStyle" Target="style9.xml"/><Relationship Id="rId2" Type="http://schemas.microsoft.com/office/2011/relationships/chartColorStyle" Target="colors9.xml"/><Relationship Id="rId3" Type="http://schemas.openxmlformats.org/officeDocument/2006/relationships/oleObject" Target="file:///\\localhost\Users\FumiakiSato\Dropbox\&#12394;&#12388;&#12360;folder\IlluminaHM450\HM450_1_120_meantable&#25244;&#31883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583629839346399"/>
          <c:y val="0.050059932376962"/>
          <c:w val="0.888529226922952"/>
          <c:h val="0.638460008202411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extracteddata!$D$5:$D$22</c:f>
              <c:numCache>
                <c:formatCode>General</c:formatCode>
                <c:ptCount val="18"/>
                <c:pt idx="0">
                  <c:v>1.7955043E7</c:v>
                </c:pt>
                <c:pt idx="1">
                  <c:v>1.7957106E7</c:v>
                </c:pt>
                <c:pt idx="2">
                  <c:v>1.7958339E7</c:v>
                </c:pt>
                <c:pt idx="3">
                  <c:v>1.7958505E7</c:v>
                </c:pt>
                <c:pt idx="4">
                  <c:v>1.7958633E7</c:v>
                </c:pt>
                <c:pt idx="5">
                  <c:v>1.7958647E7</c:v>
                </c:pt>
                <c:pt idx="6">
                  <c:v>1.7958736E7</c:v>
                </c:pt>
                <c:pt idx="7">
                  <c:v>1.7958825E7</c:v>
                </c:pt>
                <c:pt idx="8">
                  <c:v>1.7958892E7</c:v>
                </c:pt>
                <c:pt idx="9">
                  <c:v>1.7958905E7</c:v>
                </c:pt>
                <c:pt idx="10">
                  <c:v>1.7958937E7</c:v>
                </c:pt>
                <c:pt idx="11">
                  <c:v>1.7958956E7</c:v>
                </c:pt>
                <c:pt idx="12">
                  <c:v>1.7958961E7</c:v>
                </c:pt>
                <c:pt idx="13">
                  <c:v>1.7959046E7</c:v>
                </c:pt>
                <c:pt idx="14">
                  <c:v>1.7959082E7</c:v>
                </c:pt>
                <c:pt idx="15">
                  <c:v>1.7959281E7</c:v>
                </c:pt>
                <c:pt idx="16">
                  <c:v>1.7960227E7</c:v>
                </c:pt>
                <c:pt idx="17">
                  <c:v>1.7961566E7</c:v>
                </c:pt>
              </c:numCache>
            </c:numRef>
          </c:xVal>
          <c:yVal>
            <c:numRef>
              <c:f>extracteddata!$F$5:$F$22</c:f>
              <c:numCache>
                <c:formatCode>General</c:formatCode>
                <c:ptCount val="18"/>
                <c:pt idx="0">
                  <c:v>0.840061672197431</c:v>
                </c:pt>
                <c:pt idx="1">
                  <c:v>0.954923637862903</c:v>
                </c:pt>
                <c:pt idx="2">
                  <c:v>0.59641354958184</c:v>
                </c:pt>
                <c:pt idx="3">
                  <c:v>0.355460605558244</c:v>
                </c:pt>
                <c:pt idx="4">
                  <c:v>0.588100428879032</c:v>
                </c:pt>
                <c:pt idx="5">
                  <c:v>0.639072570269713</c:v>
                </c:pt>
                <c:pt idx="6">
                  <c:v>0.762109224148746</c:v>
                </c:pt>
                <c:pt idx="7">
                  <c:v>0.62291807242055</c:v>
                </c:pt>
                <c:pt idx="8">
                  <c:v>0.545391476285245</c:v>
                </c:pt>
                <c:pt idx="9">
                  <c:v>0.652421864750896</c:v>
                </c:pt>
                <c:pt idx="10">
                  <c:v>0.873256298148447</c:v>
                </c:pt>
                <c:pt idx="11">
                  <c:v>0.860886287774193</c:v>
                </c:pt>
                <c:pt idx="12">
                  <c:v>0.711199266245221</c:v>
                </c:pt>
                <c:pt idx="13">
                  <c:v>0.769433566873656</c:v>
                </c:pt>
                <c:pt idx="14">
                  <c:v>0.587081100382915</c:v>
                </c:pt>
                <c:pt idx="15">
                  <c:v>0.49571562047043</c:v>
                </c:pt>
                <c:pt idx="16">
                  <c:v>0.777099547861709</c:v>
                </c:pt>
                <c:pt idx="17">
                  <c:v>0.0956927884925329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extracteddata!$D$5:$D$22</c:f>
              <c:numCache>
                <c:formatCode>General</c:formatCode>
                <c:ptCount val="18"/>
                <c:pt idx="0">
                  <c:v>1.7955043E7</c:v>
                </c:pt>
                <c:pt idx="1">
                  <c:v>1.7957106E7</c:v>
                </c:pt>
                <c:pt idx="2">
                  <c:v>1.7958339E7</c:v>
                </c:pt>
                <c:pt idx="3">
                  <c:v>1.7958505E7</c:v>
                </c:pt>
                <c:pt idx="4">
                  <c:v>1.7958633E7</c:v>
                </c:pt>
                <c:pt idx="5">
                  <c:v>1.7958647E7</c:v>
                </c:pt>
                <c:pt idx="6">
                  <c:v>1.7958736E7</c:v>
                </c:pt>
                <c:pt idx="7">
                  <c:v>1.7958825E7</c:v>
                </c:pt>
                <c:pt idx="8">
                  <c:v>1.7958892E7</c:v>
                </c:pt>
                <c:pt idx="9">
                  <c:v>1.7958905E7</c:v>
                </c:pt>
                <c:pt idx="10">
                  <c:v>1.7958937E7</c:v>
                </c:pt>
                <c:pt idx="11">
                  <c:v>1.7958956E7</c:v>
                </c:pt>
                <c:pt idx="12">
                  <c:v>1.7958961E7</c:v>
                </c:pt>
                <c:pt idx="13">
                  <c:v>1.7959046E7</c:v>
                </c:pt>
                <c:pt idx="14">
                  <c:v>1.7959082E7</c:v>
                </c:pt>
                <c:pt idx="15">
                  <c:v>1.7959281E7</c:v>
                </c:pt>
                <c:pt idx="16">
                  <c:v>1.7960227E7</c:v>
                </c:pt>
                <c:pt idx="17">
                  <c:v>1.7961566E7</c:v>
                </c:pt>
              </c:numCache>
            </c:numRef>
          </c:xVal>
          <c:yVal>
            <c:numRef>
              <c:f>extracteddata!$G$5:$G$22</c:f>
              <c:numCache>
                <c:formatCode>General</c:formatCode>
                <c:ptCount val="18"/>
                <c:pt idx="0">
                  <c:v>0.929523053371429</c:v>
                </c:pt>
                <c:pt idx="1">
                  <c:v>0.203120484428571</c:v>
                </c:pt>
                <c:pt idx="2">
                  <c:v>0.123064838</c:v>
                </c:pt>
                <c:pt idx="3">
                  <c:v>0.0336377509142857</c:v>
                </c:pt>
                <c:pt idx="4">
                  <c:v>0.0250128875428572</c:v>
                </c:pt>
                <c:pt idx="5">
                  <c:v>0.0358977728</c:v>
                </c:pt>
                <c:pt idx="6">
                  <c:v>0.0253248099714286</c:v>
                </c:pt>
                <c:pt idx="7">
                  <c:v>0.0459427079142857</c:v>
                </c:pt>
                <c:pt idx="8">
                  <c:v>0.0395710329714286</c:v>
                </c:pt>
                <c:pt idx="9">
                  <c:v>0.0429440325428571</c:v>
                </c:pt>
                <c:pt idx="10">
                  <c:v>0.0479047789714286</c:v>
                </c:pt>
                <c:pt idx="11">
                  <c:v>0.0545792712</c:v>
                </c:pt>
                <c:pt idx="12">
                  <c:v>0.0444559903428571</c:v>
                </c:pt>
                <c:pt idx="13">
                  <c:v>0.0997273591428571</c:v>
                </c:pt>
                <c:pt idx="14">
                  <c:v>0.0934357855714286</c:v>
                </c:pt>
                <c:pt idx="15">
                  <c:v>0.4696294634</c:v>
                </c:pt>
                <c:pt idx="16">
                  <c:v>0.866598643771429</c:v>
                </c:pt>
                <c:pt idx="17">
                  <c:v>0.0466407295142857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extracteddata!$D$5:$D$22</c:f>
              <c:numCache>
                <c:formatCode>General</c:formatCode>
                <c:ptCount val="18"/>
                <c:pt idx="0">
                  <c:v>1.7955043E7</c:v>
                </c:pt>
                <c:pt idx="1">
                  <c:v>1.7957106E7</c:v>
                </c:pt>
                <c:pt idx="2">
                  <c:v>1.7958339E7</c:v>
                </c:pt>
                <c:pt idx="3">
                  <c:v>1.7958505E7</c:v>
                </c:pt>
                <c:pt idx="4">
                  <c:v>1.7958633E7</c:v>
                </c:pt>
                <c:pt idx="5">
                  <c:v>1.7958647E7</c:v>
                </c:pt>
                <c:pt idx="6">
                  <c:v>1.7958736E7</c:v>
                </c:pt>
                <c:pt idx="7">
                  <c:v>1.7958825E7</c:v>
                </c:pt>
                <c:pt idx="8">
                  <c:v>1.7958892E7</c:v>
                </c:pt>
                <c:pt idx="9">
                  <c:v>1.7958905E7</c:v>
                </c:pt>
                <c:pt idx="10">
                  <c:v>1.7958937E7</c:v>
                </c:pt>
                <c:pt idx="11">
                  <c:v>1.7958956E7</c:v>
                </c:pt>
                <c:pt idx="12">
                  <c:v>1.7958961E7</c:v>
                </c:pt>
                <c:pt idx="13">
                  <c:v>1.7959046E7</c:v>
                </c:pt>
                <c:pt idx="14">
                  <c:v>1.7959082E7</c:v>
                </c:pt>
                <c:pt idx="15">
                  <c:v>1.7959281E7</c:v>
                </c:pt>
                <c:pt idx="16">
                  <c:v>1.7960227E7</c:v>
                </c:pt>
                <c:pt idx="17">
                  <c:v>1.7961566E7</c:v>
                </c:pt>
              </c:numCache>
            </c:numRef>
          </c:xVal>
          <c:yVal>
            <c:numRef>
              <c:f>extracteddata!$H$5:$H$22</c:f>
              <c:numCache>
                <c:formatCode>General</c:formatCode>
                <c:ptCount val="18"/>
                <c:pt idx="0">
                  <c:v>0.864692446739474</c:v>
                </c:pt>
                <c:pt idx="1">
                  <c:v>0.964874282878947</c:v>
                </c:pt>
                <c:pt idx="2">
                  <c:v>0.569404637368421</c:v>
                </c:pt>
                <c:pt idx="3">
                  <c:v>0.363365093681579</c:v>
                </c:pt>
                <c:pt idx="4">
                  <c:v>0.685874029586842</c:v>
                </c:pt>
                <c:pt idx="5">
                  <c:v>0.724992388394737</c:v>
                </c:pt>
                <c:pt idx="6">
                  <c:v>0.831728694078948</c:v>
                </c:pt>
                <c:pt idx="7">
                  <c:v>0.700252057171053</c:v>
                </c:pt>
                <c:pt idx="8">
                  <c:v>0.571101452989474</c:v>
                </c:pt>
                <c:pt idx="9">
                  <c:v>0.663290033539474</c:v>
                </c:pt>
                <c:pt idx="10">
                  <c:v>0.922181428957895</c:v>
                </c:pt>
                <c:pt idx="11">
                  <c:v>0.919159601268421</c:v>
                </c:pt>
                <c:pt idx="12">
                  <c:v>0.819546115321053</c:v>
                </c:pt>
                <c:pt idx="13">
                  <c:v>0.778222635442105</c:v>
                </c:pt>
                <c:pt idx="14">
                  <c:v>0.653254399568421</c:v>
                </c:pt>
                <c:pt idx="15">
                  <c:v>0.453473317105263</c:v>
                </c:pt>
                <c:pt idx="16">
                  <c:v>0.838376646336842</c:v>
                </c:pt>
                <c:pt idx="17">
                  <c:v>0.101540917168421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D$5:$D$22</c:f>
              <c:numCache>
                <c:formatCode>General</c:formatCode>
                <c:ptCount val="18"/>
                <c:pt idx="0">
                  <c:v>1.7955043E7</c:v>
                </c:pt>
                <c:pt idx="1">
                  <c:v>1.7957106E7</c:v>
                </c:pt>
                <c:pt idx="2">
                  <c:v>1.7958339E7</c:v>
                </c:pt>
                <c:pt idx="3">
                  <c:v>1.7958505E7</c:v>
                </c:pt>
                <c:pt idx="4">
                  <c:v>1.7958633E7</c:v>
                </c:pt>
                <c:pt idx="5">
                  <c:v>1.7958647E7</c:v>
                </c:pt>
                <c:pt idx="6">
                  <c:v>1.7958736E7</c:v>
                </c:pt>
                <c:pt idx="7">
                  <c:v>1.7958825E7</c:v>
                </c:pt>
                <c:pt idx="8">
                  <c:v>1.7958892E7</c:v>
                </c:pt>
                <c:pt idx="9">
                  <c:v>1.7958905E7</c:v>
                </c:pt>
                <c:pt idx="10">
                  <c:v>1.7958937E7</c:v>
                </c:pt>
                <c:pt idx="11">
                  <c:v>1.7958956E7</c:v>
                </c:pt>
                <c:pt idx="12">
                  <c:v>1.7958961E7</c:v>
                </c:pt>
                <c:pt idx="13">
                  <c:v>1.7959046E7</c:v>
                </c:pt>
                <c:pt idx="14">
                  <c:v>1.7959082E7</c:v>
                </c:pt>
                <c:pt idx="15">
                  <c:v>1.7959281E7</c:v>
                </c:pt>
                <c:pt idx="16">
                  <c:v>1.7960227E7</c:v>
                </c:pt>
                <c:pt idx="17">
                  <c:v>1.7961566E7</c:v>
                </c:pt>
              </c:numCache>
            </c:numRef>
          </c:xVal>
          <c:yVal>
            <c:numRef>
              <c:f>extracteddata!$I$5:$I$22</c:f>
              <c:numCache>
                <c:formatCode>General</c:formatCode>
                <c:ptCount val="18"/>
                <c:pt idx="0">
                  <c:v>0.791695456363636</c:v>
                </c:pt>
                <c:pt idx="1">
                  <c:v>0.942015113386364</c:v>
                </c:pt>
                <c:pt idx="2">
                  <c:v>0.550274095454545</c:v>
                </c:pt>
                <c:pt idx="3">
                  <c:v>0.383394823977273</c:v>
                </c:pt>
                <c:pt idx="4">
                  <c:v>0.514118288431818</c:v>
                </c:pt>
                <c:pt idx="5">
                  <c:v>0.579105088477273</c:v>
                </c:pt>
                <c:pt idx="6">
                  <c:v>0.678943808181818</c:v>
                </c:pt>
                <c:pt idx="7">
                  <c:v>0.549521323045455</c:v>
                </c:pt>
                <c:pt idx="8">
                  <c:v>0.508076907045455</c:v>
                </c:pt>
                <c:pt idx="9">
                  <c:v>0.649311164363636</c:v>
                </c:pt>
                <c:pt idx="10">
                  <c:v>0.796890176204545</c:v>
                </c:pt>
                <c:pt idx="11">
                  <c:v>0.786919965681818</c:v>
                </c:pt>
                <c:pt idx="12">
                  <c:v>0.612790224386364</c:v>
                </c:pt>
                <c:pt idx="13">
                  <c:v>0.80884471625</c:v>
                </c:pt>
                <c:pt idx="14">
                  <c:v>0.585193490136364</c:v>
                </c:pt>
                <c:pt idx="15">
                  <c:v>0.499876589022727</c:v>
                </c:pt>
                <c:pt idx="16">
                  <c:v>0.682554121454545</c:v>
                </c:pt>
                <c:pt idx="17">
                  <c:v>0.0863161887045455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J$13:$J$14</c:f>
              <c:numCache>
                <c:formatCode>General</c:formatCode>
                <c:ptCount val="2"/>
                <c:pt idx="0">
                  <c:v>1.7958937E7</c:v>
                </c:pt>
                <c:pt idx="1">
                  <c:v>1.7958937E7</c:v>
                </c:pt>
              </c:numCache>
            </c:numRef>
          </c:xVal>
          <c:yVal>
            <c:numRef>
              <c:f>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805354816"/>
        <c:axId val="-1094838160"/>
      </c:scatterChart>
      <c:valAx>
        <c:axId val="-1805354816"/>
        <c:scaling>
          <c:orientation val="minMax"/>
          <c:max val="1.7961937E7"/>
          <c:min val="1.7955937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094838160"/>
        <c:crosses val="autoZero"/>
        <c:crossBetween val="midCat"/>
        <c:majorUnit val="1000.0"/>
      </c:valAx>
      <c:valAx>
        <c:axId val="-109483816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805354816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61595895732283"/>
          <c:h val="0.719243624494964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extracteddata!$D$195:$D$223</c:f>
              <c:numCache>
                <c:formatCode>General</c:formatCode>
                <c:ptCount val="29"/>
                <c:pt idx="0">
                  <c:v>7.2202615E7</c:v>
                </c:pt>
                <c:pt idx="1">
                  <c:v>7.2208666E7</c:v>
                </c:pt>
                <c:pt idx="2">
                  <c:v>7.2246001E7</c:v>
                </c:pt>
                <c:pt idx="3">
                  <c:v>7.2248378E7</c:v>
                </c:pt>
                <c:pt idx="4">
                  <c:v>7.2249085E7</c:v>
                </c:pt>
                <c:pt idx="5">
                  <c:v>7.2249338E7</c:v>
                </c:pt>
                <c:pt idx="6">
                  <c:v>7.2249355E7</c:v>
                </c:pt>
                <c:pt idx="7">
                  <c:v>7.2249465E7</c:v>
                </c:pt>
                <c:pt idx="8">
                  <c:v>7.2253329E7</c:v>
                </c:pt>
                <c:pt idx="9">
                  <c:v>7.2259543E7</c:v>
                </c:pt>
                <c:pt idx="10">
                  <c:v>7.233442E7</c:v>
                </c:pt>
                <c:pt idx="11">
                  <c:v>7.2408747E7</c:v>
                </c:pt>
                <c:pt idx="12">
                  <c:v>7.240875E7</c:v>
                </c:pt>
                <c:pt idx="13">
                  <c:v>7.2420299E7</c:v>
                </c:pt>
                <c:pt idx="14">
                  <c:v>7.2438249E7</c:v>
                </c:pt>
                <c:pt idx="15">
                  <c:v>7.2438678E7</c:v>
                </c:pt>
                <c:pt idx="16">
                  <c:v>7.2438879E7</c:v>
                </c:pt>
                <c:pt idx="17">
                  <c:v>7.2439386E7</c:v>
                </c:pt>
                <c:pt idx="18">
                  <c:v>7.2439698E7</c:v>
                </c:pt>
                <c:pt idx="19">
                  <c:v>7.2439779E7</c:v>
                </c:pt>
                <c:pt idx="20">
                  <c:v>7.2440409E7</c:v>
                </c:pt>
                <c:pt idx="21">
                  <c:v>7.2441146E7</c:v>
                </c:pt>
                <c:pt idx="22">
                  <c:v>7.2441171E7</c:v>
                </c:pt>
                <c:pt idx="23">
                  <c:v>7.2441184E7</c:v>
                </c:pt>
                <c:pt idx="24">
                  <c:v>7.2441404E7</c:v>
                </c:pt>
                <c:pt idx="25">
                  <c:v>7.2441515E7</c:v>
                </c:pt>
                <c:pt idx="26">
                  <c:v>7.2441523E7</c:v>
                </c:pt>
                <c:pt idx="27">
                  <c:v>7.2441676E7</c:v>
                </c:pt>
                <c:pt idx="28">
                  <c:v>7.2441711E7</c:v>
                </c:pt>
              </c:numCache>
            </c:numRef>
          </c:xVal>
          <c:yVal>
            <c:numRef>
              <c:f>extracteddata!$F$195:$F$223</c:f>
              <c:numCache>
                <c:formatCode>General</c:formatCode>
                <c:ptCount val="29"/>
                <c:pt idx="0">
                  <c:v>0.364000297298088</c:v>
                </c:pt>
                <c:pt idx="1">
                  <c:v>0.767278610896953</c:v>
                </c:pt>
                <c:pt idx="2">
                  <c:v>0.838121899349462</c:v>
                </c:pt>
                <c:pt idx="3">
                  <c:v>0.786397298831482</c:v>
                </c:pt>
                <c:pt idx="4">
                  <c:v>0.825154681501494</c:v>
                </c:pt>
                <c:pt idx="5">
                  <c:v>0.937509729961768</c:v>
                </c:pt>
                <c:pt idx="6">
                  <c:v>0.736431657265233</c:v>
                </c:pt>
                <c:pt idx="7">
                  <c:v>0.904931789883811</c:v>
                </c:pt>
                <c:pt idx="8">
                  <c:v>0.853372055412784</c:v>
                </c:pt>
                <c:pt idx="9">
                  <c:v>0.752413499050478</c:v>
                </c:pt>
                <c:pt idx="10">
                  <c:v>0.845114632476703</c:v>
                </c:pt>
                <c:pt idx="11">
                  <c:v>0.866146352815412</c:v>
                </c:pt>
                <c:pt idx="12">
                  <c:v>0.821551577983871</c:v>
                </c:pt>
                <c:pt idx="13">
                  <c:v>0.906890341800179</c:v>
                </c:pt>
                <c:pt idx="14">
                  <c:v>0.451217209356332</c:v>
                </c:pt>
                <c:pt idx="15">
                  <c:v>0.230522154205795</c:v>
                </c:pt>
                <c:pt idx="16">
                  <c:v>0.094714347442055</c:v>
                </c:pt>
                <c:pt idx="17">
                  <c:v>0.148662314035245</c:v>
                </c:pt>
                <c:pt idx="18">
                  <c:v>0.0779385157628435</c:v>
                </c:pt>
                <c:pt idx="19">
                  <c:v>0.0713507473509558</c:v>
                </c:pt>
                <c:pt idx="20">
                  <c:v>0.0766984050633214</c:v>
                </c:pt>
                <c:pt idx="21">
                  <c:v>0.0709108988990442</c:v>
                </c:pt>
                <c:pt idx="22">
                  <c:v>0.0669061720143369</c:v>
                </c:pt>
                <c:pt idx="23">
                  <c:v>0.0731339672869751</c:v>
                </c:pt>
                <c:pt idx="24">
                  <c:v>0.0356143134274194</c:v>
                </c:pt>
                <c:pt idx="25">
                  <c:v>0.0958266447592593</c:v>
                </c:pt>
                <c:pt idx="26">
                  <c:v>0.262500186200717</c:v>
                </c:pt>
                <c:pt idx="27">
                  <c:v>0.111187546612903</c:v>
                </c:pt>
                <c:pt idx="28">
                  <c:v>0.324362255973716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extracteddata!$D$195:$D$223</c:f>
              <c:numCache>
                <c:formatCode>General</c:formatCode>
                <c:ptCount val="29"/>
                <c:pt idx="0">
                  <c:v>7.2202615E7</c:v>
                </c:pt>
                <c:pt idx="1">
                  <c:v>7.2208666E7</c:v>
                </c:pt>
                <c:pt idx="2">
                  <c:v>7.2246001E7</c:v>
                </c:pt>
                <c:pt idx="3">
                  <c:v>7.2248378E7</c:v>
                </c:pt>
                <c:pt idx="4">
                  <c:v>7.2249085E7</c:v>
                </c:pt>
                <c:pt idx="5">
                  <c:v>7.2249338E7</c:v>
                </c:pt>
                <c:pt idx="6">
                  <c:v>7.2249355E7</c:v>
                </c:pt>
                <c:pt idx="7">
                  <c:v>7.2249465E7</c:v>
                </c:pt>
                <c:pt idx="8">
                  <c:v>7.2253329E7</c:v>
                </c:pt>
                <c:pt idx="9">
                  <c:v>7.2259543E7</c:v>
                </c:pt>
                <c:pt idx="10">
                  <c:v>7.233442E7</c:v>
                </c:pt>
                <c:pt idx="11">
                  <c:v>7.2408747E7</c:v>
                </c:pt>
                <c:pt idx="12">
                  <c:v>7.240875E7</c:v>
                </c:pt>
                <c:pt idx="13">
                  <c:v>7.2420299E7</c:v>
                </c:pt>
                <c:pt idx="14">
                  <c:v>7.2438249E7</c:v>
                </c:pt>
                <c:pt idx="15">
                  <c:v>7.2438678E7</c:v>
                </c:pt>
                <c:pt idx="16">
                  <c:v>7.2438879E7</c:v>
                </c:pt>
                <c:pt idx="17">
                  <c:v>7.2439386E7</c:v>
                </c:pt>
                <c:pt idx="18">
                  <c:v>7.2439698E7</c:v>
                </c:pt>
                <c:pt idx="19">
                  <c:v>7.2439779E7</c:v>
                </c:pt>
                <c:pt idx="20">
                  <c:v>7.2440409E7</c:v>
                </c:pt>
                <c:pt idx="21">
                  <c:v>7.2441146E7</c:v>
                </c:pt>
                <c:pt idx="22">
                  <c:v>7.2441171E7</c:v>
                </c:pt>
                <c:pt idx="23">
                  <c:v>7.2441184E7</c:v>
                </c:pt>
                <c:pt idx="24">
                  <c:v>7.2441404E7</c:v>
                </c:pt>
                <c:pt idx="25">
                  <c:v>7.2441515E7</c:v>
                </c:pt>
                <c:pt idx="26">
                  <c:v>7.2441523E7</c:v>
                </c:pt>
                <c:pt idx="27">
                  <c:v>7.2441676E7</c:v>
                </c:pt>
                <c:pt idx="28">
                  <c:v>7.2441711E7</c:v>
                </c:pt>
              </c:numCache>
            </c:numRef>
          </c:xVal>
          <c:yVal>
            <c:numRef>
              <c:f>extracteddata!$G$195:$G$223</c:f>
              <c:numCache>
                <c:formatCode>General</c:formatCode>
                <c:ptCount val="29"/>
                <c:pt idx="0">
                  <c:v>0.8899360398</c:v>
                </c:pt>
                <c:pt idx="1">
                  <c:v>0.943564182914286</c:v>
                </c:pt>
                <c:pt idx="2">
                  <c:v>0.9545181732</c:v>
                </c:pt>
                <c:pt idx="3">
                  <c:v>0.940042410342857</c:v>
                </c:pt>
                <c:pt idx="4">
                  <c:v>0.921699424971429</c:v>
                </c:pt>
                <c:pt idx="5">
                  <c:v>0.954279553514286</c:v>
                </c:pt>
                <c:pt idx="6">
                  <c:v>0.710119541971429</c:v>
                </c:pt>
                <c:pt idx="7">
                  <c:v>0.9159341792</c:v>
                </c:pt>
                <c:pt idx="8">
                  <c:v>0.945940826828572</c:v>
                </c:pt>
                <c:pt idx="9">
                  <c:v>0.956353173314286</c:v>
                </c:pt>
                <c:pt idx="10">
                  <c:v>0.965389560942857</c:v>
                </c:pt>
                <c:pt idx="11">
                  <c:v>0.976351269285714</c:v>
                </c:pt>
                <c:pt idx="12">
                  <c:v>0.968981788571429</c:v>
                </c:pt>
                <c:pt idx="13">
                  <c:v>0.973482906542857</c:v>
                </c:pt>
                <c:pt idx="14">
                  <c:v>0.141063972114286</c:v>
                </c:pt>
                <c:pt idx="15">
                  <c:v>0.0287821076571429</c:v>
                </c:pt>
                <c:pt idx="16">
                  <c:v>0.0396902608571428</c:v>
                </c:pt>
                <c:pt idx="17">
                  <c:v>0.049769408</c:v>
                </c:pt>
                <c:pt idx="18">
                  <c:v>0.0310699799142857</c:v>
                </c:pt>
                <c:pt idx="19">
                  <c:v>0.0149258764</c:v>
                </c:pt>
                <c:pt idx="20">
                  <c:v>0.0676564652285714</c:v>
                </c:pt>
                <c:pt idx="21">
                  <c:v>0.0255350647142857</c:v>
                </c:pt>
                <c:pt idx="22">
                  <c:v>0.0238944132</c:v>
                </c:pt>
                <c:pt idx="23">
                  <c:v>0.0278952940857143</c:v>
                </c:pt>
                <c:pt idx="24">
                  <c:v>0.0268065548285714</c:v>
                </c:pt>
                <c:pt idx="25">
                  <c:v>0.0545913704571429</c:v>
                </c:pt>
                <c:pt idx="26">
                  <c:v>0.156432662857143</c:v>
                </c:pt>
                <c:pt idx="27">
                  <c:v>0.0327085638285714</c:v>
                </c:pt>
                <c:pt idx="28">
                  <c:v>0.178445671428571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extracteddata!$D$195:$D$223</c:f>
              <c:numCache>
                <c:formatCode>General</c:formatCode>
                <c:ptCount val="29"/>
                <c:pt idx="0">
                  <c:v>7.2202615E7</c:v>
                </c:pt>
                <c:pt idx="1">
                  <c:v>7.2208666E7</c:v>
                </c:pt>
                <c:pt idx="2">
                  <c:v>7.2246001E7</c:v>
                </c:pt>
                <c:pt idx="3">
                  <c:v>7.2248378E7</c:v>
                </c:pt>
                <c:pt idx="4">
                  <c:v>7.2249085E7</c:v>
                </c:pt>
                <c:pt idx="5">
                  <c:v>7.2249338E7</c:v>
                </c:pt>
                <c:pt idx="6">
                  <c:v>7.2249355E7</c:v>
                </c:pt>
                <c:pt idx="7">
                  <c:v>7.2249465E7</c:v>
                </c:pt>
                <c:pt idx="8">
                  <c:v>7.2253329E7</c:v>
                </c:pt>
                <c:pt idx="9">
                  <c:v>7.2259543E7</c:v>
                </c:pt>
                <c:pt idx="10">
                  <c:v>7.233442E7</c:v>
                </c:pt>
                <c:pt idx="11">
                  <c:v>7.2408747E7</c:v>
                </c:pt>
                <c:pt idx="12">
                  <c:v>7.240875E7</c:v>
                </c:pt>
                <c:pt idx="13">
                  <c:v>7.2420299E7</c:v>
                </c:pt>
                <c:pt idx="14">
                  <c:v>7.2438249E7</c:v>
                </c:pt>
                <c:pt idx="15">
                  <c:v>7.2438678E7</c:v>
                </c:pt>
                <c:pt idx="16">
                  <c:v>7.2438879E7</c:v>
                </c:pt>
                <c:pt idx="17">
                  <c:v>7.2439386E7</c:v>
                </c:pt>
                <c:pt idx="18">
                  <c:v>7.2439698E7</c:v>
                </c:pt>
                <c:pt idx="19">
                  <c:v>7.2439779E7</c:v>
                </c:pt>
                <c:pt idx="20">
                  <c:v>7.2440409E7</c:v>
                </c:pt>
                <c:pt idx="21">
                  <c:v>7.2441146E7</c:v>
                </c:pt>
                <c:pt idx="22">
                  <c:v>7.2441171E7</c:v>
                </c:pt>
                <c:pt idx="23">
                  <c:v>7.2441184E7</c:v>
                </c:pt>
                <c:pt idx="24">
                  <c:v>7.2441404E7</c:v>
                </c:pt>
                <c:pt idx="25">
                  <c:v>7.2441515E7</c:v>
                </c:pt>
                <c:pt idx="26">
                  <c:v>7.2441523E7</c:v>
                </c:pt>
                <c:pt idx="27">
                  <c:v>7.2441676E7</c:v>
                </c:pt>
                <c:pt idx="28">
                  <c:v>7.2441711E7</c:v>
                </c:pt>
              </c:numCache>
            </c:numRef>
          </c:xVal>
          <c:yVal>
            <c:numRef>
              <c:f>extracteddata!$H$195:$H$223</c:f>
              <c:numCache>
                <c:formatCode>General</c:formatCode>
                <c:ptCount val="29"/>
                <c:pt idx="0">
                  <c:v>0.341399742384211</c:v>
                </c:pt>
                <c:pt idx="1">
                  <c:v>0.859390329128947</c:v>
                </c:pt>
                <c:pt idx="2">
                  <c:v>0.854313387394737</c:v>
                </c:pt>
                <c:pt idx="3">
                  <c:v>0.863421131955263</c:v>
                </c:pt>
                <c:pt idx="4">
                  <c:v>0.890858990286842</c:v>
                </c:pt>
                <c:pt idx="5">
                  <c:v>0.942588943542105</c:v>
                </c:pt>
                <c:pt idx="6">
                  <c:v>0.739886609752632</c:v>
                </c:pt>
                <c:pt idx="7">
                  <c:v>0.902840577210526</c:v>
                </c:pt>
                <c:pt idx="8">
                  <c:v>0.887850686805263</c:v>
                </c:pt>
                <c:pt idx="9">
                  <c:v>0.856446994834211</c:v>
                </c:pt>
                <c:pt idx="10">
                  <c:v>0.877906134381579</c:v>
                </c:pt>
                <c:pt idx="11">
                  <c:v>0.890425479757895</c:v>
                </c:pt>
                <c:pt idx="12">
                  <c:v>0.826833600131579</c:v>
                </c:pt>
                <c:pt idx="13">
                  <c:v>0.933902554613158</c:v>
                </c:pt>
                <c:pt idx="14">
                  <c:v>0.156635992047368</c:v>
                </c:pt>
                <c:pt idx="15">
                  <c:v>0.0407044753710526</c:v>
                </c:pt>
                <c:pt idx="16">
                  <c:v>0.0389672368868421</c:v>
                </c:pt>
                <c:pt idx="17">
                  <c:v>0.092340495631579</c:v>
                </c:pt>
                <c:pt idx="18">
                  <c:v>0.0222079562157895</c:v>
                </c:pt>
                <c:pt idx="19">
                  <c:v>0.0720515639710526</c:v>
                </c:pt>
                <c:pt idx="20">
                  <c:v>0.0746696819105263</c:v>
                </c:pt>
                <c:pt idx="21">
                  <c:v>0.0474927927894737</c:v>
                </c:pt>
                <c:pt idx="22">
                  <c:v>0.0383655987368421</c:v>
                </c:pt>
                <c:pt idx="23">
                  <c:v>0.0517400907351351</c:v>
                </c:pt>
                <c:pt idx="24">
                  <c:v>0.03226357015</c:v>
                </c:pt>
                <c:pt idx="25">
                  <c:v>0.0736779912131579</c:v>
                </c:pt>
                <c:pt idx="26">
                  <c:v>0.268965776315789</c:v>
                </c:pt>
                <c:pt idx="27">
                  <c:v>0.0558271794868421</c:v>
                </c:pt>
                <c:pt idx="28">
                  <c:v>0.276384574473684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D$195:$D$223</c:f>
              <c:numCache>
                <c:formatCode>General</c:formatCode>
                <c:ptCount val="29"/>
                <c:pt idx="0">
                  <c:v>7.2202615E7</c:v>
                </c:pt>
                <c:pt idx="1">
                  <c:v>7.2208666E7</c:v>
                </c:pt>
                <c:pt idx="2">
                  <c:v>7.2246001E7</c:v>
                </c:pt>
                <c:pt idx="3">
                  <c:v>7.2248378E7</c:v>
                </c:pt>
                <c:pt idx="4">
                  <c:v>7.2249085E7</c:v>
                </c:pt>
                <c:pt idx="5">
                  <c:v>7.2249338E7</c:v>
                </c:pt>
                <c:pt idx="6">
                  <c:v>7.2249355E7</c:v>
                </c:pt>
                <c:pt idx="7">
                  <c:v>7.2249465E7</c:v>
                </c:pt>
                <c:pt idx="8">
                  <c:v>7.2253329E7</c:v>
                </c:pt>
                <c:pt idx="9">
                  <c:v>7.2259543E7</c:v>
                </c:pt>
                <c:pt idx="10">
                  <c:v>7.233442E7</c:v>
                </c:pt>
                <c:pt idx="11">
                  <c:v>7.2408747E7</c:v>
                </c:pt>
                <c:pt idx="12">
                  <c:v>7.240875E7</c:v>
                </c:pt>
                <c:pt idx="13">
                  <c:v>7.2420299E7</c:v>
                </c:pt>
                <c:pt idx="14">
                  <c:v>7.2438249E7</c:v>
                </c:pt>
                <c:pt idx="15">
                  <c:v>7.2438678E7</c:v>
                </c:pt>
                <c:pt idx="16">
                  <c:v>7.2438879E7</c:v>
                </c:pt>
                <c:pt idx="17">
                  <c:v>7.2439386E7</c:v>
                </c:pt>
                <c:pt idx="18">
                  <c:v>7.2439698E7</c:v>
                </c:pt>
                <c:pt idx="19">
                  <c:v>7.2439779E7</c:v>
                </c:pt>
                <c:pt idx="20">
                  <c:v>7.2440409E7</c:v>
                </c:pt>
                <c:pt idx="21">
                  <c:v>7.2441146E7</c:v>
                </c:pt>
                <c:pt idx="22">
                  <c:v>7.2441171E7</c:v>
                </c:pt>
                <c:pt idx="23">
                  <c:v>7.2441184E7</c:v>
                </c:pt>
                <c:pt idx="24">
                  <c:v>7.2441404E7</c:v>
                </c:pt>
                <c:pt idx="25">
                  <c:v>7.2441515E7</c:v>
                </c:pt>
                <c:pt idx="26">
                  <c:v>7.2441523E7</c:v>
                </c:pt>
                <c:pt idx="27">
                  <c:v>7.2441676E7</c:v>
                </c:pt>
                <c:pt idx="28">
                  <c:v>7.2441711E7</c:v>
                </c:pt>
              </c:numCache>
            </c:numRef>
          </c:xVal>
          <c:yVal>
            <c:numRef>
              <c:f>extracteddata!$I$195:$I$223</c:f>
              <c:numCache>
                <c:formatCode>General</c:formatCode>
                <c:ptCount val="29"/>
                <c:pt idx="0">
                  <c:v>0.4693265275</c:v>
                </c:pt>
                <c:pt idx="1">
                  <c:v>0.748440686818182</c:v>
                </c:pt>
                <c:pt idx="2">
                  <c:v>0.825769162772727</c:v>
                </c:pt>
                <c:pt idx="3">
                  <c:v>0.775204811285714</c:v>
                </c:pt>
                <c:pt idx="4">
                  <c:v>0.794129976272727</c:v>
                </c:pt>
                <c:pt idx="5">
                  <c:v>0.934322880318182</c:v>
                </c:pt>
                <c:pt idx="6">
                  <c:v>0.724536584477273</c:v>
                </c:pt>
                <c:pt idx="7">
                  <c:v>0.9109740855</c:v>
                </c:pt>
                <c:pt idx="8">
                  <c:v>0.821663926590909</c:v>
                </c:pt>
                <c:pt idx="9">
                  <c:v>0.704041603386364</c:v>
                </c:pt>
                <c:pt idx="10">
                  <c:v>0.817086994840909</c:v>
                </c:pt>
                <c:pt idx="11">
                  <c:v>0.877832123022727</c:v>
                </c:pt>
                <c:pt idx="12">
                  <c:v>0.842360451818182</c:v>
                </c:pt>
                <c:pt idx="13">
                  <c:v>0.861691685681818</c:v>
                </c:pt>
                <c:pt idx="14">
                  <c:v>0.632859087136364</c:v>
                </c:pt>
                <c:pt idx="15">
                  <c:v>0.373930965295455</c:v>
                </c:pt>
                <c:pt idx="16">
                  <c:v>0.121523509727273</c:v>
                </c:pt>
                <c:pt idx="17">
                  <c:v>0.183968599545455</c:v>
                </c:pt>
                <c:pt idx="18">
                  <c:v>0.105208708431818</c:v>
                </c:pt>
                <c:pt idx="19">
                  <c:v>0.0787384752954545</c:v>
                </c:pt>
                <c:pt idx="20">
                  <c:v>0.0843321620909091</c:v>
                </c:pt>
                <c:pt idx="21">
                  <c:v>0.0708391550227273</c:v>
                </c:pt>
                <c:pt idx="22">
                  <c:v>0.0640272599090909</c:v>
                </c:pt>
                <c:pt idx="23">
                  <c:v>0.0799847392954546</c:v>
                </c:pt>
                <c:pt idx="24">
                  <c:v>0.0332938508181818</c:v>
                </c:pt>
                <c:pt idx="25">
                  <c:v>0.105433400045455</c:v>
                </c:pt>
                <c:pt idx="26">
                  <c:v>0.271367293181818</c:v>
                </c:pt>
                <c:pt idx="27">
                  <c:v>0.116362823409091</c:v>
                </c:pt>
                <c:pt idx="28">
                  <c:v>0.342975270454545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J$208:$J$209</c:f>
              <c:numCache>
                <c:formatCode>General</c:formatCode>
                <c:ptCount val="2"/>
                <c:pt idx="0">
                  <c:v>7.2438678E7</c:v>
                </c:pt>
                <c:pt idx="1">
                  <c:v>7.2438678E7</c:v>
                </c:pt>
              </c:numCache>
            </c:numRef>
          </c:xVal>
          <c:yVal>
            <c:numRef>
              <c:f>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095111712"/>
        <c:axId val="-1349467664"/>
      </c:scatterChart>
      <c:valAx>
        <c:axId val="-1095111712"/>
        <c:scaling>
          <c:orientation val="minMax"/>
          <c:max val="7.2441678E7"/>
          <c:min val="7.2435678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349467664"/>
        <c:crosses val="autoZero"/>
        <c:crossBetween val="midCat"/>
        <c:majorUnit val="1000.0"/>
      </c:valAx>
      <c:valAx>
        <c:axId val="-1349467664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095111712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0770329056090211"/>
          <c:y val="0.87373396353815"/>
          <c:w val="0.848077535832712"/>
          <c:h val="0.12214726270187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61595895732283"/>
          <c:h val="0.759741964089313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extracteddata!$D$224:$D$238</c:f>
              <c:numCache>
                <c:formatCode>General</c:formatCode>
                <c:ptCount val="15"/>
                <c:pt idx="0">
                  <c:v>5.7105339E7</c:v>
                </c:pt>
                <c:pt idx="1">
                  <c:v>5.71055E7</c:v>
                </c:pt>
                <c:pt idx="2">
                  <c:v>5.7105794E7</c:v>
                </c:pt>
                <c:pt idx="3">
                  <c:v>5.7105814E7</c:v>
                </c:pt>
                <c:pt idx="4">
                  <c:v>5.7106093E7</c:v>
                </c:pt>
                <c:pt idx="5">
                  <c:v>5.7111564E7</c:v>
                </c:pt>
                <c:pt idx="6">
                  <c:v>5.7115016E7</c:v>
                </c:pt>
                <c:pt idx="7">
                  <c:v>5.7117162E7</c:v>
                </c:pt>
                <c:pt idx="8">
                  <c:v>5.7117341E7</c:v>
                </c:pt>
                <c:pt idx="9">
                  <c:v>5.7117479E7</c:v>
                </c:pt>
                <c:pt idx="10">
                  <c:v>5.7117666E7</c:v>
                </c:pt>
                <c:pt idx="11">
                  <c:v>5.7120097E7</c:v>
                </c:pt>
                <c:pt idx="12">
                  <c:v>5.7126602E7</c:v>
                </c:pt>
                <c:pt idx="13">
                  <c:v>5.7133276E7</c:v>
                </c:pt>
                <c:pt idx="14">
                  <c:v>5.7144191E7</c:v>
                </c:pt>
              </c:numCache>
            </c:numRef>
          </c:xVal>
          <c:yVal>
            <c:numRef>
              <c:f>extracteddata!$F$224:$F$238</c:f>
              <c:numCache>
                <c:formatCode>General</c:formatCode>
                <c:ptCount val="15"/>
                <c:pt idx="0">
                  <c:v>0.771083344324373</c:v>
                </c:pt>
                <c:pt idx="1">
                  <c:v>0.791742741039427</c:v>
                </c:pt>
                <c:pt idx="2">
                  <c:v>0.459835562427121</c:v>
                </c:pt>
                <c:pt idx="3">
                  <c:v>0.521699050778973</c:v>
                </c:pt>
                <c:pt idx="4">
                  <c:v>0.895847420042712</c:v>
                </c:pt>
                <c:pt idx="5">
                  <c:v>0.908342910472222</c:v>
                </c:pt>
                <c:pt idx="6">
                  <c:v>0.774025754868578</c:v>
                </c:pt>
                <c:pt idx="7">
                  <c:v>0.653183580454898</c:v>
                </c:pt>
                <c:pt idx="8">
                  <c:v>0.606089001800974</c:v>
                </c:pt>
                <c:pt idx="9">
                  <c:v>0.245274859655556</c:v>
                </c:pt>
                <c:pt idx="10">
                  <c:v>0.272778751489546</c:v>
                </c:pt>
                <c:pt idx="11">
                  <c:v>0.574828814698626</c:v>
                </c:pt>
                <c:pt idx="12">
                  <c:v>0.905889454171744</c:v>
                </c:pt>
                <c:pt idx="13">
                  <c:v>0.80108706738411</c:v>
                </c:pt>
                <c:pt idx="14">
                  <c:v>0.268016782621266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extracteddata!$D$224:$D$238</c:f>
              <c:numCache>
                <c:formatCode>General</c:formatCode>
                <c:ptCount val="15"/>
                <c:pt idx="0">
                  <c:v>5.7105339E7</c:v>
                </c:pt>
                <c:pt idx="1">
                  <c:v>5.71055E7</c:v>
                </c:pt>
                <c:pt idx="2">
                  <c:v>5.7105794E7</c:v>
                </c:pt>
                <c:pt idx="3">
                  <c:v>5.7105814E7</c:v>
                </c:pt>
                <c:pt idx="4">
                  <c:v>5.7106093E7</c:v>
                </c:pt>
                <c:pt idx="5">
                  <c:v>5.7111564E7</c:v>
                </c:pt>
                <c:pt idx="6">
                  <c:v>5.7115016E7</c:v>
                </c:pt>
                <c:pt idx="7">
                  <c:v>5.7117162E7</c:v>
                </c:pt>
                <c:pt idx="8">
                  <c:v>5.7117341E7</c:v>
                </c:pt>
                <c:pt idx="9">
                  <c:v>5.7117479E7</c:v>
                </c:pt>
                <c:pt idx="10">
                  <c:v>5.7117666E7</c:v>
                </c:pt>
                <c:pt idx="11">
                  <c:v>5.7120097E7</c:v>
                </c:pt>
                <c:pt idx="12">
                  <c:v>5.7126602E7</c:v>
                </c:pt>
                <c:pt idx="13">
                  <c:v>5.7133276E7</c:v>
                </c:pt>
                <c:pt idx="14">
                  <c:v>5.7144191E7</c:v>
                </c:pt>
              </c:numCache>
            </c:numRef>
          </c:xVal>
          <c:yVal>
            <c:numRef>
              <c:f>extracteddata!$G$224:$G$237</c:f>
              <c:numCache>
                <c:formatCode>General</c:formatCode>
                <c:ptCount val="14"/>
                <c:pt idx="0">
                  <c:v>0.935196828771429</c:v>
                </c:pt>
                <c:pt idx="1">
                  <c:v>0.87857778</c:v>
                </c:pt>
                <c:pt idx="2">
                  <c:v>0.845292202542857</c:v>
                </c:pt>
                <c:pt idx="3">
                  <c:v>0.837411990714286</c:v>
                </c:pt>
                <c:pt idx="4">
                  <c:v>0.946454085085714</c:v>
                </c:pt>
                <c:pt idx="5">
                  <c:v>0.949230200428572</c:v>
                </c:pt>
                <c:pt idx="6">
                  <c:v>0.92282064</c:v>
                </c:pt>
                <c:pt idx="7">
                  <c:v>0.645183587428571</c:v>
                </c:pt>
                <c:pt idx="8">
                  <c:v>0.729497707942857</c:v>
                </c:pt>
                <c:pt idx="9">
                  <c:v>0.0210619855714286</c:v>
                </c:pt>
                <c:pt idx="10">
                  <c:v>0.116807227142857</c:v>
                </c:pt>
                <c:pt idx="11">
                  <c:v>0.9368530544</c:v>
                </c:pt>
                <c:pt idx="12">
                  <c:v>0.902049907857143</c:v>
                </c:pt>
                <c:pt idx="13">
                  <c:v>0.726998297342857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extracteddata!$D$224:$D$238</c:f>
              <c:numCache>
                <c:formatCode>General</c:formatCode>
                <c:ptCount val="15"/>
                <c:pt idx="0">
                  <c:v>5.7105339E7</c:v>
                </c:pt>
                <c:pt idx="1">
                  <c:v>5.71055E7</c:v>
                </c:pt>
                <c:pt idx="2">
                  <c:v>5.7105794E7</c:v>
                </c:pt>
                <c:pt idx="3">
                  <c:v>5.7105814E7</c:v>
                </c:pt>
                <c:pt idx="4">
                  <c:v>5.7106093E7</c:v>
                </c:pt>
                <c:pt idx="5">
                  <c:v>5.7111564E7</c:v>
                </c:pt>
                <c:pt idx="6">
                  <c:v>5.7115016E7</c:v>
                </c:pt>
                <c:pt idx="7">
                  <c:v>5.7117162E7</c:v>
                </c:pt>
                <c:pt idx="8">
                  <c:v>5.7117341E7</c:v>
                </c:pt>
                <c:pt idx="9">
                  <c:v>5.7117479E7</c:v>
                </c:pt>
                <c:pt idx="10">
                  <c:v>5.7117666E7</c:v>
                </c:pt>
                <c:pt idx="11">
                  <c:v>5.7120097E7</c:v>
                </c:pt>
                <c:pt idx="12">
                  <c:v>5.7126602E7</c:v>
                </c:pt>
                <c:pt idx="13">
                  <c:v>5.7133276E7</c:v>
                </c:pt>
                <c:pt idx="14">
                  <c:v>5.7144191E7</c:v>
                </c:pt>
              </c:numCache>
            </c:numRef>
          </c:xVal>
          <c:yVal>
            <c:numRef>
              <c:f>extracteddata!$H$224:$H$237</c:f>
              <c:numCache>
                <c:formatCode>General</c:formatCode>
                <c:ptCount val="14"/>
                <c:pt idx="0">
                  <c:v>0.740726877402631</c:v>
                </c:pt>
                <c:pt idx="1">
                  <c:v>0.781196429210526</c:v>
                </c:pt>
                <c:pt idx="2">
                  <c:v>0.334565816926316</c:v>
                </c:pt>
                <c:pt idx="3">
                  <c:v>0.440520144778947</c:v>
                </c:pt>
                <c:pt idx="4">
                  <c:v>0.876160562702632</c:v>
                </c:pt>
                <c:pt idx="5">
                  <c:v>0.893064368081579</c:v>
                </c:pt>
                <c:pt idx="6">
                  <c:v>0.782767835</c:v>
                </c:pt>
                <c:pt idx="7">
                  <c:v>0.495098753442105</c:v>
                </c:pt>
                <c:pt idx="8">
                  <c:v>0.407256110394595</c:v>
                </c:pt>
                <c:pt idx="9">
                  <c:v>0.0550713482315789</c:v>
                </c:pt>
                <c:pt idx="10">
                  <c:v>0.0676258274815789</c:v>
                </c:pt>
                <c:pt idx="11">
                  <c:v>0.480968113684211</c:v>
                </c:pt>
                <c:pt idx="12">
                  <c:v>0.920063428663158</c:v>
                </c:pt>
                <c:pt idx="13">
                  <c:v>0.786037139152632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D$224:$D$238</c:f>
              <c:numCache>
                <c:formatCode>General</c:formatCode>
                <c:ptCount val="15"/>
                <c:pt idx="0">
                  <c:v>5.7105339E7</c:v>
                </c:pt>
                <c:pt idx="1">
                  <c:v>5.71055E7</c:v>
                </c:pt>
                <c:pt idx="2">
                  <c:v>5.7105794E7</c:v>
                </c:pt>
                <c:pt idx="3">
                  <c:v>5.7105814E7</c:v>
                </c:pt>
                <c:pt idx="4">
                  <c:v>5.7106093E7</c:v>
                </c:pt>
                <c:pt idx="5">
                  <c:v>5.7111564E7</c:v>
                </c:pt>
                <c:pt idx="6">
                  <c:v>5.7115016E7</c:v>
                </c:pt>
                <c:pt idx="7">
                  <c:v>5.7117162E7</c:v>
                </c:pt>
                <c:pt idx="8">
                  <c:v>5.7117341E7</c:v>
                </c:pt>
                <c:pt idx="9">
                  <c:v>5.7117479E7</c:v>
                </c:pt>
                <c:pt idx="10">
                  <c:v>5.7117666E7</c:v>
                </c:pt>
                <c:pt idx="11">
                  <c:v>5.7120097E7</c:v>
                </c:pt>
                <c:pt idx="12">
                  <c:v>5.7126602E7</c:v>
                </c:pt>
                <c:pt idx="13">
                  <c:v>5.7133276E7</c:v>
                </c:pt>
                <c:pt idx="14">
                  <c:v>5.7144191E7</c:v>
                </c:pt>
              </c:numCache>
            </c:numRef>
          </c:xVal>
          <c:yVal>
            <c:numRef>
              <c:f>extracteddata!$I$224:$I$237</c:f>
              <c:numCache>
                <c:formatCode>General</c:formatCode>
                <c:ptCount val="14"/>
                <c:pt idx="0">
                  <c:v>0.787884395931818</c:v>
                </c:pt>
                <c:pt idx="1">
                  <c:v>0.763235177272727</c:v>
                </c:pt>
                <c:pt idx="2">
                  <c:v>0.561818591886364</c:v>
                </c:pt>
                <c:pt idx="3">
                  <c:v>0.583510420772727</c:v>
                </c:pt>
                <c:pt idx="4">
                  <c:v>0.913611237954546</c:v>
                </c:pt>
                <c:pt idx="5">
                  <c:v>0.897280840431818</c:v>
                </c:pt>
                <c:pt idx="6">
                  <c:v>0.724992625</c:v>
                </c:pt>
                <c:pt idx="7">
                  <c:v>0.734127515113636</c:v>
                </c:pt>
                <c:pt idx="8">
                  <c:v>0.732407334772727</c:v>
                </c:pt>
                <c:pt idx="9">
                  <c:v>0.364382379642857</c:v>
                </c:pt>
                <c:pt idx="10">
                  <c:v>0.386393220704545</c:v>
                </c:pt>
                <c:pt idx="11">
                  <c:v>0.647533213181818</c:v>
                </c:pt>
                <c:pt idx="12">
                  <c:v>0.903486856045455</c:v>
                </c:pt>
                <c:pt idx="13">
                  <c:v>0.8004152445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J$231:$J$232</c:f>
              <c:numCache>
                <c:formatCode>General</c:formatCode>
                <c:ptCount val="2"/>
                <c:pt idx="0">
                  <c:v>5.7117479E7</c:v>
                </c:pt>
                <c:pt idx="1">
                  <c:v>5.7117479E7</c:v>
                </c:pt>
              </c:numCache>
            </c:numRef>
          </c:xVal>
          <c:yVal>
            <c:numRef>
              <c:f>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648029056"/>
        <c:axId val="-1647616496"/>
      </c:scatterChart>
      <c:valAx>
        <c:axId val="-1648029056"/>
        <c:scaling>
          <c:orientation val="minMax"/>
          <c:max val="5.7120479E7"/>
          <c:min val="5.7114479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647616496"/>
        <c:crosses val="autoZero"/>
        <c:crossBetween val="midCat"/>
        <c:majorUnit val="1000.0"/>
      </c:valAx>
      <c:valAx>
        <c:axId val="-1647616496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648029056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050000005370616"/>
          <c:y val="0.915384518189958"/>
          <c:w val="0.899999989258768"/>
          <c:h val="0.05908638666493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58396531697935"/>
          <c:h val="0.704764741182953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[1]extracteddata!$D$243:$D$255</c:f>
              <c:numCache>
                <c:formatCode>General</c:formatCode>
                <c:ptCount val="13"/>
                <c:pt idx="0">
                  <c:v>2.3567941E7</c:v>
                </c:pt>
                <c:pt idx="1">
                  <c:v>2.3570444E7</c:v>
                </c:pt>
                <c:pt idx="2">
                  <c:v>2.3571706E7</c:v>
                </c:pt>
                <c:pt idx="3">
                  <c:v>2.3571724E7</c:v>
                </c:pt>
                <c:pt idx="4">
                  <c:v>2.357174E7</c:v>
                </c:pt>
                <c:pt idx="5">
                  <c:v>2.3571979E7</c:v>
                </c:pt>
                <c:pt idx="6">
                  <c:v>2.3572029E7</c:v>
                </c:pt>
                <c:pt idx="7">
                  <c:v>2.3572199E7</c:v>
                </c:pt>
                <c:pt idx="8">
                  <c:v>2.3572207E7</c:v>
                </c:pt>
                <c:pt idx="9">
                  <c:v>2.3572375E7</c:v>
                </c:pt>
                <c:pt idx="10">
                  <c:v>2.3572595E7</c:v>
                </c:pt>
                <c:pt idx="11">
                  <c:v>2.3574525E7</c:v>
                </c:pt>
                <c:pt idx="12">
                  <c:v>2.3583662E7</c:v>
                </c:pt>
              </c:numCache>
            </c:numRef>
          </c:xVal>
          <c:yVal>
            <c:numRef>
              <c:f>[1]extracteddata!$F$243:$F$255</c:f>
              <c:numCache>
                <c:formatCode>General</c:formatCode>
                <c:ptCount val="13"/>
                <c:pt idx="0">
                  <c:v>0.874257574090203</c:v>
                </c:pt>
                <c:pt idx="1">
                  <c:v>0.842192977468638</c:v>
                </c:pt>
                <c:pt idx="2">
                  <c:v>0.770802092261947</c:v>
                </c:pt>
                <c:pt idx="3">
                  <c:v>0.716828787279868</c:v>
                </c:pt>
                <c:pt idx="4">
                  <c:v>0.76163511114994</c:v>
                </c:pt>
                <c:pt idx="5">
                  <c:v>0.527454037912784</c:v>
                </c:pt>
                <c:pt idx="6">
                  <c:v>0.430402290673537</c:v>
                </c:pt>
                <c:pt idx="7">
                  <c:v>0.315736854451314</c:v>
                </c:pt>
                <c:pt idx="8">
                  <c:v>0.427677331530466</c:v>
                </c:pt>
                <c:pt idx="9">
                  <c:v>0.302469258514636</c:v>
                </c:pt>
                <c:pt idx="10">
                  <c:v>0.294834752758662</c:v>
                </c:pt>
                <c:pt idx="11">
                  <c:v>0.694491628216547</c:v>
                </c:pt>
                <c:pt idx="12">
                  <c:v>0.762653890218041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[1]extracteddata!$D$243:$D$255</c:f>
              <c:numCache>
                <c:formatCode>General</c:formatCode>
                <c:ptCount val="13"/>
                <c:pt idx="0">
                  <c:v>2.3567941E7</c:v>
                </c:pt>
                <c:pt idx="1">
                  <c:v>2.3570444E7</c:v>
                </c:pt>
                <c:pt idx="2">
                  <c:v>2.3571706E7</c:v>
                </c:pt>
                <c:pt idx="3">
                  <c:v>2.3571724E7</c:v>
                </c:pt>
                <c:pt idx="4">
                  <c:v>2.357174E7</c:v>
                </c:pt>
                <c:pt idx="5">
                  <c:v>2.3571979E7</c:v>
                </c:pt>
                <c:pt idx="6">
                  <c:v>2.3572029E7</c:v>
                </c:pt>
                <c:pt idx="7">
                  <c:v>2.3572199E7</c:v>
                </c:pt>
                <c:pt idx="8">
                  <c:v>2.3572207E7</c:v>
                </c:pt>
                <c:pt idx="9">
                  <c:v>2.3572375E7</c:v>
                </c:pt>
                <c:pt idx="10">
                  <c:v>2.3572595E7</c:v>
                </c:pt>
                <c:pt idx="11">
                  <c:v>2.3574525E7</c:v>
                </c:pt>
                <c:pt idx="12">
                  <c:v>2.3583662E7</c:v>
                </c:pt>
              </c:numCache>
            </c:numRef>
          </c:xVal>
          <c:yVal>
            <c:numRef>
              <c:f>[1]extracteddata!$G$243:$G$255</c:f>
              <c:numCache>
                <c:formatCode>General</c:formatCode>
                <c:ptCount val="13"/>
                <c:pt idx="0">
                  <c:v>0.422054093057143</c:v>
                </c:pt>
                <c:pt idx="1">
                  <c:v>0.693502901628571</c:v>
                </c:pt>
                <c:pt idx="2">
                  <c:v>0.209263984542857</c:v>
                </c:pt>
                <c:pt idx="3">
                  <c:v>0.137724732228571</c:v>
                </c:pt>
                <c:pt idx="4">
                  <c:v>0.0912097808</c:v>
                </c:pt>
                <c:pt idx="5">
                  <c:v>0.0256805010857143</c:v>
                </c:pt>
                <c:pt idx="6">
                  <c:v>0.0201111405428571</c:v>
                </c:pt>
                <c:pt idx="7">
                  <c:v>0.0448588444571429</c:v>
                </c:pt>
                <c:pt idx="8">
                  <c:v>0.0676188932285714</c:v>
                </c:pt>
                <c:pt idx="9">
                  <c:v>0.0233523386571429</c:v>
                </c:pt>
                <c:pt idx="10">
                  <c:v>0.0422885552857143</c:v>
                </c:pt>
                <c:pt idx="11">
                  <c:v>0.823969657142857</c:v>
                </c:pt>
                <c:pt idx="12">
                  <c:v>0.873857674714286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[1]extracteddata!$D$243:$D$255</c:f>
              <c:numCache>
                <c:formatCode>General</c:formatCode>
                <c:ptCount val="13"/>
                <c:pt idx="0">
                  <c:v>2.3567941E7</c:v>
                </c:pt>
                <c:pt idx="1">
                  <c:v>2.3570444E7</c:v>
                </c:pt>
                <c:pt idx="2">
                  <c:v>2.3571706E7</c:v>
                </c:pt>
                <c:pt idx="3">
                  <c:v>2.3571724E7</c:v>
                </c:pt>
                <c:pt idx="4">
                  <c:v>2.357174E7</c:v>
                </c:pt>
                <c:pt idx="5">
                  <c:v>2.3571979E7</c:v>
                </c:pt>
                <c:pt idx="6">
                  <c:v>2.3572029E7</c:v>
                </c:pt>
                <c:pt idx="7">
                  <c:v>2.3572199E7</c:v>
                </c:pt>
                <c:pt idx="8">
                  <c:v>2.3572207E7</c:v>
                </c:pt>
                <c:pt idx="9">
                  <c:v>2.3572375E7</c:v>
                </c:pt>
                <c:pt idx="10">
                  <c:v>2.3572595E7</c:v>
                </c:pt>
                <c:pt idx="11">
                  <c:v>2.3574525E7</c:v>
                </c:pt>
                <c:pt idx="12">
                  <c:v>2.3583662E7</c:v>
                </c:pt>
              </c:numCache>
            </c:numRef>
          </c:xVal>
          <c:yVal>
            <c:numRef>
              <c:f>[1]extracteddata!$H$243:$H$255</c:f>
              <c:numCache>
                <c:formatCode>General</c:formatCode>
                <c:ptCount val="13"/>
                <c:pt idx="0">
                  <c:v>0.856071882076316</c:v>
                </c:pt>
                <c:pt idx="1">
                  <c:v>0.790663578607895</c:v>
                </c:pt>
                <c:pt idx="2">
                  <c:v>0.775332176318421</c:v>
                </c:pt>
                <c:pt idx="3">
                  <c:v>0.744170927978947</c:v>
                </c:pt>
                <c:pt idx="4">
                  <c:v>0.756430119939474</c:v>
                </c:pt>
                <c:pt idx="5">
                  <c:v>0.454595565084211</c:v>
                </c:pt>
                <c:pt idx="6">
                  <c:v>0.3308415317</c:v>
                </c:pt>
                <c:pt idx="7">
                  <c:v>0.148965275392105</c:v>
                </c:pt>
                <c:pt idx="8">
                  <c:v>0.314033406223684</c:v>
                </c:pt>
                <c:pt idx="9">
                  <c:v>0.118799921013158</c:v>
                </c:pt>
                <c:pt idx="10">
                  <c:v>0.0871419357131579</c:v>
                </c:pt>
                <c:pt idx="11">
                  <c:v>0.613393895686842</c:v>
                </c:pt>
                <c:pt idx="12">
                  <c:v>0.644205319318421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D$243:$D$255</c:f>
              <c:numCache>
                <c:formatCode>General</c:formatCode>
                <c:ptCount val="13"/>
                <c:pt idx="0">
                  <c:v>2.3567941E7</c:v>
                </c:pt>
                <c:pt idx="1">
                  <c:v>2.3570444E7</c:v>
                </c:pt>
                <c:pt idx="2">
                  <c:v>2.3571706E7</c:v>
                </c:pt>
                <c:pt idx="3">
                  <c:v>2.3571724E7</c:v>
                </c:pt>
                <c:pt idx="4">
                  <c:v>2.357174E7</c:v>
                </c:pt>
                <c:pt idx="5">
                  <c:v>2.3571979E7</c:v>
                </c:pt>
                <c:pt idx="6">
                  <c:v>2.3572029E7</c:v>
                </c:pt>
                <c:pt idx="7">
                  <c:v>2.3572199E7</c:v>
                </c:pt>
                <c:pt idx="8">
                  <c:v>2.3572207E7</c:v>
                </c:pt>
                <c:pt idx="9">
                  <c:v>2.3572375E7</c:v>
                </c:pt>
                <c:pt idx="10">
                  <c:v>2.3572595E7</c:v>
                </c:pt>
                <c:pt idx="11">
                  <c:v>2.3574525E7</c:v>
                </c:pt>
                <c:pt idx="12">
                  <c:v>2.3583662E7</c:v>
                </c:pt>
              </c:numCache>
            </c:numRef>
          </c:xVal>
          <c:yVal>
            <c:numRef>
              <c:f>[1]extracteddata!$I$243:$I$255</c:f>
              <c:numCache>
                <c:formatCode>General</c:formatCode>
                <c:ptCount val="13"/>
                <c:pt idx="0">
                  <c:v>0.872680591</c:v>
                </c:pt>
                <c:pt idx="1">
                  <c:v>0.850555523772727</c:v>
                </c:pt>
                <c:pt idx="2">
                  <c:v>0.784816607431818</c:v>
                </c:pt>
                <c:pt idx="3">
                  <c:v>0.682811934727273</c:v>
                </c:pt>
                <c:pt idx="4">
                  <c:v>0.782174743431818</c:v>
                </c:pt>
                <c:pt idx="5">
                  <c:v>0.533808447431818</c:v>
                </c:pt>
                <c:pt idx="6">
                  <c:v>0.486483863954545</c:v>
                </c:pt>
                <c:pt idx="7">
                  <c:v>0.369409322113636</c:v>
                </c:pt>
                <c:pt idx="8">
                  <c:v>0.480540202409091</c:v>
                </c:pt>
                <c:pt idx="9">
                  <c:v>0.382295720409091</c:v>
                </c:pt>
                <c:pt idx="10">
                  <c:v>0.404376891204545</c:v>
                </c:pt>
                <c:pt idx="11">
                  <c:v>0.714621244136364</c:v>
                </c:pt>
                <c:pt idx="12">
                  <c:v>0.782953233954546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J$251:$J$252</c:f>
              <c:numCache>
                <c:formatCode>General</c:formatCode>
                <c:ptCount val="2"/>
                <c:pt idx="0">
                  <c:v>2.3572595E7</c:v>
                </c:pt>
                <c:pt idx="1">
                  <c:v>2.3572595E7</c:v>
                </c:pt>
              </c:numCache>
            </c:numRef>
          </c:xVal>
          <c:yVal>
            <c:numRef>
              <c:f>[1]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805091200"/>
        <c:axId val="-1095515248"/>
      </c:scatterChart>
      <c:valAx>
        <c:axId val="-1805091200"/>
        <c:scaling>
          <c:orientation val="minMax"/>
          <c:max val="2.3575595E7"/>
          <c:min val="2.3569595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095515248"/>
        <c:crosses val="autoZero"/>
        <c:crossBetween val="midCat"/>
        <c:majorUnit val="1000.0"/>
      </c:valAx>
      <c:valAx>
        <c:axId val="-1095515248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805091200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S$1</c:f>
              <c:strCache>
                <c:ptCount val="1"/>
                <c:pt idx="0">
                  <c:v>4gene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222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69696194225722"/>
                  <c:y val="-0.005046296296296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2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Sheet1!$T$2:$T$33</c:f>
              <c:numCache>
                <c:formatCode>General</c:formatCode>
                <c:ptCount val="32"/>
                <c:pt idx="0">
                  <c:v>511.5</c:v>
                </c:pt>
                <c:pt idx="1">
                  <c:v>504.0</c:v>
                </c:pt>
                <c:pt idx="2">
                  <c:v>279.0</c:v>
                </c:pt>
                <c:pt idx="3">
                  <c:v>261.0</c:v>
                </c:pt>
                <c:pt idx="4">
                  <c:v>357.5</c:v>
                </c:pt>
                <c:pt idx="5">
                  <c:v>525.0</c:v>
                </c:pt>
                <c:pt idx="6">
                  <c:v>377.0</c:v>
                </c:pt>
                <c:pt idx="7">
                  <c:v>321.5000000000001</c:v>
                </c:pt>
                <c:pt idx="8">
                  <c:v>235.5</c:v>
                </c:pt>
                <c:pt idx="9">
                  <c:v>237.0</c:v>
                </c:pt>
                <c:pt idx="10">
                  <c:v>543.0</c:v>
                </c:pt>
                <c:pt idx="11">
                  <c:v>450.0</c:v>
                </c:pt>
                <c:pt idx="12">
                  <c:v>378.5</c:v>
                </c:pt>
                <c:pt idx="13">
                  <c:v>242.0</c:v>
                </c:pt>
                <c:pt idx="14">
                  <c:v>340.5</c:v>
                </c:pt>
                <c:pt idx="15">
                  <c:v>401.5</c:v>
                </c:pt>
                <c:pt idx="16">
                  <c:v>278.0</c:v>
                </c:pt>
                <c:pt idx="17">
                  <c:v>303.5</c:v>
                </c:pt>
                <c:pt idx="18">
                  <c:v>332.0</c:v>
                </c:pt>
                <c:pt idx="19">
                  <c:v>431.0</c:v>
                </c:pt>
                <c:pt idx="20">
                  <c:v>272.0</c:v>
                </c:pt>
                <c:pt idx="21">
                  <c:v>292.0</c:v>
                </c:pt>
                <c:pt idx="22">
                  <c:v>384.5</c:v>
                </c:pt>
                <c:pt idx="23">
                  <c:v>478.5</c:v>
                </c:pt>
                <c:pt idx="24">
                  <c:v>277.5</c:v>
                </c:pt>
                <c:pt idx="25">
                  <c:v>345.5</c:v>
                </c:pt>
                <c:pt idx="26">
                  <c:v>300.0</c:v>
                </c:pt>
                <c:pt idx="27">
                  <c:v>311.5</c:v>
                </c:pt>
                <c:pt idx="28">
                  <c:v>327.5</c:v>
                </c:pt>
                <c:pt idx="29">
                  <c:v>300.5</c:v>
                </c:pt>
                <c:pt idx="30">
                  <c:v>356.0</c:v>
                </c:pt>
                <c:pt idx="31">
                  <c:v>408.4999999999989</c:v>
                </c:pt>
              </c:numCache>
            </c:numRef>
          </c:xVal>
          <c:yVal>
            <c:numRef>
              <c:f>Sheet1!$S$2:$S$33</c:f>
              <c:numCache>
                <c:formatCode>General</c:formatCode>
                <c:ptCount val="32"/>
                <c:pt idx="0">
                  <c:v>843.125</c:v>
                </c:pt>
                <c:pt idx="1">
                  <c:v>819.75</c:v>
                </c:pt>
                <c:pt idx="2">
                  <c:v>497.375</c:v>
                </c:pt>
                <c:pt idx="3">
                  <c:v>433.75</c:v>
                </c:pt>
                <c:pt idx="4">
                  <c:v>699.25</c:v>
                </c:pt>
                <c:pt idx="5">
                  <c:v>925.5</c:v>
                </c:pt>
                <c:pt idx="6">
                  <c:v>627.5</c:v>
                </c:pt>
                <c:pt idx="7">
                  <c:v>577.625</c:v>
                </c:pt>
                <c:pt idx="8">
                  <c:v>445.3750000000001</c:v>
                </c:pt>
                <c:pt idx="9">
                  <c:v>522.75</c:v>
                </c:pt>
                <c:pt idx="10">
                  <c:v>1000.125</c:v>
                </c:pt>
                <c:pt idx="11">
                  <c:v>834.0</c:v>
                </c:pt>
                <c:pt idx="12">
                  <c:v>673.625</c:v>
                </c:pt>
                <c:pt idx="13">
                  <c:v>519.5</c:v>
                </c:pt>
                <c:pt idx="14">
                  <c:v>686.25</c:v>
                </c:pt>
                <c:pt idx="15">
                  <c:v>811.0</c:v>
                </c:pt>
                <c:pt idx="16">
                  <c:v>489.5</c:v>
                </c:pt>
                <c:pt idx="17">
                  <c:v>552.25</c:v>
                </c:pt>
                <c:pt idx="18">
                  <c:v>641.0</c:v>
                </c:pt>
                <c:pt idx="19">
                  <c:v>736.25</c:v>
                </c:pt>
                <c:pt idx="20">
                  <c:v>513.5</c:v>
                </c:pt>
                <c:pt idx="21">
                  <c:v>569.5</c:v>
                </c:pt>
                <c:pt idx="22">
                  <c:v>847.875</c:v>
                </c:pt>
                <c:pt idx="23">
                  <c:v>879.2499999999998</c:v>
                </c:pt>
                <c:pt idx="24">
                  <c:v>499.75</c:v>
                </c:pt>
                <c:pt idx="25">
                  <c:v>710.625</c:v>
                </c:pt>
                <c:pt idx="26">
                  <c:v>595.375</c:v>
                </c:pt>
                <c:pt idx="27">
                  <c:v>602.0</c:v>
                </c:pt>
                <c:pt idx="28">
                  <c:v>665.75</c:v>
                </c:pt>
                <c:pt idx="29">
                  <c:v>700.7499999999999</c:v>
                </c:pt>
                <c:pt idx="30">
                  <c:v>706.875</c:v>
                </c:pt>
                <c:pt idx="31">
                  <c:v>761.6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067766448"/>
        <c:axId val="-1067779328"/>
      </c:scatterChart>
      <c:valAx>
        <c:axId val="-10677664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2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2400" dirty="0" smtClean="0"/>
                  <a:t>ACTB (copies/</a:t>
                </a:r>
                <a:r>
                  <a:rPr lang="en-US" altLang="ja-JP" sz="2400" dirty="0" err="1" smtClean="0"/>
                  <a:t>μL</a:t>
                </a:r>
                <a:r>
                  <a:rPr lang="en-US" altLang="ja-JP" sz="2400" dirty="0" smtClean="0"/>
                  <a:t>)</a:t>
                </a:r>
                <a:endParaRPr lang="ja-JP" altLang="en-US" sz="24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2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067779328"/>
        <c:crosses val="autoZero"/>
        <c:crossBetween val="midCat"/>
      </c:valAx>
      <c:valAx>
        <c:axId val="-1067779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2400" dirty="0" smtClean="0"/>
                  <a:t>Mean of four internal control markers</a:t>
                </a:r>
                <a:r>
                  <a:rPr lang="en-US" altLang="ja-JP" sz="2400" baseline="0" dirty="0" smtClean="0"/>
                  <a:t> </a:t>
                </a:r>
                <a:r>
                  <a:rPr lang="en-US" altLang="ja-JP" sz="2400" dirty="0" smtClean="0"/>
                  <a:t>(copies/</a:t>
                </a:r>
                <a:r>
                  <a:rPr lang="en-US" altLang="ja-JP" sz="2400" dirty="0" err="1" smtClean="0"/>
                  <a:t>μL</a:t>
                </a:r>
                <a:r>
                  <a:rPr lang="en-US" altLang="ja-JP" sz="2400" dirty="0" smtClean="0"/>
                  <a:t>)</a:t>
                </a:r>
                <a:endParaRPr lang="ja-JP" altLang="en-US" sz="24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0677664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pearson HV new'!$C$1</c:f>
              <c:strCache>
                <c:ptCount val="1"/>
                <c:pt idx="0">
                  <c:v>prediction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538902297493422"/>
                  <c:y val="0.010240701111320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6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pearson HV new'!$B$2:$B$134</c:f>
              <c:numCache>
                <c:formatCode>General</c:formatCode>
                <c:ptCount val="133"/>
                <c:pt idx="0">
                  <c:v>46.0</c:v>
                </c:pt>
                <c:pt idx="1">
                  <c:v>58.0</c:v>
                </c:pt>
                <c:pt idx="2">
                  <c:v>66.0</c:v>
                </c:pt>
                <c:pt idx="3">
                  <c:v>36.0</c:v>
                </c:pt>
                <c:pt idx="4">
                  <c:v>53.0</c:v>
                </c:pt>
                <c:pt idx="5">
                  <c:v>45.0</c:v>
                </c:pt>
                <c:pt idx="6">
                  <c:v>44.0</c:v>
                </c:pt>
                <c:pt idx="7">
                  <c:v>68.0</c:v>
                </c:pt>
                <c:pt idx="8">
                  <c:v>57.0</c:v>
                </c:pt>
                <c:pt idx="9">
                  <c:v>49.0</c:v>
                </c:pt>
                <c:pt idx="10">
                  <c:v>57.0</c:v>
                </c:pt>
                <c:pt idx="11">
                  <c:v>34.0</c:v>
                </c:pt>
                <c:pt idx="12">
                  <c:v>51.0</c:v>
                </c:pt>
                <c:pt idx="13">
                  <c:v>55.0</c:v>
                </c:pt>
                <c:pt idx="14">
                  <c:v>32.0</c:v>
                </c:pt>
                <c:pt idx="15">
                  <c:v>70.0</c:v>
                </c:pt>
                <c:pt idx="16">
                  <c:v>53.0</c:v>
                </c:pt>
                <c:pt idx="17">
                  <c:v>49.0</c:v>
                </c:pt>
                <c:pt idx="18">
                  <c:v>26.0</c:v>
                </c:pt>
                <c:pt idx="19">
                  <c:v>60.0</c:v>
                </c:pt>
                <c:pt idx="20">
                  <c:v>46.0</c:v>
                </c:pt>
                <c:pt idx="21">
                  <c:v>53.0</c:v>
                </c:pt>
                <c:pt idx="22">
                  <c:v>53.0</c:v>
                </c:pt>
                <c:pt idx="23">
                  <c:v>47.0</c:v>
                </c:pt>
                <c:pt idx="24">
                  <c:v>58.0</c:v>
                </c:pt>
                <c:pt idx="25">
                  <c:v>52.0</c:v>
                </c:pt>
                <c:pt idx="26">
                  <c:v>51.0</c:v>
                </c:pt>
                <c:pt idx="27">
                  <c:v>50.0</c:v>
                </c:pt>
                <c:pt idx="28">
                  <c:v>41.0</c:v>
                </c:pt>
                <c:pt idx="29">
                  <c:v>31.0</c:v>
                </c:pt>
                <c:pt idx="30">
                  <c:v>39.0</c:v>
                </c:pt>
                <c:pt idx="31">
                  <c:v>31.0</c:v>
                </c:pt>
                <c:pt idx="32">
                  <c:v>38.0</c:v>
                </c:pt>
                <c:pt idx="33">
                  <c:v>40.0</c:v>
                </c:pt>
                <c:pt idx="34">
                  <c:v>41.0</c:v>
                </c:pt>
                <c:pt idx="35">
                  <c:v>36.0</c:v>
                </c:pt>
                <c:pt idx="36">
                  <c:v>33.0</c:v>
                </c:pt>
                <c:pt idx="37">
                  <c:v>35.0</c:v>
                </c:pt>
                <c:pt idx="38">
                  <c:v>51.0</c:v>
                </c:pt>
                <c:pt idx="39">
                  <c:v>53.0</c:v>
                </c:pt>
                <c:pt idx="40">
                  <c:v>34.0</c:v>
                </c:pt>
                <c:pt idx="41">
                  <c:v>58.0</c:v>
                </c:pt>
                <c:pt idx="42">
                  <c:v>46.0</c:v>
                </c:pt>
                <c:pt idx="43">
                  <c:v>62.0</c:v>
                </c:pt>
                <c:pt idx="44">
                  <c:v>58.0</c:v>
                </c:pt>
                <c:pt idx="45">
                  <c:v>56.0</c:v>
                </c:pt>
                <c:pt idx="47">
                  <c:v>40.0</c:v>
                </c:pt>
                <c:pt idx="48">
                  <c:v>51.0</c:v>
                </c:pt>
                <c:pt idx="49">
                  <c:v>36.0</c:v>
                </c:pt>
                <c:pt idx="50">
                  <c:v>36.0</c:v>
                </c:pt>
                <c:pt idx="51">
                  <c:v>56.0</c:v>
                </c:pt>
                <c:pt idx="52">
                  <c:v>35.0</c:v>
                </c:pt>
                <c:pt idx="53">
                  <c:v>33.0</c:v>
                </c:pt>
                <c:pt idx="54">
                  <c:v>30.0</c:v>
                </c:pt>
                <c:pt idx="55">
                  <c:v>38.0</c:v>
                </c:pt>
                <c:pt idx="56">
                  <c:v>34.0</c:v>
                </c:pt>
                <c:pt idx="57">
                  <c:v>47.0</c:v>
                </c:pt>
                <c:pt idx="58">
                  <c:v>34.0</c:v>
                </c:pt>
                <c:pt idx="59">
                  <c:v>44.0</c:v>
                </c:pt>
                <c:pt idx="60">
                  <c:v>51.0</c:v>
                </c:pt>
                <c:pt idx="61">
                  <c:v>59.0</c:v>
                </c:pt>
                <c:pt idx="62">
                  <c:v>59.0</c:v>
                </c:pt>
                <c:pt idx="63">
                  <c:v>40.0</c:v>
                </c:pt>
                <c:pt idx="64">
                  <c:v>51.0</c:v>
                </c:pt>
                <c:pt idx="65">
                  <c:v>35.0</c:v>
                </c:pt>
                <c:pt idx="66">
                  <c:v>53.0</c:v>
                </c:pt>
                <c:pt idx="67">
                  <c:v>30.0</c:v>
                </c:pt>
                <c:pt idx="68">
                  <c:v>38.0</c:v>
                </c:pt>
                <c:pt idx="69">
                  <c:v>54.0</c:v>
                </c:pt>
                <c:pt idx="70">
                  <c:v>46.0</c:v>
                </c:pt>
                <c:pt idx="71">
                  <c:v>56.0</c:v>
                </c:pt>
                <c:pt idx="72">
                  <c:v>58.0</c:v>
                </c:pt>
                <c:pt idx="73">
                  <c:v>48.0</c:v>
                </c:pt>
                <c:pt idx="74">
                  <c:v>47.0</c:v>
                </c:pt>
                <c:pt idx="75">
                  <c:v>43.0</c:v>
                </c:pt>
                <c:pt idx="76">
                  <c:v>50.0</c:v>
                </c:pt>
                <c:pt idx="77">
                  <c:v>50.0</c:v>
                </c:pt>
                <c:pt idx="78">
                  <c:v>52.0</c:v>
                </c:pt>
                <c:pt idx="79">
                  <c:v>41.0</c:v>
                </c:pt>
                <c:pt idx="80">
                  <c:v>41.0</c:v>
                </c:pt>
                <c:pt idx="81">
                  <c:v>38.0</c:v>
                </c:pt>
                <c:pt idx="82">
                  <c:v>42.0</c:v>
                </c:pt>
                <c:pt idx="83">
                  <c:v>51.0</c:v>
                </c:pt>
                <c:pt idx="84">
                  <c:v>50.0</c:v>
                </c:pt>
                <c:pt idx="85">
                  <c:v>30.0</c:v>
                </c:pt>
                <c:pt idx="86">
                  <c:v>30.0</c:v>
                </c:pt>
                <c:pt idx="87">
                  <c:v>39.0</c:v>
                </c:pt>
                <c:pt idx="88">
                  <c:v>39.0</c:v>
                </c:pt>
                <c:pt idx="89">
                  <c:v>29.0</c:v>
                </c:pt>
                <c:pt idx="90">
                  <c:v>45.0</c:v>
                </c:pt>
                <c:pt idx="91">
                  <c:v>39.0</c:v>
                </c:pt>
                <c:pt idx="92">
                  <c:v>53.0</c:v>
                </c:pt>
                <c:pt idx="93">
                  <c:v>46.0</c:v>
                </c:pt>
                <c:pt idx="94">
                  <c:v>44.0</c:v>
                </c:pt>
                <c:pt idx="95">
                  <c:v>63.0</c:v>
                </c:pt>
                <c:pt idx="96">
                  <c:v>42.0</c:v>
                </c:pt>
                <c:pt idx="97">
                  <c:v>48.0</c:v>
                </c:pt>
                <c:pt idx="99">
                  <c:v>42.0</c:v>
                </c:pt>
                <c:pt idx="100">
                  <c:v>41.0</c:v>
                </c:pt>
                <c:pt idx="101">
                  <c:v>52.0</c:v>
                </c:pt>
                <c:pt idx="102">
                  <c:v>40.0</c:v>
                </c:pt>
                <c:pt idx="103">
                  <c:v>42.0</c:v>
                </c:pt>
                <c:pt idx="104">
                  <c:v>50.0</c:v>
                </c:pt>
                <c:pt idx="105">
                  <c:v>44.0</c:v>
                </c:pt>
                <c:pt idx="106">
                  <c:v>27.0</c:v>
                </c:pt>
                <c:pt idx="107">
                  <c:v>50.0</c:v>
                </c:pt>
                <c:pt idx="108">
                  <c:v>48.0</c:v>
                </c:pt>
                <c:pt idx="109">
                  <c:v>44.0</c:v>
                </c:pt>
                <c:pt idx="110">
                  <c:v>45.0</c:v>
                </c:pt>
                <c:pt idx="111">
                  <c:v>54.0</c:v>
                </c:pt>
                <c:pt idx="112">
                  <c:v>48.0</c:v>
                </c:pt>
                <c:pt idx="113">
                  <c:v>22.0</c:v>
                </c:pt>
                <c:pt idx="114">
                  <c:v>52.0</c:v>
                </c:pt>
                <c:pt idx="115">
                  <c:v>45.0</c:v>
                </c:pt>
                <c:pt idx="116">
                  <c:v>34.0</c:v>
                </c:pt>
                <c:pt idx="118">
                  <c:v>33.0</c:v>
                </c:pt>
                <c:pt idx="119">
                  <c:v>50.0</c:v>
                </c:pt>
                <c:pt idx="120">
                  <c:v>55.0</c:v>
                </c:pt>
                <c:pt idx="121">
                  <c:v>46.0</c:v>
                </c:pt>
                <c:pt idx="122">
                  <c:v>54.0</c:v>
                </c:pt>
                <c:pt idx="123">
                  <c:v>57.0</c:v>
                </c:pt>
                <c:pt idx="124">
                  <c:v>53.0</c:v>
                </c:pt>
                <c:pt idx="125">
                  <c:v>39.0</c:v>
                </c:pt>
                <c:pt idx="126">
                  <c:v>37.0</c:v>
                </c:pt>
                <c:pt idx="127">
                  <c:v>56.0</c:v>
                </c:pt>
                <c:pt idx="128">
                  <c:v>38.0</c:v>
                </c:pt>
                <c:pt idx="129">
                  <c:v>33.0</c:v>
                </c:pt>
                <c:pt idx="130">
                  <c:v>31.0</c:v>
                </c:pt>
                <c:pt idx="131">
                  <c:v>37.0</c:v>
                </c:pt>
                <c:pt idx="132">
                  <c:v>46.0</c:v>
                </c:pt>
              </c:numCache>
            </c:numRef>
          </c:xVal>
          <c:yVal>
            <c:numRef>
              <c:f>'pearson HV new'!$C$2:$C$134</c:f>
              <c:numCache>
                <c:formatCode>General</c:formatCode>
                <c:ptCount val="133"/>
                <c:pt idx="0">
                  <c:v>-0.533952927745999</c:v>
                </c:pt>
                <c:pt idx="1">
                  <c:v>0.213204113641511</c:v>
                </c:pt>
                <c:pt idx="2">
                  <c:v>0.553564552599107</c:v>
                </c:pt>
                <c:pt idx="3">
                  <c:v>0.847130252737329</c:v>
                </c:pt>
                <c:pt idx="4">
                  <c:v>-0.64806645768616</c:v>
                </c:pt>
                <c:pt idx="5">
                  <c:v>-0.323256200210129</c:v>
                </c:pt>
                <c:pt idx="6">
                  <c:v>-0.248235931471694</c:v>
                </c:pt>
                <c:pt idx="7">
                  <c:v>-0.811382563859971</c:v>
                </c:pt>
                <c:pt idx="8">
                  <c:v>0.864160561167061</c:v>
                </c:pt>
                <c:pt idx="9">
                  <c:v>-0.152374957141999</c:v>
                </c:pt>
                <c:pt idx="10">
                  <c:v>1.79286503549599</c:v>
                </c:pt>
                <c:pt idx="11">
                  <c:v>0.482547770644657</c:v>
                </c:pt>
                <c:pt idx="12">
                  <c:v>0.675630005911605</c:v>
                </c:pt>
                <c:pt idx="13">
                  <c:v>-0.198057086233423</c:v>
                </c:pt>
                <c:pt idx="14">
                  <c:v>-0.542335636060044</c:v>
                </c:pt>
                <c:pt idx="15">
                  <c:v>-2.506247103328318</c:v>
                </c:pt>
                <c:pt idx="16">
                  <c:v>-1.05913948761464</c:v>
                </c:pt>
                <c:pt idx="17">
                  <c:v>-1.62732197841802</c:v>
                </c:pt>
                <c:pt idx="18">
                  <c:v>-0.811609486286862</c:v>
                </c:pt>
                <c:pt idx="19">
                  <c:v>-0.967124102136066</c:v>
                </c:pt>
                <c:pt idx="20">
                  <c:v>-0.789865022265148</c:v>
                </c:pt>
                <c:pt idx="21">
                  <c:v>-2.80491900758939</c:v>
                </c:pt>
                <c:pt idx="22">
                  <c:v>-0.696112976246932</c:v>
                </c:pt>
                <c:pt idx="23">
                  <c:v>-1.13552988079798</c:v>
                </c:pt>
                <c:pt idx="24">
                  <c:v>1.61154915376873</c:v>
                </c:pt>
                <c:pt idx="25">
                  <c:v>-0.339184691806312</c:v>
                </c:pt>
                <c:pt idx="26">
                  <c:v>-1.27261731027667</c:v>
                </c:pt>
                <c:pt idx="27">
                  <c:v>-0.827448980729623</c:v>
                </c:pt>
                <c:pt idx="28">
                  <c:v>-0.246365580578618</c:v>
                </c:pt>
                <c:pt idx="29">
                  <c:v>-1.73073794185397</c:v>
                </c:pt>
                <c:pt idx="30">
                  <c:v>-1.01187323213284</c:v>
                </c:pt>
                <c:pt idx="31">
                  <c:v>-1.00245587044215</c:v>
                </c:pt>
                <c:pt idx="32">
                  <c:v>-1.01941297853829</c:v>
                </c:pt>
                <c:pt idx="33">
                  <c:v>0.886473214169363</c:v>
                </c:pt>
                <c:pt idx="34">
                  <c:v>-0.4874636060305</c:v>
                </c:pt>
                <c:pt idx="35">
                  <c:v>0.825922338645213</c:v>
                </c:pt>
                <c:pt idx="36">
                  <c:v>-0.416246913677748</c:v>
                </c:pt>
                <c:pt idx="37">
                  <c:v>-2.02651580811368</c:v>
                </c:pt>
                <c:pt idx="38">
                  <c:v>0.690602196672111</c:v>
                </c:pt>
                <c:pt idx="39">
                  <c:v>0.81094605912178</c:v>
                </c:pt>
                <c:pt idx="40">
                  <c:v>0.482143585951777</c:v>
                </c:pt>
                <c:pt idx="41">
                  <c:v>0.115353328473381</c:v>
                </c:pt>
                <c:pt idx="42">
                  <c:v>-0.502944459252896</c:v>
                </c:pt>
                <c:pt idx="43">
                  <c:v>-0.274328436319155</c:v>
                </c:pt>
                <c:pt idx="44">
                  <c:v>-3.13008005801832</c:v>
                </c:pt>
                <c:pt idx="45">
                  <c:v>-1.67902457833942</c:v>
                </c:pt>
                <c:pt idx="46">
                  <c:v>0.733220446394864</c:v>
                </c:pt>
                <c:pt idx="47">
                  <c:v>-0.0923816579806198</c:v>
                </c:pt>
                <c:pt idx="48">
                  <c:v>0.0953130881157742</c:v>
                </c:pt>
                <c:pt idx="49">
                  <c:v>0.284839690829371</c:v>
                </c:pt>
                <c:pt idx="50">
                  <c:v>-1.41629699856401</c:v>
                </c:pt>
                <c:pt idx="51">
                  <c:v>-0.959436917665186</c:v>
                </c:pt>
                <c:pt idx="52">
                  <c:v>-1.31167478034561</c:v>
                </c:pt>
                <c:pt idx="53">
                  <c:v>-1.35249357427711</c:v>
                </c:pt>
                <c:pt idx="54">
                  <c:v>-3.13850474578436</c:v>
                </c:pt>
                <c:pt idx="55">
                  <c:v>-1.65443929235167</c:v>
                </c:pt>
                <c:pt idx="56">
                  <c:v>-0.414778191427202</c:v>
                </c:pt>
                <c:pt idx="57">
                  <c:v>-1.10205655428729</c:v>
                </c:pt>
                <c:pt idx="58">
                  <c:v>-2.10879344761694</c:v>
                </c:pt>
                <c:pt idx="59">
                  <c:v>-2.319358963475377</c:v>
                </c:pt>
                <c:pt idx="60">
                  <c:v>0.601907244426696</c:v>
                </c:pt>
                <c:pt idx="61">
                  <c:v>-2.59355701061005</c:v>
                </c:pt>
                <c:pt idx="62">
                  <c:v>-0.995570235887294</c:v>
                </c:pt>
                <c:pt idx="63">
                  <c:v>-1.86896491074391</c:v>
                </c:pt>
                <c:pt idx="64">
                  <c:v>0.791109672716918</c:v>
                </c:pt>
                <c:pt idx="65">
                  <c:v>1.84371043520298</c:v>
                </c:pt>
                <c:pt idx="66">
                  <c:v>1.92476298335901</c:v>
                </c:pt>
                <c:pt idx="67">
                  <c:v>1.957480657854189</c:v>
                </c:pt>
                <c:pt idx="68">
                  <c:v>0.638437223342394</c:v>
                </c:pt>
                <c:pt idx="69">
                  <c:v>-1.41630871086993</c:v>
                </c:pt>
                <c:pt idx="70">
                  <c:v>-4.99424056295328</c:v>
                </c:pt>
                <c:pt idx="71">
                  <c:v>-1.94892023169638</c:v>
                </c:pt>
                <c:pt idx="72">
                  <c:v>0.603886608583935</c:v>
                </c:pt>
                <c:pt idx="73">
                  <c:v>-1.61038159055917</c:v>
                </c:pt>
                <c:pt idx="74">
                  <c:v>-1.94853345718093</c:v>
                </c:pt>
                <c:pt idx="75">
                  <c:v>-2.53752495466581</c:v>
                </c:pt>
                <c:pt idx="76">
                  <c:v>-1.42391194369677</c:v>
                </c:pt>
                <c:pt idx="77">
                  <c:v>-2.15319973706604</c:v>
                </c:pt>
                <c:pt idx="78">
                  <c:v>-1.79726100016099</c:v>
                </c:pt>
                <c:pt idx="79">
                  <c:v>-4.153516976036202</c:v>
                </c:pt>
                <c:pt idx="80">
                  <c:v>-2.22738937901647</c:v>
                </c:pt>
                <c:pt idx="81">
                  <c:v>-0.910986161259706</c:v>
                </c:pt>
                <c:pt idx="82">
                  <c:v>-2.68993098725296</c:v>
                </c:pt>
                <c:pt idx="83">
                  <c:v>-2.65924681277481</c:v>
                </c:pt>
                <c:pt idx="84">
                  <c:v>-0.551208696465769</c:v>
                </c:pt>
                <c:pt idx="85">
                  <c:v>-3.413218099656857</c:v>
                </c:pt>
                <c:pt idx="86">
                  <c:v>-2.46443656093387</c:v>
                </c:pt>
                <c:pt idx="87">
                  <c:v>-4.3487138024134</c:v>
                </c:pt>
                <c:pt idx="88">
                  <c:v>-3.52531117655292</c:v>
                </c:pt>
                <c:pt idx="89">
                  <c:v>-2.88784554561652</c:v>
                </c:pt>
                <c:pt idx="90">
                  <c:v>-3.32907422489236</c:v>
                </c:pt>
                <c:pt idx="91">
                  <c:v>-1.71537180829769</c:v>
                </c:pt>
                <c:pt idx="92">
                  <c:v>-3.375083615378597</c:v>
                </c:pt>
                <c:pt idx="93">
                  <c:v>-3.44553287637986</c:v>
                </c:pt>
                <c:pt idx="94">
                  <c:v>-3.68963015581111</c:v>
                </c:pt>
                <c:pt idx="95">
                  <c:v>-2.96158434292715</c:v>
                </c:pt>
                <c:pt idx="96">
                  <c:v>-5.157787123574947</c:v>
                </c:pt>
                <c:pt idx="97">
                  <c:v>-3.76264424735664</c:v>
                </c:pt>
                <c:pt idx="98">
                  <c:v>-2.831345194511161</c:v>
                </c:pt>
                <c:pt idx="99">
                  <c:v>-5.279058848608289</c:v>
                </c:pt>
                <c:pt idx="100">
                  <c:v>-5.05387034183686</c:v>
                </c:pt>
                <c:pt idx="101">
                  <c:v>-3.77589927367444</c:v>
                </c:pt>
                <c:pt idx="102">
                  <c:v>-4.414767871078515</c:v>
                </c:pt>
                <c:pt idx="103">
                  <c:v>-4.624842137939294</c:v>
                </c:pt>
                <c:pt idx="104">
                  <c:v>-4.77421478960719</c:v>
                </c:pt>
                <c:pt idx="105">
                  <c:v>-3.720256090541</c:v>
                </c:pt>
                <c:pt idx="106">
                  <c:v>-4.225104024745344</c:v>
                </c:pt>
                <c:pt idx="107">
                  <c:v>-2.99836005316926</c:v>
                </c:pt>
                <c:pt idx="108">
                  <c:v>-3.33633405331836</c:v>
                </c:pt>
                <c:pt idx="109">
                  <c:v>-4.3781424382229</c:v>
                </c:pt>
                <c:pt idx="110">
                  <c:v>-4.72579797757414</c:v>
                </c:pt>
                <c:pt idx="111">
                  <c:v>-3.211895517933748</c:v>
                </c:pt>
                <c:pt idx="112">
                  <c:v>-3.80186617936236</c:v>
                </c:pt>
                <c:pt idx="113">
                  <c:v>-4.108644041199049</c:v>
                </c:pt>
                <c:pt idx="114">
                  <c:v>-4.55003012352793</c:v>
                </c:pt>
                <c:pt idx="115">
                  <c:v>-4.48359902304883</c:v>
                </c:pt>
                <c:pt idx="116">
                  <c:v>-3.61673648190464</c:v>
                </c:pt>
                <c:pt idx="117">
                  <c:v>-2.50947668445081</c:v>
                </c:pt>
                <c:pt idx="118">
                  <c:v>-3.873261103839658</c:v>
                </c:pt>
                <c:pt idx="119">
                  <c:v>-3.53326107715352</c:v>
                </c:pt>
                <c:pt idx="120">
                  <c:v>-2.60491436539461</c:v>
                </c:pt>
                <c:pt idx="121">
                  <c:v>-2.99766056138497</c:v>
                </c:pt>
                <c:pt idx="122">
                  <c:v>-4.629664241849435</c:v>
                </c:pt>
                <c:pt idx="123">
                  <c:v>-3.66748625123523</c:v>
                </c:pt>
                <c:pt idx="124">
                  <c:v>-3.80596145594964</c:v>
                </c:pt>
                <c:pt idx="125">
                  <c:v>-4.28539039420451</c:v>
                </c:pt>
                <c:pt idx="126">
                  <c:v>-3.890162380833539</c:v>
                </c:pt>
                <c:pt idx="127">
                  <c:v>-3.88445906890142</c:v>
                </c:pt>
                <c:pt idx="128">
                  <c:v>-0.526141771123481</c:v>
                </c:pt>
                <c:pt idx="129">
                  <c:v>1.51505063349227</c:v>
                </c:pt>
                <c:pt idx="130">
                  <c:v>-0.533386844435051</c:v>
                </c:pt>
                <c:pt idx="131">
                  <c:v>-2.88825367229016</c:v>
                </c:pt>
                <c:pt idx="132">
                  <c:v>-0.50429656973851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077986992"/>
        <c:axId val="-1536153360"/>
      </c:scatterChart>
      <c:valAx>
        <c:axId val="-10779869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2000"/>
                  <a:t>Age</a:t>
                </a:r>
                <a:endParaRPr lang="ja-JP" altLang="en-US" sz="20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536153360"/>
        <c:crosses val="autoZero"/>
        <c:crossBetween val="midCat"/>
      </c:valAx>
      <c:valAx>
        <c:axId val="-1536153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2000" dirty="0" smtClean="0"/>
                  <a:t>Detecting</a:t>
                </a:r>
                <a:r>
                  <a:rPr lang="en-US" altLang="ja-JP" sz="2000" baseline="0" dirty="0" smtClean="0"/>
                  <a:t> </a:t>
                </a:r>
                <a:r>
                  <a:rPr lang="en-US" altLang="ja-JP" sz="2000" baseline="0" dirty="0"/>
                  <a:t>index</a:t>
                </a:r>
                <a:endParaRPr lang="ja-JP" altLang="en-US" sz="20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077986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3980482960698"/>
          <c:y val="0.0650550380162144"/>
          <c:w val="0.883789704354283"/>
          <c:h val="0.644908051415098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[1]extracteddata!$D$23:$D$48</c:f>
              <c:numCache>
                <c:formatCode>General</c:formatCode>
                <c:ptCount val="26"/>
                <c:pt idx="0">
                  <c:v>7.9358128E7</c:v>
                </c:pt>
                <c:pt idx="1">
                  <c:v>7.9381747E7</c:v>
                </c:pt>
                <c:pt idx="2">
                  <c:v>7.9381805E7</c:v>
                </c:pt>
                <c:pt idx="3">
                  <c:v>7.9381867E7</c:v>
                </c:pt>
                <c:pt idx="4">
                  <c:v>7.9382548E7</c:v>
                </c:pt>
                <c:pt idx="5">
                  <c:v>7.9382708E7</c:v>
                </c:pt>
                <c:pt idx="6">
                  <c:v>7.9382767E7</c:v>
                </c:pt>
                <c:pt idx="7">
                  <c:v>7.9382807E7</c:v>
                </c:pt>
                <c:pt idx="8">
                  <c:v>7.9382995E7</c:v>
                </c:pt>
                <c:pt idx="9">
                  <c:v>7.9382998E7</c:v>
                </c:pt>
                <c:pt idx="10">
                  <c:v>7.9383167E7</c:v>
                </c:pt>
                <c:pt idx="11">
                  <c:v>7.9383385E7</c:v>
                </c:pt>
                <c:pt idx="12">
                  <c:v>7.9383413E7</c:v>
                </c:pt>
                <c:pt idx="13">
                  <c:v>7.938356E7</c:v>
                </c:pt>
                <c:pt idx="14">
                  <c:v>7.9383632E7</c:v>
                </c:pt>
                <c:pt idx="15">
                  <c:v>7.9383644E7</c:v>
                </c:pt>
                <c:pt idx="16">
                  <c:v>7.938377E7</c:v>
                </c:pt>
                <c:pt idx="17">
                  <c:v>7.9383841E7</c:v>
                </c:pt>
                <c:pt idx="18">
                  <c:v>7.9383852E7</c:v>
                </c:pt>
                <c:pt idx="19">
                  <c:v>7.9383858E7</c:v>
                </c:pt>
                <c:pt idx="20">
                  <c:v>7.9383861E7</c:v>
                </c:pt>
                <c:pt idx="21">
                  <c:v>7.938389E7</c:v>
                </c:pt>
                <c:pt idx="22">
                  <c:v>7.9383924E7</c:v>
                </c:pt>
                <c:pt idx="23">
                  <c:v>7.9383947E7</c:v>
                </c:pt>
                <c:pt idx="24">
                  <c:v>7.938398E7</c:v>
                </c:pt>
                <c:pt idx="25">
                  <c:v>7.9386035E7</c:v>
                </c:pt>
              </c:numCache>
            </c:numRef>
          </c:xVal>
          <c:yVal>
            <c:numRef>
              <c:f>[1]extracteddata!$F$23:$F$48</c:f>
              <c:numCache>
                <c:formatCode>General</c:formatCode>
                <c:ptCount val="26"/>
                <c:pt idx="0">
                  <c:v>0.452526036206691</c:v>
                </c:pt>
                <c:pt idx="1">
                  <c:v>0.432618804791816</c:v>
                </c:pt>
                <c:pt idx="2">
                  <c:v>0.577934730814218</c:v>
                </c:pt>
                <c:pt idx="3">
                  <c:v>0.682070647526882</c:v>
                </c:pt>
                <c:pt idx="4">
                  <c:v>0.164566167217742</c:v>
                </c:pt>
                <c:pt idx="5">
                  <c:v>0.156244549284648</c:v>
                </c:pt>
                <c:pt idx="6">
                  <c:v>0.185307415989845</c:v>
                </c:pt>
                <c:pt idx="7">
                  <c:v>0.119196227855137</c:v>
                </c:pt>
                <c:pt idx="8">
                  <c:v>0.129069265679809</c:v>
                </c:pt>
                <c:pt idx="9">
                  <c:v>0.230506632398447</c:v>
                </c:pt>
                <c:pt idx="10">
                  <c:v>0.134606744596296</c:v>
                </c:pt>
                <c:pt idx="11">
                  <c:v>0.0791810597948029</c:v>
                </c:pt>
                <c:pt idx="12">
                  <c:v>0.13094587772491</c:v>
                </c:pt>
                <c:pt idx="13">
                  <c:v>0.115749466594683</c:v>
                </c:pt>
                <c:pt idx="14">
                  <c:v>0.153134944661589</c:v>
                </c:pt>
                <c:pt idx="15">
                  <c:v>0.118881203419952</c:v>
                </c:pt>
                <c:pt idx="16">
                  <c:v>0.218042175916667</c:v>
                </c:pt>
                <c:pt idx="17">
                  <c:v>0.17061808801374</c:v>
                </c:pt>
                <c:pt idx="18">
                  <c:v>0.152480808367085</c:v>
                </c:pt>
                <c:pt idx="19">
                  <c:v>0.13404943434767</c:v>
                </c:pt>
                <c:pt idx="20">
                  <c:v>0.133167459447431</c:v>
                </c:pt>
                <c:pt idx="21">
                  <c:v>0.0977949375657109</c:v>
                </c:pt>
                <c:pt idx="22">
                  <c:v>0.117331617883214</c:v>
                </c:pt>
                <c:pt idx="23">
                  <c:v>0.14485886177718</c:v>
                </c:pt>
                <c:pt idx="24">
                  <c:v>0.134187702483274</c:v>
                </c:pt>
                <c:pt idx="25">
                  <c:v>0.432966336508065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[1]extracteddata!$D$23:$D$48</c:f>
              <c:numCache>
                <c:formatCode>General</c:formatCode>
                <c:ptCount val="26"/>
                <c:pt idx="0">
                  <c:v>7.9358128E7</c:v>
                </c:pt>
                <c:pt idx="1">
                  <c:v>7.9381747E7</c:v>
                </c:pt>
                <c:pt idx="2">
                  <c:v>7.9381805E7</c:v>
                </c:pt>
                <c:pt idx="3">
                  <c:v>7.9381867E7</c:v>
                </c:pt>
                <c:pt idx="4">
                  <c:v>7.9382548E7</c:v>
                </c:pt>
                <c:pt idx="5">
                  <c:v>7.9382708E7</c:v>
                </c:pt>
                <c:pt idx="6">
                  <c:v>7.9382767E7</c:v>
                </c:pt>
                <c:pt idx="7">
                  <c:v>7.9382807E7</c:v>
                </c:pt>
                <c:pt idx="8">
                  <c:v>7.9382995E7</c:v>
                </c:pt>
                <c:pt idx="9">
                  <c:v>7.9382998E7</c:v>
                </c:pt>
                <c:pt idx="10">
                  <c:v>7.9383167E7</c:v>
                </c:pt>
                <c:pt idx="11">
                  <c:v>7.9383385E7</c:v>
                </c:pt>
                <c:pt idx="12">
                  <c:v>7.9383413E7</c:v>
                </c:pt>
                <c:pt idx="13">
                  <c:v>7.938356E7</c:v>
                </c:pt>
                <c:pt idx="14">
                  <c:v>7.9383632E7</c:v>
                </c:pt>
                <c:pt idx="15">
                  <c:v>7.9383644E7</c:v>
                </c:pt>
                <c:pt idx="16">
                  <c:v>7.938377E7</c:v>
                </c:pt>
                <c:pt idx="17">
                  <c:v>7.9383841E7</c:v>
                </c:pt>
                <c:pt idx="18">
                  <c:v>7.9383852E7</c:v>
                </c:pt>
                <c:pt idx="19">
                  <c:v>7.9383858E7</c:v>
                </c:pt>
                <c:pt idx="20">
                  <c:v>7.9383861E7</c:v>
                </c:pt>
                <c:pt idx="21">
                  <c:v>7.938389E7</c:v>
                </c:pt>
                <c:pt idx="22">
                  <c:v>7.9383924E7</c:v>
                </c:pt>
                <c:pt idx="23">
                  <c:v>7.9383947E7</c:v>
                </c:pt>
                <c:pt idx="24">
                  <c:v>7.938398E7</c:v>
                </c:pt>
                <c:pt idx="25">
                  <c:v>7.9386035E7</c:v>
                </c:pt>
              </c:numCache>
            </c:numRef>
          </c:xVal>
          <c:yVal>
            <c:numRef>
              <c:f>[1]extracteddata!$G$23:$G$48</c:f>
              <c:numCache>
                <c:formatCode>General</c:formatCode>
                <c:ptCount val="26"/>
                <c:pt idx="0">
                  <c:v>0.6879041338</c:v>
                </c:pt>
                <c:pt idx="1">
                  <c:v>0.0337481879428571</c:v>
                </c:pt>
                <c:pt idx="2">
                  <c:v>0.0486995596571429</c:v>
                </c:pt>
                <c:pt idx="3">
                  <c:v>0.0152600548</c:v>
                </c:pt>
                <c:pt idx="4">
                  <c:v>0.0279821326571429</c:v>
                </c:pt>
                <c:pt idx="5">
                  <c:v>0.108757911371429</c:v>
                </c:pt>
                <c:pt idx="6">
                  <c:v>0.1151935626</c:v>
                </c:pt>
                <c:pt idx="7">
                  <c:v>0.0326155118571429</c:v>
                </c:pt>
                <c:pt idx="8">
                  <c:v>0.0176654662</c:v>
                </c:pt>
                <c:pt idx="9">
                  <c:v>0.0548971524571429</c:v>
                </c:pt>
                <c:pt idx="10">
                  <c:v>0.00990923002857143</c:v>
                </c:pt>
                <c:pt idx="11">
                  <c:v>0.00638685094285714</c:v>
                </c:pt>
                <c:pt idx="12">
                  <c:v>0.0407542558</c:v>
                </c:pt>
                <c:pt idx="13">
                  <c:v>0.0535730109428571</c:v>
                </c:pt>
                <c:pt idx="14">
                  <c:v>0.0872304403142857</c:v>
                </c:pt>
                <c:pt idx="15">
                  <c:v>0.0455667588571429</c:v>
                </c:pt>
                <c:pt idx="16">
                  <c:v>0.0751781391428571</c:v>
                </c:pt>
                <c:pt idx="17">
                  <c:v>0.064803492</c:v>
                </c:pt>
                <c:pt idx="18">
                  <c:v>0.029383095</c:v>
                </c:pt>
                <c:pt idx="19">
                  <c:v>0.037473225</c:v>
                </c:pt>
                <c:pt idx="20">
                  <c:v>0.0506241123529412</c:v>
                </c:pt>
                <c:pt idx="21">
                  <c:v>0.0092021536</c:v>
                </c:pt>
                <c:pt idx="22">
                  <c:v>0.00707164665714286</c:v>
                </c:pt>
                <c:pt idx="23">
                  <c:v>0.0297831792941176</c:v>
                </c:pt>
                <c:pt idx="24">
                  <c:v>0.0193222408571429</c:v>
                </c:pt>
                <c:pt idx="25">
                  <c:v>0.880196537171429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[1]extracteddata!$D$23:$D$48</c:f>
              <c:numCache>
                <c:formatCode>General</c:formatCode>
                <c:ptCount val="26"/>
                <c:pt idx="0">
                  <c:v>7.9358128E7</c:v>
                </c:pt>
                <c:pt idx="1">
                  <c:v>7.9381747E7</c:v>
                </c:pt>
                <c:pt idx="2">
                  <c:v>7.9381805E7</c:v>
                </c:pt>
                <c:pt idx="3">
                  <c:v>7.9381867E7</c:v>
                </c:pt>
                <c:pt idx="4">
                  <c:v>7.9382548E7</c:v>
                </c:pt>
                <c:pt idx="5">
                  <c:v>7.9382708E7</c:v>
                </c:pt>
                <c:pt idx="6">
                  <c:v>7.9382767E7</c:v>
                </c:pt>
                <c:pt idx="7">
                  <c:v>7.9382807E7</c:v>
                </c:pt>
                <c:pt idx="8">
                  <c:v>7.9382995E7</c:v>
                </c:pt>
                <c:pt idx="9">
                  <c:v>7.9382998E7</c:v>
                </c:pt>
                <c:pt idx="10">
                  <c:v>7.9383167E7</c:v>
                </c:pt>
                <c:pt idx="11">
                  <c:v>7.9383385E7</c:v>
                </c:pt>
                <c:pt idx="12">
                  <c:v>7.9383413E7</c:v>
                </c:pt>
                <c:pt idx="13">
                  <c:v>7.938356E7</c:v>
                </c:pt>
                <c:pt idx="14">
                  <c:v>7.9383632E7</c:v>
                </c:pt>
                <c:pt idx="15">
                  <c:v>7.9383644E7</c:v>
                </c:pt>
                <c:pt idx="16">
                  <c:v>7.938377E7</c:v>
                </c:pt>
                <c:pt idx="17">
                  <c:v>7.9383841E7</c:v>
                </c:pt>
                <c:pt idx="18">
                  <c:v>7.9383852E7</c:v>
                </c:pt>
                <c:pt idx="19">
                  <c:v>7.9383858E7</c:v>
                </c:pt>
                <c:pt idx="20">
                  <c:v>7.9383861E7</c:v>
                </c:pt>
                <c:pt idx="21">
                  <c:v>7.938389E7</c:v>
                </c:pt>
                <c:pt idx="22">
                  <c:v>7.9383924E7</c:v>
                </c:pt>
                <c:pt idx="23">
                  <c:v>7.9383947E7</c:v>
                </c:pt>
                <c:pt idx="24">
                  <c:v>7.938398E7</c:v>
                </c:pt>
                <c:pt idx="25">
                  <c:v>7.9386035E7</c:v>
                </c:pt>
              </c:numCache>
            </c:numRef>
          </c:xVal>
          <c:yVal>
            <c:numRef>
              <c:f>[1]extracteddata!$H$23:$H$48</c:f>
              <c:numCache>
                <c:formatCode>General</c:formatCode>
                <c:ptCount val="26"/>
                <c:pt idx="0">
                  <c:v>0.508965643260526</c:v>
                </c:pt>
                <c:pt idx="1">
                  <c:v>0.542417656542105</c:v>
                </c:pt>
                <c:pt idx="2">
                  <c:v>0.664688507528948</c:v>
                </c:pt>
                <c:pt idx="3">
                  <c:v>0.779774905657895</c:v>
                </c:pt>
                <c:pt idx="4">
                  <c:v>0.0685100551131579</c:v>
                </c:pt>
                <c:pt idx="5">
                  <c:v>0.0758050742973684</c:v>
                </c:pt>
                <c:pt idx="6">
                  <c:v>0.138023739376316</c:v>
                </c:pt>
                <c:pt idx="7">
                  <c:v>0.0829445010763158</c:v>
                </c:pt>
                <c:pt idx="8">
                  <c:v>0.100167691842105</c:v>
                </c:pt>
                <c:pt idx="9">
                  <c:v>0.201960730052632</c:v>
                </c:pt>
                <c:pt idx="10">
                  <c:v>0.203232039460526</c:v>
                </c:pt>
                <c:pt idx="11">
                  <c:v>0.0453776827684211</c:v>
                </c:pt>
                <c:pt idx="12">
                  <c:v>0.127963828986842</c:v>
                </c:pt>
                <c:pt idx="13">
                  <c:v>0.0900888465973684</c:v>
                </c:pt>
                <c:pt idx="14">
                  <c:v>0.0927386643631579</c:v>
                </c:pt>
                <c:pt idx="15">
                  <c:v>0.0861935224210526</c:v>
                </c:pt>
                <c:pt idx="16">
                  <c:v>0.211395834513158</c:v>
                </c:pt>
                <c:pt idx="17">
                  <c:v>0.196008202973684</c:v>
                </c:pt>
                <c:pt idx="18">
                  <c:v>0.15637766995</c:v>
                </c:pt>
                <c:pt idx="19">
                  <c:v>0.156589230652632</c:v>
                </c:pt>
                <c:pt idx="20">
                  <c:v>0.119879937684211</c:v>
                </c:pt>
                <c:pt idx="21">
                  <c:v>0.1016925017</c:v>
                </c:pt>
                <c:pt idx="22">
                  <c:v>0.119126368407895</c:v>
                </c:pt>
                <c:pt idx="23">
                  <c:v>0.130008233342105</c:v>
                </c:pt>
                <c:pt idx="24">
                  <c:v>0.133960420189474</c:v>
                </c:pt>
                <c:pt idx="25">
                  <c:v>0.471386892878947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D$23:$D$48</c:f>
              <c:numCache>
                <c:formatCode>General</c:formatCode>
                <c:ptCount val="26"/>
                <c:pt idx="0">
                  <c:v>7.9358128E7</c:v>
                </c:pt>
                <c:pt idx="1">
                  <c:v>7.9381747E7</c:v>
                </c:pt>
                <c:pt idx="2">
                  <c:v>7.9381805E7</c:v>
                </c:pt>
                <c:pt idx="3">
                  <c:v>7.9381867E7</c:v>
                </c:pt>
                <c:pt idx="4">
                  <c:v>7.9382548E7</c:v>
                </c:pt>
                <c:pt idx="5">
                  <c:v>7.9382708E7</c:v>
                </c:pt>
                <c:pt idx="6">
                  <c:v>7.9382767E7</c:v>
                </c:pt>
                <c:pt idx="7">
                  <c:v>7.9382807E7</c:v>
                </c:pt>
                <c:pt idx="8">
                  <c:v>7.9382995E7</c:v>
                </c:pt>
                <c:pt idx="9">
                  <c:v>7.9382998E7</c:v>
                </c:pt>
                <c:pt idx="10">
                  <c:v>7.9383167E7</c:v>
                </c:pt>
                <c:pt idx="11">
                  <c:v>7.9383385E7</c:v>
                </c:pt>
                <c:pt idx="12">
                  <c:v>7.9383413E7</c:v>
                </c:pt>
                <c:pt idx="13">
                  <c:v>7.938356E7</c:v>
                </c:pt>
                <c:pt idx="14">
                  <c:v>7.9383632E7</c:v>
                </c:pt>
                <c:pt idx="15">
                  <c:v>7.9383644E7</c:v>
                </c:pt>
                <c:pt idx="16">
                  <c:v>7.938377E7</c:v>
                </c:pt>
                <c:pt idx="17">
                  <c:v>7.9383841E7</c:v>
                </c:pt>
                <c:pt idx="18">
                  <c:v>7.9383852E7</c:v>
                </c:pt>
                <c:pt idx="19">
                  <c:v>7.9383858E7</c:v>
                </c:pt>
                <c:pt idx="20">
                  <c:v>7.9383861E7</c:v>
                </c:pt>
                <c:pt idx="21">
                  <c:v>7.938389E7</c:v>
                </c:pt>
                <c:pt idx="22">
                  <c:v>7.9383924E7</c:v>
                </c:pt>
                <c:pt idx="23">
                  <c:v>7.9383947E7</c:v>
                </c:pt>
                <c:pt idx="24">
                  <c:v>7.938398E7</c:v>
                </c:pt>
                <c:pt idx="25">
                  <c:v>7.9386035E7</c:v>
                </c:pt>
              </c:numCache>
            </c:numRef>
          </c:xVal>
          <c:yVal>
            <c:numRef>
              <c:f>[1]extracteddata!$I$23:$I$48</c:f>
              <c:numCache>
                <c:formatCode>General</c:formatCode>
                <c:ptCount val="26"/>
                <c:pt idx="0">
                  <c:v>0.465581594045455</c:v>
                </c:pt>
                <c:pt idx="1">
                  <c:v>0.351036897590909</c:v>
                </c:pt>
                <c:pt idx="2">
                  <c:v>0.503462370795455</c:v>
                </c:pt>
                <c:pt idx="3">
                  <c:v>0.554462216363636</c:v>
                </c:pt>
                <c:pt idx="4">
                  <c:v>0.199929750863636</c:v>
                </c:pt>
                <c:pt idx="5">
                  <c:v>0.196215028113636</c:v>
                </c:pt>
                <c:pt idx="6">
                  <c:v>0.21436501</c:v>
                </c:pt>
                <c:pt idx="7">
                  <c:v>0.142714456477273</c:v>
                </c:pt>
                <c:pt idx="8">
                  <c:v>0.157393459977273</c:v>
                </c:pt>
                <c:pt idx="9">
                  <c:v>0.271111615454545</c:v>
                </c:pt>
                <c:pt idx="10">
                  <c:v>0.149085635704545</c:v>
                </c:pt>
                <c:pt idx="11">
                  <c:v>0.0894908920681818</c:v>
                </c:pt>
                <c:pt idx="12">
                  <c:v>0.123310151181818</c:v>
                </c:pt>
                <c:pt idx="13">
                  <c:v>0.154425630772727</c:v>
                </c:pt>
                <c:pt idx="14">
                  <c:v>0.197035870431818</c:v>
                </c:pt>
                <c:pt idx="15">
                  <c:v>0.140712791590909</c:v>
                </c:pt>
                <c:pt idx="16">
                  <c:v>0.224365002954545</c:v>
                </c:pt>
                <c:pt idx="17">
                  <c:v>0.159260387727273</c:v>
                </c:pt>
                <c:pt idx="18">
                  <c:v>0.143332235545455</c:v>
                </c:pt>
                <c:pt idx="19">
                  <c:v>0.104559900318182</c:v>
                </c:pt>
                <c:pt idx="20">
                  <c:v>0.121909040454545</c:v>
                </c:pt>
                <c:pt idx="21">
                  <c:v>0.0868360283409091</c:v>
                </c:pt>
                <c:pt idx="22">
                  <c:v>0.133138441727273</c:v>
                </c:pt>
                <c:pt idx="23">
                  <c:v>0.171694420909091</c:v>
                </c:pt>
                <c:pt idx="24">
                  <c:v>0.142483244159091</c:v>
                </c:pt>
                <c:pt idx="25">
                  <c:v>0.500395127090909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J$24:$J$25</c:f>
              <c:numCache>
                <c:formatCode>General</c:formatCode>
                <c:ptCount val="2"/>
                <c:pt idx="0">
                  <c:v>7.9381867E7</c:v>
                </c:pt>
                <c:pt idx="1">
                  <c:v>7.9381867E7</c:v>
                </c:pt>
              </c:numCache>
            </c:numRef>
          </c:xVal>
          <c:yVal>
            <c:numRef>
              <c:f>[1]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321802016"/>
        <c:axId val="-1369288592"/>
      </c:scatterChart>
      <c:valAx>
        <c:axId val="-1321802016"/>
        <c:scaling>
          <c:orientation val="minMax"/>
          <c:max val="7.9384867E7"/>
          <c:min val="7.9378867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369288592"/>
        <c:crosses val="autoZero"/>
        <c:crossBetween val="midCat"/>
        <c:majorUnit val="1000.0"/>
      </c:valAx>
      <c:valAx>
        <c:axId val="-1369288592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321802016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483369535184929"/>
          <c:w val="0.866916027948256"/>
          <c:h val="0.655322994520657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[1]extracteddata!$D$49:$D$64</c:f>
              <c:numCache>
                <c:formatCode>General</c:formatCode>
                <c:ptCount val="16"/>
                <c:pt idx="0">
                  <c:v>2.777921E6</c:v>
                </c:pt>
                <c:pt idx="1">
                  <c:v>2.780114E6</c:v>
                </c:pt>
                <c:pt idx="2">
                  <c:v>2.78068E6</c:v>
                </c:pt>
                <c:pt idx="3">
                  <c:v>2.781122E6</c:v>
                </c:pt>
                <c:pt idx="4">
                  <c:v>2.781241E6</c:v>
                </c:pt>
                <c:pt idx="5">
                  <c:v>2.781262E6</c:v>
                </c:pt>
                <c:pt idx="6">
                  <c:v>2.781316E6</c:v>
                </c:pt>
                <c:pt idx="7">
                  <c:v>2.781324E6</c:v>
                </c:pt>
                <c:pt idx="8">
                  <c:v>2.781399E6</c:v>
                </c:pt>
                <c:pt idx="9">
                  <c:v>2.781438E6</c:v>
                </c:pt>
                <c:pt idx="10">
                  <c:v>2.781478E6</c:v>
                </c:pt>
                <c:pt idx="11">
                  <c:v>2.781483E6</c:v>
                </c:pt>
                <c:pt idx="12">
                  <c:v>2.781489E6</c:v>
                </c:pt>
                <c:pt idx="13">
                  <c:v>2.781685E6</c:v>
                </c:pt>
                <c:pt idx="14">
                  <c:v>2.782078E6</c:v>
                </c:pt>
                <c:pt idx="15">
                  <c:v>2.785183E6</c:v>
                </c:pt>
              </c:numCache>
            </c:numRef>
          </c:xVal>
          <c:yVal>
            <c:numRef>
              <c:f>[1]extracteddata!$F$49:$F$64</c:f>
              <c:numCache>
                <c:formatCode>General</c:formatCode>
                <c:ptCount val="16"/>
                <c:pt idx="0">
                  <c:v>0.90941472078853</c:v>
                </c:pt>
                <c:pt idx="1">
                  <c:v>0.897774123787037</c:v>
                </c:pt>
                <c:pt idx="2">
                  <c:v>0.608410982330048</c:v>
                </c:pt>
                <c:pt idx="3">
                  <c:v>0.519200015597969</c:v>
                </c:pt>
                <c:pt idx="4">
                  <c:v>0.660262989650837</c:v>
                </c:pt>
                <c:pt idx="5">
                  <c:v>0.713756026711171</c:v>
                </c:pt>
                <c:pt idx="6">
                  <c:v>0.519926564438471</c:v>
                </c:pt>
                <c:pt idx="7">
                  <c:v>0.647284231421744</c:v>
                </c:pt>
                <c:pt idx="8">
                  <c:v>0.555765345206093</c:v>
                </c:pt>
                <c:pt idx="9">
                  <c:v>0.628881346325269</c:v>
                </c:pt>
                <c:pt idx="10">
                  <c:v>0.577492041338112</c:v>
                </c:pt>
                <c:pt idx="11">
                  <c:v>0.52187541958184</c:v>
                </c:pt>
                <c:pt idx="12">
                  <c:v>0.59182392891368</c:v>
                </c:pt>
                <c:pt idx="13">
                  <c:v>0.594754344986858</c:v>
                </c:pt>
                <c:pt idx="14">
                  <c:v>0.239224081718937</c:v>
                </c:pt>
                <c:pt idx="15">
                  <c:v>0.874843526771207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[1]extracteddata!$D$49:$D$64</c:f>
              <c:numCache>
                <c:formatCode>General</c:formatCode>
                <c:ptCount val="16"/>
                <c:pt idx="0">
                  <c:v>2.777921E6</c:v>
                </c:pt>
                <c:pt idx="1">
                  <c:v>2.780114E6</c:v>
                </c:pt>
                <c:pt idx="2">
                  <c:v>2.78068E6</c:v>
                </c:pt>
                <c:pt idx="3">
                  <c:v>2.781122E6</c:v>
                </c:pt>
                <c:pt idx="4">
                  <c:v>2.781241E6</c:v>
                </c:pt>
                <c:pt idx="5">
                  <c:v>2.781262E6</c:v>
                </c:pt>
                <c:pt idx="6">
                  <c:v>2.781316E6</c:v>
                </c:pt>
                <c:pt idx="7">
                  <c:v>2.781324E6</c:v>
                </c:pt>
                <c:pt idx="8">
                  <c:v>2.781399E6</c:v>
                </c:pt>
                <c:pt idx="9">
                  <c:v>2.781438E6</c:v>
                </c:pt>
                <c:pt idx="10">
                  <c:v>2.781478E6</c:v>
                </c:pt>
                <c:pt idx="11">
                  <c:v>2.781483E6</c:v>
                </c:pt>
                <c:pt idx="12">
                  <c:v>2.781489E6</c:v>
                </c:pt>
                <c:pt idx="13">
                  <c:v>2.781685E6</c:v>
                </c:pt>
                <c:pt idx="14">
                  <c:v>2.782078E6</c:v>
                </c:pt>
                <c:pt idx="15">
                  <c:v>2.785183E6</c:v>
                </c:pt>
              </c:numCache>
            </c:numRef>
          </c:xVal>
          <c:yVal>
            <c:numRef>
              <c:f>[1]extracteddata!$G$49:$G$64</c:f>
              <c:numCache>
                <c:formatCode>General</c:formatCode>
                <c:ptCount val="16"/>
                <c:pt idx="0">
                  <c:v>0.955701631428572</c:v>
                </c:pt>
                <c:pt idx="1">
                  <c:v>0.475384271428571</c:v>
                </c:pt>
                <c:pt idx="2">
                  <c:v>0.0737336837428572</c:v>
                </c:pt>
                <c:pt idx="3">
                  <c:v>0.0119058177714286</c:v>
                </c:pt>
                <c:pt idx="4">
                  <c:v>0.0260461738285714</c:v>
                </c:pt>
                <c:pt idx="5">
                  <c:v>0.0156394694857143</c:v>
                </c:pt>
                <c:pt idx="6">
                  <c:v>0.0552493445714286</c:v>
                </c:pt>
                <c:pt idx="7">
                  <c:v>0.131196138</c:v>
                </c:pt>
                <c:pt idx="8">
                  <c:v>0.0284426357428571</c:v>
                </c:pt>
                <c:pt idx="9">
                  <c:v>0.0513790136</c:v>
                </c:pt>
                <c:pt idx="10">
                  <c:v>0.0461448370285714</c:v>
                </c:pt>
                <c:pt idx="11">
                  <c:v>0.0468578054285714</c:v>
                </c:pt>
                <c:pt idx="12">
                  <c:v>0.0297966608571429</c:v>
                </c:pt>
                <c:pt idx="13">
                  <c:v>0.0276750490571429</c:v>
                </c:pt>
                <c:pt idx="14">
                  <c:v>0.0487710982285714</c:v>
                </c:pt>
                <c:pt idx="15">
                  <c:v>0.918724821285714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[1]extracteddata!$D$49:$D$64</c:f>
              <c:numCache>
                <c:formatCode>General</c:formatCode>
                <c:ptCount val="16"/>
                <c:pt idx="0">
                  <c:v>2.777921E6</c:v>
                </c:pt>
                <c:pt idx="1">
                  <c:v>2.780114E6</c:v>
                </c:pt>
                <c:pt idx="2">
                  <c:v>2.78068E6</c:v>
                </c:pt>
                <c:pt idx="3">
                  <c:v>2.781122E6</c:v>
                </c:pt>
                <c:pt idx="4">
                  <c:v>2.781241E6</c:v>
                </c:pt>
                <c:pt idx="5">
                  <c:v>2.781262E6</c:v>
                </c:pt>
                <c:pt idx="6">
                  <c:v>2.781316E6</c:v>
                </c:pt>
                <c:pt idx="7">
                  <c:v>2.781324E6</c:v>
                </c:pt>
                <c:pt idx="8">
                  <c:v>2.781399E6</c:v>
                </c:pt>
                <c:pt idx="9">
                  <c:v>2.781438E6</c:v>
                </c:pt>
                <c:pt idx="10">
                  <c:v>2.781478E6</c:v>
                </c:pt>
                <c:pt idx="11">
                  <c:v>2.781483E6</c:v>
                </c:pt>
                <c:pt idx="12">
                  <c:v>2.781489E6</c:v>
                </c:pt>
                <c:pt idx="13">
                  <c:v>2.781685E6</c:v>
                </c:pt>
                <c:pt idx="14">
                  <c:v>2.782078E6</c:v>
                </c:pt>
                <c:pt idx="15">
                  <c:v>2.785183E6</c:v>
                </c:pt>
              </c:numCache>
            </c:numRef>
          </c:xVal>
          <c:yVal>
            <c:numRef>
              <c:f>[1]extracteddata!$H$49:$H$64</c:f>
              <c:numCache>
                <c:formatCode>General</c:formatCode>
                <c:ptCount val="16"/>
                <c:pt idx="0">
                  <c:v>0.933505912368421</c:v>
                </c:pt>
                <c:pt idx="1">
                  <c:v>0.934820275478947</c:v>
                </c:pt>
                <c:pt idx="2">
                  <c:v>0.701527368360526</c:v>
                </c:pt>
                <c:pt idx="3">
                  <c:v>0.538258683473684</c:v>
                </c:pt>
                <c:pt idx="4">
                  <c:v>0.718288575418421</c:v>
                </c:pt>
                <c:pt idx="5">
                  <c:v>0.750711469723684</c:v>
                </c:pt>
                <c:pt idx="6">
                  <c:v>0.600979436184211</c:v>
                </c:pt>
                <c:pt idx="7">
                  <c:v>0.721789466052632</c:v>
                </c:pt>
                <c:pt idx="8">
                  <c:v>0.655483917368421</c:v>
                </c:pt>
                <c:pt idx="9">
                  <c:v>0.718028176884211</c:v>
                </c:pt>
                <c:pt idx="10">
                  <c:v>0.652445612236842</c:v>
                </c:pt>
                <c:pt idx="11">
                  <c:v>0.591870236447369</c:v>
                </c:pt>
                <c:pt idx="12">
                  <c:v>0.674280847052632</c:v>
                </c:pt>
                <c:pt idx="13">
                  <c:v>0.667439985223684</c:v>
                </c:pt>
                <c:pt idx="14">
                  <c:v>0.353413903860526</c:v>
                </c:pt>
                <c:pt idx="15">
                  <c:v>0.892730323439474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D$49:$D$64</c:f>
              <c:numCache>
                <c:formatCode>General</c:formatCode>
                <c:ptCount val="16"/>
                <c:pt idx="0">
                  <c:v>2.777921E6</c:v>
                </c:pt>
                <c:pt idx="1">
                  <c:v>2.780114E6</c:v>
                </c:pt>
                <c:pt idx="2">
                  <c:v>2.78068E6</c:v>
                </c:pt>
                <c:pt idx="3">
                  <c:v>2.781122E6</c:v>
                </c:pt>
                <c:pt idx="4">
                  <c:v>2.781241E6</c:v>
                </c:pt>
                <c:pt idx="5">
                  <c:v>2.781262E6</c:v>
                </c:pt>
                <c:pt idx="6">
                  <c:v>2.781316E6</c:v>
                </c:pt>
                <c:pt idx="7">
                  <c:v>2.781324E6</c:v>
                </c:pt>
                <c:pt idx="8">
                  <c:v>2.781399E6</c:v>
                </c:pt>
                <c:pt idx="9">
                  <c:v>2.781438E6</c:v>
                </c:pt>
                <c:pt idx="10">
                  <c:v>2.781478E6</c:v>
                </c:pt>
                <c:pt idx="11">
                  <c:v>2.781483E6</c:v>
                </c:pt>
                <c:pt idx="12">
                  <c:v>2.781489E6</c:v>
                </c:pt>
                <c:pt idx="13">
                  <c:v>2.781685E6</c:v>
                </c:pt>
                <c:pt idx="14">
                  <c:v>2.782078E6</c:v>
                </c:pt>
                <c:pt idx="15">
                  <c:v>2.785183E6</c:v>
                </c:pt>
              </c:numCache>
            </c:numRef>
          </c:xVal>
          <c:yVal>
            <c:numRef>
              <c:f>[1]extracteddata!$I$49:$I$64</c:f>
              <c:numCache>
                <c:formatCode>General</c:formatCode>
                <c:ptCount val="16"/>
                <c:pt idx="0">
                  <c:v>0.8628879</c:v>
                </c:pt>
                <c:pt idx="1">
                  <c:v>0.84861884175</c:v>
                </c:pt>
                <c:pt idx="2">
                  <c:v>0.525902515977273</c:v>
                </c:pt>
                <c:pt idx="3">
                  <c:v>0.550567688340909</c:v>
                </c:pt>
                <c:pt idx="4">
                  <c:v>0.632551185772727</c:v>
                </c:pt>
                <c:pt idx="5">
                  <c:v>0.673647780454546</c:v>
                </c:pt>
                <c:pt idx="6">
                  <c:v>0.501078460681818</c:v>
                </c:pt>
                <c:pt idx="7">
                  <c:v>0.610369929545455</c:v>
                </c:pt>
                <c:pt idx="8">
                  <c:v>0.521275899545455</c:v>
                </c:pt>
                <c:pt idx="9">
                  <c:v>0.559726682409091</c:v>
                </c:pt>
                <c:pt idx="10">
                  <c:v>0.515144558181818</c:v>
                </c:pt>
                <c:pt idx="11">
                  <c:v>0.454547529318182</c:v>
                </c:pt>
                <c:pt idx="12">
                  <c:v>0.551162198840909</c:v>
                </c:pt>
                <c:pt idx="13">
                  <c:v>0.4817430005</c:v>
                </c:pt>
                <c:pt idx="14">
                  <c:v>0.187938706931818</c:v>
                </c:pt>
                <c:pt idx="15">
                  <c:v>0.808162868022727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J$52:$J$53</c:f>
              <c:numCache>
                <c:formatCode>General</c:formatCode>
                <c:ptCount val="2"/>
                <c:pt idx="0">
                  <c:v>2.781262E6</c:v>
                </c:pt>
                <c:pt idx="1">
                  <c:v>2.781262E6</c:v>
                </c:pt>
              </c:numCache>
            </c:numRef>
          </c:xVal>
          <c:yVal>
            <c:numRef>
              <c:f>[1]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528546688"/>
        <c:axId val="-1528538704"/>
      </c:scatterChart>
      <c:valAx>
        <c:axId val="-1528546688"/>
        <c:scaling>
          <c:orientation val="minMax"/>
          <c:max val="2.784262E6"/>
          <c:min val="2.778262E6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528538704"/>
        <c:crosses val="autoZero"/>
        <c:crossBetween val="midCat"/>
        <c:majorUnit val="1000.0"/>
      </c:valAx>
      <c:valAx>
        <c:axId val="-1528538704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528546688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[1]extracteddata!$D$65:$D$78</c:f>
              <c:numCache>
                <c:formatCode>General</c:formatCode>
                <c:ptCount val="14"/>
                <c:pt idx="0">
                  <c:v>4.5475008E7</c:v>
                </c:pt>
                <c:pt idx="1">
                  <c:v>4.5476975E7</c:v>
                </c:pt>
                <c:pt idx="2">
                  <c:v>4.5479462E7</c:v>
                </c:pt>
                <c:pt idx="3">
                  <c:v>4.5479642E7</c:v>
                </c:pt>
                <c:pt idx="4">
                  <c:v>4.5479755E7</c:v>
                </c:pt>
                <c:pt idx="5">
                  <c:v>4.5479977E7</c:v>
                </c:pt>
                <c:pt idx="6">
                  <c:v>4.5480168E7</c:v>
                </c:pt>
                <c:pt idx="7">
                  <c:v>4.5480185E7</c:v>
                </c:pt>
                <c:pt idx="8">
                  <c:v>4.5480196E7</c:v>
                </c:pt>
                <c:pt idx="9">
                  <c:v>4.5480429E7</c:v>
                </c:pt>
                <c:pt idx="10">
                  <c:v>4.5480788E7</c:v>
                </c:pt>
                <c:pt idx="11">
                  <c:v>4.5480917E7</c:v>
                </c:pt>
                <c:pt idx="12">
                  <c:v>4.5483716E7</c:v>
                </c:pt>
                <c:pt idx="13">
                  <c:v>4.5487475E7</c:v>
                </c:pt>
              </c:numCache>
            </c:numRef>
          </c:xVal>
          <c:yVal>
            <c:numRef>
              <c:f>[1]extracteddata!$F$65:$F$78</c:f>
              <c:numCache>
                <c:formatCode>General</c:formatCode>
                <c:ptCount val="14"/>
                <c:pt idx="0">
                  <c:v>0.831698881325568</c:v>
                </c:pt>
                <c:pt idx="1">
                  <c:v>0.695600861469534</c:v>
                </c:pt>
                <c:pt idx="2">
                  <c:v>0.87586490057049</c:v>
                </c:pt>
                <c:pt idx="3">
                  <c:v>0.744153443694743</c:v>
                </c:pt>
                <c:pt idx="4">
                  <c:v>0.665912370952509</c:v>
                </c:pt>
                <c:pt idx="5">
                  <c:v>0.0843706714148148</c:v>
                </c:pt>
                <c:pt idx="6">
                  <c:v>0.106100394056153</c:v>
                </c:pt>
                <c:pt idx="7">
                  <c:v>0.180578165531661</c:v>
                </c:pt>
                <c:pt idx="8">
                  <c:v>0.112293076950418</c:v>
                </c:pt>
                <c:pt idx="9">
                  <c:v>0.0938277311051374</c:v>
                </c:pt>
                <c:pt idx="10">
                  <c:v>0.179997697860215</c:v>
                </c:pt>
                <c:pt idx="11">
                  <c:v>0.328289693369176</c:v>
                </c:pt>
                <c:pt idx="12">
                  <c:v>0.894367712298088</c:v>
                </c:pt>
                <c:pt idx="13">
                  <c:v>0.929758883334827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[1]extracteddata!$D$65:$D$78</c:f>
              <c:numCache>
                <c:formatCode>General</c:formatCode>
                <c:ptCount val="14"/>
                <c:pt idx="0">
                  <c:v>4.5475008E7</c:v>
                </c:pt>
                <c:pt idx="1">
                  <c:v>4.5476975E7</c:v>
                </c:pt>
                <c:pt idx="2">
                  <c:v>4.5479462E7</c:v>
                </c:pt>
                <c:pt idx="3">
                  <c:v>4.5479642E7</c:v>
                </c:pt>
                <c:pt idx="4">
                  <c:v>4.5479755E7</c:v>
                </c:pt>
                <c:pt idx="5">
                  <c:v>4.5479977E7</c:v>
                </c:pt>
                <c:pt idx="6">
                  <c:v>4.5480168E7</c:v>
                </c:pt>
                <c:pt idx="7">
                  <c:v>4.5480185E7</c:v>
                </c:pt>
                <c:pt idx="8">
                  <c:v>4.5480196E7</c:v>
                </c:pt>
                <c:pt idx="9">
                  <c:v>4.5480429E7</c:v>
                </c:pt>
                <c:pt idx="10">
                  <c:v>4.5480788E7</c:v>
                </c:pt>
                <c:pt idx="11">
                  <c:v>4.5480917E7</c:v>
                </c:pt>
                <c:pt idx="12">
                  <c:v>4.5483716E7</c:v>
                </c:pt>
                <c:pt idx="13">
                  <c:v>4.5487475E7</c:v>
                </c:pt>
              </c:numCache>
            </c:numRef>
          </c:xVal>
          <c:yVal>
            <c:numRef>
              <c:f>[1]extracteddata!$G$65:$G$78</c:f>
              <c:numCache>
                <c:formatCode>General</c:formatCode>
                <c:ptCount val="14"/>
                <c:pt idx="0">
                  <c:v>0.838140486914286</c:v>
                </c:pt>
                <c:pt idx="1">
                  <c:v>0.627708628571429</c:v>
                </c:pt>
                <c:pt idx="2">
                  <c:v>0.367138025714286</c:v>
                </c:pt>
                <c:pt idx="3">
                  <c:v>0.0506207911142857</c:v>
                </c:pt>
                <c:pt idx="4">
                  <c:v>0.0170541248285714</c:v>
                </c:pt>
                <c:pt idx="5">
                  <c:v>0.00837942488571429</c:v>
                </c:pt>
                <c:pt idx="6">
                  <c:v>0.0261964865142857</c:v>
                </c:pt>
                <c:pt idx="7">
                  <c:v>0.162890732857143</c:v>
                </c:pt>
                <c:pt idx="8">
                  <c:v>0.0513358190571429</c:v>
                </c:pt>
                <c:pt idx="9">
                  <c:v>0.0156201267428571</c:v>
                </c:pt>
                <c:pt idx="10">
                  <c:v>0.0283715171714286</c:v>
                </c:pt>
                <c:pt idx="11">
                  <c:v>0.0535943890857143</c:v>
                </c:pt>
                <c:pt idx="12">
                  <c:v>0.928177681171428</c:v>
                </c:pt>
                <c:pt idx="13">
                  <c:v>0.972919734628571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[1]extracteddata!$D$65:$D$78</c:f>
              <c:numCache>
                <c:formatCode>General</c:formatCode>
                <c:ptCount val="14"/>
                <c:pt idx="0">
                  <c:v>4.5475008E7</c:v>
                </c:pt>
                <c:pt idx="1">
                  <c:v>4.5476975E7</c:v>
                </c:pt>
                <c:pt idx="2">
                  <c:v>4.5479462E7</c:v>
                </c:pt>
                <c:pt idx="3">
                  <c:v>4.5479642E7</c:v>
                </c:pt>
                <c:pt idx="4">
                  <c:v>4.5479755E7</c:v>
                </c:pt>
                <c:pt idx="5">
                  <c:v>4.5479977E7</c:v>
                </c:pt>
                <c:pt idx="6">
                  <c:v>4.5480168E7</c:v>
                </c:pt>
                <c:pt idx="7">
                  <c:v>4.5480185E7</c:v>
                </c:pt>
                <c:pt idx="8">
                  <c:v>4.5480196E7</c:v>
                </c:pt>
                <c:pt idx="9">
                  <c:v>4.5480429E7</c:v>
                </c:pt>
                <c:pt idx="10">
                  <c:v>4.5480788E7</c:v>
                </c:pt>
                <c:pt idx="11">
                  <c:v>4.5480917E7</c:v>
                </c:pt>
                <c:pt idx="12">
                  <c:v>4.5483716E7</c:v>
                </c:pt>
                <c:pt idx="13">
                  <c:v>4.5487475E7</c:v>
                </c:pt>
              </c:numCache>
            </c:numRef>
          </c:xVal>
          <c:yVal>
            <c:numRef>
              <c:f>[1]extracteddata!$H$65:$H$78</c:f>
              <c:numCache>
                <c:formatCode>General</c:formatCode>
                <c:ptCount val="14"/>
                <c:pt idx="0">
                  <c:v>0.797423912468421</c:v>
                </c:pt>
                <c:pt idx="1">
                  <c:v>0.713011614473684</c:v>
                </c:pt>
                <c:pt idx="2">
                  <c:v>0.922351134210526</c:v>
                </c:pt>
                <c:pt idx="3">
                  <c:v>0.862593577236842</c:v>
                </c:pt>
                <c:pt idx="4">
                  <c:v>0.802631866960526</c:v>
                </c:pt>
                <c:pt idx="5">
                  <c:v>0.0641931084368421</c:v>
                </c:pt>
                <c:pt idx="6">
                  <c:v>0.0863358918421053</c:v>
                </c:pt>
                <c:pt idx="7">
                  <c:v>0.168565985</c:v>
                </c:pt>
                <c:pt idx="8">
                  <c:v>0.0971371460789474</c:v>
                </c:pt>
                <c:pt idx="9">
                  <c:v>0.0927879568789474</c:v>
                </c:pt>
                <c:pt idx="10">
                  <c:v>0.210641054102632</c:v>
                </c:pt>
                <c:pt idx="11">
                  <c:v>0.457772746973684</c:v>
                </c:pt>
                <c:pt idx="12">
                  <c:v>0.874137186210526</c:v>
                </c:pt>
                <c:pt idx="13">
                  <c:v>0.937058122415789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D$65:$D$78</c:f>
              <c:numCache>
                <c:formatCode>General</c:formatCode>
                <c:ptCount val="14"/>
                <c:pt idx="0">
                  <c:v>4.5475008E7</c:v>
                </c:pt>
                <c:pt idx="1">
                  <c:v>4.5476975E7</c:v>
                </c:pt>
                <c:pt idx="2">
                  <c:v>4.5479462E7</c:v>
                </c:pt>
                <c:pt idx="3">
                  <c:v>4.5479642E7</c:v>
                </c:pt>
                <c:pt idx="4">
                  <c:v>4.5479755E7</c:v>
                </c:pt>
                <c:pt idx="5">
                  <c:v>4.5479977E7</c:v>
                </c:pt>
                <c:pt idx="6">
                  <c:v>4.5480168E7</c:v>
                </c:pt>
                <c:pt idx="7">
                  <c:v>4.5480185E7</c:v>
                </c:pt>
                <c:pt idx="8">
                  <c:v>4.5480196E7</c:v>
                </c:pt>
                <c:pt idx="9">
                  <c:v>4.5480429E7</c:v>
                </c:pt>
                <c:pt idx="10">
                  <c:v>4.5480788E7</c:v>
                </c:pt>
                <c:pt idx="11">
                  <c:v>4.5480917E7</c:v>
                </c:pt>
                <c:pt idx="12">
                  <c:v>4.5483716E7</c:v>
                </c:pt>
                <c:pt idx="13">
                  <c:v>4.5487475E7</c:v>
                </c:pt>
              </c:numCache>
            </c:numRef>
          </c:xVal>
          <c:yVal>
            <c:numRef>
              <c:f>[1]extracteddata!$I$65:$I$78</c:f>
              <c:numCache>
                <c:formatCode>General</c:formatCode>
                <c:ptCount val="14"/>
                <c:pt idx="0">
                  <c:v>0.813458802181818</c:v>
                </c:pt>
                <c:pt idx="1">
                  <c:v>0.607360384090909</c:v>
                </c:pt>
                <c:pt idx="2">
                  <c:v>0.758991648181818</c:v>
                </c:pt>
                <c:pt idx="3">
                  <c:v>0.589430857954545</c:v>
                </c:pt>
                <c:pt idx="4">
                  <c:v>0.514371132772727</c:v>
                </c:pt>
                <c:pt idx="5">
                  <c:v>0.0847845445800866</c:v>
                </c:pt>
                <c:pt idx="6">
                  <c:v>0.0957139206818182</c:v>
                </c:pt>
                <c:pt idx="7">
                  <c:v>0.170403118409091</c:v>
                </c:pt>
                <c:pt idx="8">
                  <c:v>0.109719838181818</c:v>
                </c:pt>
                <c:pt idx="9">
                  <c:v>0.0792526214318182</c:v>
                </c:pt>
                <c:pt idx="10">
                  <c:v>0.166726571113636</c:v>
                </c:pt>
                <c:pt idx="11">
                  <c:v>0.272488996136364</c:v>
                </c:pt>
                <c:pt idx="12">
                  <c:v>0.886686462068182</c:v>
                </c:pt>
                <c:pt idx="13">
                  <c:v>0.899626066840909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J$67:$J$68</c:f>
              <c:numCache>
                <c:formatCode>General</c:formatCode>
                <c:ptCount val="2"/>
                <c:pt idx="0">
                  <c:v>4.5479755E7</c:v>
                </c:pt>
                <c:pt idx="1">
                  <c:v>4.5479755E7</c:v>
                </c:pt>
              </c:numCache>
            </c:numRef>
          </c:xVal>
          <c:yVal>
            <c:numRef>
              <c:f>[1]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804903056"/>
        <c:axId val="-1437961056"/>
      </c:scatterChart>
      <c:valAx>
        <c:axId val="-1804903056"/>
        <c:scaling>
          <c:orientation val="minMax"/>
          <c:max val="4.5482755E7"/>
          <c:min val="4.5476755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437961056"/>
        <c:crosses val="autoZero"/>
        <c:crossBetween val="midCat"/>
        <c:majorUnit val="1000.0"/>
      </c:valAx>
      <c:valAx>
        <c:axId val="-1437961056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804903056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75449304797396"/>
          <c:h val="0.690532462162492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[1]extracteddata!$D$79:$D$97</c:f>
              <c:numCache>
                <c:formatCode>General</c:formatCode>
                <c:ptCount val="19"/>
                <c:pt idx="0">
                  <c:v>1.71787181E8</c:v>
                </c:pt>
                <c:pt idx="1">
                  <c:v>1.71807195E8</c:v>
                </c:pt>
                <c:pt idx="2">
                  <c:v>1.71809804E8</c:v>
                </c:pt>
                <c:pt idx="3">
                  <c:v>1.71810105E8</c:v>
                </c:pt>
                <c:pt idx="4">
                  <c:v>1.718103E8</c:v>
                </c:pt>
                <c:pt idx="5">
                  <c:v>1.71810322E8</c:v>
                </c:pt>
                <c:pt idx="6">
                  <c:v>1.71810376E8</c:v>
                </c:pt>
                <c:pt idx="7">
                  <c:v>1.71810433E8</c:v>
                </c:pt>
                <c:pt idx="8">
                  <c:v>1.71810468E8</c:v>
                </c:pt>
                <c:pt idx="9">
                  <c:v>1.71810543E8</c:v>
                </c:pt>
                <c:pt idx="10">
                  <c:v>1.7181057E8</c:v>
                </c:pt>
                <c:pt idx="11">
                  <c:v>1.71810778E8</c:v>
                </c:pt>
                <c:pt idx="12">
                  <c:v>1.7181091E8</c:v>
                </c:pt>
                <c:pt idx="13">
                  <c:v>1.71810972E8</c:v>
                </c:pt>
                <c:pt idx="14">
                  <c:v>1.71811299E8</c:v>
                </c:pt>
                <c:pt idx="15">
                  <c:v>1.71811477E8</c:v>
                </c:pt>
                <c:pt idx="16">
                  <c:v>1.71811529E8</c:v>
                </c:pt>
                <c:pt idx="17">
                  <c:v>1.71814459E8</c:v>
                </c:pt>
                <c:pt idx="18">
                  <c:v>1.718403E8</c:v>
                </c:pt>
              </c:numCache>
            </c:numRef>
          </c:xVal>
          <c:yVal>
            <c:numRef>
              <c:f>[1]extracteddata!$F$79:$F$97</c:f>
              <c:numCache>
                <c:formatCode>General</c:formatCode>
                <c:ptCount val="19"/>
                <c:pt idx="0">
                  <c:v>0.242012989837814</c:v>
                </c:pt>
                <c:pt idx="1">
                  <c:v>0.658669039003584</c:v>
                </c:pt>
                <c:pt idx="2">
                  <c:v>0.929538783678017</c:v>
                </c:pt>
                <c:pt idx="3">
                  <c:v>0.540406410748507</c:v>
                </c:pt>
                <c:pt idx="4">
                  <c:v>0.551218398632019</c:v>
                </c:pt>
                <c:pt idx="5">
                  <c:v>0.570891755203704</c:v>
                </c:pt>
                <c:pt idx="6">
                  <c:v>0.521695029031959</c:v>
                </c:pt>
                <c:pt idx="7">
                  <c:v>0.455192158476703</c:v>
                </c:pt>
                <c:pt idx="8">
                  <c:v>0.475504871617682</c:v>
                </c:pt>
                <c:pt idx="9">
                  <c:v>0.338103102729391</c:v>
                </c:pt>
                <c:pt idx="10">
                  <c:v>0.227185989178614</c:v>
                </c:pt>
                <c:pt idx="11">
                  <c:v>0.290019032374552</c:v>
                </c:pt>
                <c:pt idx="12">
                  <c:v>0.302263714932497</c:v>
                </c:pt>
                <c:pt idx="13">
                  <c:v>0.445334746821386</c:v>
                </c:pt>
                <c:pt idx="14">
                  <c:v>0.405253119196535</c:v>
                </c:pt>
                <c:pt idx="15">
                  <c:v>0.248974563111709</c:v>
                </c:pt>
                <c:pt idx="16">
                  <c:v>0.295462429508662</c:v>
                </c:pt>
                <c:pt idx="17">
                  <c:v>0.725453297964457</c:v>
                </c:pt>
                <c:pt idx="18">
                  <c:v>0.673448648873059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[1]extracteddata!$D$80:$D$97</c:f>
              <c:numCache>
                <c:formatCode>General</c:formatCode>
                <c:ptCount val="18"/>
                <c:pt idx="0">
                  <c:v>1.71807195E8</c:v>
                </c:pt>
                <c:pt idx="1">
                  <c:v>1.71809804E8</c:v>
                </c:pt>
                <c:pt idx="2">
                  <c:v>1.71810105E8</c:v>
                </c:pt>
                <c:pt idx="3">
                  <c:v>1.718103E8</c:v>
                </c:pt>
                <c:pt idx="4">
                  <c:v>1.71810322E8</c:v>
                </c:pt>
                <c:pt idx="5">
                  <c:v>1.71810376E8</c:v>
                </c:pt>
                <c:pt idx="6">
                  <c:v>1.71810433E8</c:v>
                </c:pt>
                <c:pt idx="7">
                  <c:v>1.71810468E8</c:v>
                </c:pt>
                <c:pt idx="8">
                  <c:v>1.71810543E8</c:v>
                </c:pt>
                <c:pt idx="9">
                  <c:v>1.7181057E8</c:v>
                </c:pt>
                <c:pt idx="10">
                  <c:v>1.71810778E8</c:v>
                </c:pt>
                <c:pt idx="11">
                  <c:v>1.7181091E8</c:v>
                </c:pt>
                <c:pt idx="12">
                  <c:v>1.71810972E8</c:v>
                </c:pt>
                <c:pt idx="13">
                  <c:v>1.71811299E8</c:v>
                </c:pt>
                <c:pt idx="14">
                  <c:v>1.71811477E8</c:v>
                </c:pt>
                <c:pt idx="15">
                  <c:v>1.71811529E8</c:v>
                </c:pt>
                <c:pt idx="16">
                  <c:v>1.71814459E8</c:v>
                </c:pt>
                <c:pt idx="17">
                  <c:v>1.718403E8</c:v>
                </c:pt>
              </c:numCache>
            </c:numRef>
          </c:xVal>
          <c:yVal>
            <c:numRef>
              <c:f>[1]extracteddata!$G$79:$G$97</c:f>
              <c:numCache>
                <c:formatCode>General</c:formatCode>
                <c:ptCount val="19"/>
                <c:pt idx="0">
                  <c:v>0.472455497914286</c:v>
                </c:pt>
                <c:pt idx="1">
                  <c:v>0.756265721685714</c:v>
                </c:pt>
                <c:pt idx="2">
                  <c:v>0.972585720285714</c:v>
                </c:pt>
                <c:pt idx="3">
                  <c:v>0.272943776428571</c:v>
                </c:pt>
                <c:pt idx="4">
                  <c:v>0.0207225371764706</c:v>
                </c:pt>
                <c:pt idx="5">
                  <c:v>0.0211746428285714</c:v>
                </c:pt>
                <c:pt idx="6">
                  <c:v>0.0283370931428571</c:v>
                </c:pt>
                <c:pt idx="7">
                  <c:v>0.0297205378857143</c:v>
                </c:pt>
                <c:pt idx="8">
                  <c:v>0.0151147034</c:v>
                </c:pt>
                <c:pt idx="9">
                  <c:v>0.00903609114285714</c:v>
                </c:pt>
                <c:pt idx="10">
                  <c:v>0.0772192394285714</c:v>
                </c:pt>
                <c:pt idx="11">
                  <c:v>0.0121948655882353</c:v>
                </c:pt>
                <c:pt idx="12">
                  <c:v>0.0172123351428572</c:v>
                </c:pt>
                <c:pt idx="13">
                  <c:v>0.0242609403142857</c:v>
                </c:pt>
                <c:pt idx="14">
                  <c:v>0.0330871514285714</c:v>
                </c:pt>
                <c:pt idx="15">
                  <c:v>0.0374986521428571</c:v>
                </c:pt>
                <c:pt idx="16">
                  <c:v>0.0176580992</c:v>
                </c:pt>
                <c:pt idx="17">
                  <c:v>0.840950912057143</c:v>
                </c:pt>
                <c:pt idx="18">
                  <c:v>0.943956021085714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[1]extracteddata!$D$79:$D$97</c:f>
              <c:numCache>
                <c:formatCode>General</c:formatCode>
                <c:ptCount val="19"/>
                <c:pt idx="0">
                  <c:v>1.71787181E8</c:v>
                </c:pt>
                <c:pt idx="1">
                  <c:v>1.71807195E8</c:v>
                </c:pt>
                <c:pt idx="2">
                  <c:v>1.71809804E8</c:v>
                </c:pt>
                <c:pt idx="3">
                  <c:v>1.71810105E8</c:v>
                </c:pt>
                <c:pt idx="4">
                  <c:v>1.718103E8</c:v>
                </c:pt>
                <c:pt idx="5">
                  <c:v>1.71810322E8</c:v>
                </c:pt>
                <c:pt idx="6">
                  <c:v>1.71810376E8</c:v>
                </c:pt>
                <c:pt idx="7">
                  <c:v>1.71810433E8</c:v>
                </c:pt>
                <c:pt idx="8">
                  <c:v>1.71810468E8</c:v>
                </c:pt>
                <c:pt idx="9">
                  <c:v>1.71810543E8</c:v>
                </c:pt>
                <c:pt idx="10">
                  <c:v>1.7181057E8</c:v>
                </c:pt>
                <c:pt idx="11">
                  <c:v>1.71810778E8</c:v>
                </c:pt>
                <c:pt idx="12">
                  <c:v>1.7181091E8</c:v>
                </c:pt>
                <c:pt idx="13">
                  <c:v>1.71810972E8</c:v>
                </c:pt>
                <c:pt idx="14">
                  <c:v>1.71811299E8</c:v>
                </c:pt>
                <c:pt idx="15">
                  <c:v>1.71811477E8</c:v>
                </c:pt>
                <c:pt idx="16">
                  <c:v>1.71811529E8</c:v>
                </c:pt>
                <c:pt idx="17">
                  <c:v>1.71814459E8</c:v>
                </c:pt>
                <c:pt idx="18">
                  <c:v>1.718403E8</c:v>
                </c:pt>
              </c:numCache>
            </c:numRef>
          </c:xVal>
          <c:yVal>
            <c:numRef>
              <c:f>[1]extracteddata!$H$79:$H$97</c:f>
              <c:numCache>
                <c:formatCode>General</c:formatCode>
                <c:ptCount val="19"/>
                <c:pt idx="0">
                  <c:v>0.223193677521053</c:v>
                </c:pt>
                <c:pt idx="1">
                  <c:v>0.645843372478947</c:v>
                </c:pt>
                <c:pt idx="2">
                  <c:v>0.817179039994737</c:v>
                </c:pt>
                <c:pt idx="3">
                  <c:v>0.64770771516579</c:v>
                </c:pt>
                <c:pt idx="4">
                  <c:v>0.846984512368421</c:v>
                </c:pt>
                <c:pt idx="5">
                  <c:v>0.898756478947369</c:v>
                </c:pt>
                <c:pt idx="6">
                  <c:v>0.760398871610526</c:v>
                </c:pt>
                <c:pt idx="7">
                  <c:v>0.681314693544737</c:v>
                </c:pt>
                <c:pt idx="8">
                  <c:v>0.783792641321053</c:v>
                </c:pt>
                <c:pt idx="9">
                  <c:v>0.536997915394737</c:v>
                </c:pt>
                <c:pt idx="10">
                  <c:v>0.259534833526316</c:v>
                </c:pt>
                <c:pt idx="11">
                  <c:v>0.480585371184211</c:v>
                </c:pt>
                <c:pt idx="12">
                  <c:v>0.508867434605263</c:v>
                </c:pt>
                <c:pt idx="13">
                  <c:v>0.753830045131579</c:v>
                </c:pt>
                <c:pt idx="14">
                  <c:v>0.572025195921053</c:v>
                </c:pt>
                <c:pt idx="15">
                  <c:v>0.297869453421053</c:v>
                </c:pt>
                <c:pt idx="16">
                  <c:v>0.369354318336842</c:v>
                </c:pt>
                <c:pt idx="17">
                  <c:v>0.59624403665</c:v>
                </c:pt>
                <c:pt idx="18">
                  <c:v>0.531042844615789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D$79:$D$97</c:f>
              <c:numCache>
                <c:formatCode>General</c:formatCode>
                <c:ptCount val="19"/>
                <c:pt idx="0">
                  <c:v>1.71787181E8</c:v>
                </c:pt>
                <c:pt idx="1">
                  <c:v>1.71807195E8</c:v>
                </c:pt>
                <c:pt idx="2">
                  <c:v>1.71809804E8</c:v>
                </c:pt>
                <c:pt idx="3">
                  <c:v>1.71810105E8</c:v>
                </c:pt>
                <c:pt idx="4">
                  <c:v>1.718103E8</c:v>
                </c:pt>
                <c:pt idx="5">
                  <c:v>1.71810322E8</c:v>
                </c:pt>
                <c:pt idx="6">
                  <c:v>1.71810376E8</c:v>
                </c:pt>
                <c:pt idx="7">
                  <c:v>1.71810433E8</c:v>
                </c:pt>
                <c:pt idx="8">
                  <c:v>1.71810468E8</c:v>
                </c:pt>
                <c:pt idx="9">
                  <c:v>1.71810543E8</c:v>
                </c:pt>
                <c:pt idx="10">
                  <c:v>1.7181057E8</c:v>
                </c:pt>
                <c:pt idx="11">
                  <c:v>1.71810778E8</c:v>
                </c:pt>
                <c:pt idx="12">
                  <c:v>1.7181091E8</c:v>
                </c:pt>
                <c:pt idx="13">
                  <c:v>1.71810972E8</c:v>
                </c:pt>
                <c:pt idx="14">
                  <c:v>1.71811299E8</c:v>
                </c:pt>
                <c:pt idx="15">
                  <c:v>1.71811477E8</c:v>
                </c:pt>
                <c:pt idx="16">
                  <c:v>1.71811529E8</c:v>
                </c:pt>
                <c:pt idx="17">
                  <c:v>1.71814459E8</c:v>
                </c:pt>
                <c:pt idx="18">
                  <c:v>1.718403E8</c:v>
                </c:pt>
              </c:numCache>
            </c:numRef>
          </c:xVal>
          <c:yVal>
            <c:numRef>
              <c:f>[1]extracteddata!$I$79:$I$97</c:f>
              <c:numCache>
                <c:formatCode>General</c:formatCode>
                <c:ptCount val="19"/>
                <c:pt idx="0">
                  <c:v>0.330894381272727</c:v>
                </c:pt>
                <c:pt idx="1">
                  <c:v>0.617460208181818</c:v>
                </c:pt>
                <c:pt idx="2">
                  <c:v>0.96090967175</c:v>
                </c:pt>
                <c:pt idx="3">
                  <c:v>0.3427883045</c:v>
                </c:pt>
                <c:pt idx="4">
                  <c:v>0.259893194318182</c:v>
                </c:pt>
                <c:pt idx="5">
                  <c:v>0.243036215227273</c:v>
                </c:pt>
                <c:pt idx="6">
                  <c:v>0.240604609477273</c:v>
                </c:pt>
                <c:pt idx="7">
                  <c:v>0.206498332363636</c:v>
                </c:pt>
                <c:pt idx="8">
                  <c:v>0.197647975454545</c:v>
                </c:pt>
                <c:pt idx="9">
                  <c:v>0.123313241295455</c:v>
                </c:pt>
                <c:pt idx="10">
                  <c:v>0.194998852954545</c:v>
                </c:pt>
                <c:pt idx="11">
                  <c:v>0.116927754545455</c:v>
                </c:pt>
                <c:pt idx="12">
                  <c:v>0.158772010022727</c:v>
                </c:pt>
                <c:pt idx="13">
                  <c:v>0.188466498681818</c:v>
                </c:pt>
                <c:pt idx="14">
                  <c:v>0.239525150681818</c:v>
                </c:pt>
                <c:pt idx="15">
                  <c:v>0.184173623795455</c:v>
                </c:pt>
                <c:pt idx="16">
                  <c:v>0.212158218886364</c:v>
                </c:pt>
                <c:pt idx="17">
                  <c:v>0.74996969925</c:v>
                </c:pt>
                <c:pt idx="18">
                  <c:v>0.693666909295455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J$82:$J$83</c:f>
              <c:numCache>
                <c:formatCode>General</c:formatCode>
                <c:ptCount val="2"/>
                <c:pt idx="0">
                  <c:v>1.71810322E8</c:v>
                </c:pt>
                <c:pt idx="1">
                  <c:v>1.71810322E8</c:v>
                </c:pt>
              </c:numCache>
            </c:numRef>
          </c:xVal>
          <c:yVal>
            <c:numRef>
              <c:f>[1]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530996864"/>
        <c:axId val="-1544484720"/>
      </c:scatterChart>
      <c:valAx>
        <c:axId val="-1530996864"/>
        <c:scaling>
          <c:orientation val="minMax"/>
          <c:max val="1.71813322E8"/>
          <c:min val="1.71807322E8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544484720"/>
        <c:crosses val="autoZero"/>
        <c:crossBetween val="midCat"/>
        <c:majorUnit val="1000.0"/>
      </c:valAx>
      <c:valAx>
        <c:axId val="-154448472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530996864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0743189440591808"/>
          <c:y val="0.873899862226441"/>
          <c:w val="0.851362111881638"/>
          <c:h val="0.09208362838302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71208825921881"/>
          <c:h val="0.726363539959099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extracteddata!$D$98:$D$118</c:f>
              <c:numCache>
                <c:formatCode>General</c:formatCode>
                <c:ptCount val="21"/>
                <c:pt idx="0">
                  <c:v>1.16132431E8</c:v>
                </c:pt>
                <c:pt idx="1">
                  <c:v>1.16137036E8</c:v>
                </c:pt>
                <c:pt idx="2">
                  <c:v>1.16138462E8</c:v>
                </c:pt>
                <c:pt idx="3">
                  <c:v>1.16138591E8</c:v>
                </c:pt>
                <c:pt idx="4">
                  <c:v>1.1613918E8</c:v>
                </c:pt>
                <c:pt idx="5">
                  <c:v>1.16139322E8</c:v>
                </c:pt>
                <c:pt idx="6">
                  <c:v>1.16139367E8</c:v>
                </c:pt>
                <c:pt idx="7">
                  <c:v>1.16139374E8</c:v>
                </c:pt>
                <c:pt idx="8">
                  <c:v>1.16139391E8</c:v>
                </c:pt>
                <c:pt idx="9">
                  <c:v>1.16139414E8</c:v>
                </c:pt>
                <c:pt idx="10">
                  <c:v>1.16139425E8</c:v>
                </c:pt>
                <c:pt idx="11">
                  <c:v>1.16139477E8</c:v>
                </c:pt>
                <c:pt idx="12">
                  <c:v>1.16139628E8</c:v>
                </c:pt>
                <c:pt idx="13">
                  <c:v>1.16139705E8</c:v>
                </c:pt>
                <c:pt idx="14">
                  <c:v>1.16139849E8</c:v>
                </c:pt>
                <c:pt idx="15">
                  <c:v>1.16140128E8</c:v>
                </c:pt>
                <c:pt idx="16">
                  <c:v>1.16140267E8</c:v>
                </c:pt>
                <c:pt idx="17">
                  <c:v>1.16140342E8</c:v>
                </c:pt>
                <c:pt idx="18">
                  <c:v>1.16140593E8</c:v>
                </c:pt>
                <c:pt idx="19">
                  <c:v>1.16143459E8</c:v>
                </c:pt>
                <c:pt idx="20">
                  <c:v>1.1614795E8</c:v>
                </c:pt>
              </c:numCache>
            </c:numRef>
          </c:xVal>
          <c:yVal>
            <c:numRef>
              <c:f>extracteddata!$F$98:$F$118</c:f>
              <c:numCache>
                <c:formatCode>General</c:formatCode>
                <c:ptCount val="21"/>
                <c:pt idx="0">
                  <c:v>0.645567559240143</c:v>
                </c:pt>
                <c:pt idx="1">
                  <c:v>0.791353171306452</c:v>
                </c:pt>
                <c:pt idx="2">
                  <c:v>0.766814003027778</c:v>
                </c:pt>
                <c:pt idx="3">
                  <c:v>0.896589971292414</c:v>
                </c:pt>
                <c:pt idx="4">
                  <c:v>0.62325402774761</c:v>
                </c:pt>
                <c:pt idx="5">
                  <c:v>0.0852309696266428</c:v>
                </c:pt>
                <c:pt idx="6">
                  <c:v>0.208644925347073</c:v>
                </c:pt>
                <c:pt idx="7">
                  <c:v>0.216891826487157</c:v>
                </c:pt>
                <c:pt idx="8">
                  <c:v>0.210955545924731</c:v>
                </c:pt>
                <c:pt idx="9">
                  <c:v>0.1719923730227</c:v>
                </c:pt>
                <c:pt idx="10">
                  <c:v>0.169410921652927</c:v>
                </c:pt>
                <c:pt idx="11">
                  <c:v>0.0630919940235962</c:v>
                </c:pt>
                <c:pt idx="12">
                  <c:v>0.0715348929321983</c:v>
                </c:pt>
                <c:pt idx="13">
                  <c:v>0.111858758879928</c:v>
                </c:pt>
                <c:pt idx="14">
                  <c:v>0.0647975284997013</c:v>
                </c:pt>
                <c:pt idx="15">
                  <c:v>0.317232319729391</c:v>
                </c:pt>
                <c:pt idx="16">
                  <c:v>0.28165953535693</c:v>
                </c:pt>
                <c:pt idx="17">
                  <c:v>0.39601754009767</c:v>
                </c:pt>
                <c:pt idx="18">
                  <c:v>0.472467467588411</c:v>
                </c:pt>
                <c:pt idx="19">
                  <c:v>0.741623797824373</c:v>
                </c:pt>
                <c:pt idx="20">
                  <c:v>0.866988904267622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extracteddata!$D$98:$D$118</c:f>
              <c:numCache>
                <c:formatCode>General</c:formatCode>
                <c:ptCount val="21"/>
                <c:pt idx="0">
                  <c:v>1.16132431E8</c:v>
                </c:pt>
                <c:pt idx="1">
                  <c:v>1.16137036E8</c:v>
                </c:pt>
                <c:pt idx="2">
                  <c:v>1.16138462E8</c:v>
                </c:pt>
                <c:pt idx="3">
                  <c:v>1.16138591E8</c:v>
                </c:pt>
                <c:pt idx="4">
                  <c:v>1.1613918E8</c:v>
                </c:pt>
                <c:pt idx="5">
                  <c:v>1.16139322E8</c:v>
                </c:pt>
                <c:pt idx="6">
                  <c:v>1.16139367E8</c:v>
                </c:pt>
                <c:pt idx="7">
                  <c:v>1.16139374E8</c:v>
                </c:pt>
                <c:pt idx="8">
                  <c:v>1.16139391E8</c:v>
                </c:pt>
                <c:pt idx="9">
                  <c:v>1.16139414E8</c:v>
                </c:pt>
                <c:pt idx="10">
                  <c:v>1.16139425E8</c:v>
                </c:pt>
                <c:pt idx="11">
                  <c:v>1.16139477E8</c:v>
                </c:pt>
                <c:pt idx="12">
                  <c:v>1.16139628E8</c:v>
                </c:pt>
                <c:pt idx="13">
                  <c:v>1.16139705E8</c:v>
                </c:pt>
                <c:pt idx="14">
                  <c:v>1.16139849E8</c:v>
                </c:pt>
                <c:pt idx="15">
                  <c:v>1.16140128E8</c:v>
                </c:pt>
                <c:pt idx="16">
                  <c:v>1.16140267E8</c:v>
                </c:pt>
                <c:pt idx="17">
                  <c:v>1.16140342E8</c:v>
                </c:pt>
                <c:pt idx="18">
                  <c:v>1.16140593E8</c:v>
                </c:pt>
                <c:pt idx="19">
                  <c:v>1.16143459E8</c:v>
                </c:pt>
                <c:pt idx="20">
                  <c:v>1.1614795E8</c:v>
                </c:pt>
              </c:numCache>
            </c:numRef>
          </c:xVal>
          <c:yVal>
            <c:numRef>
              <c:f>extracteddata!$G$98:$G$118</c:f>
              <c:numCache>
                <c:formatCode>General</c:formatCode>
                <c:ptCount val="21"/>
                <c:pt idx="0">
                  <c:v>0.815880613571429</c:v>
                </c:pt>
                <c:pt idx="1">
                  <c:v>0.854337435628572</c:v>
                </c:pt>
                <c:pt idx="2">
                  <c:v>0.711002839971428</c:v>
                </c:pt>
                <c:pt idx="3">
                  <c:v>0.772498185457143</c:v>
                </c:pt>
                <c:pt idx="4">
                  <c:v>0.789586149685714</c:v>
                </c:pt>
                <c:pt idx="5">
                  <c:v>0.0798298889714286</c:v>
                </c:pt>
                <c:pt idx="6">
                  <c:v>0.402932004257143</c:v>
                </c:pt>
                <c:pt idx="7">
                  <c:v>0.340301613971429</c:v>
                </c:pt>
                <c:pt idx="8">
                  <c:v>0.171964178571429</c:v>
                </c:pt>
                <c:pt idx="9">
                  <c:v>0.135581419714286</c:v>
                </c:pt>
                <c:pt idx="10">
                  <c:v>0.135303537714286</c:v>
                </c:pt>
                <c:pt idx="11">
                  <c:v>0.0180842536285714</c:v>
                </c:pt>
                <c:pt idx="12">
                  <c:v>0.0163576413714286</c:v>
                </c:pt>
                <c:pt idx="13">
                  <c:v>0.044052168</c:v>
                </c:pt>
                <c:pt idx="14">
                  <c:v>0.00555464377142857</c:v>
                </c:pt>
                <c:pt idx="15">
                  <c:v>0.0231421356857143</c:v>
                </c:pt>
                <c:pt idx="16">
                  <c:v>0.0445609093714286</c:v>
                </c:pt>
                <c:pt idx="17">
                  <c:v>0.0341413832</c:v>
                </c:pt>
                <c:pt idx="18">
                  <c:v>0.205520178571429</c:v>
                </c:pt>
                <c:pt idx="19">
                  <c:v>0.944203225657143</c:v>
                </c:pt>
                <c:pt idx="20">
                  <c:v>0.9596373382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extracteddata!$D$98:$D$118</c:f>
              <c:numCache>
                <c:formatCode>General</c:formatCode>
                <c:ptCount val="21"/>
                <c:pt idx="0">
                  <c:v>1.16132431E8</c:v>
                </c:pt>
                <c:pt idx="1">
                  <c:v>1.16137036E8</c:v>
                </c:pt>
                <c:pt idx="2">
                  <c:v>1.16138462E8</c:v>
                </c:pt>
                <c:pt idx="3">
                  <c:v>1.16138591E8</c:v>
                </c:pt>
                <c:pt idx="4">
                  <c:v>1.1613918E8</c:v>
                </c:pt>
                <c:pt idx="5">
                  <c:v>1.16139322E8</c:v>
                </c:pt>
                <c:pt idx="6">
                  <c:v>1.16139367E8</c:v>
                </c:pt>
                <c:pt idx="7">
                  <c:v>1.16139374E8</c:v>
                </c:pt>
                <c:pt idx="8">
                  <c:v>1.16139391E8</c:v>
                </c:pt>
                <c:pt idx="9">
                  <c:v>1.16139414E8</c:v>
                </c:pt>
                <c:pt idx="10">
                  <c:v>1.16139425E8</c:v>
                </c:pt>
                <c:pt idx="11">
                  <c:v>1.16139477E8</c:v>
                </c:pt>
                <c:pt idx="12">
                  <c:v>1.16139628E8</c:v>
                </c:pt>
                <c:pt idx="13">
                  <c:v>1.16139705E8</c:v>
                </c:pt>
                <c:pt idx="14">
                  <c:v>1.16139849E8</c:v>
                </c:pt>
                <c:pt idx="15">
                  <c:v>1.16140128E8</c:v>
                </c:pt>
                <c:pt idx="16">
                  <c:v>1.16140267E8</c:v>
                </c:pt>
                <c:pt idx="17">
                  <c:v>1.16140342E8</c:v>
                </c:pt>
                <c:pt idx="18">
                  <c:v>1.16140593E8</c:v>
                </c:pt>
                <c:pt idx="19">
                  <c:v>1.16143459E8</c:v>
                </c:pt>
                <c:pt idx="20">
                  <c:v>1.1614795E8</c:v>
                </c:pt>
              </c:numCache>
            </c:numRef>
          </c:xVal>
          <c:yVal>
            <c:numRef>
              <c:f>extracteddata!$H$98:$H$118</c:f>
              <c:numCache>
                <c:formatCode>General</c:formatCode>
                <c:ptCount val="21"/>
                <c:pt idx="0">
                  <c:v>0.554980356157895</c:v>
                </c:pt>
                <c:pt idx="1">
                  <c:v>0.696028903005263</c:v>
                </c:pt>
                <c:pt idx="2">
                  <c:v>0.684793181073684</c:v>
                </c:pt>
                <c:pt idx="3">
                  <c:v>0.852710530957895</c:v>
                </c:pt>
                <c:pt idx="4">
                  <c:v>0.674085070460526</c:v>
                </c:pt>
                <c:pt idx="5">
                  <c:v>0.143205218589474</c:v>
                </c:pt>
                <c:pt idx="6">
                  <c:v>0.315561711773684</c:v>
                </c:pt>
                <c:pt idx="7">
                  <c:v>0.374930777360526</c:v>
                </c:pt>
                <c:pt idx="8">
                  <c:v>0.387257892171053</c:v>
                </c:pt>
                <c:pt idx="9">
                  <c:v>0.312755481973684</c:v>
                </c:pt>
                <c:pt idx="10">
                  <c:v>0.296669304815789</c:v>
                </c:pt>
                <c:pt idx="11">
                  <c:v>0.128043225973684</c:v>
                </c:pt>
                <c:pt idx="12">
                  <c:v>0.168830290781579</c:v>
                </c:pt>
                <c:pt idx="13">
                  <c:v>0.203909467657895</c:v>
                </c:pt>
                <c:pt idx="14">
                  <c:v>0.157840426713158</c:v>
                </c:pt>
                <c:pt idx="15">
                  <c:v>0.657192225868421</c:v>
                </c:pt>
                <c:pt idx="16">
                  <c:v>0.524831888718421</c:v>
                </c:pt>
                <c:pt idx="17">
                  <c:v>0.734963775257895</c:v>
                </c:pt>
                <c:pt idx="18">
                  <c:v>0.821632803552632</c:v>
                </c:pt>
                <c:pt idx="19">
                  <c:v>0.553928040876316</c:v>
                </c:pt>
                <c:pt idx="20">
                  <c:v>0.740487456960526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D$98:$D$118</c:f>
              <c:numCache>
                <c:formatCode>General</c:formatCode>
                <c:ptCount val="21"/>
                <c:pt idx="0">
                  <c:v>1.16132431E8</c:v>
                </c:pt>
                <c:pt idx="1">
                  <c:v>1.16137036E8</c:v>
                </c:pt>
                <c:pt idx="2">
                  <c:v>1.16138462E8</c:v>
                </c:pt>
                <c:pt idx="3">
                  <c:v>1.16138591E8</c:v>
                </c:pt>
                <c:pt idx="4">
                  <c:v>1.1613918E8</c:v>
                </c:pt>
                <c:pt idx="5">
                  <c:v>1.16139322E8</c:v>
                </c:pt>
                <c:pt idx="6">
                  <c:v>1.16139367E8</c:v>
                </c:pt>
                <c:pt idx="7">
                  <c:v>1.16139374E8</c:v>
                </c:pt>
                <c:pt idx="8">
                  <c:v>1.16139391E8</c:v>
                </c:pt>
                <c:pt idx="9">
                  <c:v>1.16139414E8</c:v>
                </c:pt>
                <c:pt idx="10">
                  <c:v>1.16139425E8</c:v>
                </c:pt>
                <c:pt idx="11">
                  <c:v>1.16139477E8</c:v>
                </c:pt>
                <c:pt idx="12">
                  <c:v>1.16139628E8</c:v>
                </c:pt>
                <c:pt idx="13">
                  <c:v>1.16139705E8</c:v>
                </c:pt>
                <c:pt idx="14">
                  <c:v>1.16139849E8</c:v>
                </c:pt>
                <c:pt idx="15">
                  <c:v>1.16140128E8</c:v>
                </c:pt>
                <c:pt idx="16">
                  <c:v>1.16140267E8</c:v>
                </c:pt>
                <c:pt idx="17">
                  <c:v>1.16140342E8</c:v>
                </c:pt>
                <c:pt idx="18">
                  <c:v>1.16140593E8</c:v>
                </c:pt>
                <c:pt idx="19">
                  <c:v>1.16143459E8</c:v>
                </c:pt>
                <c:pt idx="20">
                  <c:v>1.1614795E8</c:v>
                </c:pt>
              </c:numCache>
            </c:numRef>
          </c:xVal>
          <c:yVal>
            <c:numRef>
              <c:f>extracteddata!$I$98:$I$118</c:f>
              <c:numCache>
                <c:formatCode>General</c:formatCode>
                <c:ptCount val="21"/>
                <c:pt idx="0">
                  <c:v>0.664561961477273</c:v>
                </c:pt>
                <c:pt idx="1">
                  <c:v>0.801404160181818</c:v>
                </c:pt>
                <c:pt idx="2">
                  <c:v>0.785723565727273</c:v>
                </c:pt>
                <c:pt idx="3">
                  <c:v>0.914858889340909</c:v>
                </c:pt>
                <c:pt idx="4">
                  <c:v>0.548896922477273</c:v>
                </c:pt>
                <c:pt idx="5">
                  <c:v>0.0701314038409091</c:v>
                </c:pt>
                <c:pt idx="6">
                  <c:v>0.174644662090909</c:v>
                </c:pt>
                <c:pt idx="7">
                  <c:v>0.157374961863636</c:v>
                </c:pt>
                <c:pt idx="8">
                  <c:v>0.165506543590909</c:v>
                </c:pt>
                <c:pt idx="9">
                  <c:v>0.125802942909091</c:v>
                </c:pt>
                <c:pt idx="10">
                  <c:v>0.132895216659091</c:v>
                </c:pt>
                <c:pt idx="11">
                  <c:v>0.0477826377272727</c:v>
                </c:pt>
                <c:pt idx="12">
                  <c:v>0.0552723351818182</c:v>
                </c:pt>
                <c:pt idx="13">
                  <c:v>0.102898347954545</c:v>
                </c:pt>
                <c:pt idx="14">
                  <c:v>0.0550733724090909</c:v>
                </c:pt>
                <c:pt idx="15">
                  <c:v>0.1276642665</c:v>
                </c:pt>
                <c:pt idx="16">
                  <c:v>0.146116562431818</c:v>
                </c:pt>
                <c:pt idx="17">
                  <c:v>0.163882544295455</c:v>
                </c:pt>
                <c:pt idx="18">
                  <c:v>0.208893785204545</c:v>
                </c:pt>
                <c:pt idx="19">
                  <c:v>0.782490670363636</c:v>
                </c:pt>
                <c:pt idx="20">
                  <c:v>0.908900659340909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J$113:$J$114</c:f>
              <c:numCache>
                <c:formatCode>General</c:formatCode>
                <c:ptCount val="2"/>
                <c:pt idx="0">
                  <c:v>1.16140342E8</c:v>
                </c:pt>
                <c:pt idx="1">
                  <c:v>1.16140342E8</c:v>
                </c:pt>
              </c:numCache>
            </c:numRef>
          </c:xVal>
          <c:yVal>
            <c:numRef>
              <c:f>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545726800"/>
        <c:axId val="-1079625136"/>
      </c:scatterChart>
      <c:valAx>
        <c:axId val="-1545726800"/>
        <c:scaling>
          <c:orientation val="minMax"/>
          <c:max val="1.16143342E8"/>
          <c:min val="1.16137342E8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079625136"/>
        <c:crosses val="autoZero"/>
        <c:crossBetween val="midCat"/>
        <c:majorUnit val="1000.0"/>
      </c:valAx>
      <c:valAx>
        <c:axId val="-1079625136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545726800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0735734271606142"/>
          <c:y val="0.876346287128469"/>
          <c:w val="0.850703162878634"/>
          <c:h val="0.1236537128715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62665642404455"/>
          <c:h val="0.698651790046103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[1]extracteddata!$D$119:$D$150</c:f>
              <c:numCache>
                <c:formatCode>General</c:formatCode>
                <c:ptCount val="32"/>
                <c:pt idx="0">
                  <c:v>2.7209828E7</c:v>
                </c:pt>
                <c:pt idx="1">
                  <c:v>2.7211117E7</c:v>
                </c:pt>
                <c:pt idx="2">
                  <c:v>2.7211555E7</c:v>
                </c:pt>
                <c:pt idx="3">
                  <c:v>2.7211741E7</c:v>
                </c:pt>
                <c:pt idx="4">
                  <c:v>2.7212357E7</c:v>
                </c:pt>
                <c:pt idx="5">
                  <c:v>2.721287E7</c:v>
                </c:pt>
                <c:pt idx="6">
                  <c:v>2.7212935E7</c:v>
                </c:pt>
                <c:pt idx="7">
                  <c:v>2.721361E7</c:v>
                </c:pt>
                <c:pt idx="8">
                  <c:v>2.7213893E7</c:v>
                </c:pt>
                <c:pt idx="9">
                  <c:v>2.721395E7</c:v>
                </c:pt>
                <c:pt idx="10">
                  <c:v>2.7213966E7</c:v>
                </c:pt>
                <c:pt idx="11">
                  <c:v>2.7213971E7</c:v>
                </c:pt>
                <c:pt idx="12">
                  <c:v>2.7213984E7</c:v>
                </c:pt>
                <c:pt idx="13">
                  <c:v>2.7214043E7</c:v>
                </c:pt>
                <c:pt idx="14">
                  <c:v>2.7214056E7</c:v>
                </c:pt>
                <c:pt idx="15">
                  <c:v>2.7214126E7</c:v>
                </c:pt>
                <c:pt idx="16">
                  <c:v>2.7214201E7</c:v>
                </c:pt>
                <c:pt idx="17">
                  <c:v>2.7214383E7</c:v>
                </c:pt>
                <c:pt idx="18">
                  <c:v>2.7215464E7</c:v>
                </c:pt>
                <c:pt idx="19">
                  <c:v>2.7215606E7</c:v>
                </c:pt>
                <c:pt idx="20">
                  <c:v>2.721561E7</c:v>
                </c:pt>
                <c:pt idx="21">
                  <c:v>2.7217057E7</c:v>
                </c:pt>
                <c:pt idx="22">
                  <c:v>2.7217606E7</c:v>
                </c:pt>
                <c:pt idx="23">
                  <c:v>2.7218867E7</c:v>
                </c:pt>
                <c:pt idx="24">
                  <c:v>2.7219224E7</c:v>
                </c:pt>
                <c:pt idx="25">
                  <c:v>2.7219344E7</c:v>
                </c:pt>
                <c:pt idx="26">
                  <c:v>2.7219516E7</c:v>
                </c:pt>
                <c:pt idx="27">
                  <c:v>2.7219704E7</c:v>
                </c:pt>
                <c:pt idx="28">
                  <c:v>2.7220034E7</c:v>
                </c:pt>
                <c:pt idx="29">
                  <c:v>2.7220047E7</c:v>
                </c:pt>
                <c:pt idx="30">
                  <c:v>2.7220049E7</c:v>
                </c:pt>
                <c:pt idx="31">
                  <c:v>2.7220398E7</c:v>
                </c:pt>
              </c:numCache>
            </c:numRef>
          </c:xVal>
          <c:yVal>
            <c:numRef>
              <c:f>[1]extracteddata!$F$119:$F$150</c:f>
              <c:numCache>
                <c:formatCode>General</c:formatCode>
                <c:ptCount val="32"/>
                <c:pt idx="0">
                  <c:v>0.490031933522999</c:v>
                </c:pt>
                <c:pt idx="1">
                  <c:v>0.251881842624163</c:v>
                </c:pt>
                <c:pt idx="2">
                  <c:v>0.24829909950687</c:v>
                </c:pt>
                <c:pt idx="3">
                  <c:v>0.383756619712963</c:v>
                </c:pt>
                <c:pt idx="4">
                  <c:v>0.398874742661589</c:v>
                </c:pt>
                <c:pt idx="5">
                  <c:v>0.199055804450119</c:v>
                </c:pt>
                <c:pt idx="6">
                  <c:v>0.210202611955197</c:v>
                </c:pt>
                <c:pt idx="7">
                  <c:v>0.388763234435185</c:v>
                </c:pt>
                <c:pt idx="8">
                  <c:v>0.601947149618578</c:v>
                </c:pt>
                <c:pt idx="9">
                  <c:v>0.409758817012545</c:v>
                </c:pt>
                <c:pt idx="10">
                  <c:v>0.340182011914875</c:v>
                </c:pt>
                <c:pt idx="11">
                  <c:v>0.368504156710872</c:v>
                </c:pt>
                <c:pt idx="12">
                  <c:v>0.515226336781959</c:v>
                </c:pt>
                <c:pt idx="13">
                  <c:v>0.596899031370968</c:v>
                </c:pt>
                <c:pt idx="14">
                  <c:v>0.674184675271804</c:v>
                </c:pt>
                <c:pt idx="15">
                  <c:v>0.69288294362276</c:v>
                </c:pt>
                <c:pt idx="16">
                  <c:v>0.548500115192055</c:v>
                </c:pt>
                <c:pt idx="17">
                  <c:v>0.723712326091398</c:v>
                </c:pt>
                <c:pt idx="18">
                  <c:v>0.839222858243728</c:v>
                </c:pt>
                <c:pt idx="19">
                  <c:v>0.872138987957885</c:v>
                </c:pt>
                <c:pt idx="20">
                  <c:v>0.860454307728196</c:v>
                </c:pt>
                <c:pt idx="21">
                  <c:v>0.772580306024492</c:v>
                </c:pt>
                <c:pt idx="22">
                  <c:v>0.604708151220131</c:v>
                </c:pt>
                <c:pt idx="23">
                  <c:v>0.892653640053764</c:v>
                </c:pt>
                <c:pt idx="24">
                  <c:v>0.535130388282855</c:v>
                </c:pt>
                <c:pt idx="25">
                  <c:v>0.781064488020311</c:v>
                </c:pt>
                <c:pt idx="26">
                  <c:v>0.274142881762246</c:v>
                </c:pt>
                <c:pt idx="27">
                  <c:v>0.331694528595579</c:v>
                </c:pt>
                <c:pt idx="28">
                  <c:v>0.353811621982676</c:v>
                </c:pt>
                <c:pt idx="29">
                  <c:v>0.686713352090801</c:v>
                </c:pt>
                <c:pt idx="30">
                  <c:v>0.854012160114396</c:v>
                </c:pt>
                <c:pt idx="31">
                  <c:v>0.817084895430108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[1]extracteddata!$D$119:$D$150</c:f>
              <c:numCache>
                <c:formatCode>General</c:formatCode>
                <c:ptCount val="32"/>
                <c:pt idx="0">
                  <c:v>2.7209828E7</c:v>
                </c:pt>
                <c:pt idx="1">
                  <c:v>2.7211117E7</c:v>
                </c:pt>
                <c:pt idx="2">
                  <c:v>2.7211555E7</c:v>
                </c:pt>
                <c:pt idx="3">
                  <c:v>2.7211741E7</c:v>
                </c:pt>
                <c:pt idx="4">
                  <c:v>2.7212357E7</c:v>
                </c:pt>
                <c:pt idx="5">
                  <c:v>2.721287E7</c:v>
                </c:pt>
                <c:pt idx="6">
                  <c:v>2.7212935E7</c:v>
                </c:pt>
                <c:pt idx="7">
                  <c:v>2.721361E7</c:v>
                </c:pt>
                <c:pt idx="8">
                  <c:v>2.7213893E7</c:v>
                </c:pt>
                <c:pt idx="9">
                  <c:v>2.721395E7</c:v>
                </c:pt>
                <c:pt idx="10">
                  <c:v>2.7213966E7</c:v>
                </c:pt>
                <c:pt idx="11">
                  <c:v>2.7213971E7</c:v>
                </c:pt>
                <c:pt idx="12">
                  <c:v>2.7213984E7</c:v>
                </c:pt>
                <c:pt idx="13">
                  <c:v>2.7214043E7</c:v>
                </c:pt>
                <c:pt idx="14">
                  <c:v>2.7214056E7</c:v>
                </c:pt>
                <c:pt idx="15">
                  <c:v>2.7214126E7</c:v>
                </c:pt>
                <c:pt idx="16">
                  <c:v>2.7214201E7</c:v>
                </c:pt>
                <c:pt idx="17">
                  <c:v>2.7214383E7</c:v>
                </c:pt>
                <c:pt idx="18">
                  <c:v>2.7215464E7</c:v>
                </c:pt>
                <c:pt idx="19">
                  <c:v>2.7215606E7</c:v>
                </c:pt>
                <c:pt idx="20">
                  <c:v>2.721561E7</c:v>
                </c:pt>
                <c:pt idx="21">
                  <c:v>2.7217057E7</c:v>
                </c:pt>
                <c:pt idx="22">
                  <c:v>2.7217606E7</c:v>
                </c:pt>
                <c:pt idx="23">
                  <c:v>2.7218867E7</c:v>
                </c:pt>
                <c:pt idx="24">
                  <c:v>2.7219224E7</c:v>
                </c:pt>
                <c:pt idx="25">
                  <c:v>2.7219344E7</c:v>
                </c:pt>
                <c:pt idx="26">
                  <c:v>2.7219516E7</c:v>
                </c:pt>
                <c:pt idx="27">
                  <c:v>2.7219704E7</c:v>
                </c:pt>
                <c:pt idx="28">
                  <c:v>2.7220034E7</c:v>
                </c:pt>
                <c:pt idx="29">
                  <c:v>2.7220047E7</c:v>
                </c:pt>
                <c:pt idx="30">
                  <c:v>2.7220049E7</c:v>
                </c:pt>
                <c:pt idx="31">
                  <c:v>2.7220398E7</c:v>
                </c:pt>
              </c:numCache>
            </c:numRef>
          </c:xVal>
          <c:yVal>
            <c:numRef>
              <c:f>[1]extracteddata!$G$119:$G$150</c:f>
              <c:numCache>
                <c:formatCode>General</c:formatCode>
                <c:ptCount val="32"/>
                <c:pt idx="0">
                  <c:v>0.0909383692571429</c:v>
                </c:pt>
                <c:pt idx="1">
                  <c:v>0.151890457029412</c:v>
                </c:pt>
                <c:pt idx="2">
                  <c:v>0.066988036</c:v>
                </c:pt>
                <c:pt idx="3">
                  <c:v>0.172421747771429</c:v>
                </c:pt>
                <c:pt idx="4">
                  <c:v>0.0938739354</c:v>
                </c:pt>
                <c:pt idx="5">
                  <c:v>0.0313378319714286</c:v>
                </c:pt>
                <c:pt idx="6">
                  <c:v>0.0576801157714286</c:v>
                </c:pt>
                <c:pt idx="7">
                  <c:v>0.0385093131428571</c:v>
                </c:pt>
                <c:pt idx="8">
                  <c:v>0.0460497015142857</c:v>
                </c:pt>
                <c:pt idx="9">
                  <c:v>0.0213346220285714</c:v>
                </c:pt>
                <c:pt idx="10">
                  <c:v>0.0373076169714286</c:v>
                </c:pt>
                <c:pt idx="11">
                  <c:v>0.0227551449428571</c:v>
                </c:pt>
                <c:pt idx="12">
                  <c:v>0.0132257672571429</c:v>
                </c:pt>
                <c:pt idx="13">
                  <c:v>0.073811806</c:v>
                </c:pt>
                <c:pt idx="14">
                  <c:v>0.0693053105714286</c:v>
                </c:pt>
                <c:pt idx="15">
                  <c:v>0.188604141485714</c:v>
                </c:pt>
                <c:pt idx="16">
                  <c:v>0.0576077436571429</c:v>
                </c:pt>
                <c:pt idx="17">
                  <c:v>0.314055538657143</c:v>
                </c:pt>
                <c:pt idx="18">
                  <c:v>0.8980841</c:v>
                </c:pt>
                <c:pt idx="19">
                  <c:v>0.909058879971429</c:v>
                </c:pt>
                <c:pt idx="20">
                  <c:v>0.892429053</c:v>
                </c:pt>
                <c:pt idx="21">
                  <c:v>0.85984613</c:v>
                </c:pt>
                <c:pt idx="22">
                  <c:v>0.939198440457143</c:v>
                </c:pt>
                <c:pt idx="23">
                  <c:v>0.813551508571428</c:v>
                </c:pt>
                <c:pt idx="24">
                  <c:v>0.145274699</c:v>
                </c:pt>
                <c:pt idx="25">
                  <c:v>0.1745234356</c:v>
                </c:pt>
                <c:pt idx="26">
                  <c:v>0.083783436</c:v>
                </c:pt>
                <c:pt idx="27">
                  <c:v>0.065357909</c:v>
                </c:pt>
                <c:pt idx="28">
                  <c:v>0.263099996657143</c:v>
                </c:pt>
                <c:pt idx="29">
                  <c:v>0.577209845714286</c:v>
                </c:pt>
                <c:pt idx="30">
                  <c:v>0.918303147657143</c:v>
                </c:pt>
                <c:pt idx="31">
                  <c:v>0.905005342857143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[1]extracteddata!$D$119:$D$150</c:f>
              <c:numCache>
                <c:formatCode>General</c:formatCode>
                <c:ptCount val="32"/>
                <c:pt idx="0">
                  <c:v>2.7209828E7</c:v>
                </c:pt>
                <c:pt idx="1">
                  <c:v>2.7211117E7</c:v>
                </c:pt>
                <c:pt idx="2">
                  <c:v>2.7211555E7</c:v>
                </c:pt>
                <c:pt idx="3">
                  <c:v>2.7211741E7</c:v>
                </c:pt>
                <c:pt idx="4">
                  <c:v>2.7212357E7</c:v>
                </c:pt>
                <c:pt idx="5">
                  <c:v>2.721287E7</c:v>
                </c:pt>
                <c:pt idx="6">
                  <c:v>2.7212935E7</c:v>
                </c:pt>
                <c:pt idx="7">
                  <c:v>2.721361E7</c:v>
                </c:pt>
                <c:pt idx="8">
                  <c:v>2.7213893E7</c:v>
                </c:pt>
                <c:pt idx="9">
                  <c:v>2.721395E7</c:v>
                </c:pt>
                <c:pt idx="10">
                  <c:v>2.7213966E7</c:v>
                </c:pt>
                <c:pt idx="11">
                  <c:v>2.7213971E7</c:v>
                </c:pt>
                <c:pt idx="12">
                  <c:v>2.7213984E7</c:v>
                </c:pt>
                <c:pt idx="13">
                  <c:v>2.7214043E7</c:v>
                </c:pt>
                <c:pt idx="14">
                  <c:v>2.7214056E7</c:v>
                </c:pt>
                <c:pt idx="15">
                  <c:v>2.7214126E7</c:v>
                </c:pt>
                <c:pt idx="16">
                  <c:v>2.7214201E7</c:v>
                </c:pt>
                <c:pt idx="17">
                  <c:v>2.7214383E7</c:v>
                </c:pt>
                <c:pt idx="18">
                  <c:v>2.7215464E7</c:v>
                </c:pt>
                <c:pt idx="19">
                  <c:v>2.7215606E7</c:v>
                </c:pt>
                <c:pt idx="20">
                  <c:v>2.721561E7</c:v>
                </c:pt>
                <c:pt idx="21">
                  <c:v>2.7217057E7</c:v>
                </c:pt>
                <c:pt idx="22">
                  <c:v>2.7217606E7</c:v>
                </c:pt>
                <c:pt idx="23">
                  <c:v>2.7218867E7</c:v>
                </c:pt>
                <c:pt idx="24">
                  <c:v>2.7219224E7</c:v>
                </c:pt>
                <c:pt idx="25">
                  <c:v>2.7219344E7</c:v>
                </c:pt>
                <c:pt idx="26">
                  <c:v>2.7219516E7</c:v>
                </c:pt>
                <c:pt idx="27">
                  <c:v>2.7219704E7</c:v>
                </c:pt>
                <c:pt idx="28">
                  <c:v>2.7220034E7</c:v>
                </c:pt>
                <c:pt idx="29">
                  <c:v>2.7220047E7</c:v>
                </c:pt>
                <c:pt idx="30">
                  <c:v>2.7220049E7</c:v>
                </c:pt>
                <c:pt idx="31">
                  <c:v>2.7220398E7</c:v>
                </c:pt>
              </c:numCache>
            </c:numRef>
          </c:xVal>
          <c:yVal>
            <c:numRef>
              <c:f>[1]extracteddata!$H$119:$H$150</c:f>
              <c:numCache>
                <c:formatCode>General</c:formatCode>
                <c:ptCount val="32"/>
                <c:pt idx="0">
                  <c:v>0.668172958439474</c:v>
                </c:pt>
                <c:pt idx="1">
                  <c:v>0.104755545421622</c:v>
                </c:pt>
                <c:pt idx="2">
                  <c:v>0.254863876802632</c:v>
                </c:pt>
                <c:pt idx="3">
                  <c:v>0.429554485636842</c:v>
                </c:pt>
                <c:pt idx="4">
                  <c:v>0.613756031378947</c:v>
                </c:pt>
                <c:pt idx="5">
                  <c:v>0.382315656760526</c:v>
                </c:pt>
                <c:pt idx="6">
                  <c:v>0.392778370760526</c:v>
                </c:pt>
                <c:pt idx="7">
                  <c:v>0.629685215394737</c:v>
                </c:pt>
                <c:pt idx="8">
                  <c:v>0.769022822257895</c:v>
                </c:pt>
                <c:pt idx="9">
                  <c:v>0.635934306528947</c:v>
                </c:pt>
                <c:pt idx="10">
                  <c:v>0.567892276226316</c:v>
                </c:pt>
                <c:pt idx="11">
                  <c:v>0.584603378260526</c:v>
                </c:pt>
                <c:pt idx="12">
                  <c:v>0.684446403881579</c:v>
                </c:pt>
                <c:pt idx="13">
                  <c:v>0.718556479868421</c:v>
                </c:pt>
                <c:pt idx="14">
                  <c:v>0.796591999078948</c:v>
                </c:pt>
                <c:pt idx="15">
                  <c:v>0.770536464252632</c:v>
                </c:pt>
                <c:pt idx="16">
                  <c:v>0.66040035801579</c:v>
                </c:pt>
                <c:pt idx="17">
                  <c:v>0.81930719125</c:v>
                </c:pt>
                <c:pt idx="18">
                  <c:v>0.837098001052631</c:v>
                </c:pt>
                <c:pt idx="19">
                  <c:v>0.866822052234211</c:v>
                </c:pt>
                <c:pt idx="20">
                  <c:v>0.863826918</c:v>
                </c:pt>
                <c:pt idx="21">
                  <c:v>0.745859185526316</c:v>
                </c:pt>
                <c:pt idx="22">
                  <c:v>0.529485940105263</c:v>
                </c:pt>
                <c:pt idx="23">
                  <c:v>0.899963183947369</c:v>
                </c:pt>
                <c:pt idx="24">
                  <c:v>0.497384350389474</c:v>
                </c:pt>
                <c:pt idx="25">
                  <c:v>0.821600254686842</c:v>
                </c:pt>
                <c:pt idx="26">
                  <c:v>0.246782603263158</c:v>
                </c:pt>
                <c:pt idx="27">
                  <c:v>0.318353451442105</c:v>
                </c:pt>
                <c:pt idx="28">
                  <c:v>0.289153371928947</c:v>
                </c:pt>
                <c:pt idx="29">
                  <c:v>0.672171679473684</c:v>
                </c:pt>
                <c:pt idx="30">
                  <c:v>0.869852815952632</c:v>
                </c:pt>
                <c:pt idx="31">
                  <c:v>0.849593235789474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D$119:$D$150</c:f>
              <c:numCache>
                <c:formatCode>General</c:formatCode>
                <c:ptCount val="32"/>
                <c:pt idx="0">
                  <c:v>2.7209828E7</c:v>
                </c:pt>
                <c:pt idx="1">
                  <c:v>2.7211117E7</c:v>
                </c:pt>
                <c:pt idx="2">
                  <c:v>2.7211555E7</c:v>
                </c:pt>
                <c:pt idx="3">
                  <c:v>2.7211741E7</c:v>
                </c:pt>
                <c:pt idx="4">
                  <c:v>2.7212357E7</c:v>
                </c:pt>
                <c:pt idx="5">
                  <c:v>2.721287E7</c:v>
                </c:pt>
                <c:pt idx="6">
                  <c:v>2.7212935E7</c:v>
                </c:pt>
                <c:pt idx="7">
                  <c:v>2.721361E7</c:v>
                </c:pt>
                <c:pt idx="8">
                  <c:v>2.7213893E7</c:v>
                </c:pt>
                <c:pt idx="9">
                  <c:v>2.721395E7</c:v>
                </c:pt>
                <c:pt idx="10">
                  <c:v>2.7213966E7</c:v>
                </c:pt>
                <c:pt idx="11">
                  <c:v>2.7213971E7</c:v>
                </c:pt>
                <c:pt idx="12">
                  <c:v>2.7213984E7</c:v>
                </c:pt>
                <c:pt idx="13">
                  <c:v>2.7214043E7</c:v>
                </c:pt>
                <c:pt idx="14">
                  <c:v>2.7214056E7</c:v>
                </c:pt>
                <c:pt idx="15">
                  <c:v>2.7214126E7</c:v>
                </c:pt>
                <c:pt idx="16">
                  <c:v>2.7214201E7</c:v>
                </c:pt>
                <c:pt idx="17">
                  <c:v>2.7214383E7</c:v>
                </c:pt>
                <c:pt idx="18">
                  <c:v>2.7215464E7</c:v>
                </c:pt>
                <c:pt idx="19">
                  <c:v>2.7215606E7</c:v>
                </c:pt>
                <c:pt idx="20">
                  <c:v>2.721561E7</c:v>
                </c:pt>
                <c:pt idx="21">
                  <c:v>2.7217057E7</c:v>
                </c:pt>
                <c:pt idx="22">
                  <c:v>2.7217606E7</c:v>
                </c:pt>
                <c:pt idx="23">
                  <c:v>2.7218867E7</c:v>
                </c:pt>
                <c:pt idx="24">
                  <c:v>2.7219224E7</c:v>
                </c:pt>
                <c:pt idx="25">
                  <c:v>2.7219344E7</c:v>
                </c:pt>
                <c:pt idx="26">
                  <c:v>2.7219516E7</c:v>
                </c:pt>
                <c:pt idx="27">
                  <c:v>2.7219704E7</c:v>
                </c:pt>
                <c:pt idx="28">
                  <c:v>2.7220034E7</c:v>
                </c:pt>
                <c:pt idx="29">
                  <c:v>2.7220047E7</c:v>
                </c:pt>
                <c:pt idx="30">
                  <c:v>2.7220049E7</c:v>
                </c:pt>
                <c:pt idx="31">
                  <c:v>2.7220398E7</c:v>
                </c:pt>
              </c:numCache>
            </c:numRef>
          </c:xVal>
          <c:yVal>
            <c:numRef>
              <c:f>[1]extracteddata!$I$119:$I$150</c:f>
              <c:numCache>
                <c:formatCode>General</c:formatCode>
                <c:ptCount val="32"/>
                <c:pt idx="0">
                  <c:v>0.353538141772727</c:v>
                </c:pt>
                <c:pt idx="1">
                  <c:v>0.327773176704545</c:v>
                </c:pt>
                <c:pt idx="2">
                  <c:v>0.289770126818182</c:v>
                </c:pt>
                <c:pt idx="3">
                  <c:v>0.3903023125</c:v>
                </c:pt>
                <c:pt idx="4">
                  <c:v>0.307671483954545</c:v>
                </c:pt>
                <c:pt idx="5">
                  <c:v>0.139793484886364</c:v>
                </c:pt>
                <c:pt idx="6">
                  <c:v>0.1489556145</c:v>
                </c:pt>
                <c:pt idx="7">
                  <c:v>0.20098469275</c:v>
                </c:pt>
                <c:pt idx="8">
                  <c:v>0.418751478363636</c:v>
                </c:pt>
                <c:pt idx="9">
                  <c:v>0.248286448545454</c:v>
                </c:pt>
                <c:pt idx="10">
                  <c:v>0.209321155681818</c:v>
                </c:pt>
                <c:pt idx="11">
                  <c:v>0.229414586318182</c:v>
                </c:pt>
                <c:pt idx="12">
                  <c:v>0.342079057772727</c:v>
                </c:pt>
                <c:pt idx="13">
                  <c:v>0.455510769772727</c:v>
                </c:pt>
                <c:pt idx="14">
                  <c:v>0.499685169545455</c:v>
                </c:pt>
                <c:pt idx="15">
                  <c:v>0.573076532318182</c:v>
                </c:pt>
                <c:pt idx="16">
                  <c:v>0.461249088727273</c:v>
                </c:pt>
                <c:pt idx="17">
                  <c:v>0.573421723863636</c:v>
                </c:pt>
                <c:pt idx="18">
                  <c:v>0.778076663636364</c:v>
                </c:pt>
                <c:pt idx="19">
                  <c:v>0.825687477795455</c:v>
                </c:pt>
                <c:pt idx="20">
                  <c:v>0.816736890681818</c:v>
                </c:pt>
                <c:pt idx="21">
                  <c:v>0.696076596363636</c:v>
                </c:pt>
                <c:pt idx="22">
                  <c:v>0.487996623454545</c:v>
                </c:pt>
                <c:pt idx="23">
                  <c:v>0.847146470454546</c:v>
                </c:pt>
                <c:pt idx="24">
                  <c:v>0.451283989590909</c:v>
                </c:pt>
                <c:pt idx="25">
                  <c:v>0.673128817113636</c:v>
                </c:pt>
                <c:pt idx="26">
                  <c:v>0.228793555454545</c:v>
                </c:pt>
                <c:pt idx="27">
                  <c:v>0.261461280045455</c:v>
                </c:pt>
                <c:pt idx="28">
                  <c:v>0.349892970159091</c:v>
                </c:pt>
                <c:pt idx="29">
                  <c:v>0.682327090909091</c:v>
                </c:pt>
                <c:pt idx="30">
                  <c:v>0.852662856772728</c:v>
                </c:pt>
                <c:pt idx="31">
                  <c:v>0.779701125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J$124:$J$125</c:f>
              <c:numCache>
                <c:formatCode>General</c:formatCode>
                <c:ptCount val="2"/>
                <c:pt idx="0">
                  <c:v>2.721361E7</c:v>
                </c:pt>
                <c:pt idx="1">
                  <c:v>2.721361E7</c:v>
                </c:pt>
              </c:numCache>
            </c:numRef>
          </c:xVal>
          <c:yVal>
            <c:numRef>
              <c:f>[1]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067472304"/>
        <c:axId val="-1067483520"/>
      </c:scatterChart>
      <c:valAx>
        <c:axId val="-1067472304"/>
        <c:scaling>
          <c:orientation val="minMax"/>
          <c:max val="2.721661E7"/>
          <c:min val="2.721061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067483520"/>
        <c:crosses val="autoZero"/>
        <c:crossBetween val="midCat"/>
        <c:majorUnit val="1000.0"/>
      </c:valAx>
      <c:valAx>
        <c:axId val="-106748352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067472304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61595895732283"/>
          <c:h val="0.701660327638686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[1]extracteddata!$D$151:$D$177</c:f>
              <c:numCache>
                <c:formatCode>General</c:formatCode>
                <c:ptCount val="27"/>
                <c:pt idx="0">
                  <c:v>1.82929273E8</c:v>
                </c:pt>
                <c:pt idx="1">
                  <c:v>1.82968758E8</c:v>
                </c:pt>
                <c:pt idx="2">
                  <c:v>1.82970675E8</c:v>
                </c:pt>
                <c:pt idx="3">
                  <c:v>1.82970719E8</c:v>
                </c:pt>
                <c:pt idx="4">
                  <c:v>1.82970728E8</c:v>
                </c:pt>
                <c:pt idx="5">
                  <c:v>1.82970833E8</c:v>
                </c:pt>
                <c:pt idx="6">
                  <c:v>1.82970846E8</c:v>
                </c:pt>
                <c:pt idx="7">
                  <c:v>1.8297085E8</c:v>
                </c:pt>
                <c:pt idx="8">
                  <c:v>1.82970903E8</c:v>
                </c:pt>
                <c:pt idx="9">
                  <c:v>1.82970927E8</c:v>
                </c:pt>
                <c:pt idx="10">
                  <c:v>1.82971009E8</c:v>
                </c:pt>
                <c:pt idx="11">
                  <c:v>1.82971025E8</c:v>
                </c:pt>
                <c:pt idx="12">
                  <c:v>1.82971069E8</c:v>
                </c:pt>
                <c:pt idx="13">
                  <c:v>1.8297143E8</c:v>
                </c:pt>
                <c:pt idx="14">
                  <c:v>1.82971442E8</c:v>
                </c:pt>
                <c:pt idx="15">
                  <c:v>1.82971483E8</c:v>
                </c:pt>
                <c:pt idx="16">
                  <c:v>1.82971663E8</c:v>
                </c:pt>
                <c:pt idx="17">
                  <c:v>1.82972048E8</c:v>
                </c:pt>
                <c:pt idx="18">
                  <c:v>1.82972326E8</c:v>
                </c:pt>
                <c:pt idx="19">
                  <c:v>1.82972625E8</c:v>
                </c:pt>
                <c:pt idx="20">
                  <c:v>1.82972742E8</c:v>
                </c:pt>
                <c:pt idx="21">
                  <c:v>1.82973032E8</c:v>
                </c:pt>
                <c:pt idx="22">
                  <c:v>1.82975699E8</c:v>
                </c:pt>
                <c:pt idx="23">
                  <c:v>1.82981707E8</c:v>
                </c:pt>
                <c:pt idx="24">
                  <c:v>1.82983386E8</c:v>
                </c:pt>
                <c:pt idx="25">
                  <c:v>1.82984429E8</c:v>
                </c:pt>
                <c:pt idx="26">
                  <c:v>1.82987901E8</c:v>
                </c:pt>
              </c:numCache>
            </c:numRef>
          </c:xVal>
          <c:yVal>
            <c:numRef>
              <c:f>[1]extracteddata!$F$151:$F$177</c:f>
              <c:numCache>
                <c:formatCode>General</c:formatCode>
                <c:ptCount val="27"/>
                <c:pt idx="0">
                  <c:v>0.74352446510454</c:v>
                </c:pt>
                <c:pt idx="1">
                  <c:v>0.893793702129928</c:v>
                </c:pt>
                <c:pt idx="2">
                  <c:v>0.742235512992832</c:v>
                </c:pt>
                <c:pt idx="3">
                  <c:v>0.664504786378734</c:v>
                </c:pt>
                <c:pt idx="4">
                  <c:v>0.433455655132019</c:v>
                </c:pt>
                <c:pt idx="5">
                  <c:v>0.22940421071356</c:v>
                </c:pt>
                <c:pt idx="6">
                  <c:v>0.200715942584827</c:v>
                </c:pt>
                <c:pt idx="7">
                  <c:v>0.19760169584717</c:v>
                </c:pt>
                <c:pt idx="8">
                  <c:v>0.167568514765532</c:v>
                </c:pt>
                <c:pt idx="9">
                  <c:v>0.104187852780765</c:v>
                </c:pt>
                <c:pt idx="10">
                  <c:v>0.156495383046595</c:v>
                </c:pt>
                <c:pt idx="11">
                  <c:v>0.163577123953704</c:v>
                </c:pt>
                <c:pt idx="12">
                  <c:v>0.161408077703704</c:v>
                </c:pt>
                <c:pt idx="13">
                  <c:v>0.149750534852449</c:v>
                </c:pt>
                <c:pt idx="14">
                  <c:v>0.156804180296296</c:v>
                </c:pt>
                <c:pt idx="15">
                  <c:v>0.15538663910693</c:v>
                </c:pt>
                <c:pt idx="16">
                  <c:v>0.114016318589606</c:v>
                </c:pt>
                <c:pt idx="17">
                  <c:v>0.170370161266726</c:v>
                </c:pt>
                <c:pt idx="18">
                  <c:v>0.254071015108124</c:v>
                </c:pt>
                <c:pt idx="19">
                  <c:v>0.459567730213262</c:v>
                </c:pt>
                <c:pt idx="20">
                  <c:v>0.247865341887097</c:v>
                </c:pt>
                <c:pt idx="21">
                  <c:v>0.595738204801673</c:v>
                </c:pt>
                <c:pt idx="22">
                  <c:v>0.894575110039725</c:v>
                </c:pt>
                <c:pt idx="23">
                  <c:v>0.809488043918459</c:v>
                </c:pt>
                <c:pt idx="24">
                  <c:v>0.881506771654719</c:v>
                </c:pt>
                <c:pt idx="25">
                  <c:v>0.790182447522999</c:v>
                </c:pt>
                <c:pt idx="26">
                  <c:v>0.807748585084528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[1]extracteddata!$D$151:$D$177</c:f>
              <c:numCache>
                <c:formatCode>General</c:formatCode>
                <c:ptCount val="27"/>
                <c:pt idx="0">
                  <c:v>1.82929273E8</c:v>
                </c:pt>
                <c:pt idx="1">
                  <c:v>1.82968758E8</c:v>
                </c:pt>
                <c:pt idx="2">
                  <c:v>1.82970675E8</c:v>
                </c:pt>
                <c:pt idx="3">
                  <c:v>1.82970719E8</c:v>
                </c:pt>
                <c:pt idx="4">
                  <c:v>1.82970728E8</c:v>
                </c:pt>
                <c:pt idx="5">
                  <c:v>1.82970833E8</c:v>
                </c:pt>
                <c:pt idx="6">
                  <c:v>1.82970846E8</c:v>
                </c:pt>
                <c:pt idx="7">
                  <c:v>1.8297085E8</c:v>
                </c:pt>
                <c:pt idx="8">
                  <c:v>1.82970903E8</c:v>
                </c:pt>
                <c:pt idx="9">
                  <c:v>1.82970927E8</c:v>
                </c:pt>
                <c:pt idx="10">
                  <c:v>1.82971009E8</c:v>
                </c:pt>
                <c:pt idx="11">
                  <c:v>1.82971025E8</c:v>
                </c:pt>
                <c:pt idx="12">
                  <c:v>1.82971069E8</c:v>
                </c:pt>
                <c:pt idx="13">
                  <c:v>1.8297143E8</c:v>
                </c:pt>
                <c:pt idx="14">
                  <c:v>1.82971442E8</c:v>
                </c:pt>
                <c:pt idx="15">
                  <c:v>1.82971483E8</c:v>
                </c:pt>
                <c:pt idx="16">
                  <c:v>1.82971663E8</c:v>
                </c:pt>
                <c:pt idx="17">
                  <c:v>1.82972048E8</c:v>
                </c:pt>
                <c:pt idx="18">
                  <c:v>1.82972326E8</c:v>
                </c:pt>
                <c:pt idx="19">
                  <c:v>1.82972625E8</c:v>
                </c:pt>
                <c:pt idx="20">
                  <c:v>1.82972742E8</c:v>
                </c:pt>
                <c:pt idx="21">
                  <c:v>1.82973032E8</c:v>
                </c:pt>
                <c:pt idx="22">
                  <c:v>1.82975699E8</c:v>
                </c:pt>
                <c:pt idx="23">
                  <c:v>1.82981707E8</c:v>
                </c:pt>
                <c:pt idx="24">
                  <c:v>1.82983386E8</c:v>
                </c:pt>
                <c:pt idx="25">
                  <c:v>1.82984429E8</c:v>
                </c:pt>
                <c:pt idx="26">
                  <c:v>1.82987901E8</c:v>
                </c:pt>
              </c:numCache>
            </c:numRef>
          </c:xVal>
          <c:yVal>
            <c:numRef>
              <c:f>[1]extracteddata!$G$151:$G$177</c:f>
              <c:numCache>
                <c:formatCode>General</c:formatCode>
                <c:ptCount val="27"/>
                <c:pt idx="0">
                  <c:v>0.424380882285714</c:v>
                </c:pt>
                <c:pt idx="1">
                  <c:v>0.9763475996</c:v>
                </c:pt>
                <c:pt idx="2">
                  <c:v>0.807787035428571</c:v>
                </c:pt>
                <c:pt idx="3">
                  <c:v>0.871142016</c:v>
                </c:pt>
                <c:pt idx="4">
                  <c:v>0.4151872732</c:v>
                </c:pt>
                <c:pt idx="5">
                  <c:v>0.0311690666571429</c:v>
                </c:pt>
                <c:pt idx="6">
                  <c:v>0.0318462440285714</c:v>
                </c:pt>
                <c:pt idx="7">
                  <c:v>0.0311983768857143</c:v>
                </c:pt>
                <c:pt idx="8">
                  <c:v>0.027269555</c:v>
                </c:pt>
                <c:pt idx="9">
                  <c:v>0.0137871848285714</c:v>
                </c:pt>
                <c:pt idx="10">
                  <c:v>0.0199408128</c:v>
                </c:pt>
                <c:pt idx="11">
                  <c:v>0.00821332637142857</c:v>
                </c:pt>
                <c:pt idx="12">
                  <c:v>0.0174824577428571</c:v>
                </c:pt>
                <c:pt idx="13">
                  <c:v>0.0214704467714286</c:v>
                </c:pt>
                <c:pt idx="14">
                  <c:v>0.0254680761142857</c:v>
                </c:pt>
                <c:pt idx="15">
                  <c:v>0.0382880422857143</c:v>
                </c:pt>
                <c:pt idx="16">
                  <c:v>0.00607040471428571</c:v>
                </c:pt>
                <c:pt idx="17">
                  <c:v>0.0148194246857143</c:v>
                </c:pt>
                <c:pt idx="18">
                  <c:v>0.00820618402857143</c:v>
                </c:pt>
                <c:pt idx="19">
                  <c:v>0.142613416542857</c:v>
                </c:pt>
                <c:pt idx="20">
                  <c:v>0.133270082771429</c:v>
                </c:pt>
                <c:pt idx="21">
                  <c:v>0.764031507657143</c:v>
                </c:pt>
                <c:pt idx="22">
                  <c:v>0.967795515914286</c:v>
                </c:pt>
                <c:pt idx="23">
                  <c:v>0.877386245971429</c:v>
                </c:pt>
                <c:pt idx="24">
                  <c:v>0.88757806</c:v>
                </c:pt>
                <c:pt idx="25">
                  <c:v>0.900787848828571</c:v>
                </c:pt>
                <c:pt idx="26">
                  <c:v>0.953993390285714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[1]extracteddata!$D$151:$D$177</c:f>
              <c:numCache>
                <c:formatCode>General</c:formatCode>
                <c:ptCount val="27"/>
                <c:pt idx="0">
                  <c:v>1.82929273E8</c:v>
                </c:pt>
                <c:pt idx="1">
                  <c:v>1.82968758E8</c:v>
                </c:pt>
                <c:pt idx="2">
                  <c:v>1.82970675E8</c:v>
                </c:pt>
                <c:pt idx="3">
                  <c:v>1.82970719E8</c:v>
                </c:pt>
                <c:pt idx="4">
                  <c:v>1.82970728E8</c:v>
                </c:pt>
                <c:pt idx="5">
                  <c:v>1.82970833E8</c:v>
                </c:pt>
                <c:pt idx="6">
                  <c:v>1.82970846E8</c:v>
                </c:pt>
                <c:pt idx="7">
                  <c:v>1.8297085E8</c:v>
                </c:pt>
                <c:pt idx="8">
                  <c:v>1.82970903E8</c:v>
                </c:pt>
                <c:pt idx="9">
                  <c:v>1.82970927E8</c:v>
                </c:pt>
                <c:pt idx="10">
                  <c:v>1.82971009E8</c:v>
                </c:pt>
                <c:pt idx="11">
                  <c:v>1.82971025E8</c:v>
                </c:pt>
                <c:pt idx="12">
                  <c:v>1.82971069E8</c:v>
                </c:pt>
                <c:pt idx="13">
                  <c:v>1.8297143E8</c:v>
                </c:pt>
                <c:pt idx="14">
                  <c:v>1.82971442E8</c:v>
                </c:pt>
                <c:pt idx="15">
                  <c:v>1.82971483E8</c:v>
                </c:pt>
                <c:pt idx="16">
                  <c:v>1.82971663E8</c:v>
                </c:pt>
                <c:pt idx="17">
                  <c:v>1.82972048E8</c:v>
                </c:pt>
                <c:pt idx="18">
                  <c:v>1.82972326E8</c:v>
                </c:pt>
                <c:pt idx="19">
                  <c:v>1.82972625E8</c:v>
                </c:pt>
                <c:pt idx="20">
                  <c:v>1.82972742E8</c:v>
                </c:pt>
                <c:pt idx="21">
                  <c:v>1.82973032E8</c:v>
                </c:pt>
                <c:pt idx="22">
                  <c:v>1.82975699E8</c:v>
                </c:pt>
                <c:pt idx="23">
                  <c:v>1.82981707E8</c:v>
                </c:pt>
                <c:pt idx="24">
                  <c:v>1.82983386E8</c:v>
                </c:pt>
                <c:pt idx="25">
                  <c:v>1.82984429E8</c:v>
                </c:pt>
                <c:pt idx="26">
                  <c:v>1.82987901E8</c:v>
                </c:pt>
              </c:numCache>
            </c:numRef>
          </c:xVal>
          <c:yVal>
            <c:numRef>
              <c:f>[1]extracteddata!$H$151:$H$177</c:f>
              <c:numCache>
                <c:formatCode>General</c:formatCode>
                <c:ptCount val="27"/>
                <c:pt idx="0">
                  <c:v>0.543944685394737</c:v>
                </c:pt>
                <c:pt idx="1">
                  <c:v>0.82803581376579</c:v>
                </c:pt>
                <c:pt idx="2">
                  <c:v>0.814215301842105</c:v>
                </c:pt>
                <c:pt idx="3">
                  <c:v>0.736812241468421</c:v>
                </c:pt>
                <c:pt idx="4">
                  <c:v>0.607672942042105</c:v>
                </c:pt>
                <c:pt idx="5">
                  <c:v>0.522049758723684</c:v>
                </c:pt>
                <c:pt idx="6">
                  <c:v>0.500530559207895</c:v>
                </c:pt>
                <c:pt idx="7">
                  <c:v>0.50633262197973</c:v>
                </c:pt>
                <c:pt idx="8">
                  <c:v>0.363896644781579</c:v>
                </c:pt>
                <c:pt idx="9">
                  <c:v>0.296796420947368</c:v>
                </c:pt>
                <c:pt idx="10">
                  <c:v>0.428454987631579</c:v>
                </c:pt>
                <c:pt idx="11">
                  <c:v>0.460487956618421</c:v>
                </c:pt>
                <c:pt idx="12">
                  <c:v>0.435172735118421</c:v>
                </c:pt>
                <c:pt idx="13">
                  <c:v>0.420322617813158</c:v>
                </c:pt>
                <c:pt idx="14">
                  <c:v>0.44703000451579</c:v>
                </c:pt>
                <c:pt idx="15">
                  <c:v>0.450883238289474</c:v>
                </c:pt>
                <c:pt idx="16">
                  <c:v>0.420986736184211</c:v>
                </c:pt>
                <c:pt idx="17">
                  <c:v>0.492313142118421</c:v>
                </c:pt>
                <c:pt idx="18">
                  <c:v>0.592899823342105</c:v>
                </c:pt>
                <c:pt idx="19">
                  <c:v>0.736867577673684</c:v>
                </c:pt>
                <c:pt idx="20">
                  <c:v>0.444025405144737</c:v>
                </c:pt>
                <c:pt idx="21">
                  <c:v>0.697990505726316</c:v>
                </c:pt>
                <c:pt idx="22">
                  <c:v>0.794226532592105</c:v>
                </c:pt>
                <c:pt idx="23">
                  <c:v>0.670756468118421</c:v>
                </c:pt>
                <c:pt idx="24">
                  <c:v>0.806995404210526</c:v>
                </c:pt>
                <c:pt idx="25">
                  <c:v>0.639058661986842</c:v>
                </c:pt>
                <c:pt idx="26">
                  <c:v>0.728349271855263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D$151:$D$177</c:f>
              <c:numCache>
                <c:formatCode>General</c:formatCode>
                <c:ptCount val="27"/>
                <c:pt idx="0">
                  <c:v>1.82929273E8</c:v>
                </c:pt>
                <c:pt idx="1">
                  <c:v>1.82968758E8</c:v>
                </c:pt>
                <c:pt idx="2">
                  <c:v>1.82970675E8</c:v>
                </c:pt>
                <c:pt idx="3">
                  <c:v>1.82970719E8</c:v>
                </c:pt>
                <c:pt idx="4">
                  <c:v>1.82970728E8</c:v>
                </c:pt>
                <c:pt idx="5">
                  <c:v>1.82970833E8</c:v>
                </c:pt>
                <c:pt idx="6">
                  <c:v>1.82970846E8</c:v>
                </c:pt>
                <c:pt idx="7">
                  <c:v>1.8297085E8</c:v>
                </c:pt>
                <c:pt idx="8">
                  <c:v>1.82970903E8</c:v>
                </c:pt>
                <c:pt idx="9">
                  <c:v>1.82970927E8</c:v>
                </c:pt>
                <c:pt idx="10">
                  <c:v>1.82971009E8</c:v>
                </c:pt>
                <c:pt idx="11">
                  <c:v>1.82971025E8</c:v>
                </c:pt>
                <c:pt idx="12">
                  <c:v>1.82971069E8</c:v>
                </c:pt>
                <c:pt idx="13">
                  <c:v>1.8297143E8</c:v>
                </c:pt>
                <c:pt idx="14">
                  <c:v>1.82971442E8</c:v>
                </c:pt>
                <c:pt idx="15">
                  <c:v>1.82971483E8</c:v>
                </c:pt>
                <c:pt idx="16">
                  <c:v>1.82971663E8</c:v>
                </c:pt>
                <c:pt idx="17">
                  <c:v>1.82972048E8</c:v>
                </c:pt>
                <c:pt idx="18">
                  <c:v>1.82972326E8</c:v>
                </c:pt>
                <c:pt idx="19">
                  <c:v>1.82972625E8</c:v>
                </c:pt>
                <c:pt idx="20">
                  <c:v>1.82972742E8</c:v>
                </c:pt>
                <c:pt idx="21">
                  <c:v>1.82973032E8</c:v>
                </c:pt>
                <c:pt idx="22">
                  <c:v>1.82975699E8</c:v>
                </c:pt>
                <c:pt idx="23">
                  <c:v>1.82981707E8</c:v>
                </c:pt>
                <c:pt idx="24">
                  <c:v>1.82983386E8</c:v>
                </c:pt>
                <c:pt idx="25">
                  <c:v>1.82984429E8</c:v>
                </c:pt>
                <c:pt idx="26">
                  <c:v>1.82987901E8</c:v>
                </c:pt>
              </c:numCache>
            </c:numRef>
          </c:xVal>
          <c:yVal>
            <c:numRef>
              <c:f>[1]extracteddata!$I$151:$I$177</c:f>
              <c:numCache>
                <c:formatCode>General</c:formatCode>
                <c:ptCount val="27"/>
                <c:pt idx="0">
                  <c:v>0.847803436363636</c:v>
                </c:pt>
                <c:pt idx="1">
                  <c:v>0.918981649522727</c:v>
                </c:pt>
                <c:pt idx="2">
                  <c:v>0.652751020454546</c:v>
                </c:pt>
                <c:pt idx="3">
                  <c:v>0.605490929681818</c:v>
                </c:pt>
                <c:pt idx="4">
                  <c:v>0.334349404340909</c:v>
                </c:pt>
                <c:pt idx="5">
                  <c:v>0.116287323318182</c:v>
                </c:pt>
                <c:pt idx="6">
                  <c:v>0.110235469772727</c:v>
                </c:pt>
                <c:pt idx="7">
                  <c:v>0.0894631248636364</c:v>
                </c:pt>
                <c:pt idx="8">
                  <c:v>0.087541077</c:v>
                </c:pt>
                <c:pt idx="9">
                  <c:v>0.0408427280454545</c:v>
                </c:pt>
                <c:pt idx="10">
                  <c:v>0.0683773606818182</c:v>
                </c:pt>
                <c:pt idx="11">
                  <c:v>0.0693443850432901</c:v>
                </c:pt>
                <c:pt idx="12">
                  <c:v>0.0697626940227273</c:v>
                </c:pt>
                <c:pt idx="13">
                  <c:v>0.0550372085681818</c:v>
                </c:pt>
                <c:pt idx="14">
                  <c:v>0.0642817273636364</c:v>
                </c:pt>
                <c:pt idx="15">
                  <c:v>0.0626589959090909</c:v>
                </c:pt>
                <c:pt idx="16">
                  <c:v>0.0308940970681818</c:v>
                </c:pt>
                <c:pt idx="17">
                  <c:v>0.0612401221590909</c:v>
                </c:pt>
                <c:pt idx="18">
                  <c:v>0.111828302659091</c:v>
                </c:pt>
                <c:pt idx="19">
                  <c:v>0.300146503727273</c:v>
                </c:pt>
                <c:pt idx="20">
                  <c:v>0.172045859181818</c:v>
                </c:pt>
                <c:pt idx="21">
                  <c:v>0.446077255318182</c:v>
                </c:pt>
                <c:pt idx="22">
                  <c:v>0.954559985136364</c:v>
                </c:pt>
                <c:pt idx="23">
                  <c:v>0.903158429909091</c:v>
                </c:pt>
                <c:pt idx="24">
                  <c:v>0.929922818181818</c:v>
                </c:pt>
                <c:pt idx="25">
                  <c:v>0.868005329681818</c:v>
                </c:pt>
                <c:pt idx="26">
                  <c:v>0.830743938227273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[1]extracteddata!$J$167:$J$168</c:f>
              <c:numCache>
                <c:formatCode>General</c:formatCode>
                <c:ptCount val="2"/>
                <c:pt idx="0">
                  <c:v>1.82972326E8</c:v>
                </c:pt>
                <c:pt idx="1">
                  <c:v>1.82972326E8</c:v>
                </c:pt>
              </c:numCache>
            </c:numRef>
          </c:xVal>
          <c:yVal>
            <c:numRef>
              <c:f>[1]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106280400"/>
        <c:axId val="-1376249904"/>
      </c:scatterChart>
      <c:valAx>
        <c:axId val="-1106280400"/>
        <c:scaling>
          <c:orientation val="minMax"/>
          <c:max val="1.82975326E8"/>
          <c:min val="1.82969326E8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376249904"/>
        <c:crosses val="autoZero"/>
        <c:crossBetween val="midCat"/>
        <c:majorUnit val="1000.0"/>
      </c:valAx>
      <c:valAx>
        <c:axId val="-1376249904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106280400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0743189440591808"/>
          <c:y val="0.872520706618259"/>
          <c:w val="0.851362111881638"/>
          <c:h val="0.12332094341500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28573470939973"/>
          <c:y val="0.0333262643353023"/>
          <c:w val="0.861595895732283"/>
          <c:h val="0.701453511312931"/>
        </c:manualLayout>
      </c:layout>
      <c:scatterChart>
        <c:scatterStyle val="lineMarker"/>
        <c:varyColors val="0"/>
        <c:ser>
          <c:idx val="0"/>
          <c:order val="0"/>
          <c:tx>
            <c:v>BC-Mean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extracteddata!$D$178:$D$194</c:f>
              <c:numCache>
                <c:formatCode>General</c:formatCode>
                <c:ptCount val="17"/>
                <c:pt idx="0">
                  <c:v>9.8441923E7</c:v>
                </c:pt>
                <c:pt idx="1">
                  <c:v>9.8450242E7</c:v>
                </c:pt>
                <c:pt idx="2">
                  <c:v>9.8451002E7</c:v>
                </c:pt>
                <c:pt idx="3">
                  <c:v>9.8451116E7</c:v>
                </c:pt>
                <c:pt idx="4">
                  <c:v>9.8451119E7</c:v>
                </c:pt>
                <c:pt idx="5">
                  <c:v>9.8451287E7</c:v>
                </c:pt>
                <c:pt idx="6">
                  <c:v>9.8451398E7</c:v>
                </c:pt>
                <c:pt idx="7">
                  <c:v>9.8451718E7</c:v>
                </c:pt>
                <c:pt idx="8">
                  <c:v>9.8452218E7</c:v>
                </c:pt>
                <c:pt idx="9">
                  <c:v>9.8452812E7</c:v>
                </c:pt>
                <c:pt idx="10">
                  <c:v>9.8452879E7</c:v>
                </c:pt>
                <c:pt idx="11">
                  <c:v>9.845294E7</c:v>
                </c:pt>
                <c:pt idx="12">
                  <c:v>9.8453086E7</c:v>
                </c:pt>
                <c:pt idx="13">
                  <c:v>9.8482769E7</c:v>
                </c:pt>
                <c:pt idx="14">
                  <c:v>9.8497864E7</c:v>
                </c:pt>
                <c:pt idx="15">
                  <c:v>9.8504973E7</c:v>
                </c:pt>
                <c:pt idx="16">
                  <c:v>9.851269E7</c:v>
                </c:pt>
              </c:numCache>
            </c:numRef>
          </c:xVal>
          <c:yVal>
            <c:numRef>
              <c:f>extracteddata!$F$178:$F$194</c:f>
              <c:numCache>
                <c:formatCode>General</c:formatCode>
                <c:ptCount val="17"/>
                <c:pt idx="0">
                  <c:v>0.91211474909319</c:v>
                </c:pt>
                <c:pt idx="1">
                  <c:v>0.597388829360812</c:v>
                </c:pt>
                <c:pt idx="2">
                  <c:v>0.0466071400137395</c:v>
                </c:pt>
                <c:pt idx="3">
                  <c:v>0.0551376710301673</c:v>
                </c:pt>
                <c:pt idx="4">
                  <c:v>0.0501158687311828</c:v>
                </c:pt>
                <c:pt idx="5">
                  <c:v>0.0722375178524492</c:v>
                </c:pt>
                <c:pt idx="6">
                  <c:v>0.0489826974501195</c:v>
                </c:pt>
                <c:pt idx="7">
                  <c:v>0.135210052044872</c:v>
                </c:pt>
                <c:pt idx="8">
                  <c:v>0.0651218267051971</c:v>
                </c:pt>
                <c:pt idx="9">
                  <c:v>0.333458658825866</c:v>
                </c:pt>
                <c:pt idx="10">
                  <c:v>0.227724983528375</c:v>
                </c:pt>
                <c:pt idx="11">
                  <c:v>0.291682427953405</c:v>
                </c:pt>
                <c:pt idx="12">
                  <c:v>0.354334066116487</c:v>
                </c:pt>
                <c:pt idx="13">
                  <c:v>0.504583017296296</c:v>
                </c:pt>
                <c:pt idx="14">
                  <c:v>0.377396944615591</c:v>
                </c:pt>
                <c:pt idx="15">
                  <c:v>0.615857387112007</c:v>
                </c:pt>
                <c:pt idx="16">
                  <c:v>0.844861040987157</c:v>
                </c:pt>
              </c:numCache>
            </c:numRef>
          </c:yVal>
          <c:smooth val="0"/>
        </c:ser>
        <c:ser>
          <c:idx val="1"/>
          <c:order val="1"/>
          <c:tx>
            <c:v>nonBC-Mean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extracteddata!$D$178:$D$194</c:f>
              <c:numCache>
                <c:formatCode>General</c:formatCode>
                <c:ptCount val="17"/>
                <c:pt idx="0">
                  <c:v>9.8441923E7</c:v>
                </c:pt>
                <c:pt idx="1">
                  <c:v>9.8450242E7</c:v>
                </c:pt>
                <c:pt idx="2">
                  <c:v>9.8451002E7</c:v>
                </c:pt>
                <c:pt idx="3">
                  <c:v>9.8451116E7</c:v>
                </c:pt>
                <c:pt idx="4">
                  <c:v>9.8451119E7</c:v>
                </c:pt>
                <c:pt idx="5">
                  <c:v>9.8451287E7</c:v>
                </c:pt>
                <c:pt idx="6">
                  <c:v>9.8451398E7</c:v>
                </c:pt>
                <c:pt idx="7">
                  <c:v>9.8451718E7</c:v>
                </c:pt>
                <c:pt idx="8">
                  <c:v>9.8452218E7</c:v>
                </c:pt>
                <c:pt idx="9">
                  <c:v>9.8452812E7</c:v>
                </c:pt>
                <c:pt idx="10">
                  <c:v>9.8452879E7</c:v>
                </c:pt>
                <c:pt idx="11">
                  <c:v>9.845294E7</c:v>
                </c:pt>
                <c:pt idx="12">
                  <c:v>9.8453086E7</c:v>
                </c:pt>
                <c:pt idx="13">
                  <c:v>9.8482769E7</c:v>
                </c:pt>
                <c:pt idx="14">
                  <c:v>9.8497864E7</c:v>
                </c:pt>
                <c:pt idx="15">
                  <c:v>9.8504973E7</c:v>
                </c:pt>
                <c:pt idx="16">
                  <c:v>9.851269E7</c:v>
                </c:pt>
              </c:numCache>
            </c:numRef>
          </c:xVal>
          <c:yVal>
            <c:numRef>
              <c:f>extracteddata!$G$178:$G$194</c:f>
              <c:numCache>
                <c:formatCode>General</c:formatCode>
                <c:ptCount val="17"/>
                <c:pt idx="0">
                  <c:v>0.977488637857143</c:v>
                </c:pt>
                <c:pt idx="1">
                  <c:v>0.673602657142857</c:v>
                </c:pt>
                <c:pt idx="2">
                  <c:v>0.0128862868</c:v>
                </c:pt>
                <c:pt idx="3">
                  <c:v>0.0352329664</c:v>
                </c:pt>
                <c:pt idx="4">
                  <c:v>0.028046844</c:v>
                </c:pt>
                <c:pt idx="5">
                  <c:v>0.0445701680857143</c:v>
                </c:pt>
                <c:pt idx="6">
                  <c:v>0.0216098294571429</c:v>
                </c:pt>
                <c:pt idx="7">
                  <c:v>0.126534890294118</c:v>
                </c:pt>
                <c:pt idx="8">
                  <c:v>0.0147403257714286</c:v>
                </c:pt>
                <c:pt idx="9">
                  <c:v>0.0188577899428571</c:v>
                </c:pt>
                <c:pt idx="10">
                  <c:v>0.0277552708857143</c:v>
                </c:pt>
                <c:pt idx="11">
                  <c:v>0.0320815246285714</c:v>
                </c:pt>
                <c:pt idx="12">
                  <c:v>0.0422020767142857</c:v>
                </c:pt>
                <c:pt idx="13">
                  <c:v>0.132823792</c:v>
                </c:pt>
                <c:pt idx="14">
                  <c:v>0.129204730771429</c:v>
                </c:pt>
                <c:pt idx="15">
                  <c:v>0.825444133257143</c:v>
                </c:pt>
                <c:pt idx="16">
                  <c:v>0.919468536685714</c:v>
                </c:pt>
              </c:numCache>
            </c:numRef>
          </c:yVal>
          <c:smooth val="0"/>
        </c:ser>
        <c:ser>
          <c:idx val="2"/>
          <c:order val="2"/>
          <c:tx>
            <c:v>Lum-Mean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extracteddata!$D$178:$D$194</c:f>
              <c:numCache>
                <c:formatCode>General</c:formatCode>
                <c:ptCount val="17"/>
                <c:pt idx="0">
                  <c:v>9.8441923E7</c:v>
                </c:pt>
                <c:pt idx="1">
                  <c:v>9.8450242E7</c:v>
                </c:pt>
                <c:pt idx="2">
                  <c:v>9.8451002E7</c:v>
                </c:pt>
                <c:pt idx="3">
                  <c:v>9.8451116E7</c:v>
                </c:pt>
                <c:pt idx="4">
                  <c:v>9.8451119E7</c:v>
                </c:pt>
                <c:pt idx="5">
                  <c:v>9.8451287E7</c:v>
                </c:pt>
                <c:pt idx="6">
                  <c:v>9.8451398E7</c:v>
                </c:pt>
                <c:pt idx="7">
                  <c:v>9.8451718E7</c:v>
                </c:pt>
                <c:pt idx="8">
                  <c:v>9.8452218E7</c:v>
                </c:pt>
                <c:pt idx="9">
                  <c:v>9.8452812E7</c:v>
                </c:pt>
                <c:pt idx="10">
                  <c:v>9.8452879E7</c:v>
                </c:pt>
                <c:pt idx="11">
                  <c:v>9.845294E7</c:v>
                </c:pt>
                <c:pt idx="12">
                  <c:v>9.8453086E7</c:v>
                </c:pt>
                <c:pt idx="13">
                  <c:v>9.8482769E7</c:v>
                </c:pt>
                <c:pt idx="14">
                  <c:v>9.8497864E7</c:v>
                </c:pt>
                <c:pt idx="15">
                  <c:v>9.8504973E7</c:v>
                </c:pt>
                <c:pt idx="16">
                  <c:v>9.851269E7</c:v>
                </c:pt>
              </c:numCache>
            </c:numRef>
          </c:xVal>
          <c:yVal>
            <c:numRef>
              <c:f>extracteddata!$H$178:$H$194</c:f>
              <c:numCache>
                <c:formatCode>General</c:formatCode>
                <c:ptCount val="17"/>
                <c:pt idx="0">
                  <c:v>0.829109605328948</c:v>
                </c:pt>
                <c:pt idx="1">
                  <c:v>0.555769585263158</c:v>
                </c:pt>
                <c:pt idx="2">
                  <c:v>0.0442985579684211</c:v>
                </c:pt>
                <c:pt idx="3">
                  <c:v>0.0601672194447368</c:v>
                </c:pt>
                <c:pt idx="4">
                  <c:v>0.049327693331579</c:v>
                </c:pt>
                <c:pt idx="5">
                  <c:v>0.0566689183394737</c:v>
                </c:pt>
                <c:pt idx="6">
                  <c:v>0.0320610788868421</c:v>
                </c:pt>
                <c:pt idx="7">
                  <c:v>0.138011155648649</c:v>
                </c:pt>
                <c:pt idx="8">
                  <c:v>0.0673682759105263</c:v>
                </c:pt>
                <c:pt idx="9">
                  <c:v>0.420461184528947</c:v>
                </c:pt>
                <c:pt idx="10">
                  <c:v>0.190993856647368</c:v>
                </c:pt>
                <c:pt idx="11">
                  <c:v>0.172656778368421</c:v>
                </c:pt>
                <c:pt idx="12">
                  <c:v>0.135336132315789</c:v>
                </c:pt>
                <c:pt idx="13">
                  <c:v>0.324085462755263</c:v>
                </c:pt>
                <c:pt idx="14">
                  <c:v>0.358748807781579</c:v>
                </c:pt>
                <c:pt idx="15">
                  <c:v>0.353196330763158</c:v>
                </c:pt>
                <c:pt idx="16">
                  <c:v>0.813984336097368</c:v>
                </c:pt>
              </c:numCache>
            </c:numRef>
          </c:yVal>
          <c:smooth val="0"/>
        </c:ser>
        <c:ser>
          <c:idx val="3"/>
          <c:order val="3"/>
          <c:tx>
            <c:v>TN-Mean</c:v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D$178:$D$194</c:f>
              <c:numCache>
                <c:formatCode>General</c:formatCode>
                <c:ptCount val="17"/>
                <c:pt idx="0">
                  <c:v>9.8441923E7</c:v>
                </c:pt>
                <c:pt idx="1">
                  <c:v>9.8450242E7</c:v>
                </c:pt>
                <c:pt idx="2">
                  <c:v>9.8451002E7</c:v>
                </c:pt>
                <c:pt idx="3">
                  <c:v>9.8451116E7</c:v>
                </c:pt>
                <c:pt idx="4">
                  <c:v>9.8451119E7</c:v>
                </c:pt>
                <c:pt idx="5">
                  <c:v>9.8451287E7</c:v>
                </c:pt>
                <c:pt idx="6">
                  <c:v>9.8451398E7</c:v>
                </c:pt>
                <c:pt idx="7">
                  <c:v>9.8451718E7</c:v>
                </c:pt>
                <c:pt idx="8">
                  <c:v>9.8452218E7</c:v>
                </c:pt>
                <c:pt idx="9">
                  <c:v>9.8452812E7</c:v>
                </c:pt>
                <c:pt idx="10">
                  <c:v>9.8452879E7</c:v>
                </c:pt>
                <c:pt idx="11">
                  <c:v>9.845294E7</c:v>
                </c:pt>
                <c:pt idx="12">
                  <c:v>9.8453086E7</c:v>
                </c:pt>
                <c:pt idx="13">
                  <c:v>9.8482769E7</c:v>
                </c:pt>
                <c:pt idx="14">
                  <c:v>9.8497864E7</c:v>
                </c:pt>
                <c:pt idx="15">
                  <c:v>9.8504973E7</c:v>
                </c:pt>
                <c:pt idx="16">
                  <c:v>9.851269E7</c:v>
                </c:pt>
              </c:numCache>
            </c:numRef>
          </c:xVal>
          <c:yVal>
            <c:numRef>
              <c:f>extracteddata!$I$178:$I$194</c:f>
              <c:numCache>
                <c:formatCode>General</c:formatCode>
                <c:ptCount val="17"/>
                <c:pt idx="0">
                  <c:v>0.927282907613636</c:v>
                </c:pt>
                <c:pt idx="1">
                  <c:v>0.5970784</c:v>
                </c:pt>
                <c:pt idx="2">
                  <c:v>0.0396011640227273</c:v>
                </c:pt>
                <c:pt idx="3">
                  <c:v>0.0371079523409091</c:v>
                </c:pt>
                <c:pt idx="4">
                  <c:v>0.0394129505454545</c:v>
                </c:pt>
                <c:pt idx="5">
                  <c:v>0.0603177034772727</c:v>
                </c:pt>
                <c:pt idx="6">
                  <c:v>0.0421038176136364</c:v>
                </c:pt>
                <c:pt idx="7">
                  <c:v>0.12059351997619</c:v>
                </c:pt>
                <c:pt idx="8">
                  <c:v>0.0485621820909091</c:v>
                </c:pt>
                <c:pt idx="9">
                  <c:v>0.304559143590909</c:v>
                </c:pt>
                <c:pt idx="10">
                  <c:v>0.252841412272727</c:v>
                </c:pt>
                <c:pt idx="11">
                  <c:v>0.381048581818182</c:v>
                </c:pt>
                <c:pt idx="12">
                  <c:v>0.490692209454545</c:v>
                </c:pt>
                <c:pt idx="13">
                  <c:v>0.635725547477273</c:v>
                </c:pt>
                <c:pt idx="14">
                  <c:v>0.348912912909091</c:v>
                </c:pt>
                <c:pt idx="15">
                  <c:v>0.804564534840909</c:v>
                </c:pt>
                <c:pt idx="16">
                  <c:v>0.844663431</c:v>
                </c:pt>
              </c:numCache>
            </c:numRef>
          </c:yVal>
          <c:smooth val="0"/>
        </c:ser>
        <c:ser>
          <c:idx val="5"/>
          <c:order val="4"/>
          <c:tx>
            <c:v>probe-position</c:v>
          </c:tx>
          <c:spPr>
            <a:ln w="1905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extracteddata!$J$188:$J$189</c:f>
              <c:numCache>
                <c:formatCode>General</c:formatCode>
                <c:ptCount val="2"/>
                <c:pt idx="0">
                  <c:v>9.8453086E7</c:v>
                </c:pt>
                <c:pt idx="1">
                  <c:v>9.8453086E7</c:v>
                </c:pt>
              </c:numCache>
            </c:numRef>
          </c:xVal>
          <c:yVal>
            <c:numRef>
              <c:f>extracteddata!$K$2:$K$3</c:f>
              <c:numCache>
                <c:formatCode>General</c:formatCode>
                <c:ptCount val="2"/>
                <c:pt idx="0">
                  <c:v>0.0</c:v>
                </c:pt>
                <c:pt idx="1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106319808"/>
        <c:axId val="-1347811600"/>
      </c:scatterChart>
      <c:valAx>
        <c:axId val="-1106319808"/>
        <c:scaling>
          <c:orientation val="minMax"/>
          <c:max val="9.8456086E7"/>
          <c:min val="9.8450086E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347811600"/>
        <c:crosses val="autoZero"/>
        <c:crossBetween val="midCat"/>
        <c:majorUnit val="1000.0"/>
      </c:valAx>
      <c:valAx>
        <c:axId val="-134781160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Verdana" charset="0"/>
                <a:ea typeface="+mn-ea"/>
                <a:cs typeface="+mn-cs"/>
              </a:defRPr>
            </a:pPr>
            <a:endParaRPr lang="ja-JP"/>
          </a:p>
        </c:txPr>
        <c:crossAx val="-1106319808"/>
        <c:crosses val="autoZero"/>
        <c:crossBetween val="midCat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0743189440591808"/>
          <c:y val="0.875184257270871"/>
          <c:w val="0.851362111881638"/>
          <c:h val="0.1248157427291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Verdana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aseline="0">
          <a:latin typeface="Verdana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C6D07C-D377-45EF-8E27-9913C1D20A6B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0ED9E0-1DE8-405E-B69B-162C5FFCE1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0507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8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9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2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ED9E0-1DE8-405E-B69B-162C5FFCE1AB}" type="slidenum">
              <a:rPr kumimoji="1" lang="ja-JP" altLang="en-US" smtClean="0"/>
              <a:t>1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5732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sz="1200" dirty="0" smtClean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ED9E0-1DE8-405E-B69B-162C5FFCE1AB}" type="slidenum">
              <a:rPr kumimoji="1" lang="ja-JP" altLang="en-US" smtClean="0"/>
              <a:t>1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52198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baseline="0" dirty="0" smtClean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ED9E0-1DE8-405E-B69B-162C5FFCE1AB}" type="slidenum">
              <a:rPr kumimoji="1" lang="ja-JP" altLang="en-US" smtClean="0"/>
              <a:t>1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7879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baseline="0" dirty="0" smtClean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ED9E0-1DE8-405E-B69B-162C5FFCE1AB}" type="slidenum">
              <a:rPr kumimoji="1" lang="ja-JP" altLang="en-US" smtClean="0"/>
              <a:t>1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8919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ED9E0-1DE8-405E-B69B-162C5FFCE1AB}" type="slidenum">
              <a:rPr kumimoji="1" lang="ja-JP" altLang="en-US" smtClean="0"/>
              <a:t>2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68909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ED9E0-1DE8-405E-B69B-162C5FFCE1AB}" type="slidenum">
              <a:rPr kumimoji="1" lang="ja-JP" altLang="en-US" smtClean="0"/>
              <a:t>2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4428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0ED9E0-1DE8-405E-B69B-162C5FFCE1AB}" type="slidenum">
              <a:rPr kumimoji="1" lang="ja-JP" altLang="en-US" smtClean="0"/>
              <a:t>2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3113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7996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949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6967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34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2933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223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1480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641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6608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360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341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B638B0-61E2-4040-9A78-D6FBA20D6FEF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174669-2390-4790-881E-4A31DF5B7C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4615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Relationship Id="rId3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tiff"/><Relationship Id="rId3" Type="http://schemas.openxmlformats.org/officeDocument/2006/relationships/chart" Target="../charts/char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8.xml"/><Relationship Id="rId3" Type="http://schemas.openxmlformats.org/officeDocument/2006/relationships/image" Target="../media/image12.tif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tiff"/><Relationship Id="rId3" Type="http://schemas.openxmlformats.org/officeDocument/2006/relationships/chart" Target="../charts/chart9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tiff"/><Relationship Id="rId3" Type="http://schemas.openxmlformats.org/officeDocument/2006/relationships/chart" Target="../charts/chart10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1.xml"/><Relationship Id="rId3" Type="http://schemas.openxmlformats.org/officeDocument/2006/relationships/image" Target="../media/image15.tif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2.xml"/><Relationship Id="rId3" Type="http://schemas.openxmlformats.org/officeDocument/2006/relationships/image" Target="../media/image16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4" Type="http://schemas.openxmlformats.org/officeDocument/2006/relationships/image" Target="../media/image18.jpeg"/><Relationship Id="rId5" Type="http://schemas.openxmlformats.org/officeDocument/2006/relationships/image" Target="../media/image19.jpeg"/><Relationship Id="rId6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4" Type="http://schemas.openxmlformats.org/officeDocument/2006/relationships/image" Target="../media/image22.jpeg"/><Relationship Id="rId5" Type="http://schemas.openxmlformats.org/officeDocument/2006/relationships/image" Target="../media/image23.jpeg"/><Relationship Id="rId6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chart" Target="../charts/chart13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25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4" Type="http://schemas.openxmlformats.org/officeDocument/2006/relationships/image" Target="../media/image27.emf"/><Relationship Id="rId5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4" Type="http://schemas.openxmlformats.org/officeDocument/2006/relationships/image" Target="../media/image31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9.tif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Relationship Id="rId3" Type="http://schemas.openxmlformats.org/officeDocument/2006/relationships/chart" Target="../charts/chart14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4" Type="http://schemas.openxmlformats.org/officeDocument/2006/relationships/image" Target="../media/image34.emf"/><Relationship Id="rId5" Type="http://schemas.openxmlformats.org/officeDocument/2006/relationships/image" Target="../media/image35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2.emf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eg"/><Relationship Id="rId4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7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8.emf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9.png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0.pn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1.emf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9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tif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2.emf"/><Relationship Id="rId3" Type="http://schemas.openxmlformats.org/officeDocument/2006/relationships/image" Target="../media/image4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tiff"/><Relationship Id="rId3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tiff"/><Relationship Id="rId3" Type="http://schemas.openxmlformats.org/officeDocument/2006/relationships/chart" Target="../charts/char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3.xml"/><Relationship Id="rId3" Type="http://schemas.openxmlformats.org/officeDocument/2006/relationships/image" Target="../media/image7.tif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4.xml"/><Relationship Id="rId3" Type="http://schemas.openxmlformats.org/officeDocument/2006/relationships/image" Target="../media/image8.tif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5.xml"/><Relationship Id="rId3" Type="http://schemas.openxmlformats.org/officeDocument/2006/relationships/image" Target="../media/image9.tif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6.xml"/><Relationship Id="rId3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3141" y="1806767"/>
            <a:ext cx="4493730" cy="3357384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5007" y="1806766"/>
            <a:ext cx="4493730" cy="3357385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387626" y="242010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1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967698" y="1437434"/>
            <a:ext cx="2330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Before microdissection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489073" y="1437954"/>
            <a:ext cx="2185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fter microdissection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52579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91440" y="126057"/>
            <a:ext cx="2502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G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 flipV="1">
            <a:off x="4023360" y="3571012"/>
            <a:ext cx="2788920" cy="1788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6078436" y="3263235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440" y="433014"/>
            <a:ext cx="3519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Luminal-dominant marker: </a:t>
            </a:r>
            <a:r>
              <a:rPr kumimoji="1" lang="en-US" altLang="ja-JP" dirty="0" smtClean="0"/>
              <a:t>HOXA10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2925" t="9975"/>
          <a:stretch/>
        </p:blipFill>
        <p:spPr>
          <a:xfrm>
            <a:off x="164592" y="798345"/>
            <a:ext cx="11329416" cy="2504609"/>
          </a:xfrm>
          <a:prstGeom prst="rect">
            <a:avLst/>
          </a:prstGeom>
        </p:spPr>
      </p:pic>
      <p:graphicFrame>
        <p:nvGraphicFramePr>
          <p:cNvPr id="10" name="グラフ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4149549"/>
              </p:ext>
            </p:extLst>
          </p:nvPr>
        </p:nvGraphicFramePr>
        <p:xfrm>
          <a:off x="320040" y="3672000"/>
          <a:ext cx="11871960" cy="30834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6911483" y="3404226"/>
            <a:ext cx="1891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337738" y="3610129"/>
            <a:ext cx="601396" cy="16342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5388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2941581"/>
              </p:ext>
            </p:extLst>
          </p:nvPr>
        </p:nvGraphicFramePr>
        <p:xfrm>
          <a:off x="292608" y="3570299"/>
          <a:ext cx="11804904" cy="3205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91440" y="126057"/>
            <a:ext cx="250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H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3913632" y="3539482"/>
            <a:ext cx="2569464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5621236" y="3263235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440" y="433014"/>
            <a:ext cx="3509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Luminal-dominant marker: </a:t>
            </a:r>
            <a:r>
              <a:rPr kumimoji="1" lang="en-US" altLang="ja-JP" dirty="0" smtClean="0"/>
              <a:t>B3GNT5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3744" t="10848"/>
          <a:stretch/>
        </p:blipFill>
        <p:spPr>
          <a:xfrm>
            <a:off x="173736" y="762733"/>
            <a:ext cx="11301984" cy="2540222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>
            <a:off x="6773581" y="336761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291071" y="3571012"/>
            <a:ext cx="540653" cy="102876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61563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91440" y="126057"/>
            <a:ext cx="2414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I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5937866" y="3528972"/>
            <a:ext cx="517798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5895556" y="3221195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440" y="433014"/>
            <a:ext cx="30896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TN-dominant marker: </a:t>
            </a:r>
            <a:r>
              <a:rPr kumimoji="1" lang="en-US" altLang="ja-JP" dirty="0" smtClean="0"/>
              <a:t>ST3GAL6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1875" t="4905"/>
          <a:stretch/>
        </p:blipFill>
        <p:spPr>
          <a:xfrm>
            <a:off x="173736" y="781433"/>
            <a:ext cx="11219688" cy="2502821"/>
          </a:xfrm>
          <a:prstGeom prst="rect">
            <a:avLst/>
          </a:prstGeom>
        </p:spPr>
      </p:pic>
      <p:graphicFrame>
        <p:nvGraphicFramePr>
          <p:cNvPr id="10" name="グラフ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6433875"/>
              </p:ext>
            </p:extLst>
          </p:nvPr>
        </p:nvGraphicFramePr>
        <p:xfrm>
          <a:off x="301752" y="3570298"/>
          <a:ext cx="11804904" cy="31505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6731541" y="336761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274675" y="3584029"/>
            <a:ext cx="504000" cy="8408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747351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91440" y="126057"/>
            <a:ext cx="2430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J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5937866" y="3592032"/>
            <a:ext cx="517798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5895556" y="3284255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440" y="433014"/>
            <a:ext cx="2917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TN-dominant marker: </a:t>
            </a:r>
            <a:r>
              <a:rPr kumimoji="1" lang="en-US" altLang="ja-JP" dirty="0" smtClean="0"/>
              <a:t>DACH1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/>
          <a:srcRect l="3750" t="11203"/>
          <a:stretch/>
        </p:blipFill>
        <p:spPr>
          <a:xfrm>
            <a:off x="155448" y="789063"/>
            <a:ext cx="11237976" cy="2495191"/>
          </a:xfrm>
          <a:prstGeom prst="rect">
            <a:avLst/>
          </a:prstGeom>
        </p:spPr>
      </p:pic>
      <p:graphicFrame>
        <p:nvGraphicFramePr>
          <p:cNvPr id="11" name="グラフ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4559904"/>
              </p:ext>
            </p:extLst>
          </p:nvPr>
        </p:nvGraphicFramePr>
        <p:xfrm>
          <a:off x="246888" y="3701406"/>
          <a:ext cx="11850624" cy="3083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6689501" y="343067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253657" y="3636362"/>
            <a:ext cx="468000" cy="174156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148303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グラフ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6813781"/>
              </p:ext>
            </p:extLst>
          </p:nvPr>
        </p:nvGraphicFramePr>
        <p:xfrm>
          <a:off x="265176" y="3284254"/>
          <a:ext cx="11823192" cy="34823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91440" y="126057"/>
            <a:ext cx="24770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K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6084170" y="3219442"/>
            <a:ext cx="435502" cy="156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6041860" y="2911665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440" y="433014"/>
            <a:ext cx="2860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TN-dominant marker: </a:t>
            </a:r>
            <a:r>
              <a:rPr kumimoji="1" lang="en-US" altLang="ja-JP" dirty="0" smtClean="0"/>
              <a:t>P2RX3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/>
          <a:srcRect l="4200" t="13680"/>
          <a:stretch/>
        </p:blipFill>
        <p:spPr>
          <a:xfrm>
            <a:off x="155448" y="737252"/>
            <a:ext cx="11210544" cy="2194947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6836643" y="2999757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249540" y="3219442"/>
            <a:ext cx="624226" cy="164423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04683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0468356"/>
              </p:ext>
            </p:extLst>
          </p:nvPr>
        </p:nvGraphicFramePr>
        <p:xfrm>
          <a:off x="283464" y="3271992"/>
          <a:ext cx="11908536" cy="35860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91440" y="126057"/>
            <a:ext cx="24545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L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5449824" y="3250972"/>
            <a:ext cx="1069848" cy="156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5758396" y="2943195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440" y="433014"/>
            <a:ext cx="3677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"/>
            <a:r>
              <a:rPr lang="en-US" altLang="ja-JP" dirty="0" smtClean="0"/>
              <a:t>TN-dominant marker: chr8:23572595</a:t>
            </a:r>
            <a:endParaRPr lang="cs-CZ" altLang="ja-JP" dirty="0">
              <a:solidFill>
                <a:srgbClr val="00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3600" t="10937"/>
          <a:stretch/>
        </p:blipFill>
        <p:spPr>
          <a:xfrm>
            <a:off x="182880" y="802346"/>
            <a:ext cx="11192256" cy="2126488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>
            <a:off x="6868174" y="3020773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281070" y="3250972"/>
            <a:ext cx="634737" cy="12237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5814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1200" y="3763193"/>
            <a:ext cx="5663184" cy="3090672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47" y="672521"/>
            <a:ext cx="5672328" cy="3090672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8152" y="672521"/>
            <a:ext cx="5669280" cy="3090672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47" y="3763193"/>
            <a:ext cx="5672328" cy="3090672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387626" y="24201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4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07367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041" y="3540744"/>
            <a:ext cx="4481779" cy="2472538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041" y="833879"/>
            <a:ext cx="4481779" cy="2472538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819" y="833879"/>
            <a:ext cx="4481779" cy="2472538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819" y="3540744"/>
            <a:ext cx="4481780" cy="2472538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387626" y="24201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5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32413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9274937"/>
              </p:ext>
            </p:extLst>
          </p:nvPr>
        </p:nvGraphicFramePr>
        <p:xfrm>
          <a:off x="462455" y="1825625"/>
          <a:ext cx="10891345" cy="48541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387626" y="24201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6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10968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55711" y="36032"/>
            <a:ext cx="2489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7</a:t>
            </a:r>
            <a:r>
              <a:rPr lang="en-US" altLang="ja-JP" dirty="0" smtClean="0"/>
              <a:t>-A</a:t>
            </a:r>
            <a:endParaRPr kumimoji="1" lang="ja-JP" altLang="en-US" dirty="0"/>
          </a:p>
        </p:txBody>
      </p:sp>
      <p:grpSp>
        <p:nvGrpSpPr>
          <p:cNvPr id="21" name="図形グループ 20"/>
          <p:cNvGrpSpPr/>
          <p:nvPr/>
        </p:nvGrpSpPr>
        <p:grpSpPr>
          <a:xfrm>
            <a:off x="110035" y="5302847"/>
            <a:ext cx="1427819" cy="1292796"/>
            <a:chOff x="692239" y="1978095"/>
            <a:chExt cx="1984079" cy="1333540"/>
          </a:xfrm>
        </p:grpSpPr>
        <p:grpSp>
          <p:nvGrpSpPr>
            <p:cNvPr id="18" name="図形グループ 17"/>
            <p:cNvGrpSpPr/>
            <p:nvPr/>
          </p:nvGrpSpPr>
          <p:grpSpPr>
            <a:xfrm>
              <a:off x="987477" y="1978095"/>
              <a:ext cx="1688841" cy="1082346"/>
              <a:chOff x="3415004" y="363899"/>
              <a:chExt cx="1688841" cy="1082346"/>
            </a:xfrm>
          </p:grpSpPr>
          <p:cxnSp>
            <p:nvCxnSpPr>
              <p:cNvPr id="15" name="直線コネクタ 14"/>
              <p:cNvCxnSpPr/>
              <p:nvPr/>
            </p:nvCxnSpPr>
            <p:spPr>
              <a:xfrm>
                <a:off x="3415004" y="363899"/>
                <a:ext cx="0" cy="108234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コネクタ 16"/>
              <p:cNvCxnSpPr/>
              <p:nvPr/>
            </p:nvCxnSpPr>
            <p:spPr>
              <a:xfrm>
                <a:off x="3415004" y="1446245"/>
                <a:ext cx="168884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テキスト ボックス 18"/>
            <p:cNvSpPr txBox="1"/>
            <p:nvPr/>
          </p:nvSpPr>
          <p:spPr>
            <a:xfrm>
              <a:off x="1005933" y="3041780"/>
              <a:ext cx="1670385" cy="2698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1100" b="1" dirty="0" smtClean="0">
                  <a:latin typeface="Meiryo" charset="-128"/>
                  <a:ea typeface="Meiryo" charset="-128"/>
                  <a:cs typeface="Meiryo" charset="-128"/>
                </a:rPr>
                <a:t>１−</a:t>
              </a:r>
              <a:r>
                <a:rPr kumimoji="1" lang="en-US" altLang="ja-JP" sz="1100" b="1" dirty="0" smtClean="0">
                  <a:latin typeface="Meiryo" charset="-128"/>
                  <a:ea typeface="Meiryo" charset="-128"/>
                  <a:cs typeface="Meiryo" charset="-128"/>
                </a:rPr>
                <a:t>Specificity</a:t>
              </a:r>
              <a:endParaRPr kumimoji="1" lang="ja-JP" altLang="en-US" sz="1100" b="1" dirty="0">
                <a:latin typeface="Meiryo" charset="-128"/>
                <a:ea typeface="Meiryo" charset="-128"/>
                <a:cs typeface="Meiryo" charset="-128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 rot="16200000">
              <a:off x="341983" y="2394156"/>
              <a:ext cx="962123" cy="2616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 smtClean="0">
                  <a:latin typeface="Meiryo" charset="-128"/>
                  <a:ea typeface="Meiryo" charset="-128"/>
                  <a:cs typeface="Meiryo" charset="-128"/>
                </a:rPr>
                <a:t>Sensitivity</a:t>
              </a:r>
              <a:endParaRPr kumimoji="1" lang="ja-JP" altLang="en-US" sz="1100" b="1" dirty="0">
                <a:latin typeface="Meiryo" charset="-128"/>
                <a:ea typeface="Meiryo" charset="-128"/>
                <a:cs typeface="Meiryo" charset="-128"/>
              </a:endParaRPr>
            </a:p>
          </p:txBody>
        </p:sp>
      </p:grp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3"/>
          <a:srcRect l="7977" t="3975" r="5952" b="5380"/>
          <a:stretch/>
        </p:blipFill>
        <p:spPr>
          <a:xfrm>
            <a:off x="2811099" y="218867"/>
            <a:ext cx="9362954" cy="6682274"/>
          </a:xfrm>
          <a:prstGeom prst="rect">
            <a:avLst/>
          </a:prstGeom>
        </p:spPr>
      </p:pic>
      <p:sp>
        <p:nvSpPr>
          <p:cNvPr id="3" name="正方形/長方形 2"/>
          <p:cNvSpPr/>
          <p:nvPr/>
        </p:nvSpPr>
        <p:spPr>
          <a:xfrm>
            <a:off x="2975276" y="1790796"/>
            <a:ext cx="9050693" cy="1679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/>
          <p:cNvSpPr/>
          <p:nvPr/>
        </p:nvSpPr>
        <p:spPr>
          <a:xfrm>
            <a:off x="2967229" y="3400194"/>
            <a:ext cx="9050693" cy="1554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2959182" y="5001431"/>
            <a:ext cx="9050693" cy="1866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2951135" y="6660783"/>
            <a:ext cx="9050693" cy="1866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/>
          <p:cNvSpPr/>
          <p:nvPr/>
        </p:nvSpPr>
        <p:spPr>
          <a:xfrm>
            <a:off x="2827192" y="503171"/>
            <a:ext cx="269382" cy="59342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/>
          <p:cNvSpPr/>
          <p:nvPr/>
        </p:nvSpPr>
        <p:spPr>
          <a:xfrm>
            <a:off x="5139979" y="521838"/>
            <a:ext cx="207751" cy="59342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/>
          <p:cNvSpPr/>
          <p:nvPr/>
        </p:nvSpPr>
        <p:spPr>
          <a:xfrm>
            <a:off x="7359456" y="540505"/>
            <a:ext cx="207751" cy="59342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/>
          <p:cNvSpPr/>
          <p:nvPr/>
        </p:nvSpPr>
        <p:spPr>
          <a:xfrm>
            <a:off x="9684324" y="3752033"/>
            <a:ext cx="144000" cy="28356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/>
          <p:cNvSpPr/>
          <p:nvPr/>
        </p:nvSpPr>
        <p:spPr>
          <a:xfrm>
            <a:off x="9628903" y="446345"/>
            <a:ext cx="202919" cy="28356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/>
          <p:cNvSpPr/>
          <p:nvPr/>
        </p:nvSpPr>
        <p:spPr>
          <a:xfrm>
            <a:off x="1564853" y="818494"/>
            <a:ext cx="119616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Common BC </a:t>
            </a:r>
          </a:p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markers</a:t>
            </a:r>
            <a:endParaRPr lang="ja-JP" altLang="en-US" sz="1200" dirty="0"/>
          </a:p>
        </p:txBody>
      </p:sp>
      <p:sp>
        <p:nvSpPr>
          <p:cNvPr id="26" name="正方形/長方形 25"/>
          <p:cNvSpPr/>
          <p:nvPr/>
        </p:nvSpPr>
        <p:spPr>
          <a:xfrm>
            <a:off x="1564853" y="2427728"/>
            <a:ext cx="15905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Luminal-dominant</a:t>
            </a:r>
          </a:p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markers</a:t>
            </a:r>
            <a:endParaRPr lang="ja-JP" altLang="en-US" sz="1200" dirty="0"/>
          </a:p>
        </p:txBody>
      </p:sp>
      <p:sp>
        <p:nvSpPr>
          <p:cNvPr id="27" name="正方形/長方形 26"/>
          <p:cNvSpPr/>
          <p:nvPr/>
        </p:nvSpPr>
        <p:spPr>
          <a:xfrm>
            <a:off x="1564853" y="4049144"/>
            <a:ext cx="124906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TN-dominant </a:t>
            </a:r>
            <a:endParaRPr lang="en-US" altLang="ja-JP" sz="1200" dirty="0" smtClean="0">
              <a:latin typeface="Verdana" panose="020B060403050404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markers</a:t>
            </a:r>
            <a:endParaRPr lang="ja-JP" altLang="en-US" sz="1200" dirty="0"/>
          </a:p>
        </p:txBody>
      </p:sp>
      <p:sp>
        <p:nvSpPr>
          <p:cNvPr id="13" name="正方形/長方形 12"/>
          <p:cNvSpPr/>
          <p:nvPr/>
        </p:nvSpPr>
        <p:spPr>
          <a:xfrm>
            <a:off x="9738058" y="3548187"/>
            <a:ext cx="2226479" cy="1358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正方形/長方形 1"/>
          <p:cNvSpPr/>
          <p:nvPr/>
        </p:nvSpPr>
        <p:spPr>
          <a:xfrm>
            <a:off x="1564853" y="5657014"/>
            <a:ext cx="14382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Internal </a:t>
            </a:r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control</a:t>
            </a:r>
            <a:r>
              <a:rPr lang="ja-JP" altLang="en-US" sz="1200" dirty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  <a:endParaRPr lang="en-US" altLang="ja-JP" sz="1200" dirty="0" smtClean="0">
              <a:latin typeface="Verdana" panose="020B060403050404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markers</a:t>
            </a:r>
            <a:endParaRPr lang="ja-JP" altLang="en-US" sz="1200" dirty="0"/>
          </a:p>
        </p:txBody>
      </p:sp>
      <p:sp>
        <p:nvSpPr>
          <p:cNvPr id="28" name="正方形/長方形 27"/>
          <p:cNvSpPr/>
          <p:nvPr/>
        </p:nvSpPr>
        <p:spPr>
          <a:xfrm>
            <a:off x="10181250" y="3594325"/>
            <a:ext cx="1114548" cy="1358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9591087" y="3551086"/>
            <a:ext cx="2628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40"/>
              </a:lnSpc>
            </a:pPr>
            <a:r>
              <a:rPr lang="en-US" altLang="ja-JP" sz="950" b="1" dirty="0" smtClean="0">
                <a:latin typeface="Courier" charset="0"/>
                <a:ea typeface="Courier" charset="0"/>
                <a:cs typeface="Courier" charset="0"/>
              </a:rPr>
              <a:t>Gene:chr8:23572595</a:t>
            </a:r>
            <a:r>
              <a:rPr lang="ja-JP" altLang="en-US" sz="950" b="1" dirty="0">
                <a:latin typeface="Courier" charset="0"/>
                <a:ea typeface="Courier" charset="0"/>
                <a:cs typeface="Courier" charset="0"/>
              </a:rPr>
              <a:t> </a:t>
            </a:r>
            <a:r>
              <a:rPr lang="en-US" altLang="ja-JP" sz="950" b="1" dirty="0" smtClean="0">
                <a:latin typeface="Courier" charset="0"/>
                <a:ea typeface="Courier" charset="0"/>
                <a:cs typeface="Courier" charset="0"/>
              </a:rPr>
              <a:t>, AUC =0.65489.</a:t>
            </a:r>
            <a:endParaRPr kumimoji="1" lang="ja-JP" altLang="en-US" sz="950" b="1" dirty="0">
              <a:latin typeface="Courier" charset="0"/>
              <a:ea typeface="Courier" charset="0"/>
              <a:cs typeface="Courier" charset="0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>
            <a:off x="1469204" y="1856971"/>
            <a:ext cx="1050560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1469204" y="3481954"/>
            <a:ext cx="1050560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1469204" y="5106937"/>
            <a:ext cx="10505607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1754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87627" y="242010"/>
            <a:ext cx="26765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l Figure 2-A</a:t>
            </a: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07" t="5223" r="6539" b="9043"/>
          <a:stretch/>
        </p:blipFill>
        <p:spPr>
          <a:xfrm flipV="1">
            <a:off x="2940943" y="1286456"/>
            <a:ext cx="8356059" cy="4666871"/>
          </a:xfrm>
          <a:prstGeom prst="rect">
            <a:avLst/>
          </a:prstGeom>
        </p:spPr>
      </p:pic>
      <p:grpSp>
        <p:nvGrpSpPr>
          <p:cNvPr id="11" name="図形グループ 10"/>
          <p:cNvGrpSpPr/>
          <p:nvPr/>
        </p:nvGrpSpPr>
        <p:grpSpPr>
          <a:xfrm>
            <a:off x="3020993" y="5890265"/>
            <a:ext cx="7999105" cy="218874"/>
            <a:chOff x="137720" y="773719"/>
            <a:chExt cx="12818030" cy="512737"/>
          </a:xfrm>
        </p:grpSpPr>
        <p:sp>
          <p:nvSpPr>
            <p:cNvPr id="5" name="正方形/長方形 4"/>
            <p:cNvSpPr/>
            <p:nvPr/>
          </p:nvSpPr>
          <p:spPr>
            <a:xfrm>
              <a:off x="137720" y="773723"/>
              <a:ext cx="3888000" cy="512733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4025721" y="773722"/>
              <a:ext cx="1655999" cy="512733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正方形/長方形 6"/>
            <p:cNvSpPr/>
            <p:nvPr/>
          </p:nvSpPr>
          <p:spPr>
            <a:xfrm>
              <a:off x="5681720" y="773721"/>
              <a:ext cx="503999" cy="512733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正方形/長方形 7"/>
            <p:cNvSpPr/>
            <p:nvPr/>
          </p:nvSpPr>
          <p:spPr>
            <a:xfrm>
              <a:off x="6185719" y="773719"/>
              <a:ext cx="180000" cy="512733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/>
            <p:cNvSpPr/>
            <p:nvPr/>
          </p:nvSpPr>
          <p:spPr>
            <a:xfrm>
              <a:off x="6367750" y="773719"/>
              <a:ext cx="1440000" cy="512733"/>
            </a:xfrm>
            <a:prstGeom prst="rect">
              <a:avLst/>
            </a:prstGeom>
            <a:solidFill>
              <a:srgbClr val="B34F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正方形/長方形 9"/>
            <p:cNvSpPr/>
            <p:nvPr/>
          </p:nvSpPr>
          <p:spPr>
            <a:xfrm>
              <a:off x="7807750" y="773719"/>
              <a:ext cx="5148000" cy="512733"/>
            </a:xfrm>
            <a:prstGeom prst="rect">
              <a:avLst/>
            </a:prstGeom>
            <a:solidFill>
              <a:srgbClr val="FF2D7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2" name="テキスト ボックス 11"/>
          <p:cNvSpPr txBox="1"/>
          <p:nvPr/>
        </p:nvSpPr>
        <p:spPr>
          <a:xfrm>
            <a:off x="3772276" y="5888421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Meiryo" charset="-128"/>
                <a:ea typeface="Meiryo" charset="-128"/>
                <a:cs typeface="Meiryo" charset="-128"/>
              </a:rPr>
              <a:t>Luminal A</a:t>
            </a:r>
            <a:endParaRPr kumimoji="1" lang="ja-JP" altLang="en-US" sz="12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512375" y="5888421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Meiryo" charset="-128"/>
                <a:ea typeface="Meiryo" charset="-128"/>
                <a:cs typeface="Meiryo" charset="-128"/>
              </a:rPr>
              <a:t>Luminal B</a:t>
            </a:r>
            <a:endParaRPr kumimoji="1" lang="ja-JP" altLang="en-US" sz="12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558048" y="6236283"/>
            <a:ext cx="1301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Meiryo" charset="-128"/>
                <a:ea typeface="Meiryo" charset="-128"/>
                <a:cs typeface="Meiryo" charset="-128"/>
              </a:rPr>
              <a:t>HER2-enriched</a:t>
            </a:r>
            <a:endParaRPr kumimoji="1" lang="ja-JP" altLang="en-US" sz="12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854333" y="6236283"/>
            <a:ext cx="10458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smtClean="0">
                <a:latin typeface="Meiryo" charset="-128"/>
                <a:ea typeface="Meiryo" charset="-128"/>
                <a:cs typeface="Meiryo" charset="-128"/>
              </a:rPr>
              <a:t>Normal-like</a:t>
            </a:r>
            <a:endParaRPr kumimoji="1" lang="ja-JP" altLang="en-US" sz="12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906859" y="5877148"/>
            <a:ext cx="899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>
                <a:latin typeface="Meiryo" charset="-128"/>
                <a:ea typeface="Meiryo" charset="-128"/>
                <a:cs typeface="Meiryo" charset="-128"/>
              </a:rPr>
              <a:t>B</a:t>
            </a:r>
            <a:r>
              <a:rPr lang="en-US" altLang="ja-JP" sz="1200" smtClean="0">
                <a:latin typeface="Meiryo" charset="-128"/>
                <a:ea typeface="Meiryo" charset="-128"/>
                <a:cs typeface="Meiryo" charset="-128"/>
              </a:rPr>
              <a:t>asal</a:t>
            </a:r>
            <a:r>
              <a:rPr kumimoji="1" lang="en-US" altLang="ja-JP" sz="1200" smtClean="0">
                <a:latin typeface="Meiryo" charset="-128"/>
                <a:ea typeface="Meiryo" charset="-128"/>
                <a:cs typeface="Meiryo" charset="-128"/>
              </a:rPr>
              <a:t>-like</a:t>
            </a:r>
            <a:endParaRPr kumimoji="1" lang="ja-JP" altLang="en-US" sz="12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9107456" y="5895201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Meiryo" charset="-128"/>
                <a:ea typeface="Meiryo" charset="-128"/>
                <a:cs typeface="Meiryo" charset="-128"/>
              </a:rPr>
              <a:t>PBMC</a:t>
            </a:r>
            <a:endParaRPr kumimoji="1" lang="ja-JP" altLang="en-US" sz="1200" dirty="0">
              <a:latin typeface="Meiryo" charset="-128"/>
              <a:ea typeface="Meiryo" charset="-128"/>
              <a:cs typeface="Meiryo" charset="-128"/>
            </a:endParaRPr>
          </a:p>
        </p:txBody>
      </p:sp>
      <p:cxnSp>
        <p:nvCxnSpPr>
          <p:cNvPr id="19" name="直線矢印コネクタ 18"/>
          <p:cNvCxnSpPr/>
          <p:nvPr/>
        </p:nvCxnSpPr>
        <p:spPr>
          <a:xfrm flipV="1">
            <a:off x="6563549" y="6016394"/>
            <a:ext cx="74444" cy="21090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/>
          <p:cNvCxnSpPr/>
          <p:nvPr/>
        </p:nvCxnSpPr>
        <p:spPr>
          <a:xfrm flipH="1" flipV="1">
            <a:off x="6840453" y="6011138"/>
            <a:ext cx="65771" cy="21387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図 2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66" t="5223" r="6539" b="9043"/>
          <a:stretch/>
        </p:blipFill>
        <p:spPr>
          <a:xfrm>
            <a:off x="11044502" y="1259862"/>
            <a:ext cx="287413" cy="4666871"/>
          </a:xfrm>
          <a:prstGeom prst="rect">
            <a:avLst/>
          </a:prstGeom>
        </p:spPr>
      </p:pic>
      <p:grpSp>
        <p:nvGrpSpPr>
          <p:cNvPr id="31" name="図形グループ 30"/>
          <p:cNvGrpSpPr/>
          <p:nvPr/>
        </p:nvGrpSpPr>
        <p:grpSpPr>
          <a:xfrm>
            <a:off x="2679807" y="1379482"/>
            <a:ext cx="228600" cy="4437994"/>
            <a:chOff x="511267" y="1120281"/>
            <a:chExt cx="228600" cy="5033866"/>
          </a:xfrm>
        </p:grpSpPr>
        <p:sp>
          <p:nvSpPr>
            <p:cNvPr id="26" name="正方形/長方形 25"/>
            <p:cNvSpPr/>
            <p:nvPr/>
          </p:nvSpPr>
          <p:spPr>
            <a:xfrm>
              <a:off x="511267" y="2556775"/>
              <a:ext cx="228600" cy="18000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511267" y="4276507"/>
              <a:ext cx="228600" cy="187764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正方形/長方形 28"/>
            <p:cNvSpPr/>
            <p:nvPr/>
          </p:nvSpPr>
          <p:spPr>
            <a:xfrm>
              <a:off x="511267" y="1836775"/>
              <a:ext cx="228600" cy="720000"/>
            </a:xfrm>
            <a:prstGeom prst="rect">
              <a:avLst/>
            </a:prstGeom>
            <a:solidFill>
              <a:srgbClr val="B34F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正方形/長方形 29"/>
            <p:cNvSpPr/>
            <p:nvPr/>
          </p:nvSpPr>
          <p:spPr>
            <a:xfrm>
              <a:off x="511267" y="1120281"/>
              <a:ext cx="228600" cy="720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2" name="テキスト ボックス 31"/>
          <p:cNvSpPr txBox="1"/>
          <p:nvPr/>
        </p:nvSpPr>
        <p:spPr>
          <a:xfrm>
            <a:off x="1205412" y="1755377"/>
            <a:ext cx="130195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Verdana" charset="0"/>
                <a:ea typeface="Verdana" charset="0"/>
                <a:cs typeface="Verdana" charset="0"/>
              </a:rPr>
              <a:t>C</a:t>
            </a:r>
            <a: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  <a:t>ommon BC</a:t>
            </a:r>
            <a:b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</a:br>
            <a: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en-US" altLang="ja-JP" sz="1400" dirty="0">
                <a:latin typeface="Verdana" charset="0"/>
                <a:ea typeface="Verdana" charset="0"/>
                <a:cs typeface="Verdana" charset="0"/>
              </a:rPr>
              <a:t>m</a:t>
            </a:r>
            <a: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  <a:t>arkers</a:t>
            </a:r>
            <a:endParaRPr kumimoji="1" lang="ja-JP" altLang="en-US" sz="14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81228" y="3123993"/>
            <a:ext cx="18261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  <a:t>Luminal-dominant</a:t>
            </a:r>
          </a:p>
          <a:p>
            <a:pPr algn="r"/>
            <a: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  <a:t>markers</a:t>
            </a:r>
            <a:endParaRPr kumimoji="1" lang="ja-JP" altLang="en-US" sz="14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144496" y="4650443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  <a:t>TN-dominant</a:t>
            </a:r>
          </a:p>
          <a:p>
            <a:pPr algn="r"/>
            <a:r>
              <a:rPr kumimoji="1" lang="en-US" altLang="ja-JP" sz="1400" dirty="0" smtClean="0">
                <a:latin typeface="Verdana" charset="0"/>
                <a:ea typeface="Verdana" charset="0"/>
                <a:cs typeface="Verdana" charset="0"/>
              </a:rPr>
              <a:t>markers</a:t>
            </a:r>
            <a:endParaRPr kumimoji="1" lang="ja-JP" altLang="en-US" sz="14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5" name="左大かっこ 34"/>
          <p:cNvSpPr/>
          <p:nvPr/>
        </p:nvSpPr>
        <p:spPr>
          <a:xfrm>
            <a:off x="2482140" y="1557180"/>
            <a:ext cx="103523" cy="889641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40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090368" y="5852087"/>
            <a:ext cx="929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smtClean="0">
                <a:latin typeface="Verdana" charset="0"/>
                <a:ea typeface="Verdana" charset="0"/>
                <a:cs typeface="Verdana" charset="0"/>
              </a:rPr>
              <a:t>Subtype</a:t>
            </a:r>
            <a:endParaRPr kumimoji="1" lang="ja-JP" altLang="en-US" sz="1400" dirty="0">
              <a:latin typeface="Verdana" charset="0"/>
              <a:ea typeface="Verdana" charset="0"/>
              <a:cs typeface="Verdan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1507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/>
          <a:srcRect l="9002"/>
          <a:stretch/>
        </p:blipFill>
        <p:spPr>
          <a:xfrm>
            <a:off x="611561" y="2338789"/>
            <a:ext cx="3918740" cy="3238107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387626" y="242010"/>
            <a:ext cx="2481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7</a:t>
            </a:r>
            <a:r>
              <a:rPr lang="en-US" altLang="ja-JP" dirty="0" smtClean="0"/>
              <a:t>-B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947883" y="5371443"/>
            <a:ext cx="1204176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ja-JP" altLang="en-US" sz="1100" b="1" dirty="0" smtClean="0">
                <a:latin typeface="Meiryo" charset="-128"/>
                <a:ea typeface="Meiryo" charset="-128"/>
                <a:cs typeface="Meiryo" charset="-128"/>
              </a:rPr>
              <a:t>１−</a:t>
            </a:r>
            <a:r>
              <a:rPr kumimoji="1" lang="en-US" altLang="ja-JP" sz="1100" b="1" dirty="0" smtClean="0">
                <a:latin typeface="Meiryo" charset="-128"/>
                <a:ea typeface="Meiryo" charset="-128"/>
                <a:cs typeface="Meiryo" charset="-128"/>
              </a:rPr>
              <a:t>Specificity</a:t>
            </a:r>
            <a:endParaRPr kumimoji="1" lang="ja-JP" altLang="en-US" sz="1100" b="1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-307" y="3575009"/>
            <a:ext cx="9621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smtClean="0">
                <a:latin typeface="Meiryo" charset="-128"/>
                <a:ea typeface="Meiryo" charset="-128"/>
                <a:cs typeface="Meiryo" charset="-128"/>
              </a:rPr>
              <a:t>Sensitivity</a:t>
            </a:r>
            <a:endParaRPr kumimoji="1" lang="ja-JP" altLang="en-US" sz="1100" b="1" dirty="0">
              <a:latin typeface="Meiryo" charset="-128"/>
              <a:ea typeface="Meiryo" charset="-128"/>
              <a:cs typeface="Meiryo" charset="-128"/>
            </a:endParaRPr>
          </a:p>
        </p:txBody>
      </p:sp>
      <p:pic>
        <p:nvPicPr>
          <p:cNvPr id="7" name="コンテンツ プレースホルダー 6"/>
          <p:cNvPicPr>
            <a:picLocks noGrp="1" noChangeAspect="1"/>
          </p:cNvPicPr>
          <p:nvPr>
            <p:ph idx="1"/>
          </p:nvPr>
        </p:nvPicPr>
        <p:blipFill rotWithShape="1">
          <a:blip r:embed="rId4"/>
          <a:srcRect l="8442"/>
          <a:stretch/>
        </p:blipFill>
        <p:spPr>
          <a:xfrm>
            <a:off x="4250792" y="2338789"/>
            <a:ext cx="3942817" cy="3238107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5"/>
          <a:srcRect l="8442" r="5345"/>
          <a:stretch/>
        </p:blipFill>
        <p:spPr>
          <a:xfrm>
            <a:off x="7931943" y="2338789"/>
            <a:ext cx="3712662" cy="3238107"/>
          </a:xfrm>
          <a:prstGeom prst="rect">
            <a:avLst/>
          </a:prstGeom>
        </p:spPr>
      </p:pic>
      <p:sp>
        <p:nvSpPr>
          <p:cNvPr id="15" name="テキスト ボックス 14"/>
          <p:cNvSpPr txBox="1"/>
          <p:nvPr/>
        </p:nvSpPr>
        <p:spPr>
          <a:xfrm>
            <a:off x="5576313" y="5371443"/>
            <a:ext cx="1204176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ja-JP" altLang="en-US" sz="1100" b="1" dirty="0" smtClean="0">
                <a:latin typeface="Meiryo" charset="-128"/>
                <a:ea typeface="Meiryo" charset="-128"/>
                <a:cs typeface="Meiryo" charset="-128"/>
              </a:rPr>
              <a:t>１−</a:t>
            </a:r>
            <a:r>
              <a:rPr kumimoji="1" lang="en-US" altLang="ja-JP" sz="1100" b="1" dirty="0" smtClean="0">
                <a:latin typeface="Meiryo" charset="-128"/>
                <a:ea typeface="Meiryo" charset="-128"/>
                <a:cs typeface="Meiryo" charset="-128"/>
              </a:rPr>
              <a:t>Specificity</a:t>
            </a:r>
            <a:endParaRPr kumimoji="1" lang="ja-JP" altLang="en-US" sz="1100" b="1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9204743" y="5371443"/>
            <a:ext cx="1204176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ja-JP" altLang="en-US" sz="1100" b="1" dirty="0" smtClean="0">
                <a:latin typeface="Meiryo" charset="-128"/>
                <a:ea typeface="Meiryo" charset="-128"/>
                <a:cs typeface="Meiryo" charset="-128"/>
              </a:rPr>
              <a:t>１−</a:t>
            </a:r>
            <a:r>
              <a:rPr kumimoji="1" lang="en-US" altLang="ja-JP" sz="1100" b="1" dirty="0" smtClean="0">
                <a:latin typeface="Meiryo" charset="-128"/>
                <a:ea typeface="Meiryo" charset="-128"/>
                <a:cs typeface="Meiryo" charset="-128"/>
              </a:rPr>
              <a:t>Specificity</a:t>
            </a:r>
            <a:endParaRPr kumimoji="1" lang="ja-JP" altLang="en-US" sz="1100" b="1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207224" y="2089123"/>
            <a:ext cx="272741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Meiryo" charset="-128"/>
                <a:ea typeface="Meiryo" charset="-128"/>
                <a:cs typeface="Meiryo" charset="-128"/>
              </a:rPr>
              <a:t>Geometric mean of 12 markers</a:t>
            </a:r>
          </a:p>
          <a:p>
            <a:pPr algn="ctr"/>
            <a:r>
              <a:rPr kumimoji="1" lang="en-US" altLang="ja-JP" sz="1200" b="1" dirty="0" smtClean="0">
                <a:latin typeface="Meiryo" charset="-128"/>
                <a:ea typeface="Meiryo" charset="-128"/>
                <a:cs typeface="Meiryo" charset="-128"/>
              </a:rPr>
              <a:t>AUC=0.76925</a:t>
            </a:r>
            <a:endParaRPr kumimoji="1" lang="ja-JP" altLang="en-US" sz="1200" b="1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-3161865" y="-1211859"/>
            <a:ext cx="272741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smtClean="0">
                <a:latin typeface="Meiryo" charset="-128"/>
                <a:ea typeface="Meiryo" charset="-128"/>
                <a:cs typeface="Meiryo" charset="-128"/>
              </a:rPr>
              <a:t>Geometric mean of 12 markers</a:t>
            </a:r>
          </a:p>
          <a:p>
            <a:pPr algn="ctr"/>
            <a:r>
              <a:rPr kumimoji="1" lang="en-US" altLang="ja-JP" sz="1200" b="1" dirty="0" smtClean="0">
                <a:latin typeface="Meiryo" charset="-128"/>
                <a:ea typeface="Meiryo" charset="-128"/>
                <a:cs typeface="Meiryo" charset="-128"/>
              </a:rPr>
              <a:t>AUC=0.76925</a:t>
            </a:r>
            <a:endParaRPr kumimoji="1" lang="ja-JP" altLang="en-US" sz="1200" b="1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578384" y="2089122"/>
            <a:ext cx="328763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Meiryo" charset="-128"/>
                <a:ea typeface="Meiryo" charset="-128"/>
                <a:cs typeface="Meiryo" charset="-128"/>
              </a:rPr>
              <a:t>Geometric mean of 4 internal controls</a:t>
            </a:r>
          </a:p>
          <a:p>
            <a:pPr algn="ctr"/>
            <a:r>
              <a:rPr kumimoji="1" lang="en-US" altLang="ja-JP" sz="1200" b="1" dirty="0" smtClean="0">
                <a:latin typeface="Meiryo" charset="-128"/>
                <a:ea typeface="Meiryo" charset="-128"/>
                <a:cs typeface="Meiryo" charset="-128"/>
              </a:rPr>
              <a:t>AUC=0.89023</a:t>
            </a:r>
            <a:endParaRPr kumimoji="1" lang="ja-JP" altLang="en-US" sz="1200" b="1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324245" y="2089121"/>
            <a:ext cx="296517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Meiryo" charset="-128"/>
                <a:ea typeface="Meiryo" charset="-128"/>
                <a:cs typeface="Meiryo" charset="-128"/>
              </a:rPr>
              <a:t>Number of meth-positive markers</a:t>
            </a:r>
          </a:p>
          <a:p>
            <a:pPr algn="ctr"/>
            <a:r>
              <a:rPr kumimoji="1" lang="en-US" altLang="ja-JP" sz="1200" b="1" dirty="0" smtClean="0">
                <a:latin typeface="Meiryo" charset="-128"/>
                <a:ea typeface="Meiryo" charset="-128"/>
                <a:cs typeface="Meiryo" charset="-128"/>
              </a:rPr>
              <a:t>AUC=0.82148</a:t>
            </a:r>
            <a:endParaRPr kumimoji="1" lang="ja-JP" altLang="en-US" sz="1200" b="1" dirty="0">
              <a:latin typeface="Meiryo" charset="-128"/>
              <a:ea typeface="Meiryo" charset="-128"/>
              <a:cs typeface="Meiryo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007478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87626" y="242010"/>
            <a:ext cx="2480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7</a:t>
            </a:r>
            <a:r>
              <a:rPr lang="en-US" altLang="ja-JP" dirty="0" smtClean="0"/>
              <a:t>-C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2001569" y="2513922"/>
            <a:ext cx="17957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Verdana" charset="0"/>
                <a:ea typeface="Verdana" charset="0"/>
                <a:cs typeface="Verdana" charset="0"/>
              </a:rPr>
              <a:t>Training set (n=167)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1946716" y="4921626"/>
            <a:ext cx="1942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Verdana" charset="0"/>
                <a:ea typeface="Verdana" charset="0"/>
                <a:cs typeface="Verdana" charset="0"/>
              </a:rPr>
              <a:t>Validation set (n=111)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098065" y="1272002"/>
            <a:ext cx="952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smtClean="0">
                <a:latin typeface="Verdana" charset="0"/>
                <a:ea typeface="Verdana" charset="0"/>
                <a:cs typeface="Verdana" charset="0"/>
              </a:rPr>
              <a:t>Stage 0-I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130125" y="1589687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Verdana" charset="0"/>
                <a:ea typeface="Verdana" charset="0"/>
                <a:cs typeface="Verdana" charset="0"/>
              </a:rPr>
              <a:t>Stage IIA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868772" y="1911235"/>
            <a:ext cx="11817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smtClean="0">
                <a:latin typeface="Verdana" charset="0"/>
                <a:ea typeface="Verdana" charset="0"/>
                <a:cs typeface="Verdana" charset="0"/>
              </a:rPr>
              <a:t>Stage IIB-III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84390" y="2326886"/>
            <a:ext cx="12661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Verdana" charset="0"/>
                <a:ea typeface="Verdana" charset="0"/>
                <a:cs typeface="Verdana" charset="0"/>
              </a:rPr>
              <a:t>Stage IV-MBC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644690" y="320452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smtClean="0">
                <a:latin typeface="Verdana" charset="0"/>
                <a:ea typeface="Verdana" charset="0"/>
                <a:cs typeface="Verdana" charset="0"/>
              </a:rPr>
              <a:t>HV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103160" y="4130495"/>
            <a:ext cx="952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Verdana" charset="0"/>
                <a:ea typeface="Verdana" charset="0"/>
                <a:cs typeface="Verdana" charset="0"/>
              </a:rPr>
              <a:t>Stage 0-I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135220" y="4332770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Verdana" charset="0"/>
                <a:ea typeface="Verdana" charset="0"/>
                <a:cs typeface="Verdana" charset="0"/>
              </a:rPr>
              <a:t>Stage IIA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873867" y="4521151"/>
            <a:ext cx="11817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smtClean="0">
                <a:latin typeface="Verdana" charset="0"/>
                <a:ea typeface="Verdana" charset="0"/>
                <a:cs typeface="Verdana" charset="0"/>
              </a:rPr>
              <a:t>Stage IIB-III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89485" y="4794758"/>
            <a:ext cx="12661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>
                <a:latin typeface="Verdana" charset="0"/>
                <a:ea typeface="Verdana" charset="0"/>
                <a:cs typeface="Verdana" charset="0"/>
              </a:rPr>
              <a:t>Stage IV-MBC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649785" y="542382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smtClean="0">
                <a:latin typeface="Verdana" charset="0"/>
                <a:ea typeface="Verdana" charset="0"/>
                <a:cs typeface="Verdana" charset="0"/>
              </a:rPr>
              <a:t>HV</a:t>
            </a:r>
            <a:endParaRPr kumimoji="1" lang="ja-JP" altLang="en-US" sz="12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864369" y="979161"/>
            <a:ext cx="5180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smtClean="0">
                <a:latin typeface="Verdana" charset="0"/>
                <a:ea typeface="Verdana" charset="0"/>
                <a:cs typeface="Verdana" charset="0"/>
              </a:rPr>
              <a:t>Stage</a:t>
            </a:r>
            <a:endParaRPr kumimoji="1" lang="ja-JP" altLang="en-US" sz="9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013051" y="893724"/>
            <a:ext cx="50045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JAK3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421985" y="1022206"/>
            <a:ext cx="44275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SHF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640485" y="893724"/>
            <a:ext cx="72167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HOXA10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036721" y="1022206"/>
            <a:ext cx="639919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DACH1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8362071" y="893724"/>
            <a:ext cx="691215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Mean12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9010171" y="1022206"/>
            <a:ext cx="328936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IC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275882" y="978019"/>
            <a:ext cx="6639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smtClean="0">
                <a:latin typeface="Verdana" charset="0"/>
                <a:ea typeface="Verdana" charset="0"/>
                <a:cs typeface="Verdana" charset="0"/>
              </a:rPr>
              <a:t>Subtype</a:t>
            </a:r>
            <a:endParaRPr kumimoji="1" lang="ja-JP" altLang="en-US" sz="9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388795" y="1022206"/>
            <a:ext cx="705641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RASGF1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889181" y="893724"/>
            <a:ext cx="62869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CPXM1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805943" y="893724"/>
            <a:ext cx="569387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DNM3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289951" y="1022206"/>
            <a:ext cx="53251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CAV2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6090641" y="1022206"/>
            <a:ext cx="710451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B3GNT5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6521512" y="893724"/>
            <a:ext cx="77457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ST3GAL6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7485915" y="893724"/>
            <a:ext cx="60305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 smtClean="0">
                <a:latin typeface="Verdana" charset="0"/>
                <a:ea typeface="Verdana" charset="0"/>
                <a:cs typeface="Verdana" charset="0"/>
              </a:rPr>
              <a:t>P2RX3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7760600" y="1037594"/>
            <a:ext cx="984565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de-DE" altLang="ja-JP" sz="800" dirty="0">
                <a:latin typeface="Verdana" charset="0"/>
                <a:ea typeface="Verdana" charset="0"/>
                <a:cs typeface="Verdana" charset="0"/>
              </a:rPr>
              <a:t>chr8:23572595</a:t>
            </a:r>
            <a:endParaRPr kumimoji="1" lang="ja-JP" altLang="en-US" sz="800" dirty="0">
              <a:latin typeface="Verdana" charset="0"/>
              <a:ea typeface="Verdana" charset="0"/>
              <a:cs typeface="Verdana" charset="0"/>
            </a:endParaRPr>
          </a:p>
        </p:txBody>
      </p:sp>
      <p:pic>
        <p:nvPicPr>
          <p:cNvPr id="51" name="図 5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827" t="6957" r="4833" b="9913"/>
          <a:stretch/>
        </p:blipFill>
        <p:spPr>
          <a:xfrm>
            <a:off x="9649150" y="1192889"/>
            <a:ext cx="362786" cy="4866200"/>
          </a:xfrm>
          <a:prstGeom prst="rect">
            <a:avLst/>
          </a:prstGeom>
        </p:spPr>
      </p:pic>
      <p:pic>
        <p:nvPicPr>
          <p:cNvPr id="53" name="図 5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29" t="7413" r="9458" b="10992"/>
          <a:stretch/>
        </p:blipFill>
        <p:spPr>
          <a:xfrm>
            <a:off x="3074687" y="1227943"/>
            <a:ext cx="6329238" cy="2820564"/>
          </a:xfrm>
          <a:prstGeom prst="rect">
            <a:avLst/>
          </a:prstGeom>
        </p:spPr>
      </p:pic>
      <p:pic>
        <p:nvPicPr>
          <p:cNvPr id="54" name="図 5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43" t="7413" r="77354" b="10992"/>
          <a:stretch/>
        </p:blipFill>
        <p:spPr>
          <a:xfrm>
            <a:off x="2005596" y="1222969"/>
            <a:ext cx="772483" cy="2817205"/>
          </a:xfrm>
          <a:prstGeom prst="rect">
            <a:avLst/>
          </a:prstGeom>
        </p:spPr>
      </p:pic>
      <p:pic>
        <p:nvPicPr>
          <p:cNvPr id="55" name="図 5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57" t="7401" r="9458" b="10979"/>
          <a:stretch/>
        </p:blipFill>
        <p:spPr>
          <a:xfrm>
            <a:off x="3081404" y="4153779"/>
            <a:ext cx="6315803" cy="1844496"/>
          </a:xfrm>
          <a:prstGeom prst="rect">
            <a:avLst/>
          </a:prstGeom>
        </p:spPr>
      </p:pic>
      <p:pic>
        <p:nvPicPr>
          <p:cNvPr id="56" name="図 5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23" t="7401" r="77643" b="10979"/>
          <a:stretch/>
        </p:blipFill>
        <p:spPr>
          <a:xfrm>
            <a:off x="2012313" y="4157932"/>
            <a:ext cx="748630" cy="1840343"/>
          </a:xfrm>
          <a:prstGeom prst="rect">
            <a:avLst/>
          </a:prstGeom>
        </p:spPr>
      </p:pic>
      <p:sp>
        <p:nvSpPr>
          <p:cNvPr id="50" name="正方形/長方形 49"/>
          <p:cNvSpPr/>
          <p:nvPr/>
        </p:nvSpPr>
        <p:spPr>
          <a:xfrm>
            <a:off x="2330246" y="1204204"/>
            <a:ext cx="105618" cy="48270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9908368" y="1101698"/>
            <a:ext cx="4443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dirty="0" smtClean="0">
                <a:latin typeface="Verdana" charset="0"/>
                <a:ea typeface="Verdana" charset="0"/>
                <a:cs typeface="Verdana" charset="0"/>
              </a:rPr>
              <a:t>Max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9908368" y="5854677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dirty="0" smtClean="0">
                <a:latin typeface="Verdana" charset="0"/>
                <a:ea typeface="Verdana" charset="0"/>
                <a:cs typeface="Verdana" charset="0"/>
              </a:rPr>
              <a:t>Min</a:t>
            </a:r>
            <a:endParaRPr kumimoji="1" lang="ja-JP" altLang="en-US" sz="1000" dirty="0">
              <a:latin typeface="Verdana" charset="0"/>
              <a:ea typeface="Verdana" charset="0"/>
              <a:cs typeface="Verdana" charset="0"/>
            </a:endParaRPr>
          </a:p>
        </p:txBody>
      </p:sp>
      <p:grpSp>
        <p:nvGrpSpPr>
          <p:cNvPr id="52" name="図形グループ 51"/>
          <p:cNvGrpSpPr/>
          <p:nvPr/>
        </p:nvGrpSpPr>
        <p:grpSpPr>
          <a:xfrm>
            <a:off x="10317454" y="4794758"/>
            <a:ext cx="194027" cy="1160856"/>
            <a:chOff x="2845179" y="1546953"/>
            <a:chExt cx="342215" cy="1160856"/>
          </a:xfrm>
        </p:grpSpPr>
        <p:sp>
          <p:nvSpPr>
            <p:cNvPr id="57" name="正方形/長方形 56"/>
            <p:cNvSpPr/>
            <p:nvPr/>
          </p:nvSpPr>
          <p:spPr>
            <a:xfrm>
              <a:off x="2845179" y="1546953"/>
              <a:ext cx="342215" cy="193476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正方形/長方形 57"/>
            <p:cNvSpPr/>
            <p:nvPr/>
          </p:nvSpPr>
          <p:spPr>
            <a:xfrm>
              <a:off x="2845179" y="1740429"/>
              <a:ext cx="342215" cy="193476"/>
            </a:xfrm>
            <a:prstGeom prst="rect">
              <a:avLst/>
            </a:prstGeom>
            <a:solidFill>
              <a:srgbClr val="FF9F2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正方形/長方形 58"/>
            <p:cNvSpPr/>
            <p:nvPr/>
          </p:nvSpPr>
          <p:spPr>
            <a:xfrm>
              <a:off x="2845179" y="1933905"/>
              <a:ext cx="342215" cy="193476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0" name="正方形/長方形 59"/>
            <p:cNvSpPr/>
            <p:nvPr/>
          </p:nvSpPr>
          <p:spPr>
            <a:xfrm>
              <a:off x="2845179" y="2127381"/>
              <a:ext cx="342215" cy="193476"/>
            </a:xfrm>
            <a:prstGeom prst="rect">
              <a:avLst/>
            </a:prstGeom>
            <a:solidFill>
              <a:srgbClr val="5DFDF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1" name="正方形/長方形 60"/>
            <p:cNvSpPr/>
            <p:nvPr/>
          </p:nvSpPr>
          <p:spPr>
            <a:xfrm>
              <a:off x="2845179" y="2320857"/>
              <a:ext cx="342215" cy="193476"/>
            </a:xfrm>
            <a:prstGeom prst="rect">
              <a:avLst/>
            </a:prstGeom>
            <a:solidFill>
              <a:srgbClr val="1885F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正方形/長方形 61"/>
            <p:cNvSpPr/>
            <p:nvPr/>
          </p:nvSpPr>
          <p:spPr>
            <a:xfrm>
              <a:off x="2845179" y="2514333"/>
              <a:ext cx="342215" cy="193476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63" name="テキスト ボックス 62"/>
          <p:cNvSpPr txBox="1"/>
          <p:nvPr/>
        </p:nvSpPr>
        <p:spPr>
          <a:xfrm>
            <a:off x="10511481" y="4755465"/>
            <a:ext cx="788999" cy="122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900" dirty="0" smtClean="0">
                <a:latin typeface="Verdana" charset="0"/>
                <a:ea typeface="Verdana" charset="0"/>
                <a:cs typeface="Verdana" charset="0"/>
              </a:rPr>
              <a:t>TN</a:t>
            </a:r>
          </a:p>
          <a:p>
            <a:pPr>
              <a:lnSpc>
                <a:spcPts val="1500"/>
              </a:lnSpc>
            </a:pPr>
            <a:r>
              <a:rPr lang="en-US" altLang="ja-JP" sz="900" dirty="0" smtClean="0">
                <a:latin typeface="Verdana" charset="0"/>
                <a:ea typeface="Verdana" charset="0"/>
                <a:cs typeface="Verdana" charset="0"/>
              </a:rPr>
              <a:t>HER2</a:t>
            </a:r>
          </a:p>
          <a:p>
            <a:pPr>
              <a:lnSpc>
                <a:spcPts val="1500"/>
              </a:lnSpc>
            </a:pPr>
            <a:r>
              <a:rPr kumimoji="1" lang="en-US" altLang="ja-JP" sz="900" dirty="0" err="1" smtClean="0">
                <a:latin typeface="Verdana" charset="0"/>
                <a:ea typeface="Verdana" charset="0"/>
                <a:cs typeface="Verdana" charset="0"/>
              </a:rPr>
              <a:t>Lum</a:t>
            </a:r>
            <a:r>
              <a:rPr kumimoji="1" lang="en-US" altLang="ja-JP" sz="900" dirty="0" smtClean="0">
                <a:latin typeface="Verdana" charset="0"/>
                <a:ea typeface="Verdana" charset="0"/>
                <a:cs typeface="Verdana" charset="0"/>
              </a:rPr>
              <a:t> HER2</a:t>
            </a:r>
          </a:p>
          <a:p>
            <a:pPr>
              <a:lnSpc>
                <a:spcPts val="1500"/>
              </a:lnSpc>
            </a:pPr>
            <a:r>
              <a:rPr lang="en-US" altLang="ja-JP" sz="900" dirty="0" err="1" smtClean="0">
                <a:latin typeface="Verdana" charset="0"/>
                <a:ea typeface="Verdana" charset="0"/>
                <a:cs typeface="Verdana" charset="0"/>
              </a:rPr>
              <a:t>Lum</a:t>
            </a:r>
            <a:endParaRPr lang="en-US" altLang="ja-JP" sz="900" dirty="0" smtClean="0">
              <a:latin typeface="Verdana" charset="0"/>
              <a:ea typeface="Verdana" charset="0"/>
              <a:cs typeface="Verdana" charset="0"/>
            </a:endParaRPr>
          </a:p>
          <a:p>
            <a:pPr>
              <a:lnSpc>
                <a:spcPts val="1500"/>
              </a:lnSpc>
            </a:pPr>
            <a:r>
              <a:rPr kumimoji="1" lang="en-US" altLang="ja-JP" sz="900" dirty="0" smtClean="0">
                <a:latin typeface="Verdana" charset="0"/>
                <a:ea typeface="Verdana" charset="0"/>
                <a:cs typeface="Verdana" charset="0"/>
              </a:rPr>
              <a:t>DCIS</a:t>
            </a:r>
          </a:p>
          <a:p>
            <a:pPr>
              <a:lnSpc>
                <a:spcPts val="1500"/>
              </a:lnSpc>
            </a:pPr>
            <a:r>
              <a:rPr lang="en-US" altLang="ja-JP" sz="900" dirty="0" smtClean="0">
                <a:latin typeface="Verdana" charset="0"/>
                <a:ea typeface="Verdana" charset="0"/>
                <a:cs typeface="Verdana" charset="0"/>
              </a:rPr>
              <a:t>HV</a:t>
            </a:r>
            <a:endParaRPr kumimoji="1" lang="ja-JP" altLang="en-US" sz="9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0082485" y="4521151"/>
            <a:ext cx="663964" cy="2605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900" smtClean="0">
                <a:latin typeface="Verdana" charset="0"/>
                <a:ea typeface="Verdana" charset="0"/>
                <a:cs typeface="Verdana" charset="0"/>
              </a:rPr>
              <a:t>Subtype</a:t>
            </a:r>
            <a:endParaRPr kumimoji="1" lang="ja-JP" altLang="en-US" sz="9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9593830" y="744046"/>
            <a:ext cx="487633" cy="4528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kumimoji="1" lang="en-US" altLang="ja-JP" sz="900" smtClean="0">
                <a:latin typeface="Verdana" charset="0"/>
                <a:ea typeface="Verdana" charset="0"/>
                <a:cs typeface="Verdana" charset="0"/>
              </a:rPr>
              <a:t>Color</a:t>
            </a:r>
            <a:br>
              <a:rPr kumimoji="1" lang="en-US" altLang="ja-JP" sz="900" smtClean="0">
                <a:latin typeface="Verdana" charset="0"/>
                <a:ea typeface="Verdana" charset="0"/>
                <a:cs typeface="Verdana" charset="0"/>
              </a:rPr>
            </a:br>
            <a:r>
              <a:rPr kumimoji="1" lang="en-US" altLang="ja-JP" sz="900" smtClean="0">
                <a:latin typeface="Verdana" charset="0"/>
                <a:ea typeface="Verdana" charset="0"/>
                <a:cs typeface="Verdana" charset="0"/>
              </a:rPr>
              <a:t>scale</a:t>
            </a:r>
            <a:endParaRPr kumimoji="1" lang="ja-JP" altLang="en-US" sz="900" dirty="0">
              <a:latin typeface="Verdana" charset="0"/>
              <a:ea typeface="Verdana" charset="0"/>
              <a:cs typeface="Verdan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085799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25552" y="227965"/>
            <a:ext cx="2874264" cy="421259"/>
          </a:xfrm>
        </p:spPr>
        <p:txBody>
          <a:bodyPr>
            <a:normAutofit/>
          </a:bodyPr>
          <a:lstStyle/>
          <a:p>
            <a:r>
              <a:rPr lang="en-US" altLang="ja-JP" sz="1800" dirty="0" smtClean="0">
                <a:latin typeface="+mn-lt"/>
                <a:ea typeface="Verdana" charset="0"/>
                <a:cs typeface="Verdana" charset="0"/>
              </a:rPr>
              <a:t>Supplemental Figure 8 </a:t>
            </a:r>
            <a:endParaRPr kumimoji="1" lang="ja-JP" altLang="en-US" sz="1800" dirty="0">
              <a:latin typeface="+mn-lt"/>
              <a:ea typeface="Verdana" charset="0"/>
              <a:cs typeface="Verdana" charset="0"/>
            </a:endParaRPr>
          </a:p>
        </p:txBody>
      </p:sp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0042038"/>
              </p:ext>
            </p:extLst>
          </p:nvPr>
        </p:nvGraphicFramePr>
        <p:xfrm>
          <a:off x="1158740" y="1546009"/>
          <a:ext cx="9519592" cy="51976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9385955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図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1704" y="81976"/>
            <a:ext cx="3698646" cy="3418957"/>
          </a:xfrm>
          <a:prstGeom prst="rect">
            <a:avLst/>
          </a:prstGeom>
        </p:spPr>
      </p:pic>
      <p:pic>
        <p:nvPicPr>
          <p:cNvPr id="41" name="図 4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76174" y="81977"/>
            <a:ext cx="3698648" cy="3418957"/>
          </a:xfrm>
          <a:prstGeom prst="rect">
            <a:avLst/>
          </a:prstGeom>
        </p:spPr>
      </p:pic>
      <p:pic>
        <p:nvPicPr>
          <p:cNvPr id="40" name="図 3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1704" y="3439043"/>
            <a:ext cx="3698647" cy="3418957"/>
          </a:xfrm>
          <a:prstGeom prst="rect">
            <a:avLst/>
          </a:prstGeom>
        </p:spPr>
      </p:pic>
      <p:pic>
        <p:nvPicPr>
          <p:cNvPr id="39" name="図 3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76176" y="3439043"/>
            <a:ext cx="3698646" cy="3418957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363562" y="258418"/>
            <a:ext cx="2634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l Figure 9</a:t>
            </a:r>
            <a:endParaRPr kumimoji="1" lang="ja-JP" altLang="en-US" dirty="0"/>
          </a:p>
        </p:txBody>
      </p:sp>
      <p:sp>
        <p:nvSpPr>
          <p:cNvPr id="13" name="正方形/長方形 12"/>
          <p:cNvSpPr/>
          <p:nvPr/>
        </p:nvSpPr>
        <p:spPr>
          <a:xfrm>
            <a:off x="5857750" y="1345645"/>
            <a:ext cx="822561" cy="3314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1" name="図形グループ 20"/>
          <p:cNvGrpSpPr/>
          <p:nvPr/>
        </p:nvGrpSpPr>
        <p:grpSpPr>
          <a:xfrm>
            <a:off x="9075944" y="2774420"/>
            <a:ext cx="1797032" cy="338554"/>
            <a:chOff x="9075944" y="2774420"/>
            <a:chExt cx="1797032" cy="338554"/>
          </a:xfrm>
        </p:grpSpPr>
        <p:sp>
          <p:nvSpPr>
            <p:cNvPr id="11" name="テキスト ボックス 10"/>
            <p:cNvSpPr txBox="1"/>
            <p:nvPr/>
          </p:nvSpPr>
          <p:spPr>
            <a:xfrm>
              <a:off x="9236168" y="2774420"/>
              <a:ext cx="16368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Training set</a:t>
              </a:r>
              <a:r>
                <a:rPr kumimoji="1" lang="en-US" altLang="ja-JP" sz="800" smtClean="0">
                  <a:latin typeface="Verdana" charset="0"/>
                  <a:ea typeface="Verdana" charset="0"/>
                  <a:cs typeface="Verdana" charset="0"/>
                </a:rPr>
                <a:t>: AUC=0.8980</a:t>
              </a:r>
              <a:endParaRPr kumimoji="1" lang="en-US" altLang="ja-JP" sz="800" dirty="0" smtClean="0">
                <a:latin typeface="Verdana" charset="0"/>
                <a:ea typeface="Verdana" charset="0"/>
                <a:cs typeface="Verdana" charset="0"/>
              </a:endParaRPr>
            </a:p>
            <a:p>
              <a:r>
                <a:rPr lang="en-US" altLang="ja-JP" sz="800" dirty="0">
                  <a:latin typeface="Verdana" charset="0"/>
                  <a:ea typeface="Verdana" charset="0"/>
                  <a:cs typeface="Verdana" charset="0"/>
                </a:rPr>
                <a:t>Validation </a:t>
              </a:r>
              <a:r>
                <a:rPr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set: AUC=0.8805</a:t>
              </a:r>
              <a:endParaRPr lang="ja-JP" altLang="en-US" sz="800" dirty="0">
                <a:latin typeface="Verdana" charset="0"/>
                <a:ea typeface="Verdana" charset="0"/>
                <a:cs typeface="Verdana" charset="0"/>
              </a:endParaRPr>
            </a:p>
          </p:txBody>
        </p:sp>
        <p:grpSp>
          <p:nvGrpSpPr>
            <p:cNvPr id="20" name="図形グループ 19"/>
            <p:cNvGrpSpPr/>
            <p:nvPr/>
          </p:nvGrpSpPr>
          <p:grpSpPr>
            <a:xfrm>
              <a:off x="9075944" y="2877479"/>
              <a:ext cx="199825" cy="132435"/>
              <a:chOff x="8696607" y="2877727"/>
              <a:chExt cx="399477" cy="132435"/>
            </a:xfrm>
          </p:grpSpPr>
          <p:cxnSp>
            <p:nvCxnSpPr>
              <p:cNvPr id="3" name="直線コネクタ 2"/>
              <p:cNvCxnSpPr/>
              <p:nvPr/>
            </p:nvCxnSpPr>
            <p:spPr>
              <a:xfrm>
                <a:off x="8696607" y="2877727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コネクタ 16"/>
              <p:cNvCxnSpPr/>
              <p:nvPr/>
            </p:nvCxnSpPr>
            <p:spPr>
              <a:xfrm>
                <a:off x="8696607" y="3010162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" name="図形グループ 21"/>
          <p:cNvGrpSpPr/>
          <p:nvPr/>
        </p:nvGrpSpPr>
        <p:grpSpPr>
          <a:xfrm>
            <a:off x="4883279" y="2774420"/>
            <a:ext cx="1797032" cy="338554"/>
            <a:chOff x="9075944" y="2774420"/>
            <a:chExt cx="1797032" cy="338554"/>
          </a:xfrm>
        </p:grpSpPr>
        <p:sp>
          <p:nvSpPr>
            <p:cNvPr id="23" name="テキスト ボックス 22"/>
            <p:cNvSpPr txBox="1"/>
            <p:nvPr/>
          </p:nvSpPr>
          <p:spPr>
            <a:xfrm>
              <a:off x="9236168" y="2774420"/>
              <a:ext cx="16368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Training set: AUC=0.9112</a:t>
              </a:r>
            </a:p>
            <a:p>
              <a:r>
                <a:rPr lang="en-US" altLang="ja-JP" sz="800" dirty="0">
                  <a:latin typeface="Verdana" charset="0"/>
                  <a:ea typeface="Verdana" charset="0"/>
                  <a:cs typeface="Verdana" charset="0"/>
                </a:rPr>
                <a:t>Validation </a:t>
              </a:r>
              <a:r>
                <a:rPr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set: AUC=0.8535</a:t>
              </a:r>
              <a:endParaRPr lang="ja-JP" altLang="en-US" sz="800" dirty="0">
                <a:latin typeface="Verdana" charset="0"/>
                <a:ea typeface="Verdana" charset="0"/>
                <a:cs typeface="Verdana" charset="0"/>
              </a:endParaRPr>
            </a:p>
          </p:txBody>
        </p:sp>
        <p:grpSp>
          <p:nvGrpSpPr>
            <p:cNvPr id="24" name="図形グループ 23"/>
            <p:cNvGrpSpPr/>
            <p:nvPr/>
          </p:nvGrpSpPr>
          <p:grpSpPr>
            <a:xfrm>
              <a:off x="9075944" y="2877479"/>
              <a:ext cx="199825" cy="132435"/>
              <a:chOff x="8696607" y="2877727"/>
              <a:chExt cx="399477" cy="132435"/>
            </a:xfrm>
          </p:grpSpPr>
          <p:cxnSp>
            <p:nvCxnSpPr>
              <p:cNvPr id="25" name="直線コネクタ 24"/>
              <p:cNvCxnSpPr/>
              <p:nvPr/>
            </p:nvCxnSpPr>
            <p:spPr>
              <a:xfrm>
                <a:off x="8696607" y="2877727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線コネクタ 25"/>
              <p:cNvCxnSpPr/>
              <p:nvPr/>
            </p:nvCxnSpPr>
            <p:spPr>
              <a:xfrm>
                <a:off x="8696607" y="3010162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" name="図形グループ 26"/>
          <p:cNvGrpSpPr/>
          <p:nvPr/>
        </p:nvGrpSpPr>
        <p:grpSpPr>
          <a:xfrm>
            <a:off x="4883279" y="6049013"/>
            <a:ext cx="1797032" cy="338554"/>
            <a:chOff x="9075944" y="2774420"/>
            <a:chExt cx="1797032" cy="338554"/>
          </a:xfrm>
        </p:grpSpPr>
        <p:sp>
          <p:nvSpPr>
            <p:cNvPr id="28" name="テキスト ボックス 27"/>
            <p:cNvSpPr txBox="1"/>
            <p:nvPr/>
          </p:nvSpPr>
          <p:spPr>
            <a:xfrm>
              <a:off x="9236168" y="2774420"/>
              <a:ext cx="16368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Training set: AUC=0.8961</a:t>
              </a:r>
            </a:p>
            <a:p>
              <a:r>
                <a:rPr lang="en-US" altLang="ja-JP" sz="800" dirty="0">
                  <a:latin typeface="Verdana" charset="0"/>
                  <a:ea typeface="Verdana" charset="0"/>
                  <a:cs typeface="Verdana" charset="0"/>
                </a:rPr>
                <a:t>Validation </a:t>
              </a:r>
              <a:r>
                <a:rPr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set: AUC=0.9009</a:t>
              </a:r>
              <a:endParaRPr lang="ja-JP" altLang="en-US" sz="800" dirty="0">
                <a:latin typeface="Verdana" charset="0"/>
                <a:ea typeface="Verdana" charset="0"/>
                <a:cs typeface="Verdana" charset="0"/>
              </a:endParaRPr>
            </a:p>
          </p:txBody>
        </p:sp>
        <p:grpSp>
          <p:nvGrpSpPr>
            <p:cNvPr id="29" name="図形グループ 28"/>
            <p:cNvGrpSpPr/>
            <p:nvPr/>
          </p:nvGrpSpPr>
          <p:grpSpPr>
            <a:xfrm>
              <a:off x="9075944" y="2877479"/>
              <a:ext cx="199825" cy="132435"/>
              <a:chOff x="8696607" y="2877727"/>
              <a:chExt cx="399477" cy="132435"/>
            </a:xfrm>
          </p:grpSpPr>
          <p:cxnSp>
            <p:nvCxnSpPr>
              <p:cNvPr id="30" name="直線コネクタ 29"/>
              <p:cNvCxnSpPr/>
              <p:nvPr/>
            </p:nvCxnSpPr>
            <p:spPr>
              <a:xfrm>
                <a:off x="8696607" y="2877727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線コネクタ 30"/>
              <p:cNvCxnSpPr/>
              <p:nvPr/>
            </p:nvCxnSpPr>
            <p:spPr>
              <a:xfrm>
                <a:off x="8696607" y="3010162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" name="図形グループ 31"/>
          <p:cNvGrpSpPr/>
          <p:nvPr/>
        </p:nvGrpSpPr>
        <p:grpSpPr>
          <a:xfrm>
            <a:off x="9075944" y="6049013"/>
            <a:ext cx="1797032" cy="338554"/>
            <a:chOff x="9075944" y="2774420"/>
            <a:chExt cx="1797032" cy="338554"/>
          </a:xfrm>
        </p:grpSpPr>
        <p:sp>
          <p:nvSpPr>
            <p:cNvPr id="33" name="テキスト ボックス 32"/>
            <p:cNvSpPr txBox="1"/>
            <p:nvPr/>
          </p:nvSpPr>
          <p:spPr>
            <a:xfrm>
              <a:off x="9236168" y="2774420"/>
              <a:ext cx="16368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Training set: AUC=0.9599</a:t>
              </a:r>
            </a:p>
            <a:p>
              <a:r>
                <a:rPr lang="en-US" altLang="ja-JP" sz="800" dirty="0">
                  <a:latin typeface="Verdana" charset="0"/>
                  <a:ea typeface="Verdana" charset="0"/>
                  <a:cs typeface="Verdana" charset="0"/>
                </a:rPr>
                <a:t>Validation </a:t>
              </a:r>
              <a:r>
                <a:rPr lang="en-US" altLang="ja-JP" sz="800" dirty="0" smtClean="0">
                  <a:latin typeface="Verdana" charset="0"/>
                  <a:ea typeface="Verdana" charset="0"/>
                  <a:cs typeface="Verdana" charset="0"/>
                </a:rPr>
                <a:t>set: AUC=0.8839</a:t>
              </a:r>
              <a:endParaRPr lang="ja-JP" altLang="en-US" sz="800" dirty="0">
                <a:latin typeface="Verdana" charset="0"/>
                <a:ea typeface="Verdana" charset="0"/>
                <a:cs typeface="Verdana" charset="0"/>
              </a:endParaRPr>
            </a:p>
          </p:txBody>
        </p:sp>
        <p:grpSp>
          <p:nvGrpSpPr>
            <p:cNvPr id="34" name="図形グループ 33"/>
            <p:cNvGrpSpPr/>
            <p:nvPr/>
          </p:nvGrpSpPr>
          <p:grpSpPr>
            <a:xfrm>
              <a:off x="9075944" y="2877479"/>
              <a:ext cx="199825" cy="132435"/>
              <a:chOff x="8696607" y="2877727"/>
              <a:chExt cx="399477" cy="132435"/>
            </a:xfrm>
          </p:grpSpPr>
          <p:cxnSp>
            <p:nvCxnSpPr>
              <p:cNvPr id="35" name="直線コネクタ 34"/>
              <p:cNvCxnSpPr/>
              <p:nvPr/>
            </p:nvCxnSpPr>
            <p:spPr>
              <a:xfrm>
                <a:off x="8696607" y="2877727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線コネクタ 35"/>
              <p:cNvCxnSpPr/>
              <p:nvPr/>
            </p:nvCxnSpPr>
            <p:spPr>
              <a:xfrm>
                <a:off x="8696607" y="3010162"/>
                <a:ext cx="399477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テキスト ボックス 1"/>
          <p:cNvSpPr txBox="1"/>
          <p:nvPr/>
        </p:nvSpPr>
        <p:spPr>
          <a:xfrm>
            <a:off x="4353008" y="49447"/>
            <a:ext cx="199605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OC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urves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or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tage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-I</a:t>
            </a:r>
            <a:endParaRPr kumimoji="1" lang="ja-JP" altLang="en-US" sz="1100" dirty="0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8531622" y="49447"/>
            <a:ext cx="199766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OC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urves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or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tage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A</a:t>
            </a:r>
            <a:endParaRPr kumimoji="1" lang="ja-JP" altLang="en-US" sz="1100" dirty="0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231179" y="3410557"/>
            <a:ext cx="2239716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OC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urves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or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tage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B-III</a:t>
            </a:r>
            <a:endParaRPr kumimoji="1" lang="ja-JP" altLang="en-US" sz="1100" dirty="0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8711960" y="3410557"/>
            <a:ext cx="163698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OC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urves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or</a:t>
            </a:r>
            <a:r>
              <a:rPr kumimoji="1" lang="ja-JP" altLang="en-US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100" dirty="0" smtClean="0">
                <a:latin typeface="Verdana" panose="020B0604030504040204" pitchFamily="34" charset="0"/>
                <a:cs typeface="Verdana" panose="020B0604030504040204" pitchFamily="34" charset="0"/>
              </a:rPr>
              <a:t>MBC</a:t>
            </a:r>
            <a:endParaRPr kumimoji="1" lang="ja-JP" altLang="en-US" sz="1100" dirty="0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13784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68" r="4125" b="9781"/>
          <a:stretch/>
        </p:blipFill>
        <p:spPr>
          <a:xfrm>
            <a:off x="2340862" y="1827137"/>
            <a:ext cx="3520442" cy="2798065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70" r="5260" b="8033"/>
          <a:stretch/>
        </p:blipFill>
        <p:spPr>
          <a:xfrm>
            <a:off x="6003606" y="1810511"/>
            <a:ext cx="3478722" cy="2880361"/>
          </a:xfrm>
          <a:prstGeom prst="rect">
            <a:avLst/>
          </a:prstGeom>
        </p:spPr>
      </p:pic>
      <p:sp>
        <p:nvSpPr>
          <p:cNvPr id="4" name="タイトル 1"/>
          <p:cNvSpPr txBox="1">
            <a:spLocks/>
          </p:cNvSpPr>
          <p:nvPr/>
        </p:nvSpPr>
        <p:spPr>
          <a:xfrm>
            <a:off x="225552" y="227965"/>
            <a:ext cx="2874264" cy="4212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 smtClean="0">
                <a:latin typeface="+mn-lt"/>
                <a:ea typeface="Verdana" charset="0"/>
                <a:cs typeface="Verdana" charset="0"/>
              </a:rPr>
              <a:t>Supplemental Figure 10 </a:t>
            </a:r>
            <a:endParaRPr lang="ja-JP" altLang="en-US" sz="1800" dirty="0">
              <a:latin typeface="+mn-lt"/>
              <a:ea typeface="Verdana" charset="0"/>
              <a:cs typeface="Verdana" charset="0"/>
            </a:endParaRPr>
          </a:p>
        </p:txBody>
      </p:sp>
      <p:sp>
        <p:nvSpPr>
          <p:cNvPr id="5" name="タイトル 1"/>
          <p:cNvSpPr txBox="1">
            <a:spLocks/>
          </p:cNvSpPr>
          <p:nvPr/>
        </p:nvSpPr>
        <p:spPr>
          <a:xfrm>
            <a:off x="3715512" y="1477644"/>
            <a:ext cx="1222248" cy="4212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smtClean="0">
                <a:latin typeface="Verdana" charset="0"/>
                <a:ea typeface="Verdana" charset="0"/>
                <a:cs typeface="Verdana" charset="0"/>
              </a:rPr>
              <a:t>HER2 BC</a:t>
            </a:r>
            <a:endParaRPr lang="ja-JP" altLang="en-US" sz="18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6" name="タイトル 1"/>
          <p:cNvSpPr txBox="1">
            <a:spLocks/>
          </p:cNvSpPr>
          <p:nvPr/>
        </p:nvSpPr>
        <p:spPr>
          <a:xfrm>
            <a:off x="7040880" y="1477644"/>
            <a:ext cx="1828800" cy="421259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 smtClean="0">
                <a:latin typeface="Verdana" charset="0"/>
                <a:ea typeface="Verdana" charset="0"/>
                <a:cs typeface="Verdana" charset="0"/>
              </a:rPr>
              <a:t>Luminal HER2</a:t>
            </a:r>
            <a:endParaRPr lang="ja-JP" altLang="en-US" sz="1800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687820" y="4374965"/>
            <a:ext cx="3203121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en-US" altLang="ja-JP" sz="900" b="1" dirty="0" smtClean="0">
                <a:latin typeface="Verdana" charset="0"/>
                <a:ea typeface="Verdana" charset="0"/>
                <a:cs typeface="Verdana" charset="0"/>
              </a:rPr>
              <a:t>    I                   IIA             IIB-III             MBC</a:t>
            </a:r>
            <a:endParaRPr kumimoji="1" lang="ja-JP" altLang="en-US" sz="900" b="1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973588" y="4637648"/>
            <a:ext cx="615874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 smtClean="0">
                <a:latin typeface="Verdana" charset="0"/>
                <a:ea typeface="Verdana" charset="0"/>
                <a:cs typeface="Verdana" charset="0"/>
              </a:rPr>
              <a:t>Stage</a:t>
            </a:r>
            <a:endParaRPr kumimoji="1" lang="ja-JP" altLang="en-US" sz="1050" b="1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353732" y="4374965"/>
            <a:ext cx="3163045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Verdana" charset="0"/>
                <a:ea typeface="Verdana" charset="0"/>
                <a:cs typeface="Verdana" charset="0"/>
              </a:rPr>
              <a:t> </a:t>
            </a:r>
            <a:r>
              <a:rPr lang="en-US" altLang="ja-JP" sz="900" b="1" dirty="0" smtClean="0">
                <a:latin typeface="Verdana" charset="0"/>
                <a:ea typeface="Verdana" charset="0"/>
                <a:cs typeface="Verdana" charset="0"/>
              </a:rPr>
              <a:t>    I                   IIA             IIB-III            MBC</a:t>
            </a:r>
            <a:endParaRPr kumimoji="1" lang="ja-JP" altLang="en-US" sz="900" b="1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647813" y="4637648"/>
            <a:ext cx="615874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b="1" dirty="0" smtClean="0">
                <a:latin typeface="Verdana" charset="0"/>
                <a:ea typeface="Verdana" charset="0"/>
                <a:cs typeface="Verdana" charset="0"/>
              </a:rPr>
              <a:t>Stage</a:t>
            </a:r>
            <a:endParaRPr kumimoji="1" lang="ja-JP" altLang="en-US" sz="1050" b="1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1672104" y="2956751"/>
            <a:ext cx="154561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Verdana" charset="0"/>
                <a:ea typeface="Verdana" charset="0"/>
                <a:cs typeface="Verdana" charset="0"/>
              </a:rPr>
              <a:t>Detecting </a:t>
            </a:r>
            <a:r>
              <a:rPr lang="en-US" altLang="ja-JP" sz="1200" b="1" dirty="0" smtClean="0">
                <a:latin typeface="Verdana" charset="0"/>
                <a:ea typeface="Verdana" charset="0"/>
                <a:cs typeface="Verdana" charset="0"/>
              </a:rPr>
              <a:t>index</a:t>
            </a:r>
            <a:endParaRPr kumimoji="1" lang="ja-JP" altLang="en-US" sz="1200" b="1" dirty="0"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5313069" y="2956751"/>
            <a:ext cx="154561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Verdana" charset="0"/>
                <a:ea typeface="Verdana" charset="0"/>
                <a:cs typeface="Verdana" charset="0"/>
              </a:rPr>
              <a:t>Detecting index</a:t>
            </a:r>
            <a:endParaRPr kumimoji="1" lang="ja-JP" altLang="en-US" sz="1200" b="1" dirty="0">
              <a:latin typeface="Verdana" charset="0"/>
              <a:ea typeface="Verdana" charset="0"/>
              <a:cs typeface="Verdan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1565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87627" y="175508"/>
            <a:ext cx="24862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l Figure 11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5751" y="611342"/>
            <a:ext cx="7563113" cy="5464628"/>
          </a:xfrm>
          <a:prstGeom prst="rect">
            <a:avLst/>
          </a:prstGeom>
        </p:spPr>
      </p:pic>
      <p:cxnSp>
        <p:nvCxnSpPr>
          <p:cNvPr id="6" name="直線コネクタ 5"/>
          <p:cNvCxnSpPr/>
          <p:nvPr/>
        </p:nvCxnSpPr>
        <p:spPr>
          <a:xfrm>
            <a:off x="4528457" y="5849257"/>
            <a:ext cx="27432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7467600" y="5849257"/>
            <a:ext cx="27432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5050971" y="5849257"/>
            <a:ext cx="1949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Healthy volunteers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705877" y="5819994"/>
            <a:ext cx="22666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reast </a:t>
            </a:r>
            <a:r>
              <a:rPr kumimoji="1" lang="en-US" altLang="ja-JP" smtClean="0"/>
              <a:t>cancer patients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1034825" y="3158989"/>
            <a:ext cx="518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 smtClean="0"/>
              <a:t>cfDNA</a:t>
            </a:r>
            <a:r>
              <a:rPr lang="en-US" altLang="ja-JP" dirty="0" smtClean="0"/>
              <a:t> concentration (copies/ mL, log10 transformed)</a:t>
            </a:r>
            <a:endParaRPr kumimoji="1" lang="ja-JP" altLang="en-US" dirty="0"/>
          </a:p>
        </p:txBody>
      </p:sp>
      <p:sp>
        <p:nvSpPr>
          <p:cNvPr id="12" name="左大かっこ 11"/>
          <p:cNvSpPr/>
          <p:nvPr/>
        </p:nvSpPr>
        <p:spPr>
          <a:xfrm rot="5400000">
            <a:off x="5691006" y="899683"/>
            <a:ext cx="243114" cy="1557065"/>
          </a:xfrm>
          <a:prstGeom prst="leftBracket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左大かっこ 12"/>
          <p:cNvSpPr/>
          <p:nvPr/>
        </p:nvSpPr>
        <p:spPr>
          <a:xfrm rot="16200000" flipV="1">
            <a:off x="8601529" y="3490484"/>
            <a:ext cx="243114" cy="1557065"/>
          </a:xfrm>
          <a:prstGeom prst="leftBracket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630462" y="1181692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*</a:t>
            </a:r>
            <a:endParaRPr kumimoji="1" lang="ja-JP" altLang="en-US" sz="36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599041" y="4361781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*</a:t>
            </a:r>
            <a:endParaRPr kumimoji="1" lang="ja-JP" altLang="en-US" sz="3600" dirty="0"/>
          </a:p>
        </p:txBody>
      </p:sp>
    </p:spTree>
    <p:extLst>
      <p:ext uri="{BB962C8B-B14F-4D97-AF65-F5344CB8AC3E}">
        <p14:creationId xmlns:p14="http://schemas.microsoft.com/office/powerpoint/2010/main" val="201733488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9384" y="1556280"/>
            <a:ext cx="5385592" cy="4137355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3800677" y="1077686"/>
            <a:ext cx="1838645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/>
              <a:t>Negative </a:t>
            </a:r>
            <a:r>
              <a:rPr lang="en-US" altLang="ja-JP" dirty="0" smtClean="0"/>
              <a:t>droplets</a:t>
            </a:r>
            <a:endParaRPr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6932180" y="3924643"/>
            <a:ext cx="213064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/>
              <a:t>Droplets with signals</a:t>
            </a:r>
            <a:endParaRPr lang="ja-JP" altLang="en-US" dirty="0"/>
          </a:p>
        </p:txBody>
      </p:sp>
      <p:cxnSp>
        <p:nvCxnSpPr>
          <p:cNvPr id="6" name="直線矢印コネクタ 5"/>
          <p:cNvCxnSpPr/>
          <p:nvPr/>
        </p:nvCxnSpPr>
        <p:spPr>
          <a:xfrm>
            <a:off x="5425369" y="1447019"/>
            <a:ext cx="24493" cy="300139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/>
          <p:cNvCxnSpPr>
            <a:endCxn id="20" idx="1"/>
          </p:cNvCxnSpPr>
          <p:nvPr/>
        </p:nvCxnSpPr>
        <p:spPr>
          <a:xfrm flipH="1">
            <a:off x="7519792" y="4293975"/>
            <a:ext cx="190411" cy="53928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3800676" y="5752313"/>
            <a:ext cx="585916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/>
              <a:t>Upper limit of the peak range as a baseline of droplet signals</a:t>
            </a:r>
            <a:endParaRPr lang="ja-JP" altLang="en-US" dirty="0"/>
          </a:p>
        </p:txBody>
      </p:sp>
      <p:cxnSp>
        <p:nvCxnSpPr>
          <p:cNvPr id="11" name="直線矢印コネクタ 10"/>
          <p:cNvCxnSpPr/>
          <p:nvPr/>
        </p:nvCxnSpPr>
        <p:spPr>
          <a:xfrm flipH="1" flipV="1">
            <a:off x="5929785" y="4478694"/>
            <a:ext cx="371500" cy="129462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6497223" y="2913774"/>
            <a:ext cx="4023563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/>
              <a:t>Distribution of droplet signals delineated by </a:t>
            </a:r>
            <a:r>
              <a:rPr lang="en-US" altLang="ja-JP" dirty="0" err="1"/>
              <a:t>ksdensity</a:t>
            </a:r>
            <a:r>
              <a:rPr lang="en-US" altLang="ja-JP" dirty="0"/>
              <a:t> function of </a:t>
            </a:r>
            <a:r>
              <a:rPr lang="en-US" altLang="ja-JP" dirty="0" err="1"/>
              <a:t>Matlab</a:t>
            </a:r>
            <a:endParaRPr lang="ja-JP" altLang="en-US" dirty="0"/>
          </a:p>
        </p:txBody>
      </p:sp>
      <p:cxnSp>
        <p:nvCxnSpPr>
          <p:cNvPr id="18" name="直線矢印コネクタ 17"/>
          <p:cNvCxnSpPr/>
          <p:nvPr/>
        </p:nvCxnSpPr>
        <p:spPr>
          <a:xfrm flipH="1">
            <a:off x="5558288" y="3283105"/>
            <a:ext cx="938935" cy="563832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右中かっこ 19"/>
          <p:cNvSpPr/>
          <p:nvPr/>
        </p:nvSpPr>
        <p:spPr>
          <a:xfrm rot="16200000">
            <a:off x="7405172" y="3357869"/>
            <a:ext cx="229239" cy="3180010"/>
          </a:xfrm>
          <a:prstGeom prst="rightBrace">
            <a:avLst>
              <a:gd name="adj1" fmla="val 29775"/>
              <a:gd name="adj2" fmla="val 500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87626" y="242010"/>
            <a:ext cx="2606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 smtClean="0"/>
              <a:t>12-A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48149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/>
          <a:srcRect l="11007" t="2024" r="6684" b="2995"/>
          <a:stretch/>
        </p:blipFill>
        <p:spPr>
          <a:xfrm>
            <a:off x="3831276" y="791836"/>
            <a:ext cx="3698853" cy="5219404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4276250" y="3804815"/>
            <a:ext cx="546948" cy="2002471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8" name="角丸四角形 7"/>
          <p:cNvSpPr/>
          <p:nvPr/>
        </p:nvSpPr>
        <p:spPr>
          <a:xfrm>
            <a:off x="6528936" y="1023605"/>
            <a:ext cx="1001193" cy="2512359"/>
          </a:xfrm>
          <a:prstGeom prst="roundRect">
            <a:avLst/>
          </a:prstGeom>
          <a:noFill/>
          <a:ln w="28575" cmpd="sng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grpSp>
        <p:nvGrpSpPr>
          <p:cNvPr id="9" name="図形グループ 8"/>
          <p:cNvGrpSpPr/>
          <p:nvPr/>
        </p:nvGrpSpPr>
        <p:grpSpPr>
          <a:xfrm>
            <a:off x="4359684" y="3767732"/>
            <a:ext cx="2975769" cy="1086635"/>
            <a:chOff x="843598" y="3893694"/>
            <a:chExt cx="2975769" cy="1086635"/>
          </a:xfrm>
        </p:grpSpPr>
        <p:cxnSp>
          <p:nvCxnSpPr>
            <p:cNvPr id="10" name="直線コネクタ 9"/>
            <p:cNvCxnSpPr/>
            <p:nvPr/>
          </p:nvCxnSpPr>
          <p:spPr>
            <a:xfrm>
              <a:off x="843598" y="3930777"/>
              <a:ext cx="2975769" cy="0"/>
            </a:xfrm>
            <a:prstGeom prst="line">
              <a:avLst/>
            </a:prstGeom>
            <a:ln>
              <a:solidFill>
                <a:srgbClr val="6B09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テキスト ボックス 10"/>
            <p:cNvSpPr txBox="1"/>
            <p:nvPr/>
          </p:nvSpPr>
          <p:spPr>
            <a:xfrm>
              <a:off x="1459251" y="3893694"/>
              <a:ext cx="13796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Upper cutoff</a:t>
              </a:r>
              <a:endParaRPr lang="ja-JP" altLang="en-US" dirty="0"/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456014" y="4610997"/>
              <a:ext cx="13706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Lower cutoff</a:t>
              </a:r>
              <a:endParaRPr lang="ja-JP" altLang="en-US" dirty="0"/>
            </a:p>
          </p:txBody>
        </p:sp>
      </p:grpSp>
      <p:sp>
        <p:nvSpPr>
          <p:cNvPr id="13" name="テキスト ボックス 12"/>
          <p:cNvSpPr txBox="1"/>
          <p:nvPr/>
        </p:nvSpPr>
        <p:spPr>
          <a:xfrm>
            <a:off x="7775057" y="1023605"/>
            <a:ext cx="2590165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/>
              <a:t>Defective droplets </a:t>
            </a:r>
            <a:r>
              <a:rPr lang="en-US" altLang="ja-JP"/>
              <a:t>with extremely high signals</a:t>
            </a:r>
            <a:endParaRPr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719944" y="6036046"/>
            <a:ext cx="3418049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/>
              <a:t>Positive control reaction using </a:t>
            </a:r>
            <a:r>
              <a:rPr lang="en-US" altLang="ja-JP" dirty="0" err="1"/>
              <a:t>SssI</a:t>
            </a:r>
            <a:r>
              <a:rPr lang="en-US" altLang="ja-JP" dirty="0"/>
              <a:t> treated fully methylated DNA</a:t>
            </a:r>
            <a:endParaRPr lang="ja-JP" altLang="en-US" dirty="0"/>
          </a:p>
        </p:txBody>
      </p:sp>
      <p:cxnSp>
        <p:nvCxnSpPr>
          <p:cNvPr id="3" name="直線矢印コネクタ 2"/>
          <p:cNvCxnSpPr>
            <a:stCxn id="13" idx="1"/>
          </p:cNvCxnSpPr>
          <p:nvPr/>
        </p:nvCxnSpPr>
        <p:spPr>
          <a:xfrm flipH="1" flipV="1">
            <a:off x="7530128" y="1346770"/>
            <a:ext cx="24492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矢印コネクタ 6"/>
          <p:cNvCxnSpPr>
            <a:endCxn id="6" idx="2"/>
          </p:cNvCxnSpPr>
          <p:nvPr/>
        </p:nvCxnSpPr>
        <p:spPr>
          <a:xfrm flipV="1">
            <a:off x="4438650" y="5807286"/>
            <a:ext cx="111074" cy="2208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402140" y="242010"/>
            <a:ext cx="2598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 smtClean="0"/>
              <a:t>12-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292052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</p:bld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4035" y="2357563"/>
            <a:ext cx="4506247" cy="3379685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4992005" y="530071"/>
            <a:ext cx="39859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ignal distribution of positive droplets in concatenated datasets of all positive </a:t>
            </a:r>
            <a:r>
              <a:rPr lang="en-US" altLang="ja-JP"/>
              <a:t>control reactions.</a:t>
            </a:r>
            <a:endParaRPr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979633" y="6023435"/>
            <a:ext cx="40720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Upper limit of peak range of negative droplets was </a:t>
            </a:r>
            <a:r>
              <a:rPr lang="en-US" altLang="ja-JP" dirty="0" smtClean="0"/>
              <a:t>set </a:t>
            </a:r>
            <a:r>
              <a:rPr lang="en-US" altLang="ja-JP" dirty="0"/>
              <a:t>as zero.</a:t>
            </a:r>
            <a:endParaRPr lang="ja-JP" altLang="en-US" dirty="0"/>
          </a:p>
        </p:txBody>
      </p:sp>
      <p:cxnSp>
        <p:nvCxnSpPr>
          <p:cNvPr id="5" name="直線矢印コネクタ 4"/>
          <p:cNvCxnSpPr/>
          <p:nvPr/>
        </p:nvCxnSpPr>
        <p:spPr>
          <a:xfrm flipV="1">
            <a:off x="4280030" y="5485349"/>
            <a:ext cx="9330" cy="538086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/>
          <p:cNvSpPr txBox="1"/>
          <p:nvPr/>
        </p:nvSpPr>
        <p:spPr>
          <a:xfrm>
            <a:off x="4927377" y="1582317"/>
            <a:ext cx="4279217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/>
              <a:t>Upper range limit of main peak of positive droplets was </a:t>
            </a:r>
            <a:r>
              <a:rPr lang="en-US" altLang="ja-JP" dirty="0" smtClean="0"/>
              <a:t>set </a:t>
            </a:r>
            <a:r>
              <a:rPr lang="en-US" altLang="ja-JP" dirty="0"/>
              <a:t>as upper cutoff point</a:t>
            </a:r>
            <a:endParaRPr lang="ja-JP" altLang="en-US" dirty="0"/>
          </a:p>
        </p:txBody>
      </p:sp>
      <p:cxnSp>
        <p:nvCxnSpPr>
          <p:cNvPr id="7" name="直線矢印コネクタ 6"/>
          <p:cNvCxnSpPr/>
          <p:nvPr/>
        </p:nvCxnSpPr>
        <p:spPr>
          <a:xfrm flipH="1">
            <a:off x="7228504" y="2228649"/>
            <a:ext cx="12441" cy="394513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402140" y="242010"/>
            <a:ext cx="2597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 smtClean="0"/>
              <a:t>12-C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3554925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5568334" y="596071"/>
            <a:ext cx="4247188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/>
              <a:t>Marker concentration was calculated using </a:t>
            </a:r>
          </a:p>
          <a:p>
            <a:r>
              <a:rPr lang="en-US" altLang="ja-JP" dirty="0"/>
              <a:t>moving tentative cutoff thresholds</a:t>
            </a: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1660" y="2220937"/>
            <a:ext cx="6012026" cy="4618598"/>
          </a:xfrm>
          <a:prstGeom prst="rect">
            <a:avLst/>
          </a:prstGeom>
        </p:spPr>
      </p:pic>
      <p:cxnSp>
        <p:nvCxnSpPr>
          <p:cNvPr id="6" name="直線コネクタ 5"/>
          <p:cNvCxnSpPr/>
          <p:nvPr/>
        </p:nvCxnSpPr>
        <p:spPr>
          <a:xfrm flipV="1">
            <a:off x="8282054" y="2403157"/>
            <a:ext cx="0" cy="3995671"/>
          </a:xfrm>
          <a:prstGeom prst="line">
            <a:avLst/>
          </a:prstGeom>
          <a:ln w="12700" cmpd="sng">
            <a:solidFill>
              <a:srgbClr val="6B09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 flipV="1">
            <a:off x="4550193" y="2403157"/>
            <a:ext cx="0" cy="3995671"/>
          </a:xfrm>
          <a:prstGeom prst="line">
            <a:avLst/>
          </a:prstGeom>
          <a:ln w="12700" cmpd="sng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 flipV="1">
            <a:off x="4702593" y="2405045"/>
            <a:ext cx="0" cy="3995671"/>
          </a:xfrm>
          <a:prstGeom prst="line">
            <a:avLst/>
          </a:prstGeom>
          <a:ln w="12700" cmpd="sng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 flipV="1">
            <a:off x="4854993" y="2406933"/>
            <a:ext cx="0" cy="3995671"/>
          </a:xfrm>
          <a:prstGeom prst="line">
            <a:avLst/>
          </a:prstGeom>
          <a:ln w="12700" cmpd="sng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 flipV="1">
            <a:off x="5007393" y="2408821"/>
            <a:ext cx="0" cy="3995671"/>
          </a:xfrm>
          <a:prstGeom prst="line">
            <a:avLst/>
          </a:prstGeom>
          <a:ln w="12700" cmpd="sng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 flipV="1">
            <a:off x="5159793" y="2410709"/>
            <a:ext cx="0" cy="3995671"/>
          </a:xfrm>
          <a:prstGeom prst="line">
            <a:avLst/>
          </a:prstGeom>
          <a:ln w="12700" cmpd="sng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 flipV="1">
            <a:off x="5312193" y="2412597"/>
            <a:ext cx="0" cy="3995671"/>
          </a:xfrm>
          <a:prstGeom prst="line">
            <a:avLst/>
          </a:prstGeom>
          <a:ln w="12700" cmpd="sng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 flipV="1">
            <a:off x="5464593" y="2414485"/>
            <a:ext cx="0" cy="3995671"/>
          </a:xfrm>
          <a:prstGeom prst="line">
            <a:avLst/>
          </a:prstGeom>
          <a:ln w="12700" cmpd="sng">
            <a:solidFill>
              <a:srgbClr val="FF0000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/>
          <p:cNvCxnSpPr/>
          <p:nvPr/>
        </p:nvCxnSpPr>
        <p:spPr>
          <a:xfrm flipH="1">
            <a:off x="4550194" y="3226735"/>
            <a:ext cx="3731861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矢印コネクタ 16"/>
          <p:cNvCxnSpPr/>
          <p:nvPr/>
        </p:nvCxnSpPr>
        <p:spPr>
          <a:xfrm flipH="1">
            <a:off x="4702593" y="3390424"/>
            <a:ext cx="3579462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/>
          <p:cNvCxnSpPr/>
          <p:nvPr/>
        </p:nvCxnSpPr>
        <p:spPr>
          <a:xfrm flipH="1">
            <a:off x="4854993" y="3554113"/>
            <a:ext cx="3427062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/>
          <p:cNvCxnSpPr/>
          <p:nvPr/>
        </p:nvCxnSpPr>
        <p:spPr>
          <a:xfrm flipH="1">
            <a:off x="5007393" y="3717802"/>
            <a:ext cx="3274662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/>
          <p:cNvCxnSpPr/>
          <p:nvPr/>
        </p:nvCxnSpPr>
        <p:spPr>
          <a:xfrm flipH="1">
            <a:off x="5159793" y="3881491"/>
            <a:ext cx="3122262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/>
          <p:cNvCxnSpPr/>
          <p:nvPr/>
        </p:nvCxnSpPr>
        <p:spPr>
          <a:xfrm flipH="1">
            <a:off x="5312193" y="4045180"/>
            <a:ext cx="2969862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/>
          <p:cNvCxnSpPr/>
          <p:nvPr/>
        </p:nvCxnSpPr>
        <p:spPr>
          <a:xfrm flipH="1">
            <a:off x="5464593" y="4208869"/>
            <a:ext cx="2817462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8180261" y="1637723"/>
            <a:ext cx="216116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/>
              <a:t>Upper cutoff point</a:t>
            </a:r>
            <a:endParaRPr lang="ja-JP" altLang="en-US" dirty="0"/>
          </a:p>
        </p:txBody>
      </p:sp>
      <p:cxnSp>
        <p:nvCxnSpPr>
          <p:cNvPr id="24" name="直線矢印コネクタ 23"/>
          <p:cNvCxnSpPr/>
          <p:nvPr/>
        </p:nvCxnSpPr>
        <p:spPr>
          <a:xfrm flipH="1">
            <a:off x="8282055" y="2007585"/>
            <a:ext cx="12441" cy="394513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1770535" y="1155221"/>
            <a:ext cx="2621039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/>
              <a:t>Signal baseline as upper range limit of </a:t>
            </a:r>
            <a:r>
              <a:rPr lang="en-US" altLang="ja-JP"/>
              <a:t>negative droplets</a:t>
            </a:r>
            <a:endParaRPr lang="ja-JP" altLang="en-US" dirty="0"/>
          </a:p>
        </p:txBody>
      </p:sp>
      <p:cxnSp>
        <p:nvCxnSpPr>
          <p:cNvPr id="26" name="直線矢印コネクタ 25"/>
          <p:cNvCxnSpPr/>
          <p:nvPr/>
        </p:nvCxnSpPr>
        <p:spPr>
          <a:xfrm>
            <a:off x="4391574" y="2030152"/>
            <a:ext cx="149339" cy="46332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>
            <a:off x="4550193" y="2204840"/>
            <a:ext cx="3262640" cy="0"/>
          </a:xfrm>
          <a:prstGeom prst="straightConnector1">
            <a:avLst/>
          </a:prstGeom>
          <a:ln w="254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 flipH="1">
            <a:off x="5581651" y="1250827"/>
            <a:ext cx="261257" cy="970111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387626" y="242010"/>
            <a:ext cx="2616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 smtClean="0"/>
              <a:t>12-D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856471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図 8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12" t="65120" r="7593" b="8573"/>
          <a:stretch/>
        </p:blipFill>
        <p:spPr>
          <a:xfrm>
            <a:off x="1836683" y="4591983"/>
            <a:ext cx="9811978" cy="1774948"/>
          </a:xfrm>
          <a:prstGeom prst="rect">
            <a:avLst/>
          </a:prstGeom>
        </p:spPr>
      </p:pic>
      <p:pic>
        <p:nvPicPr>
          <p:cNvPr id="80" name="図 7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12" t="35094" r="7793" b="38599"/>
          <a:stretch/>
        </p:blipFill>
        <p:spPr>
          <a:xfrm>
            <a:off x="1840241" y="2443005"/>
            <a:ext cx="9811978" cy="1774948"/>
          </a:xfrm>
          <a:prstGeom prst="rect">
            <a:avLst/>
          </a:prstGeom>
        </p:spPr>
      </p:pic>
      <p:pic>
        <p:nvPicPr>
          <p:cNvPr id="35" name="図 3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79" t="4834" r="7526" b="68859"/>
          <a:stretch/>
        </p:blipFill>
        <p:spPr>
          <a:xfrm>
            <a:off x="1836683" y="430295"/>
            <a:ext cx="9811978" cy="1774948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195109" y="125940"/>
            <a:ext cx="26765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/>
              <a:t>2</a:t>
            </a:r>
            <a:r>
              <a:rPr lang="en-US" altLang="ja-JP" dirty="0" smtClean="0"/>
              <a:t>-B</a:t>
            </a:r>
            <a:endParaRPr kumimoji="1" lang="ja-JP" altLang="en-US" dirty="0"/>
          </a:p>
        </p:txBody>
      </p:sp>
      <p:sp>
        <p:nvSpPr>
          <p:cNvPr id="4" name="右大かっこ 3"/>
          <p:cNvSpPr/>
          <p:nvPr/>
        </p:nvSpPr>
        <p:spPr>
          <a:xfrm rot="5400000" flipV="1">
            <a:off x="2747098" y="2042697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右大かっこ 4"/>
          <p:cNvSpPr/>
          <p:nvPr/>
        </p:nvSpPr>
        <p:spPr>
          <a:xfrm rot="5400000" flipV="1">
            <a:off x="3643281" y="2042698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右大かっこ 5"/>
          <p:cNvSpPr/>
          <p:nvPr/>
        </p:nvSpPr>
        <p:spPr>
          <a:xfrm rot="5400000" flipV="1">
            <a:off x="5193110" y="2042698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右大かっこ 6"/>
          <p:cNvSpPr/>
          <p:nvPr/>
        </p:nvSpPr>
        <p:spPr>
          <a:xfrm rot="5400000" flipV="1">
            <a:off x="6089427" y="2042697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右大かっこ 7"/>
          <p:cNvSpPr/>
          <p:nvPr/>
        </p:nvSpPr>
        <p:spPr>
          <a:xfrm rot="5400000" flipV="1">
            <a:off x="7607860" y="2042697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右大かっこ 8"/>
          <p:cNvSpPr/>
          <p:nvPr/>
        </p:nvSpPr>
        <p:spPr>
          <a:xfrm rot="5400000" flipV="1">
            <a:off x="8535846" y="2042697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右大かっこ 9"/>
          <p:cNvSpPr/>
          <p:nvPr/>
        </p:nvSpPr>
        <p:spPr>
          <a:xfrm rot="5400000" flipV="1">
            <a:off x="10070186" y="2042698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右大かっこ 10"/>
          <p:cNvSpPr/>
          <p:nvPr/>
        </p:nvSpPr>
        <p:spPr>
          <a:xfrm rot="5400000" flipV="1">
            <a:off x="10919342" y="2042697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右大かっこ 11"/>
          <p:cNvSpPr/>
          <p:nvPr/>
        </p:nvSpPr>
        <p:spPr>
          <a:xfrm rot="5400000" flipV="1">
            <a:off x="2787737" y="4046565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右大かっこ 12"/>
          <p:cNvSpPr/>
          <p:nvPr/>
        </p:nvSpPr>
        <p:spPr>
          <a:xfrm rot="5400000" flipV="1">
            <a:off x="3683919" y="4046566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大かっこ 13"/>
          <p:cNvSpPr/>
          <p:nvPr/>
        </p:nvSpPr>
        <p:spPr>
          <a:xfrm rot="5400000" flipV="1">
            <a:off x="5233748" y="4046565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右大かっこ 14"/>
          <p:cNvSpPr/>
          <p:nvPr/>
        </p:nvSpPr>
        <p:spPr>
          <a:xfrm rot="5400000" flipV="1">
            <a:off x="6130066" y="4046566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右大かっこ 15"/>
          <p:cNvSpPr/>
          <p:nvPr/>
        </p:nvSpPr>
        <p:spPr>
          <a:xfrm rot="5400000" flipV="1">
            <a:off x="7648499" y="4044990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右大かっこ 16"/>
          <p:cNvSpPr/>
          <p:nvPr/>
        </p:nvSpPr>
        <p:spPr>
          <a:xfrm rot="5400000" flipV="1">
            <a:off x="8576486" y="4044990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大かっこ 17"/>
          <p:cNvSpPr/>
          <p:nvPr/>
        </p:nvSpPr>
        <p:spPr>
          <a:xfrm rot="5400000" flipV="1">
            <a:off x="10110824" y="4044988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右大かっこ 18"/>
          <p:cNvSpPr/>
          <p:nvPr/>
        </p:nvSpPr>
        <p:spPr>
          <a:xfrm rot="5400000" flipV="1">
            <a:off x="10959982" y="4044991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右大かっこ 19"/>
          <p:cNvSpPr/>
          <p:nvPr/>
        </p:nvSpPr>
        <p:spPr>
          <a:xfrm rot="5400000" flipV="1">
            <a:off x="2787737" y="6166959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大かっこ 20"/>
          <p:cNvSpPr/>
          <p:nvPr/>
        </p:nvSpPr>
        <p:spPr>
          <a:xfrm rot="5400000" flipV="1">
            <a:off x="3653436" y="6166960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右大かっこ 21"/>
          <p:cNvSpPr/>
          <p:nvPr/>
        </p:nvSpPr>
        <p:spPr>
          <a:xfrm rot="5400000" flipV="1">
            <a:off x="5233748" y="6166959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右大かっこ 22"/>
          <p:cNvSpPr/>
          <p:nvPr/>
        </p:nvSpPr>
        <p:spPr>
          <a:xfrm rot="5400000" flipV="1">
            <a:off x="6114164" y="6166960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右大かっこ 23"/>
          <p:cNvSpPr/>
          <p:nvPr/>
        </p:nvSpPr>
        <p:spPr>
          <a:xfrm rot="5400000" flipV="1">
            <a:off x="7648499" y="6166959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右大かっこ 24"/>
          <p:cNvSpPr/>
          <p:nvPr/>
        </p:nvSpPr>
        <p:spPr>
          <a:xfrm rot="5400000" flipV="1">
            <a:off x="8576485" y="6166960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右大かっこ 25"/>
          <p:cNvSpPr/>
          <p:nvPr/>
        </p:nvSpPr>
        <p:spPr>
          <a:xfrm rot="5400000" flipV="1">
            <a:off x="10110824" y="6165382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右大かっこ 26"/>
          <p:cNvSpPr/>
          <p:nvPr/>
        </p:nvSpPr>
        <p:spPr>
          <a:xfrm rot="5400000" flipV="1">
            <a:off x="10959980" y="6165383"/>
            <a:ext cx="45719" cy="457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05764" y="6007209"/>
            <a:ext cx="1923925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: T-test, 10</a:t>
            </a:r>
            <a:r>
              <a:rPr lang="en-US" altLang="ja-JP" sz="1100" baseline="30000" dirty="0" smtClean="0">
                <a:latin typeface="Meiryo" charset="-128"/>
                <a:ea typeface="Meiryo" charset="-128"/>
                <a:cs typeface="Meiryo" charset="-128"/>
              </a:rPr>
              <a:t>-10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&lt;p</a:t>
            </a:r>
            <a:r>
              <a:rPr kumimoji="1"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&lt;10</a:t>
            </a:r>
            <a:r>
              <a:rPr kumimoji="1" lang="en-US" altLang="ja-JP" sz="1100" baseline="30000" dirty="0" smtClean="0">
                <a:latin typeface="Meiryo" charset="-128"/>
                <a:ea typeface="Meiryo" charset="-128"/>
                <a:cs typeface="Meiryo" charset="-128"/>
              </a:rPr>
              <a:t>-3</a:t>
            </a:r>
          </a:p>
          <a:p>
            <a:r>
              <a:rPr lang="en-US" altLang="ja-JP" sz="1100" dirty="0"/>
              <a:t>†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: </a:t>
            </a:r>
            <a:r>
              <a:rPr lang="en-US" altLang="ja-JP" sz="1100" dirty="0">
                <a:latin typeface="Meiryo" charset="-128"/>
                <a:ea typeface="Meiryo" charset="-128"/>
                <a:cs typeface="Meiryo" charset="-128"/>
              </a:rPr>
              <a:t>T-test, 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10</a:t>
            </a:r>
            <a:r>
              <a:rPr lang="en-US" altLang="ja-JP" sz="1100" baseline="30000" dirty="0" smtClean="0">
                <a:latin typeface="Meiryo" charset="-128"/>
                <a:ea typeface="Meiryo" charset="-128"/>
                <a:cs typeface="Meiryo" charset="-128"/>
              </a:rPr>
              <a:t>-20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&lt;p&lt;10</a:t>
            </a:r>
            <a:r>
              <a:rPr lang="en-US" altLang="ja-JP" sz="1100" baseline="30000" dirty="0" smtClean="0">
                <a:latin typeface="Meiryo" charset="-128"/>
                <a:ea typeface="Meiryo" charset="-128"/>
                <a:cs typeface="Meiryo" charset="-128"/>
              </a:rPr>
              <a:t>-10</a:t>
            </a:r>
            <a:endParaRPr lang="ja-JP" altLang="en-US" sz="1100" baseline="30000" dirty="0">
              <a:latin typeface="Meiryo" charset="-128"/>
              <a:ea typeface="Meiryo" charset="-128"/>
              <a:cs typeface="Meiryo" charset="-128"/>
            </a:endParaRPr>
          </a:p>
          <a:p>
            <a:r>
              <a:rPr lang="en-US" altLang="ja-JP" sz="1100" dirty="0" smtClean="0"/>
              <a:t>§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: </a:t>
            </a:r>
            <a:r>
              <a:rPr lang="en-US" altLang="ja-JP" sz="1100" dirty="0">
                <a:latin typeface="Meiryo" charset="-128"/>
                <a:ea typeface="Meiryo" charset="-128"/>
                <a:cs typeface="Meiryo" charset="-128"/>
              </a:rPr>
              <a:t>T-test, 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10</a:t>
            </a:r>
            <a:r>
              <a:rPr lang="en-US" altLang="ja-JP" sz="1100" baseline="30000" dirty="0" smtClean="0">
                <a:latin typeface="Meiryo" charset="-128"/>
                <a:ea typeface="Meiryo" charset="-128"/>
                <a:cs typeface="Meiryo" charset="-128"/>
              </a:rPr>
              <a:t>-30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&lt;p&lt;10</a:t>
            </a:r>
            <a:r>
              <a:rPr lang="en-US" altLang="ja-JP" sz="1100" baseline="30000" dirty="0" smtClean="0">
                <a:latin typeface="Meiryo" charset="-128"/>
                <a:ea typeface="Meiryo" charset="-128"/>
                <a:cs typeface="Meiryo" charset="-128"/>
              </a:rPr>
              <a:t>-20</a:t>
            </a:r>
            <a:endParaRPr lang="ja-JP" altLang="en-US" sz="1100" baseline="30000" dirty="0">
              <a:latin typeface="Meiryo" charset="-128"/>
              <a:ea typeface="Meiryo" charset="-128"/>
              <a:cs typeface="Meiryo" charset="-128"/>
            </a:endParaRPr>
          </a:p>
          <a:p>
            <a:r>
              <a:rPr lang="en-US" altLang="ja-JP" sz="1100" dirty="0" smtClean="0"/>
              <a:t>¶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: </a:t>
            </a:r>
            <a:r>
              <a:rPr lang="en-US" altLang="ja-JP" sz="1100" dirty="0">
                <a:latin typeface="Meiryo" charset="-128"/>
                <a:ea typeface="Meiryo" charset="-128"/>
                <a:cs typeface="Meiryo" charset="-128"/>
              </a:rPr>
              <a:t>T-test, </a:t>
            </a:r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p&lt;10</a:t>
            </a:r>
            <a:r>
              <a:rPr lang="en-US" altLang="ja-JP" sz="1100" baseline="30000" dirty="0" smtClean="0">
                <a:latin typeface="Meiryo" charset="-128"/>
                <a:ea typeface="Meiryo" charset="-128"/>
                <a:cs typeface="Meiryo" charset="-128"/>
              </a:rPr>
              <a:t>-30</a:t>
            </a:r>
            <a:endParaRPr lang="ja-JP" altLang="en-US" sz="1100" baseline="300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636954" y="2248437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533137" y="2289078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5082966" y="2248438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979283" y="2289078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7497716" y="2248437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8425702" y="2289078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9960042" y="2248438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809198" y="2258598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†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2670148" y="4252305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3567872" y="4250730"/>
            <a:ext cx="267564" cy="261610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altLang="ja-JP" sz="1100" dirty="0"/>
              <a:t>§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7537577" y="4250730"/>
            <a:ext cx="267564" cy="261610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altLang="ja-JP" sz="1100" dirty="0" smtClean="0"/>
              <a:t>§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8459668" y="4250730"/>
            <a:ext cx="267564" cy="261610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altLang="ja-JP" sz="1100" dirty="0"/>
              <a:t>§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9984991" y="4285801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10841853" y="4250731"/>
            <a:ext cx="267564" cy="261610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altLang="ja-JP" sz="1100" dirty="0"/>
              <a:t>§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2666304" y="6375328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†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3445994" y="6391954"/>
            <a:ext cx="488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Meiryo" charset="-128"/>
                <a:ea typeface="Meiryo" charset="-128"/>
                <a:cs typeface="Meiryo" charset="-128"/>
              </a:rPr>
              <a:t>0.003</a:t>
            </a:r>
            <a:endParaRPr kumimoji="1" lang="ja-JP" altLang="en-US" sz="8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5119015" y="6375328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†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6006578" y="6417354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7526296" y="6375328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†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8455823" y="6391954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9902027" y="6391954"/>
            <a:ext cx="4876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Meiryo" charset="-128"/>
                <a:ea typeface="Meiryo" charset="-128"/>
                <a:cs typeface="Meiryo" charset="-128"/>
              </a:rPr>
              <a:t>0.005</a:t>
            </a:r>
            <a:endParaRPr kumimoji="1" lang="ja-JP" altLang="en-US" sz="8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10729558" y="6391954"/>
            <a:ext cx="536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Meiryo" charset="-128"/>
                <a:ea typeface="Meiryo" charset="-128"/>
                <a:cs typeface="Meiryo" charset="-128"/>
              </a:rPr>
              <a:t>0.014</a:t>
            </a:r>
            <a:endParaRPr kumimoji="1" lang="ja-JP" altLang="en-US" sz="8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353058" y="577534"/>
            <a:ext cx="119616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Common BC </a:t>
            </a:r>
          </a:p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markers</a:t>
            </a:r>
            <a:endParaRPr lang="ja-JP" altLang="en-US" sz="1200" dirty="0"/>
          </a:p>
        </p:txBody>
      </p:sp>
      <p:sp>
        <p:nvSpPr>
          <p:cNvPr id="32" name="正方形/長方形 31"/>
          <p:cNvSpPr/>
          <p:nvPr/>
        </p:nvSpPr>
        <p:spPr>
          <a:xfrm>
            <a:off x="353058" y="2643963"/>
            <a:ext cx="15905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Luminal-dominant</a:t>
            </a:r>
          </a:p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markers</a:t>
            </a:r>
            <a:endParaRPr lang="ja-JP" altLang="en-US" sz="1200" dirty="0"/>
          </a:p>
        </p:txBody>
      </p:sp>
      <p:sp>
        <p:nvSpPr>
          <p:cNvPr id="33" name="正方形/長方形 32"/>
          <p:cNvSpPr/>
          <p:nvPr/>
        </p:nvSpPr>
        <p:spPr>
          <a:xfrm>
            <a:off x="353058" y="4764142"/>
            <a:ext cx="124906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TN-dominant </a:t>
            </a:r>
            <a:endParaRPr lang="en-US" altLang="ja-JP" sz="1200" dirty="0" smtClean="0">
              <a:latin typeface="Verdana" panose="020B060403050404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Verdana" panose="020B060403050404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markers</a:t>
            </a:r>
            <a:endParaRPr lang="ja-JP" altLang="en-US" sz="1200" dirty="0"/>
          </a:p>
        </p:txBody>
      </p:sp>
      <p:sp>
        <p:nvSpPr>
          <p:cNvPr id="74" name="右大かっこ 73"/>
          <p:cNvSpPr/>
          <p:nvPr/>
        </p:nvSpPr>
        <p:spPr>
          <a:xfrm rot="5400000" flipV="1">
            <a:off x="3027138" y="3972176"/>
            <a:ext cx="45719" cy="936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916215" y="4417316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76" name="右大かっこ 75"/>
          <p:cNvSpPr/>
          <p:nvPr/>
        </p:nvSpPr>
        <p:spPr>
          <a:xfrm rot="5400000" flipV="1">
            <a:off x="5464149" y="3981176"/>
            <a:ext cx="45719" cy="918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5353226" y="4417316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04" name="右大かっこ 103"/>
          <p:cNvSpPr/>
          <p:nvPr/>
        </p:nvSpPr>
        <p:spPr>
          <a:xfrm rot="5400000" flipV="1">
            <a:off x="7887901" y="3972177"/>
            <a:ext cx="45719" cy="936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7778913" y="4417316"/>
            <a:ext cx="267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06" name="右大かっこ 105"/>
          <p:cNvSpPr/>
          <p:nvPr/>
        </p:nvSpPr>
        <p:spPr>
          <a:xfrm rot="5400000" flipV="1">
            <a:off x="10316752" y="4008180"/>
            <a:ext cx="45719" cy="864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10205829" y="4417320"/>
            <a:ext cx="267565" cy="261610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altLang="ja-JP" sz="1100" dirty="0"/>
              <a:t>§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08" name="右大かっこ 107"/>
          <p:cNvSpPr/>
          <p:nvPr/>
        </p:nvSpPr>
        <p:spPr>
          <a:xfrm rot="5400000" flipV="1">
            <a:off x="3220182" y="5896689"/>
            <a:ext cx="45719" cy="132371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3103479" y="6597912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11" name="右大かっこ 110"/>
          <p:cNvSpPr/>
          <p:nvPr/>
        </p:nvSpPr>
        <p:spPr>
          <a:xfrm rot="5400000" flipV="1">
            <a:off x="5671067" y="5886844"/>
            <a:ext cx="45721" cy="1343397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5470722" y="6569754"/>
            <a:ext cx="488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Meiryo" charset="-128"/>
                <a:ea typeface="Meiryo" charset="-128"/>
                <a:cs typeface="Meiryo" charset="-128"/>
              </a:rPr>
              <a:t>0.23</a:t>
            </a:r>
            <a:endParaRPr kumimoji="1" lang="ja-JP" altLang="en-US" sz="8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13" name="右大かっこ 112"/>
          <p:cNvSpPr/>
          <p:nvPr/>
        </p:nvSpPr>
        <p:spPr>
          <a:xfrm rot="5400000" flipV="1">
            <a:off x="8112899" y="5865541"/>
            <a:ext cx="45719" cy="13860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8002755" y="6597912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Meiryo" charset="-128"/>
                <a:ea typeface="Meiryo" charset="-128"/>
                <a:cs typeface="Meiryo" charset="-128"/>
              </a:rPr>
              <a:t>*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115" name="右大かっこ 114"/>
          <p:cNvSpPr/>
          <p:nvPr/>
        </p:nvSpPr>
        <p:spPr>
          <a:xfrm rot="5400000" flipV="1">
            <a:off x="10536983" y="5906944"/>
            <a:ext cx="45719" cy="1303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10315656" y="6569755"/>
            <a:ext cx="488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Meiryo" charset="-128"/>
                <a:ea typeface="Meiryo" charset="-128"/>
                <a:cs typeface="Meiryo" charset="-128"/>
              </a:rPr>
              <a:t>0.010</a:t>
            </a:r>
            <a:endParaRPr kumimoji="1" lang="ja-JP" altLang="en-US" sz="8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5122858" y="4247414"/>
            <a:ext cx="266007" cy="26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¶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6026693" y="4244667"/>
            <a:ext cx="267564" cy="261610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altLang="ja-JP" sz="1100" dirty="0" smtClean="0"/>
              <a:t>§</a:t>
            </a:r>
            <a:endParaRPr kumimoji="1" lang="ja-JP" altLang="en-US" sz="1100" dirty="0">
              <a:latin typeface="Meiryo" charset="-128"/>
              <a:ea typeface="Meiryo" charset="-128"/>
              <a:cs typeface="Meiryo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2376146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9943" y="1371600"/>
            <a:ext cx="4511524" cy="4720686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18200" y="1371601"/>
            <a:ext cx="4665133" cy="4720686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4061927" y="6102179"/>
            <a:ext cx="4013470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/>
              <a:t>Signal intensity </a:t>
            </a:r>
            <a:r>
              <a:rPr lang="en-US" altLang="ja-JP"/>
              <a:t>of droplets from baseline</a:t>
            </a:r>
            <a:endParaRPr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185308" y="741775"/>
            <a:ext cx="7592786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dirty="0"/>
              <a:t>Tentative threshold with the highest AUC was selected as </a:t>
            </a:r>
            <a:r>
              <a:rPr lang="en-US" altLang="ja-JP"/>
              <a:t>optimized threshold</a:t>
            </a:r>
            <a:endParaRPr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 flipH="1" flipV="1">
            <a:off x="4061927" y="5794188"/>
            <a:ext cx="498054" cy="298098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/>
          <p:cNvCxnSpPr/>
          <p:nvPr/>
        </p:nvCxnSpPr>
        <p:spPr>
          <a:xfrm flipV="1">
            <a:off x="7458269" y="5794188"/>
            <a:ext cx="580950" cy="298099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/>
          <p:cNvCxnSpPr/>
          <p:nvPr/>
        </p:nvCxnSpPr>
        <p:spPr>
          <a:xfrm flipH="1">
            <a:off x="2440761" y="1111109"/>
            <a:ext cx="865386" cy="1039893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/>
          <p:cNvCxnSpPr/>
          <p:nvPr/>
        </p:nvCxnSpPr>
        <p:spPr>
          <a:xfrm>
            <a:off x="6581193" y="1111108"/>
            <a:ext cx="1392713" cy="810998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387626" y="242010"/>
            <a:ext cx="2586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 smtClean="0"/>
              <a:t>12-E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63080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91440" y="126057"/>
            <a:ext cx="2529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A</a:t>
            </a:r>
            <a:endParaRPr kumimoji="1" lang="ja-JP" altLang="en-US" dirty="0"/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2"/>
          <a:srcRect t="5520"/>
          <a:stretch/>
        </p:blipFill>
        <p:spPr>
          <a:xfrm>
            <a:off x="91440" y="729000"/>
            <a:ext cx="11457432" cy="2602653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91440" y="544334"/>
            <a:ext cx="2619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Common BC marker: </a:t>
            </a:r>
            <a:r>
              <a:rPr kumimoji="1" lang="en-US" altLang="ja-JP" dirty="0" smtClean="0"/>
              <a:t>JAK3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>
            <a:off x="5632704" y="3511296"/>
            <a:ext cx="969264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5758396" y="3223485"/>
            <a:ext cx="644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graphicFrame>
        <p:nvGraphicFramePr>
          <p:cNvPr id="16" name="グラフ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169852"/>
              </p:ext>
            </p:extLst>
          </p:nvPr>
        </p:nvGraphicFramePr>
        <p:xfrm>
          <a:off x="457200" y="3672000"/>
          <a:ext cx="11622024" cy="2934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6700011" y="340965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0" name="直線矢印コネクタ 9"/>
          <p:cNvCxnSpPr/>
          <p:nvPr/>
        </p:nvCxnSpPr>
        <p:spPr>
          <a:xfrm flipH="1">
            <a:off x="6333619" y="3615559"/>
            <a:ext cx="394041" cy="16769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96815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91440" y="126057"/>
            <a:ext cx="2481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B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/>
          <a:srcRect l="975" t="5296"/>
          <a:stretch/>
        </p:blipFill>
        <p:spPr>
          <a:xfrm>
            <a:off x="256032" y="913666"/>
            <a:ext cx="11356848" cy="2440764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91440" y="560815"/>
            <a:ext cx="30095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Common </a:t>
            </a:r>
            <a:r>
              <a:rPr lang="en-US" altLang="ja-JP" dirty="0"/>
              <a:t>BC </a:t>
            </a:r>
            <a:r>
              <a:rPr lang="en-US" altLang="ja-JP" dirty="0" smtClean="0"/>
              <a:t>marker: </a:t>
            </a:r>
            <a:r>
              <a:rPr kumimoji="1" lang="en-US" altLang="ja-JP" dirty="0" smtClean="0"/>
              <a:t>RASGRF1</a:t>
            </a:r>
            <a:endParaRPr kumimoji="1" lang="ja-JP" altLang="en-US" dirty="0"/>
          </a:p>
        </p:txBody>
      </p:sp>
      <p:graphicFrame>
        <p:nvGraphicFramePr>
          <p:cNvPr id="11" name="グラフ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452066"/>
              </p:ext>
            </p:extLst>
          </p:nvPr>
        </p:nvGraphicFramePr>
        <p:xfrm>
          <a:off x="530352" y="3600000"/>
          <a:ext cx="11594592" cy="3027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2" name="直線矢印コネクタ 11"/>
          <p:cNvCxnSpPr/>
          <p:nvPr/>
        </p:nvCxnSpPr>
        <p:spPr>
          <a:xfrm>
            <a:off x="5989320" y="3541244"/>
            <a:ext cx="630936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6005284" y="3263707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829456" y="3381540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430912" y="3576480"/>
            <a:ext cx="450150" cy="184666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779565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グラフ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6048833"/>
              </p:ext>
            </p:extLst>
          </p:nvPr>
        </p:nvGraphicFramePr>
        <p:xfrm>
          <a:off x="365760" y="3672000"/>
          <a:ext cx="11826240" cy="3018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91440" y="126057"/>
            <a:ext cx="2480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C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440" y="560815"/>
            <a:ext cx="2877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Common </a:t>
            </a:r>
            <a:r>
              <a:rPr lang="en-US" altLang="ja-JP" dirty="0"/>
              <a:t>BC </a:t>
            </a:r>
            <a:r>
              <a:rPr lang="en-US" altLang="ja-JP" dirty="0" smtClean="0"/>
              <a:t>marker: </a:t>
            </a:r>
            <a:r>
              <a:rPr kumimoji="1" lang="en-US" altLang="ja-JP" dirty="0" smtClean="0"/>
              <a:t>CPXM1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5980176" y="3519934"/>
            <a:ext cx="1234440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6261316" y="3232123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/>
          <a:srcRect l="2775" t="6142"/>
          <a:stretch/>
        </p:blipFill>
        <p:spPr>
          <a:xfrm>
            <a:off x="243840" y="980676"/>
            <a:ext cx="11332464" cy="2328650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6752561" y="346220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379780" y="3699641"/>
            <a:ext cx="432000" cy="10036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73191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9700290"/>
              </p:ext>
            </p:extLst>
          </p:nvPr>
        </p:nvGraphicFramePr>
        <p:xfrm>
          <a:off x="502920" y="3600000"/>
          <a:ext cx="11603736" cy="3117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91440" y="126057"/>
            <a:ext cx="2499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D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5971032" y="3509424"/>
            <a:ext cx="603504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5996140" y="3211103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2475" t="8282"/>
          <a:stretch/>
        </p:blipFill>
        <p:spPr>
          <a:xfrm>
            <a:off x="219456" y="698216"/>
            <a:ext cx="11329416" cy="2512887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91440" y="560815"/>
            <a:ext cx="2560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Common </a:t>
            </a:r>
            <a:r>
              <a:rPr lang="en-US" altLang="ja-JP" dirty="0"/>
              <a:t>BC </a:t>
            </a:r>
            <a:r>
              <a:rPr lang="en-US" altLang="ja-JP" dirty="0" smtClean="0"/>
              <a:t>marker: </a:t>
            </a:r>
            <a:r>
              <a:rPr kumimoji="1" lang="en-US" altLang="ja-JP" dirty="0" smtClean="0"/>
              <a:t>SHF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710521" y="339914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365149" y="3594539"/>
            <a:ext cx="394041" cy="16769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509248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グラフ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3688160"/>
              </p:ext>
            </p:extLst>
          </p:nvPr>
        </p:nvGraphicFramePr>
        <p:xfrm>
          <a:off x="292608" y="3636000"/>
          <a:ext cx="11804904" cy="31413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91440" y="126057"/>
            <a:ext cx="2469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E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6195060" y="3530900"/>
            <a:ext cx="580644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6179020" y="3211103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/>
          <a:srcRect l="3075" t="10499"/>
          <a:stretch/>
        </p:blipFill>
        <p:spPr>
          <a:xfrm>
            <a:off x="173736" y="807824"/>
            <a:ext cx="11347704" cy="2465475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91440" y="469590"/>
            <a:ext cx="3349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Luminal-dominant marker: </a:t>
            </a:r>
            <a:r>
              <a:rPr kumimoji="1" lang="en-US" altLang="ja-JP" dirty="0" smtClean="0"/>
              <a:t>DNM3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815621" y="340965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>
            <a:stCxn id="11" idx="1"/>
          </p:cNvCxnSpPr>
          <p:nvPr/>
        </p:nvCxnSpPr>
        <p:spPr>
          <a:xfrm flipH="1">
            <a:off x="6354641" y="3594322"/>
            <a:ext cx="504000" cy="14689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126417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5950335"/>
              </p:ext>
            </p:extLst>
          </p:nvPr>
        </p:nvGraphicFramePr>
        <p:xfrm>
          <a:off x="301752" y="3584448"/>
          <a:ext cx="11814048" cy="31729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91440" y="126057"/>
            <a:ext cx="2462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-F</a:t>
            </a:r>
            <a:endParaRPr kumimoji="1" lang="ja-JP" altLang="en-US" dirty="0"/>
          </a:p>
        </p:txBody>
      </p:sp>
      <p:cxnSp>
        <p:nvCxnSpPr>
          <p:cNvPr id="12" name="直線矢印コネクタ 11"/>
          <p:cNvCxnSpPr/>
          <p:nvPr/>
        </p:nvCxnSpPr>
        <p:spPr>
          <a:xfrm>
            <a:off x="5660136" y="3575177"/>
            <a:ext cx="771506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5730964" y="3302125"/>
            <a:ext cx="669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FF0000"/>
                </a:solidFill>
                <a:latin typeface="Verdana" charset="0"/>
                <a:ea typeface="Verdana" charset="0"/>
                <a:cs typeface="Verdana" charset="0"/>
              </a:rPr>
              <a:t>DMR</a:t>
            </a:r>
            <a:endParaRPr kumimoji="1" lang="ja-JP" altLang="en-US" sz="1400" b="1" dirty="0">
              <a:solidFill>
                <a:srgbClr val="FF0000"/>
              </a:solidFill>
              <a:latin typeface="Verdana" charset="0"/>
              <a:ea typeface="Verdana" charset="0"/>
              <a:cs typeface="Verdana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3750" t="6125"/>
          <a:stretch/>
        </p:blipFill>
        <p:spPr>
          <a:xfrm>
            <a:off x="173736" y="802346"/>
            <a:ext cx="11347704" cy="2573348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91440" y="433014"/>
            <a:ext cx="3238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Luminal-dominant marker: </a:t>
            </a:r>
            <a:r>
              <a:rPr kumimoji="1" lang="en-US" altLang="ja-JP" dirty="0" smtClean="0"/>
              <a:t>CAV2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710521" y="3315066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arget probe locus</a:t>
            </a:r>
            <a:endParaRPr kumimoji="1" lang="ja-JP" altLang="en-US" dirty="0"/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6344129" y="3520969"/>
            <a:ext cx="394041" cy="16769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06083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007</TotalTime>
  <Words>610</Words>
  <Application>Microsoft Macintosh PowerPoint</Application>
  <PresentationFormat>ワイド画面</PresentationFormat>
  <Paragraphs>236</Paragraphs>
  <Slides>30</Slides>
  <Notes>7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0</vt:i4>
      </vt:variant>
    </vt:vector>
  </HeadingPairs>
  <TitlesOfParts>
    <vt:vector size="40" baseType="lpstr">
      <vt:lpstr>Calibri</vt:lpstr>
      <vt:lpstr>Calibri Light</vt:lpstr>
      <vt:lpstr>Courier</vt:lpstr>
      <vt:lpstr>Meiryo</vt:lpstr>
      <vt:lpstr>ＭＳ Ｐゴシック</vt:lpstr>
      <vt:lpstr>Times New Roman</vt:lpstr>
      <vt:lpstr>Verdana</vt:lpstr>
      <vt:lpstr>Yu Mincho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Supplemental Figure 8 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tsue Uehiro</dc:creator>
  <cp:lastModifiedBy>佐藤史顕</cp:lastModifiedBy>
  <cp:revision>283</cp:revision>
  <dcterms:created xsi:type="dcterms:W3CDTF">2014-06-15T12:49:51Z</dcterms:created>
  <dcterms:modified xsi:type="dcterms:W3CDTF">2016-11-27T18:55:37Z</dcterms:modified>
</cp:coreProperties>
</file>